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283" r:id="rId2"/>
    <p:sldId id="299" r:id="rId3"/>
    <p:sldId id="296" r:id="rId4"/>
    <p:sldId id="298" r:id="rId5"/>
    <p:sldId id="297" r:id="rId6"/>
    <p:sldId id="272" r:id="rId7"/>
    <p:sldId id="300" r:id="rId8"/>
    <p:sldId id="303" r:id="rId9"/>
    <p:sldId id="304" r:id="rId10"/>
    <p:sldId id="305" r:id="rId11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F30CCA5-3923-D003-563F-26CF711A8023}" name="Stanislas Dehaene" initials="SD" userId="516944819e68dc0c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BBE57"/>
    <a:srgbClr val="3EA0D1"/>
    <a:srgbClr val="C70111"/>
    <a:srgbClr val="F99E4B"/>
    <a:srgbClr val="D7191C"/>
    <a:srgbClr val="89B790"/>
    <a:srgbClr val="FFFFBF"/>
    <a:srgbClr val="6AAE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784"/>
    <p:restoredTop sz="94792"/>
  </p:normalViewPr>
  <p:slideViewPr>
    <p:cSldViewPr snapToGrid="0">
      <p:cViewPr varScale="1">
        <p:scale>
          <a:sx n="70" d="100"/>
          <a:sy n="70" d="100"/>
        </p:scale>
        <p:origin x="238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6" d="100"/>
          <a:sy n="96" d="100"/>
        </p:scale>
        <p:origin x="3688" y="17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anislas Dehaene" userId="516944819e68dc0c" providerId="LiveId" clId="{0454576E-37AC-4F25-A3FF-231DF9C41E8D}"/>
    <pc:docChg chg="undo custSel modSld">
      <pc:chgData name="Stanislas Dehaene" userId="516944819e68dc0c" providerId="LiveId" clId="{0454576E-37AC-4F25-A3FF-231DF9C41E8D}" dt="2024-10-17T14:05:22.322" v="720" actId="1038"/>
      <pc:docMkLst>
        <pc:docMk/>
      </pc:docMkLst>
      <pc:sldChg chg="modSp mod">
        <pc:chgData name="Stanislas Dehaene" userId="516944819e68dc0c" providerId="LiveId" clId="{0454576E-37AC-4F25-A3FF-231DF9C41E8D}" dt="2024-10-16T08:39:22.725" v="112" actId="20577"/>
        <pc:sldMkLst>
          <pc:docMk/>
          <pc:sldMk cId="1898854225" sldId="287"/>
        </pc:sldMkLst>
        <pc:spChg chg="mod">
          <ac:chgData name="Stanislas Dehaene" userId="516944819e68dc0c" providerId="LiveId" clId="{0454576E-37AC-4F25-A3FF-231DF9C41E8D}" dt="2024-10-16T08:39:13.966" v="100" actId="1035"/>
          <ac:spMkLst>
            <pc:docMk/>
            <pc:sldMk cId="1898854225" sldId="287"/>
            <ac:spMk id="4" creationId="{E4BD739C-DB2D-7A6C-4131-310B23AE8506}"/>
          </ac:spMkLst>
        </pc:spChg>
        <pc:spChg chg="mod">
          <ac:chgData name="Stanislas Dehaene" userId="516944819e68dc0c" providerId="LiveId" clId="{0454576E-37AC-4F25-A3FF-231DF9C41E8D}" dt="2024-10-16T08:39:13.966" v="100" actId="1035"/>
          <ac:spMkLst>
            <pc:docMk/>
            <pc:sldMk cId="1898854225" sldId="287"/>
            <ac:spMk id="6" creationId="{7777B342-B4C0-9980-8669-C77CCA548A35}"/>
          </ac:spMkLst>
        </pc:spChg>
        <pc:spChg chg="mod">
          <ac:chgData name="Stanislas Dehaene" userId="516944819e68dc0c" providerId="LiveId" clId="{0454576E-37AC-4F25-A3FF-231DF9C41E8D}" dt="2024-10-16T08:39:22.725" v="112" actId="20577"/>
          <ac:spMkLst>
            <pc:docMk/>
            <pc:sldMk cId="1898854225" sldId="287"/>
            <ac:spMk id="8" creationId="{6F511ED8-259E-5714-5150-A3FEE5F04E86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10" creationId="{3E7EA383-5F3B-FBBA-69B7-802318FCA45A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12" creationId="{124A6570-CC60-DBFB-9A93-F7262DD1BACF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14" creationId="{147BF8F8-E87B-46D1-73DB-18104B1FFC21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22" creationId="{D31FFA3B-F6BB-4A13-333C-8892991C11E7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23" creationId="{624ABD78-A2FE-F5EB-F794-59AFB7B4BE79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24" creationId="{4C34C661-84C7-28C0-4932-8DB12819FE64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25" creationId="{99CFEF48-F78A-5E50-821C-EE0C6227E4FF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26" creationId="{A49CFB82-4877-8B5A-C6E3-CC93E9873B1F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28" creationId="{1AED4C94-01D1-1455-65A8-DED675A767BC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0" creationId="{A0030273-41B3-7FA3-B2C1-F1BA004BBDF8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1" creationId="{2EEF1DF8-8355-AC7A-B549-44C03E320802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2" creationId="{3865F5AD-99ED-E067-17BD-48A0755F7DAB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3" creationId="{F79E2FBD-05BC-E562-02D7-1E2F2E2E6FDA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4" creationId="{E26FE066-2CC3-BBBE-D1A3-C8DDC2731F43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6" creationId="{7B1D0EAE-46ED-35E8-A0E5-A9D0DD6917B6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38" creationId="{E118F29C-AC07-1144-68BF-451FC2C82AE7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40" creationId="{B7690322-6265-4150-5ADC-369B98A6DB2C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46" creationId="{8870B85F-2A85-0D38-F1C4-C6AA165AD69D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48" creationId="{F47EA857-901E-2426-2194-725B02A6923B}"/>
          </ac:spMkLst>
        </pc:spChg>
        <pc:spChg chg="mod">
          <ac:chgData name="Stanislas Dehaene" userId="516944819e68dc0c" providerId="LiveId" clId="{0454576E-37AC-4F25-A3FF-231DF9C41E8D}" dt="2024-10-16T08:39:08.143" v="84" actId="1035"/>
          <ac:spMkLst>
            <pc:docMk/>
            <pc:sldMk cId="1898854225" sldId="287"/>
            <ac:spMk id="50" creationId="{A6C9F389-EB84-CA31-7DB4-BD92D3426083}"/>
          </ac:spMkLst>
        </pc:spChg>
        <pc:spChg chg="mod">
          <ac:chgData name="Stanislas Dehaene" userId="516944819e68dc0c" providerId="LiveId" clId="{0454576E-37AC-4F25-A3FF-231DF9C41E8D}" dt="2024-10-16T08:38:34.447" v="59" actId="1037"/>
          <ac:spMkLst>
            <pc:docMk/>
            <pc:sldMk cId="1898854225" sldId="287"/>
            <ac:spMk id="60" creationId="{09394256-FA36-A841-D1D5-CCE85E7FDFCF}"/>
          </ac:spMkLst>
        </pc:spChg>
        <pc:spChg chg="mod">
          <ac:chgData name="Stanislas Dehaene" userId="516944819e68dc0c" providerId="LiveId" clId="{0454576E-37AC-4F25-A3FF-231DF9C41E8D}" dt="2024-10-16T08:38:34.447" v="59" actId="1037"/>
          <ac:spMkLst>
            <pc:docMk/>
            <pc:sldMk cId="1898854225" sldId="287"/>
            <ac:spMk id="61" creationId="{4E038727-5861-1899-5A0B-73EC1901E14A}"/>
          </ac:spMkLst>
        </pc:spChg>
        <pc:spChg chg="mod">
          <ac:chgData name="Stanislas Dehaene" userId="516944819e68dc0c" providerId="LiveId" clId="{0454576E-37AC-4F25-A3FF-231DF9C41E8D}" dt="2024-10-16T08:38:45.488" v="69" actId="1035"/>
          <ac:spMkLst>
            <pc:docMk/>
            <pc:sldMk cId="1898854225" sldId="287"/>
            <ac:spMk id="110" creationId="{D9B032BE-B524-C6A1-927F-0E55C39B3BC3}"/>
          </ac:spMkLst>
        </pc:spChg>
        <pc:spChg chg="mod">
          <ac:chgData name="Stanislas Dehaene" userId="516944819e68dc0c" providerId="LiveId" clId="{0454576E-37AC-4F25-A3FF-231DF9C41E8D}" dt="2024-10-16T08:39:19.464" v="110" actId="1036"/>
          <ac:spMkLst>
            <pc:docMk/>
            <pc:sldMk cId="1898854225" sldId="287"/>
            <ac:spMk id="146" creationId="{5FA47AA6-CE52-A633-0624-400CD06851C8}"/>
          </ac:spMkLst>
        </pc:sp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5" creationId="{4F7786C0-9B5E-9237-AE36-0B80BB36F2E5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7" creationId="{82740057-BD60-3B13-762E-66628D920CED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9" creationId="{6007FB4B-489A-ED4F-48C1-C8967A5F489C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3" creationId="{7BB4EBCF-C37F-9254-F283-B1B4C6EDA52C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5" creationId="{C3101FCC-D37E-BA4A-53B7-1904329162AD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7" creationId="{DF63B3F5-D182-2EF8-5791-B8E849C8A606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27" creationId="{1F90AECB-FFBF-8291-0C47-A17ACAC7947D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66" creationId="{E7BE4C2E-6F17-8E3C-CEC4-541D6726F200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70" creationId="{EB172542-DE6F-2CFB-BAF4-9351B759DE96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85" creationId="{60AF49E3-A766-5B05-8EF7-ACA2C921CFAE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17" creationId="{C89EB243-D666-C475-352A-157CC5D80F16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19" creationId="{FAE4C6C2-625E-155E-323C-45A96775C89E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21" creationId="{234AACBC-C5A6-F0C7-37E1-7B062751B40B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23" creationId="{30B106FC-02C2-067F-74D5-B2914E8FC303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25" creationId="{75DC7FE4-7B98-1BE0-369C-F4EC174BBD86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27" creationId="{E135CA66-BC9B-086C-9881-D061A752D051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37" creationId="{2D01B233-AAD4-F86A-87B5-12CAA9707D90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39" creationId="{5512532E-9DFF-11F2-6690-6B83411B5D01}"/>
          </ac:picMkLst>
        </pc:picChg>
        <pc:picChg chg="mod">
          <ac:chgData name="Stanislas Dehaene" userId="516944819e68dc0c" providerId="LiveId" clId="{0454576E-37AC-4F25-A3FF-231DF9C41E8D}" dt="2024-10-16T08:39:08.143" v="84" actId="1035"/>
          <ac:picMkLst>
            <pc:docMk/>
            <pc:sldMk cId="1898854225" sldId="287"/>
            <ac:picMk id="141" creationId="{59DD24EC-B9B8-3CC4-9B97-723211E6A3F9}"/>
          </ac:picMkLst>
        </pc:picChg>
      </pc:sldChg>
      <pc:sldChg chg="modSp mod">
        <pc:chgData name="Stanislas Dehaene" userId="516944819e68dc0c" providerId="LiveId" clId="{0454576E-37AC-4F25-A3FF-231DF9C41E8D}" dt="2024-10-16T08:41:35.715" v="123"/>
        <pc:sldMkLst>
          <pc:docMk/>
          <pc:sldMk cId="4160801306" sldId="288"/>
        </pc:sldMkLst>
        <pc:graphicFrameChg chg="mod modGraphic">
          <ac:chgData name="Stanislas Dehaene" userId="516944819e68dc0c" providerId="LiveId" clId="{0454576E-37AC-4F25-A3FF-231DF9C41E8D}" dt="2024-10-16T08:41:35.715" v="123"/>
          <ac:graphicFrameMkLst>
            <pc:docMk/>
            <pc:sldMk cId="4160801306" sldId="288"/>
            <ac:graphicFrameMk id="104" creationId="{2BDC7B5D-EAA1-C58C-1668-8D537B4969E1}"/>
          </ac:graphicFrameMkLst>
        </pc:graphicFrameChg>
      </pc:sldChg>
      <pc:sldChg chg="addSp delSp modSp mod">
        <pc:chgData name="Stanislas Dehaene" userId="516944819e68dc0c" providerId="LiveId" clId="{0454576E-37AC-4F25-A3FF-231DF9C41E8D}" dt="2024-10-17T14:01:42.128" v="629" actId="1036"/>
        <pc:sldMkLst>
          <pc:docMk/>
          <pc:sldMk cId="3578471984" sldId="293"/>
        </pc:sldMkLst>
        <pc:spChg chg="add mod topLvl">
          <ac:chgData name="Stanislas Dehaene" userId="516944819e68dc0c" providerId="LiveId" clId="{0454576E-37AC-4F25-A3FF-231DF9C41E8D}" dt="2024-10-17T13:58:56.172" v="395" actId="1037"/>
          <ac:spMkLst>
            <pc:docMk/>
            <pc:sldMk cId="3578471984" sldId="293"/>
            <ac:spMk id="4" creationId="{FF42F256-E3B8-C7EA-F642-D273644C62CA}"/>
          </ac:spMkLst>
        </pc:spChg>
        <pc:spChg chg="mod">
          <ac:chgData name="Stanislas Dehaene" userId="516944819e68dc0c" providerId="LiveId" clId="{0454576E-37AC-4F25-A3FF-231DF9C41E8D}" dt="2024-10-17T14:01:13.408" v="576" actId="113"/>
          <ac:spMkLst>
            <pc:docMk/>
            <pc:sldMk cId="3578471984" sldId="293"/>
            <ac:spMk id="7" creationId="{F406C956-2CE9-33C2-C517-64BB254BE0A9}"/>
          </ac:spMkLst>
        </pc:spChg>
        <pc:spChg chg="mod">
          <ac:chgData name="Stanislas Dehaene" userId="516944819e68dc0c" providerId="LiveId" clId="{0454576E-37AC-4F25-A3FF-231DF9C41E8D}" dt="2024-10-17T14:01:13.408" v="576" actId="113"/>
          <ac:spMkLst>
            <pc:docMk/>
            <pc:sldMk cId="3578471984" sldId="293"/>
            <ac:spMk id="8" creationId="{51901B0D-EAEA-69F3-9CE6-8D3D0331C147}"/>
          </ac:spMkLst>
        </pc:spChg>
        <pc:spChg chg="mod">
          <ac:chgData name="Stanislas Dehaene" userId="516944819e68dc0c" providerId="LiveId" clId="{0454576E-37AC-4F25-A3FF-231DF9C41E8D}" dt="2024-10-17T14:01:13.408" v="576" actId="113"/>
          <ac:spMkLst>
            <pc:docMk/>
            <pc:sldMk cId="3578471984" sldId="293"/>
            <ac:spMk id="9" creationId="{BD89C8D8-EB77-E796-BAA1-AD43B10393EA}"/>
          </ac:spMkLst>
        </pc:spChg>
        <pc:spChg chg="mod ord">
          <ac:chgData name="Stanislas Dehaene" userId="516944819e68dc0c" providerId="LiveId" clId="{0454576E-37AC-4F25-A3FF-231DF9C41E8D}" dt="2024-10-17T14:01:35.491" v="611" actId="1037"/>
          <ac:spMkLst>
            <pc:docMk/>
            <pc:sldMk cId="3578471984" sldId="293"/>
            <ac:spMk id="10" creationId="{92D99E56-A35A-3FB6-FCB7-511ACEBD04CC}"/>
          </ac:spMkLst>
        </pc:spChg>
        <pc:spChg chg="mod">
          <ac:chgData name="Stanislas Dehaene" userId="516944819e68dc0c" providerId="LiveId" clId="{0454576E-37AC-4F25-A3FF-231DF9C41E8D}" dt="2024-10-17T14:01:42.128" v="629" actId="1036"/>
          <ac:spMkLst>
            <pc:docMk/>
            <pc:sldMk cId="3578471984" sldId="293"/>
            <ac:spMk id="13" creationId="{254AC920-BE2D-B4A3-7DC9-76FCEB274A0B}"/>
          </ac:spMkLst>
        </pc:spChg>
        <pc:spChg chg="mod">
          <ac:chgData name="Stanislas Dehaene" userId="516944819e68dc0c" providerId="LiveId" clId="{0454576E-37AC-4F25-A3FF-231DF9C41E8D}" dt="2024-10-17T14:01:17.637" v="577" actId="113"/>
          <ac:spMkLst>
            <pc:docMk/>
            <pc:sldMk cId="3578471984" sldId="293"/>
            <ac:spMk id="20" creationId="{EA029FE2-4AF4-4C15-220C-F03A70A70660}"/>
          </ac:spMkLst>
        </pc:spChg>
        <pc:spChg chg="mod">
          <ac:chgData name="Stanislas Dehaene" userId="516944819e68dc0c" providerId="LiveId" clId="{0454576E-37AC-4F25-A3FF-231DF9C41E8D}" dt="2024-10-17T14:01:17.637" v="577" actId="113"/>
          <ac:spMkLst>
            <pc:docMk/>
            <pc:sldMk cId="3578471984" sldId="293"/>
            <ac:spMk id="24" creationId="{22EE45F5-9DAC-7C54-76C0-DD0F2C99C990}"/>
          </ac:spMkLst>
        </pc:spChg>
        <pc:spChg chg="mod">
          <ac:chgData name="Stanislas Dehaene" userId="516944819e68dc0c" providerId="LiveId" clId="{0454576E-37AC-4F25-A3FF-231DF9C41E8D}" dt="2024-10-17T14:01:17.637" v="577" actId="113"/>
          <ac:spMkLst>
            <pc:docMk/>
            <pc:sldMk cId="3578471984" sldId="293"/>
            <ac:spMk id="25" creationId="{46EBC343-E68C-AA8D-EE79-C0F32EBD60D0}"/>
          </ac:spMkLst>
        </pc:spChg>
        <pc:spChg chg="mod topLvl">
          <ac:chgData name="Stanislas Dehaene" userId="516944819e68dc0c" providerId="LiveId" clId="{0454576E-37AC-4F25-A3FF-231DF9C41E8D}" dt="2024-10-17T14:01:22.993" v="578" actId="113"/>
          <ac:spMkLst>
            <pc:docMk/>
            <pc:sldMk cId="3578471984" sldId="293"/>
            <ac:spMk id="29" creationId="{866810B9-9741-3103-00C5-CC7B3450E815}"/>
          </ac:spMkLst>
        </pc:spChg>
        <pc:spChg chg="mod">
          <ac:chgData name="Stanislas Dehaene" userId="516944819e68dc0c" providerId="LiveId" clId="{0454576E-37AC-4F25-A3FF-231DF9C41E8D}" dt="2024-10-17T14:00:30.246" v="451" actId="403"/>
          <ac:spMkLst>
            <pc:docMk/>
            <pc:sldMk cId="3578471984" sldId="293"/>
            <ac:spMk id="30" creationId="{10A6A7C2-176E-8317-4174-93663341DF8A}"/>
          </ac:spMkLst>
        </pc:spChg>
        <pc:spChg chg="mod">
          <ac:chgData name="Stanislas Dehaene" userId="516944819e68dc0c" providerId="LiveId" clId="{0454576E-37AC-4F25-A3FF-231DF9C41E8D}" dt="2024-10-17T14:00:07.847" v="448" actId="403"/>
          <ac:spMkLst>
            <pc:docMk/>
            <pc:sldMk cId="3578471984" sldId="293"/>
            <ac:spMk id="31" creationId="{6FCD7376-3CAA-93DC-8B57-2D3934795399}"/>
          </ac:spMkLst>
        </pc:spChg>
        <pc:spChg chg="mod topLvl">
          <ac:chgData name="Stanislas Dehaene" userId="516944819e68dc0c" providerId="LiveId" clId="{0454576E-37AC-4F25-A3FF-231DF9C41E8D}" dt="2024-10-17T14:01:22.993" v="578" actId="113"/>
          <ac:spMkLst>
            <pc:docMk/>
            <pc:sldMk cId="3578471984" sldId="293"/>
            <ac:spMk id="32" creationId="{9D82DE07-7F92-795A-61BA-28F92E495150}"/>
          </ac:spMkLst>
        </pc:spChg>
        <pc:spChg chg="mod topLvl">
          <ac:chgData name="Stanislas Dehaene" userId="516944819e68dc0c" providerId="LiveId" clId="{0454576E-37AC-4F25-A3FF-231DF9C41E8D}" dt="2024-10-17T14:01:22.993" v="578" actId="113"/>
          <ac:spMkLst>
            <pc:docMk/>
            <pc:sldMk cId="3578471984" sldId="293"/>
            <ac:spMk id="33" creationId="{35C4E2FA-4A08-8865-D965-20C01B4310D0}"/>
          </ac:spMkLst>
        </pc:spChg>
        <pc:spChg chg="mod topLvl">
          <ac:chgData name="Stanislas Dehaene" userId="516944819e68dc0c" providerId="LiveId" clId="{0454576E-37AC-4F25-A3FF-231DF9C41E8D}" dt="2024-10-17T14:01:22.993" v="578" actId="113"/>
          <ac:spMkLst>
            <pc:docMk/>
            <pc:sldMk cId="3578471984" sldId="293"/>
            <ac:spMk id="34" creationId="{5E8427FC-A074-4845-D7A3-9F4CEB1B048A}"/>
          </ac:spMkLst>
        </pc:spChg>
        <pc:grpChg chg="mod ord">
          <ac:chgData name="Stanislas Dehaene" userId="516944819e68dc0c" providerId="LiveId" clId="{0454576E-37AC-4F25-A3FF-231DF9C41E8D}" dt="2024-10-17T14:00:39.968" v="504" actId="1035"/>
          <ac:grpSpMkLst>
            <pc:docMk/>
            <pc:sldMk cId="3578471984" sldId="293"/>
            <ac:grpSpMk id="5" creationId="{B7A410FA-A09C-E7DB-D055-A49316710CBE}"/>
          </ac:grpSpMkLst>
        </pc:grpChg>
        <pc:grpChg chg="add del mod">
          <ac:chgData name="Stanislas Dehaene" userId="516944819e68dc0c" providerId="LiveId" clId="{0454576E-37AC-4F25-A3FF-231DF9C41E8D}" dt="2024-10-17T13:58:12.324" v="314" actId="165"/>
          <ac:grpSpMkLst>
            <pc:docMk/>
            <pc:sldMk cId="3578471984" sldId="293"/>
            <ac:grpSpMk id="6" creationId="{2E15CE21-585B-D7E2-E0BC-5FB74E340229}"/>
          </ac:grpSpMkLst>
        </pc:grpChg>
        <pc:grpChg chg="add mod">
          <ac:chgData name="Stanislas Dehaene" userId="516944819e68dc0c" providerId="LiveId" clId="{0454576E-37AC-4F25-A3FF-231DF9C41E8D}" dt="2024-10-17T13:58:53.057" v="387" actId="1035"/>
          <ac:grpSpMkLst>
            <pc:docMk/>
            <pc:sldMk cId="3578471984" sldId="293"/>
            <ac:grpSpMk id="11" creationId="{234D0E59-8166-A873-5339-AAC0C7B507ED}"/>
          </ac:grpSpMkLst>
        </pc:grpChg>
        <pc:grpChg chg="add mod">
          <ac:chgData name="Stanislas Dehaene" userId="516944819e68dc0c" providerId="LiveId" clId="{0454576E-37AC-4F25-A3FF-231DF9C41E8D}" dt="2024-10-17T13:58:39.445" v="353" actId="552"/>
          <ac:grpSpMkLst>
            <pc:docMk/>
            <pc:sldMk cId="3578471984" sldId="293"/>
            <ac:grpSpMk id="12" creationId="{275DE24D-4D07-57C8-B4CC-703926ADD9F5}"/>
          </ac:grpSpMkLst>
        </pc:grpChg>
        <pc:grpChg chg="mod">
          <ac:chgData name="Stanislas Dehaene" userId="516944819e68dc0c" providerId="LiveId" clId="{0454576E-37AC-4F25-A3FF-231DF9C41E8D}" dt="2024-10-17T13:58:03.563" v="312" actId="1037"/>
          <ac:grpSpMkLst>
            <pc:docMk/>
            <pc:sldMk cId="3578471984" sldId="293"/>
            <ac:grpSpMk id="17" creationId="{E17A2A20-C46A-E033-91A9-FEC585D50369}"/>
          </ac:grpSpMkLst>
        </pc:grpChg>
        <pc:grpChg chg="mod">
          <ac:chgData name="Stanislas Dehaene" userId="516944819e68dc0c" providerId="LiveId" clId="{0454576E-37AC-4F25-A3FF-231DF9C41E8D}" dt="2024-10-17T13:58:03.563" v="312" actId="1037"/>
          <ac:grpSpMkLst>
            <pc:docMk/>
            <pc:sldMk cId="3578471984" sldId="293"/>
            <ac:grpSpMk id="18" creationId="{44C51F5F-C0D8-682B-0798-6A5A1538E782}"/>
          </ac:grpSpMkLst>
        </pc:grpChg>
        <pc:graphicFrameChg chg="mod">
          <ac:chgData name="Stanislas Dehaene" userId="516944819e68dc0c" providerId="LiveId" clId="{0454576E-37AC-4F25-A3FF-231DF9C41E8D}" dt="2024-10-17T13:59:46.398" v="443" actId="1036"/>
          <ac:graphicFrameMkLst>
            <pc:docMk/>
            <pc:sldMk cId="3578471984" sldId="293"/>
            <ac:graphicFrameMk id="19" creationId="{65CC7EB2-DF58-C837-3E59-8C54B292EC86}"/>
          </ac:graphicFrameMkLst>
        </pc:graphicFrameChg>
        <pc:graphicFrameChg chg="mod ord">
          <ac:chgData name="Stanislas Dehaene" userId="516944819e68dc0c" providerId="LiveId" clId="{0454576E-37AC-4F25-A3FF-231DF9C41E8D}" dt="2024-10-17T13:59:36.008" v="424" actId="166"/>
          <ac:graphicFrameMkLst>
            <pc:docMk/>
            <pc:sldMk cId="3578471984" sldId="293"/>
            <ac:graphicFrameMk id="21" creationId="{C7591DDC-E970-DC30-8E30-332FEF7429BD}"/>
          </ac:graphicFrameMkLst>
        </pc:graphicFrameChg>
        <pc:picChg chg="mod">
          <ac:chgData name="Stanislas Dehaene" userId="516944819e68dc0c" providerId="LiveId" clId="{0454576E-37AC-4F25-A3FF-231DF9C41E8D}" dt="2024-10-17T13:58:03.563" v="312" actId="1037"/>
          <ac:picMkLst>
            <pc:docMk/>
            <pc:sldMk cId="3578471984" sldId="293"/>
            <ac:picMk id="3" creationId="{8C5395D4-9CA5-2BA2-15AF-A06E18047E7C}"/>
          </ac:picMkLst>
        </pc:picChg>
      </pc:sldChg>
      <pc:sldChg chg="modSp mod">
        <pc:chgData name="Stanislas Dehaene" userId="516944819e68dc0c" providerId="LiveId" clId="{0454576E-37AC-4F25-A3FF-231DF9C41E8D}" dt="2024-10-17T14:02:32.415" v="638" actId="403"/>
        <pc:sldMkLst>
          <pc:docMk/>
          <pc:sldMk cId="2687687460" sldId="295"/>
        </pc:sldMkLst>
        <pc:spChg chg="mod">
          <ac:chgData name="Stanislas Dehaene" userId="516944819e68dc0c" providerId="LiveId" clId="{0454576E-37AC-4F25-A3FF-231DF9C41E8D}" dt="2024-10-17T14:02:32.415" v="638" actId="403"/>
          <ac:spMkLst>
            <pc:docMk/>
            <pc:sldMk cId="2687687460" sldId="295"/>
            <ac:spMk id="7" creationId="{31DFF842-B70F-384E-8318-99191B5EA034}"/>
          </ac:spMkLst>
        </pc:spChg>
      </pc:sldChg>
      <pc:sldChg chg="addSp delSp modSp mod">
        <pc:chgData name="Stanislas Dehaene" userId="516944819e68dc0c" providerId="LiveId" clId="{0454576E-37AC-4F25-A3FF-231DF9C41E8D}" dt="2024-10-17T14:05:22.322" v="720" actId="1038"/>
        <pc:sldMkLst>
          <pc:docMk/>
          <pc:sldMk cId="2809291138" sldId="298"/>
        </pc:sldMkLst>
        <pc:spChg chg="mod">
          <ac:chgData name="Stanislas Dehaene" userId="516944819e68dc0c" providerId="LiveId" clId="{0454576E-37AC-4F25-A3FF-231DF9C41E8D}" dt="2024-10-17T14:03:54.331" v="644" actId="403"/>
          <ac:spMkLst>
            <pc:docMk/>
            <pc:sldMk cId="2809291138" sldId="298"/>
            <ac:spMk id="5" creationId="{B863981C-3B75-35A1-0FDC-94BFD580106A}"/>
          </ac:spMkLst>
        </pc:spChg>
        <pc:spChg chg="mod">
          <ac:chgData name="Stanislas Dehaene" userId="516944819e68dc0c" providerId="LiveId" clId="{0454576E-37AC-4F25-A3FF-231DF9C41E8D}" dt="2024-10-17T14:03:54.331" v="644" actId="403"/>
          <ac:spMkLst>
            <pc:docMk/>
            <pc:sldMk cId="2809291138" sldId="298"/>
            <ac:spMk id="6" creationId="{8F15DE58-C25C-051C-1527-14785EADE339}"/>
          </ac:spMkLst>
        </pc:spChg>
        <pc:spChg chg="del">
          <ac:chgData name="Stanislas Dehaene" userId="516944819e68dc0c" providerId="LiveId" clId="{0454576E-37AC-4F25-A3FF-231DF9C41E8D}" dt="2024-10-17T14:03:36.631" v="639" actId="478"/>
          <ac:spMkLst>
            <pc:docMk/>
            <pc:sldMk cId="2809291138" sldId="298"/>
            <ac:spMk id="11" creationId="{85C8301C-B514-6BA9-B8CF-1749BDDBB6BF}"/>
          </ac:spMkLst>
        </pc:spChg>
        <pc:spChg chg="del">
          <ac:chgData name="Stanislas Dehaene" userId="516944819e68dc0c" providerId="LiveId" clId="{0454576E-37AC-4F25-A3FF-231DF9C41E8D}" dt="2024-10-17T14:04:33.071" v="656" actId="478"/>
          <ac:spMkLst>
            <pc:docMk/>
            <pc:sldMk cId="2809291138" sldId="298"/>
            <ac:spMk id="12" creationId="{FC8376FB-DA12-6A81-EB4D-5AE773534845}"/>
          </ac:spMkLst>
        </pc:spChg>
        <pc:spChg chg="add mod">
          <ac:chgData name="Stanislas Dehaene" userId="516944819e68dc0c" providerId="LiveId" clId="{0454576E-37AC-4F25-A3FF-231DF9C41E8D}" dt="2024-10-17T14:04:54.301" v="657"/>
          <ac:spMkLst>
            <pc:docMk/>
            <pc:sldMk cId="2809291138" sldId="298"/>
            <ac:spMk id="13" creationId="{A049D4E7-D983-1763-0481-C00482EBF882}"/>
          </ac:spMkLst>
        </pc:spChg>
        <pc:spChg chg="add mod">
          <ac:chgData name="Stanislas Dehaene" userId="516944819e68dc0c" providerId="LiveId" clId="{0454576E-37AC-4F25-A3FF-231DF9C41E8D}" dt="2024-10-17T14:05:22.322" v="720" actId="1038"/>
          <ac:spMkLst>
            <pc:docMk/>
            <pc:sldMk cId="2809291138" sldId="298"/>
            <ac:spMk id="14" creationId="{13393A5A-DEC6-EBC1-8028-F72AE58F76C9}"/>
          </ac:spMkLst>
        </pc:spChg>
        <pc:spChg chg="mod">
          <ac:chgData name="Stanislas Dehaene" userId="516944819e68dc0c" providerId="LiveId" clId="{0454576E-37AC-4F25-A3FF-231DF9C41E8D}" dt="2024-10-17T14:04:21.289" v="655" actId="113"/>
          <ac:spMkLst>
            <pc:docMk/>
            <pc:sldMk cId="2809291138" sldId="298"/>
            <ac:spMk id="20" creationId="{DA94DA08-3E87-2305-EF7C-5D9B533B1AA2}"/>
          </ac:spMkLst>
        </pc:spChg>
        <pc:spChg chg="mod">
          <ac:chgData name="Stanislas Dehaene" userId="516944819e68dc0c" providerId="LiveId" clId="{0454576E-37AC-4F25-A3FF-231DF9C41E8D}" dt="2024-10-17T14:04:21.289" v="655" actId="113"/>
          <ac:spMkLst>
            <pc:docMk/>
            <pc:sldMk cId="2809291138" sldId="298"/>
            <ac:spMk id="21" creationId="{B3B26220-B8AC-F630-D54A-EDB834B0F344}"/>
          </ac:spMkLst>
        </pc:spChg>
        <pc:spChg chg="mod">
          <ac:chgData name="Stanislas Dehaene" userId="516944819e68dc0c" providerId="LiveId" clId="{0454576E-37AC-4F25-A3FF-231DF9C41E8D}" dt="2024-10-17T14:04:21.289" v="655" actId="113"/>
          <ac:spMkLst>
            <pc:docMk/>
            <pc:sldMk cId="2809291138" sldId="298"/>
            <ac:spMk id="22" creationId="{6C8F638F-0250-FA4E-63C8-A2AA8A594692}"/>
          </ac:spMkLst>
        </pc:spChg>
        <pc:spChg chg="mod">
          <ac:chgData name="Stanislas Dehaene" userId="516944819e68dc0c" providerId="LiveId" clId="{0454576E-37AC-4F25-A3FF-231DF9C41E8D}" dt="2024-10-17T14:04:21.289" v="655" actId="113"/>
          <ac:spMkLst>
            <pc:docMk/>
            <pc:sldMk cId="2809291138" sldId="298"/>
            <ac:spMk id="23" creationId="{B3D6D20D-9AB6-BA79-951D-D2AB193AFFCD}"/>
          </ac:spMkLst>
        </pc:spChg>
        <pc:spChg chg="mod">
          <ac:chgData name="Stanislas Dehaene" userId="516944819e68dc0c" providerId="LiveId" clId="{0454576E-37AC-4F25-A3FF-231DF9C41E8D}" dt="2024-10-17T14:03:41.661" v="640" actId="113"/>
          <ac:spMkLst>
            <pc:docMk/>
            <pc:sldMk cId="2809291138" sldId="298"/>
            <ac:spMk id="41" creationId="{60FEDAB2-649F-1CC4-D461-ED74B72F2FB3}"/>
          </ac:spMkLst>
        </pc:spChg>
        <pc:spChg chg="mod">
          <ac:chgData name="Stanislas Dehaene" userId="516944819e68dc0c" providerId="LiveId" clId="{0454576E-37AC-4F25-A3FF-231DF9C41E8D}" dt="2024-10-17T14:03:41.661" v="640" actId="113"/>
          <ac:spMkLst>
            <pc:docMk/>
            <pc:sldMk cId="2809291138" sldId="298"/>
            <ac:spMk id="42" creationId="{8758A1A9-6CA9-E9C0-A044-26C9A4A425D7}"/>
          </ac:spMkLst>
        </pc:spChg>
        <pc:spChg chg="mod">
          <ac:chgData name="Stanislas Dehaene" userId="516944819e68dc0c" providerId="LiveId" clId="{0454576E-37AC-4F25-A3FF-231DF9C41E8D}" dt="2024-10-17T14:03:41.661" v="640" actId="113"/>
          <ac:spMkLst>
            <pc:docMk/>
            <pc:sldMk cId="2809291138" sldId="298"/>
            <ac:spMk id="43" creationId="{D678BDAA-A173-263B-664F-5FCFEB24962C}"/>
          </ac:spMkLst>
        </pc:spChg>
        <pc:spChg chg="mod">
          <ac:chgData name="Stanislas Dehaene" userId="516944819e68dc0c" providerId="LiveId" clId="{0454576E-37AC-4F25-A3FF-231DF9C41E8D}" dt="2024-10-17T14:03:41.661" v="640" actId="113"/>
          <ac:spMkLst>
            <pc:docMk/>
            <pc:sldMk cId="2809291138" sldId="298"/>
            <ac:spMk id="48" creationId="{A932E5F6-D1BF-AE9B-9E49-BE9D1F0210AA}"/>
          </ac:spMkLst>
        </pc:spChg>
        <pc:spChg chg="mod">
          <ac:chgData name="Stanislas Dehaene" userId="516944819e68dc0c" providerId="LiveId" clId="{0454576E-37AC-4F25-A3FF-231DF9C41E8D}" dt="2024-10-17T14:03:41.661" v="640" actId="113"/>
          <ac:spMkLst>
            <pc:docMk/>
            <pc:sldMk cId="2809291138" sldId="298"/>
            <ac:spMk id="49" creationId="{EC71FB42-0A0D-2CDB-2B1F-899C248C97E5}"/>
          </ac:spMkLst>
        </pc:spChg>
        <pc:spChg chg="mod">
          <ac:chgData name="Stanislas Dehaene" userId="516944819e68dc0c" providerId="LiveId" clId="{0454576E-37AC-4F25-A3FF-231DF9C41E8D}" dt="2024-10-17T14:03:41.661" v="640" actId="113"/>
          <ac:spMkLst>
            <pc:docMk/>
            <pc:sldMk cId="2809291138" sldId="298"/>
            <ac:spMk id="50" creationId="{A8B22364-75FA-3A9C-404F-D0D45ED7DC71}"/>
          </ac:spMkLst>
        </pc:spChg>
        <pc:grpChg chg="add mod">
          <ac:chgData name="Stanislas Dehaene" userId="516944819e68dc0c" providerId="LiveId" clId="{0454576E-37AC-4F25-A3FF-231DF9C41E8D}" dt="2024-10-17T14:05:09.964" v="700" actId="1037"/>
          <ac:grpSpMkLst>
            <pc:docMk/>
            <pc:sldMk cId="2809291138" sldId="298"/>
            <ac:grpSpMk id="3" creationId="{76E66A2E-030D-2315-8CC6-963CF06D912A}"/>
          </ac:grpSpMkLst>
        </pc:grpChg>
        <pc:grpChg chg="add mod">
          <ac:chgData name="Stanislas Dehaene" userId="516944819e68dc0c" providerId="LiveId" clId="{0454576E-37AC-4F25-A3FF-231DF9C41E8D}" dt="2024-10-17T14:05:09.964" v="700" actId="1037"/>
          <ac:grpSpMkLst>
            <pc:docMk/>
            <pc:sldMk cId="2809291138" sldId="298"/>
            <ac:grpSpMk id="7" creationId="{14966CDD-A82A-4B2A-B088-192A4C3BE00F}"/>
          </ac:grpSpMkLst>
        </pc:grpChg>
        <pc:grpChg chg="mod">
          <ac:chgData name="Stanislas Dehaene" userId="516944819e68dc0c" providerId="LiveId" clId="{0454576E-37AC-4F25-A3FF-231DF9C41E8D}" dt="2024-10-17T14:05:09.964" v="700" actId="1037"/>
          <ac:grpSpMkLst>
            <pc:docMk/>
            <pc:sldMk cId="2809291138" sldId="298"/>
            <ac:grpSpMk id="40" creationId="{FA87A034-9594-9890-128C-0D2F4545462F}"/>
          </ac:grpSpMkLst>
        </pc:grpChg>
        <pc:grpChg chg="mod">
          <ac:chgData name="Stanislas Dehaene" userId="516944819e68dc0c" providerId="LiveId" clId="{0454576E-37AC-4F25-A3FF-231DF9C41E8D}" dt="2024-10-17T14:05:09.964" v="700" actId="1037"/>
          <ac:grpSpMkLst>
            <pc:docMk/>
            <pc:sldMk cId="2809291138" sldId="298"/>
            <ac:grpSpMk id="47" creationId="{48EBFAA6-C2EC-2146-0F59-37791884B813}"/>
          </ac:grpSpMkLst>
        </pc:grpChg>
        <pc:grpChg chg="mod">
          <ac:chgData name="Stanislas Dehaene" userId="516944819e68dc0c" providerId="LiveId" clId="{0454576E-37AC-4F25-A3FF-231DF9C41E8D}" dt="2024-10-17T14:05:09.964" v="700" actId="1037"/>
          <ac:grpSpMkLst>
            <pc:docMk/>
            <pc:sldMk cId="2809291138" sldId="298"/>
            <ac:grpSpMk id="61" creationId="{8266E00A-5C19-6DB7-CEE4-7E707D056D2A}"/>
          </ac:grpSpMkLst>
        </pc:grpChg>
        <pc:picChg chg="mod">
          <ac:chgData name="Stanislas Dehaene" userId="516944819e68dc0c" providerId="LiveId" clId="{0454576E-37AC-4F25-A3FF-231DF9C41E8D}" dt="2024-10-17T14:05:09.964" v="700" actId="1037"/>
          <ac:picMkLst>
            <pc:docMk/>
            <pc:sldMk cId="2809291138" sldId="298"/>
            <ac:picMk id="8" creationId="{46BF7883-5E4B-BB8F-FB4F-9DCA41165C0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F7AEB9-B3D7-BB47-ABB2-259E41AA7D2E}" type="datetimeFigureOut">
              <a:rPr lang="fr-FR" smtClean="0"/>
              <a:t>04/09/2025</a:t>
            </a:fld>
            <a:endParaRPr lang="fr-FR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fr-FR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AE0597-09A3-7F44-8628-639BBDD106B2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0139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AE0597-09A3-7F44-8628-639BBDD106B2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0119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AE0597-09A3-7F44-8628-639BBDD106B2}" type="slidenum">
              <a:rPr lang="fr-FR" smtClean="0"/>
              <a:t>7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17265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AE0597-09A3-7F44-8628-639BBDD106B2}" type="slidenum">
              <a:rPr lang="fr-FR" smtClean="0"/>
              <a:t>8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6981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493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893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920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10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847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62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998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263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347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457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319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46B6B-8919-CB46-B705-026A00D86A11}" type="datetimeFigureOut">
              <a:rPr lang="en-US" smtClean="0"/>
              <a:t>9/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D33FD-BD1D-7B4F-9274-B78CF6D799A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288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10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33.png"/><Relationship Id="rId18" Type="http://schemas.openxmlformats.org/officeDocument/2006/relationships/image" Target="../media/image138.png"/><Relationship Id="rId26" Type="http://schemas.openxmlformats.org/officeDocument/2006/relationships/image" Target="../media/image146.png"/><Relationship Id="rId39" Type="http://schemas.openxmlformats.org/officeDocument/2006/relationships/image" Target="../media/image159.png"/><Relationship Id="rId21" Type="http://schemas.openxmlformats.org/officeDocument/2006/relationships/image" Target="../media/image141.png"/><Relationship Id="rId34" Type="http://schemas.openxmlformats.org/officeDocument/2006/relationships/image" Target="../media/image154.png"/><Relationship Id="rId42" Type="http://schemas.openxmlformats.org/officeDocument/2006/relationships/image" Target="../media/image162.png"/><Relationship Id="rId47" Type="http://schemas.openxmlformats.org/officeDocument/2006/relationships/image" Target="../media/image167.png"/><Relationship Id="rId50" Type="http://schemas.openxmlformats.org/officeDocument/2006/relationships/image" Target="../media/image170.png"/><Relationship Id="rId7" Type="http://schemas.openxmlformats.org/officeDocument/2006/relationships/image" Target="../media/image127.png"/><Relationship Id="rId2" Type="http://schemas.openxmlformats.org/officeDocument/2006/relationships/image" Target="../media/image122.png"/><Relationship Id="rId16" Type="http://schemas.openxmlformats.org/officeDocument/2006/relationships/image" Target="../media/image136.png"/><Relationship Id="rId29" Type="http://schemas.openxmlformats.org/officeDocument/2006/relationships/image" Target="../media/image149.png"/><Relationship Id="rId11" Type="http://schemas.openxmlformats.org/officeDocument/2006/relationships/image" Target="../media/image131.png"/><Relationship Id="rId24" Type="http://schemas.openxmlformats.org/officeDocument/2006/relationships/image" Target="../media/image144.png"/><Relationship Id="rId32" Type="http://schemas.openxmlformats.org/officeDocument/2006/relationships/image" Target="../media/image152.png"/><Relationship Id="rId37" Type="http://schemas.openxmlformats.org/officeDocument/2006/relationships/image" Target="../media/image157.png"/><Relationship Id="rId40" Type="http://schemas.openxmlformats.org/officeDocument/2006/relationships/image" Target="../media/image160.png"/><Relationship Id="rId45" Type="http://schemas.openxmlformats.org/officeDocument/2006/relationships/image" Target="../media/image165.png"/><Relationship Id="rId53" Type="http://schemas.openxmlformats.org/officeDocument/2006/relationships/image" Target="../media/image173.png"/><Relationship Id="rId5" Type="http://schemas.openxmlformats.org/officeDocument/2006/relationships/image" Target="../media/image125.png"/><Relationship Id="rId10" Type="http://schemas.openxmlformats.org/officeDocument/2006/relationships/image" Target="../media/image130.png"/><Relationship Id="rId19" Type="http://schemas.openxmlformats.org/officeDocument/2006/relationships/image" Target="../media/image139.png"/><Relationship Id="rId31" Type="http://schemas.openxmlformats.org/officeDocument/2006/relationships/image" Target="../media/image151.png"/><Relationship Id="rId44" Type="http://schemas.openxmlformats.org/officeDocument/2006/relationships/image" Target="../media/image164.png"/><Relationship Id="rId52" Type="http://schemas.openxmlformats.org/officeDocument/2006/relationships/image" Target="../media/image172.png"/><Relationship Id="rId4" Type="http://schemas.openxmlformats.org/officeDocument/2006/relationships/image" Target="../media/image124.png"/><Relationship Id="rId9" Type="http://schemas.openxmlformats.org/officeDocument/2006/relationships/image" Target="../media/image129.png"/><Relationship Id="rId14" Type="http://schemas.openxmlformats.org/officeDocument/2006/relationships/image" Target="../media/image134.png"/><Relationship Id="rId22" Type="http://schemas.openxmlformats.org/officeDocument/2006/relationships/image" Target="../media/image142.png"/><Relationship Id="rId27" Type="http://schemas.openxmlformats.org/officeDocument/2006/relationships/image" Target="../media/image147.png"/><Relationship Id="rId30" Type="http://schemas.openxmlformats.org/officeDocument/2006/relationships/image" Target="../media/image150.png"/><Relationship Id="rId35" Type="http://schemas.openxmlformats.org/officeDocument/2006/relationships/image" Target="../media/image155.png"/><Relationship Id="rId43" Type="http://schemas.openxmlformats.org/officeDocument/2006/relationships/image" Target="../media/image163.png"/><Relationship Id="rId48" Type="http://schemas.openxmlformats.org/officeDocument/2006/relationships/image" Target="../media/image168.png"/><Relationship Id="rId8" Type="http://schemas.openxmlformats.org/officeDocument/2006/relationships/image" Target="../media/image128.png"/><Relationship Id="rId51" Type="http://schemas.openxmlformats.org/officeDocument/2006/relationships/image" Target="../media/image171.png"/><Relationship Id="rId3" Type="http://schemas.openxmlformats.org/officeDocument/2006/relationships/image" Target="../media/image123.png"/><Relationship Id="rId12" Type="http://schemas.openxmlformats.org/officeDocument/2006/relationships/image" Target="../media/image132.png"/><Relationship Id="rId17" Type="http://schemas.openxmlformats.org/officeDocument/2006/relationships/image" Target="../media/image137.png"/><Relationship Id="rId25" Type="http://schemas.openxmlformats.org/officeDocument/2006/relationships/image" Target="../media/image145.png"/><Relationship Id="rId33" Type="http://schemas.openxmlformats.org/officeDocument/2006/relationships/image" Target="../media/image153.png"/><Relationship Id="rId38" Type="http://schemas.openxmlformats.org/officeDocument/2006/relationships/image" Target="../media/image158.png"/><Relationship Id="rId46" Type="http://schemas.openxmlformats.org/officeDocument/2006/relationships/image" Target="../media/image166.png"/><Relationship Id="rId20" Type="http://schemas.openxmlformats.org/officeDocument/2006/relationships/image" Target="../media/image140.png"/><Relationship Id="rId41" Type="http://schemas.openxmlformats.org/officeDocument/2006/relationships/image" Target="../media/image1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6.png"/><Relationship Id="rId15" Type="http://schemas.openxmlformats.org/officeDocument/2006/relationships/image" Target="../media/image135.png"/><Relationship Id="rId23" Type="http://schemas.openxmlformats.org/officeDocument/2006/relationships/image" Target="../media/image143.png"/><Relationship Id="rId28" Type="http://schemas.openxmlformats.org/officeDocument/2006/relationships/image" Target="../media/image148.png"/><Relationship Id="rId36" Type="http://schemas.openxmlformats.org/officeDocument/2006/relationships/image" Target="../media/image156.png"/><Relationship Id="rId49" Type="http://schemas.openxmlformats.org/officeDocument/2006/relationships/image" Target="../media/image16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Relationship Id="rId9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7.png"/><Relationship Id="rId18" Type="http://schemas.openxmlformats.org/officeDocument/2006/relationships/image" Target="../media/image72.png"/><Relationship Id="rId26" Type="http://schemas.openxmlformats.org/officeDocument/2006/relationships/image" Target="../media/image80.png"/><Relationship Id="rId39" Type="http://schemas.openxmlformats.org/officeDocument/2006/relationships/image" Target="../media/image93.png"/><Relationship Id="rId21" Type="http://schemas.openxmlformats.org/officeDocument/2006/relationships/image" Target="../media/image75.png"/><Relationship Id="rId34" Type="http://schemas.openxmlformats.org/officeDocument/2006/relationships/image" Target="../media/image88.png"/><Relationship Id="rId42" Type="http://schemas.openxmlformats.org/officeDocument/2006/relationships/image" Target="../media/image96.png"/><Relationship Id="rId47" Type="http://schemas.openxmlformats.org/officeDocument/2006/relationships/image" Target="../media/image101.png"/><Relationship Id="rId50" Type="http://schemas.openxmlformats.org/officeDocument/2006/relationships/image" Target="../media/image104.png"/><Relationship Id="rId7" Type="http://schemas.openxmlformats.org/officeDocument/2006/relationships/image" Target="../media/image61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70.png"/><Relationship Id="rId29" Type="http://schemas.openxmlformats.org/officeDocument/2006/relationships/image" Target="../media/image83.png"/><Relationship Id="rId11" Type="http://schemas.openxmlformats.org/officeDocument/2006/relationships/image" Target="../media/image65.png"/><Relationship Id="rId24" Type="http://schemas.openxmlformats.org/officeDocument/2006/relationships/image" Target="../media/image78.png"/><Relationship Id="rId32" Type="http://schemas.openxmlformats.org/officeDocument/2006/relationships/image" Target="../media/image86.png"/><Relationship Id="rId37" Type="http://schemas.openxmlformats.org/officeDocument/2006/relationships/image" Target="../media/image91.png"/><Relationship Id="rId40" Type="http://schemas.openxmlformats.org/officeDocument/2006/relationships/image" Target="../media/image94.png"/><Relationship Id="rId45" Type="http://schemas.openxmlformats.org/officeDocument/2006/relationships/image" Target="../media/image99.png"/><Relationship Id="rId5" Type="http://schemas.openxmlformats.org/officeDocument/2006/relationships/image" Target="../media/image59.png"/><Relationship Id="rId15" Type="http://schemas.openxmlformats.org/officeDocument/2006/relationships/image" Target="../media/image69.png"/><Relationship Id="rId23" Type="http://schemas.openxmlformats.org/officeDocument/2006/relationships/image" Target="../media/image77.png"/><Relationship Id="rId28" Type="http://schemas.openxmlformats.org/officeDocument/2006/relationships/image" Target="../media/image82.png"/><Relationship Id="rId36" Type="http://schemas.openxmlformats.org/officeDocument/2006/relationships/image" Target="../media/image90.png"/><Relationship Id="rId49" Type="http://schemas.openxmlformats.org/officeDocument/2006/relationships/image" Target="../media/image103.png"/><Relationship Id="rId10" Type="http://schemas.openxmlformats.org/officeDocument/2006/relationships/image" Target="../media/image64.png"/><Relationship Id="rId19" Type="http://schemas.openxmlformats.org/officeDocument/2006/relationships/image" Target="../media/image73.png"/><Relationship Id="rId31" Type="http://schemas.openxmlformats.org/officeDocument/2006/relationships/image" Target="../media/image85.png"/><Relationship Id="rId44" Type="http://schemas.openxmlformats.org/officeDocument/2006/relationships/image" Target="../media/image98.png"/><Relationship Id="rId52" Type="http://schemas.openxmlformats.org/officeDocument/2006/relationships/image" Target="../media/image106.png"/><Relationship Id="rId4" Type="http://schemas.openxmlformats.org/officeDocument/2006/relationships/image" Target="../media/image58.png"/><Relationship Id="rId9" Type="http://schemas.openxmlformats.org/officeDocument/2006/relationships/image" Target="../media/image63.png"/><Relationship Id="rId14" Type="http://schemas.openxmlformats.org/officeDocument/2006/relationships/image" Target="../media/image68.png"/><Relationship Id="rId22" Type="http://schemas.openxmlformats.org/officeDocument/2006/relationships/image" Target="../media/image76.png"/><Relationship Id="rId27" Type="http://schemas.openxmlformats.org/officeDocument/2006/relationships/image" Target="../media/image81.png"/><Relationship Id="rId30" Type="http://schemas.openxmlformats.org/officeDocument/2006/relationships/image" Target="../media/image84.png"/><Relationship Id="rId35" Type="http://schemas.openxmlformats.org/officeDocument/2006/relationships/image" Target="../media/image89.png"/><Relationship Id="rId43" Type="http://schemas.openxmlformats.org/officeDocument/2006/relationships/image" Target="../media/image97.png"/><Relationship Id="rId48" Type="http://schemas.openxmlformats.org/officeDocument/2006/relationships/image" Target="../media/image102.png"/><Relationship Id="rId8" Type="http://schemas.openxmlformats.org/officeDocument/2006/relationships/image" Target="../media/image62.png"/><Relationship Id="rId51" Type="http://schemas.openxmlformats.org/officeDocument/2006/relationships/image" Target="../media/image105.png"/><Relationship Id="rId3" Type="http://schemas.openxmlformats.org/officeDocument/2006/relationships/image" Target="../media/image57.png"/><Relationship Id="rId12" Type="http://schemas.openxmlformats.org/officeDocument/2006/relationships/image" Target="../media/image66.png"/><Relationship Id="rId17" Type="http://schemas.openxmlformats.org/officeDocument/2006/relationships/image" Target="../media/image71.png"/><Relationship Id="rId25" Type="http://schemas.openxmlformats.org/officeDocument/2006/relationships/image" Target="../media/image79.png"/><Relationship Id="rId33" Type="http://schemas.openxmlformats.org/officeDocument/2006/relationships/image" Target="../media/image87.png"/><Relationship Id="rId38" Type="http://schemas.openxmlformats.org/officeDocument/2006/relationships/image" Target="../media/image92.png"/><Relationship Id="rId46" Type="http://schemas.openxmlformats.org/officeDocument/2006/relationships/image" Target="../media/image100.png"/><Relationship Id="rId20" Type="http://schemas.openxmlformats.org/officeDocument/2006/relationships/image" Target="../media/image74.png"/><Relationship Id="rId41" Type="http://schemas.openxmlformats.org/officeDocument/2006/relationships/image" Target="../media/image9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3.png"/><Relationship Id="rId13" Type="http://schemas.openxmlformats.org/officeDocument/2006/relationships/image" Target="../media/image118.png"/><Relationship Id="rId3" Type="http://schemas.openxmlformats.org/officeDocument/2006/relationships/image" Target="../media/image108.png"/><Relationship Id="rId7" Type="http://schemas.openxmlformats.org/officeDocument/2006/relationships/image" Target="../media/image112.png"/><Relationship Id="rId12" Type="http://schemas.openxmlformats.org/officeDocument/2006/relationships/image" Target="../media/image117.png"/><Relationship Id="rId2" Type="http://schemas.openxmlformats.org/officeDocument/2006/relationships/image" Target="../media/image107.png"/><Relationship Id="rId16" Type="http://schemas.openxmlformats.org/officeDocument/2006/relationships/image" Target="../media/image1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1.png"/><Relationship Id="rId11" Type="http://schemas.openxmlformats.org/officeDocument/2006/relationships/image" Target="../media/image116.png"/><Relationship Id="rId5" Type="http://schemas.openxmlformats.org/officeDocument/2006/relationships/image" Target="../media/image110.png"/><Relationship Id="rId15" Type="http://schemas.openxmlformats.org/officeDocument/2006/relationships/image" Target="../media/image120.png"/><Relationship Id="rId10" Type="http://schemas.openxmlformats.org/officeDocument/2006/relationships/image" Target="../media/image115.png"/><Relationship Id="rId4" Type="http://schemas.openxmlformats.org/officeDocument/2006/relationships/image" Target="../media/image109.png"/><Relationship Id="rId9" Type="http://schemas.openxmlformats.org/officeDocument/2006/relationships/image" Target="../media/image114.png"/><Relationship Id="rId14" Type="http://schemas.openxmlformats.org/officeDocument/2006/relationships/image" Target="../media/image1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0B6BB833-33F2-2821-15A4-2B473B4FC199}"/>
              </a:ext>
            </a:extLst>
          </p:cNvPr>
          <p:cNvSpPr txBox="1"/>
          <p:nvPr/>
        </p:nvSpPr>
        <p:spPr>
          <a:xfrm>
            <a:off x="2065161" y="839114"/>
            <a:ext cx="99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5-year-olds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5CC996DC-8EB5-1518-2750-EE8C61BDAADB}"/>
              </a:ext>
            </a:extLst>
          </p:cNvPr>
          <p:cNvSpPr txBox="1"/>
          <p:nvPr/>
        </p:nvSpPr>
        <p:spPr>
          <a:xfrm>
            <a:off x="254924" y="2518910"/>
            <a:ext cx="6395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Zigzags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72BF62CF-7C90-1841-8AB9-B9ABA35A0AA3}"/>
              </a:ext>
            </a:extLst>
          </p:cNvPr>
          <p:cNvSpPr txBox="1"/>
          <p:nvPr/>
        </p:nvSpPr>
        <p:spPr>
          <a:xfrm>
            <a:off x="-7487" y="3368816"/>
            <a:ext cx="11644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High-</a:t>
            </a:r>
            <a:r>
              <a:rPr lang="fr-FR" sz="1200" b="1" dirty="0" err="1"/>
              <a:t>frequency</a:t>
            </a:r>
            <a:endParaRPr lang="fr-FR" sz="1200" b="1" dirty="0"/>
          </a:p>
          <a:p>
            <a:pPr algn="ctr"/>
            <a:r>
              <a:rPr lang="fr-FR" sz="1200" b="1" dirty="0" err="1"/>
              <a:t>sinusoids</a:t>
            </a:r>
            <a:endParaRPr lang="fr-FR" sz="1200" b="1" dirty="0"/>
          </a:p>
        </p:txBody>
      </p:sp>
      <p:sp>
        <p:nvSpPr>
          <p:cNvPr id="23" name="ZoneTexte 1">
            <a:extLst>
              <a:ext uri="{FF2B5EF4-FFF2-40B4-BE49-F238E27FC236}">
                <a16:creationId xmlns:a16="http://schemas.microsoft.com/office/drawing/2014/main" id="{0B88F633-5854-2B5C-9C3E-D32D8D5CA8E4}"/>
              </a:ext>
            </a:extLst>
          </p:cNvPr>
          <p:cNvSpPr txBox="1"/>
          <p:nvPr/>
        </p:nvSpPr>
        <p:spPr>
          <a:xfrm>
            <a:off x="4938076" y="839115"/>
            <a:ext cx="99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6-year-olds</a:t>
            </a:r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86FB77E0-2A2D-C60E-3D5A-0547DDED49F3}"/>
              </a:ext>
            </a:extLst>
          </p:cNvPr>
          <p:cNvGrpSpPr/>
          <p:nvPr/>
        </p:nvGrpSpPr>
        <p:grpSpPr>
          <a:xfrm>
            <a:off x="1157131" y="2205261"/>
            <a:ext cx="2795016" cy="2788776"/>
            <a:chOff x="731874" y="-3324268"/>
            <a:chExt cx="4968917" cy="4957824"/>
          </a:xfrm>
        </p:grpSpPr>
        <p:pic>
          <p:nvPicPr>
            <p:cNvPr id="6" name="Image 5" descr="Une image contenant écriture manuscrite, typographie&#10;&#10;Description générée automatiquement">
              <a:extLst>
                <a:ext uri="{FF2B5EF4-FFF2-40B4-BE49-F238E27FC236}">
                  <a16:creationId xmlns:a16="http://schemas.microsoft.com/office/drawing/2014/main" id="{E0D02BBF-09BE-9F1F-E298-FE5C35D4DC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31874" y="-1645356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2" name="Image 11" descr="Une image contenant léger&#10;&#10;Description générée automatiquement avec une confiance moyenne">
              <a:extLst>
                <a:ext uri="{FF2B5EF4-FFF2-40B4-BE49-F238E27FC236}">
                  <a16:creationId xmlns:a16="http://schemas.microsoft.com/office/drawing/2014/main" id="{D62407A3-2AA9-6976-7DFE-3A5C432A15F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00791" y="-3324268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Image 13" descr="Une image contenant art&#10;&#10;Description générée automatiquement">
              <a:extLst>
                <a:ext uri="{FF2B5EF4-FFF2-40B4-BE49-F238E27FC236}">
                  <a16:creationId xmlns:a16="http://schemas.microsoft.com/office/drawing/2014/main" id="{98D39B7B-4D25-4A74-863A-710E6866B5B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12503" y="-3324268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C8C36200-DC27-E87D-88C4-C737254C3F4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38758" y="-3324268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0" name="Image 19" descr="Une image contenant Graphique, écriture manuscrite, typographie&#10;&#10;Description générée automatiquement">
              <a:extLst>
                <a:ext uri="{FF2B5EF4-FFF2-40B4-BE49-F238E27FC236}">
                  <a16:creationId xmlns:a16="http://schemas.microsoft.com/office/drawing/2014/main" id="{3B3B735F-C136-4A1D-FB78-BC462D5E406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412503" y="33556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2" name="Image 21" descr="Une image contenant art&#10;&#10;Description générée automatiquement">
              <a:extLst>
                <a:ext uri="{FF2B5EF4-FFF2-40B4-BE49-F238E27FC236}">
                  <a16:creationId xmlns:a16="http://schemas.microsoft.com/office/drawing/2014/main" id="{3FC60E94-E6B8-E6E7-6CE1-16481E732B0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31874" y="33556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6" name="Image 25" descr="Une image contenant écriture manuscrite, léger&#10;&#10;Description générée automatiquement">
              <a:extLst>
                <a:ext uri="{FF2B5EF4-FFF2-40B4-BE49-F238E27FC236}">
                  <a16:creationId xmlns:a16="http://schemas.microsoft.com/office/drawing/2014/main" id="{2405D733-0F2E-362F-E41B-906F2A8DB5C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93133" y="-1645356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9" name="Image 28" descr="Une image contenant écriture manuscrite, typographie&#10;&#10;Description générée automatiquement">
              <a:extLst>
                <a:ext uri="{FF2B5EF4-FFF2-40B4-BE49-F238E27FC236}">
                  <a16:creationId xmlns:a16="http://schemas.microsoft.com/office/drawing/2014/main" id="{B0A62770-128A-0B27-2D50-800E29F97F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412503" y="-1645356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sp>
        <p:nvSpPr>
          <p:cNvPr id="67" name="CasellaDiTesto 6">
            <a:extLst>
              <a:ext uri="{FF2B5EF4-FFF2-40B4-BE49-F238E27FC236}">
                <a16:creationId xmlns:a16="http://schemas.microsoft.com/office/drawing/2014/main" id="{6C50AA8B-4534-D5A1-0292-DC26553AC7A4}"/>
              </a:ext>
            </a:extLst>
          </p:cNvPr>
          <p:cNvSpPr txBox="1"/>
          <p:nvPr/>
        </p:nvSpPr>
        <p:spPr>
          <a:xfrm>
            <a:off x="8222" y="4358204"/>
            <a:ext cx="11330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Low-</a:t>
            </a:r>
            <a:r>
              <a:rPr lang="fr-FR" sz="1200" b="1" dirty="0" err="1"/>
              <a:t>frequency</a:t>
            </a:r>
            <a:endParaRPr lang="fr-FR" sz="1200" b="1" dirty="0"/>
          </a:p>
          <a:p>
            <a:pPr algn="ctr"/>
            <a:r>
              <a:rPr lang="fr-FR" sz="1200" b="1" dirty="0" err="1"/>
              <a:t>Sinusoids</a:t>
            </a:r>
            <a:endParaRPr lang="fr-FR" sz="1200" b="1" dirty="0"/>
          </a:p>
        </p:txBody>
      </p:sp>
      <p:grpSp>
        <p:nvGrpSpPr>
          <p:cNvPr id="31" name="Groupe 30">
            <a:extLst>
              <a:ext uri="{FF2B5EF4-FFF2-40B4-BE49-F238E27FC236}">
                <a16:creationId xmlns:a16="http://schemas.microsoft.com/office/drawing/2014/main" id="{8F24A065-B02D-BE81-A3D1-80E99B7EA881}"/>
              </a:ext>
            </a:extLst>
          </p:cNvPr>
          <p:cNvGrpSpPr/>
          <p:nvPr/>
        </p:nvGrpSpPr>
        <p:grpSpPr>
          <a:xfrm>
            <a:off x="4038076" y="2205261"/>
            <a:ext cx="2787903" cy="2788776"/>
            <a:chOff x="6400000" y="1080000"/>
            <a:chExt cx="4956272" cy="4957824"/>
          </a:xfrm>
        </p:grpSpPr>
        <p:pic>
          <p:nvPicPr>
            <p:cNvPr id="8" name="Image 7" descr="Une image contenant Police, Graphique, Néon, typographie&#10;&#10;Description générée automatiquement">
              <a:extLst>
                <a:ext uri="{FF2B5EF4-FFF2-40B4-BE49-F238E27FC236}">
                  <a16:creationId xmlns:a16="http://schemas.microsoft.com/office/drawing/2014/main" id="{B7F9E0AB-A815-2C13-5527-F5CB80BDC67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400000" y="275891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0" name="Image 9" descr="Une image contenant Graphique, léger&#10;&#10;Description générée automatiquement">
              <a:extLst>
                <a:ext uri="{FF2B5EF4-FFF2-40B4-BE49-F238E27FC236}">
                  <a16:creationId xmlns:a16="http://schemas.microsoft.com/office/drawing/2014/main" id="{DAD64DF2-FE92-6176-BA3F-A733378EB3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756272" y="108000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27DACEC1-0100-DF80-6622-C3BEF0B2AF7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8080629" y="108000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339DEB8C-E61D-5CB3-C62B-ABF1CEB69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400000" y="108000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9" name="Image 18" descr="Une image contenant Graphique, lampe, léger&#10;&#10;Description générée automatiquement">
              <a:extLst>
                <a:ext uri="{FF2B5EF4-FFF2-40B4-BE49-F238E27FC236}">
                  <a16:creationId xmlns:a16="http://schemas.microsoft.com/office/drawing/2014/main" id="{039B9358-D384-3827-53C5-039A61F3CE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8080629" y="443782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4" name="Image 23" descr="Une image contenant art, Graphique&#10;&#10;Description générée automatiquement">
              <a:extLst>
                <a:ext uri="{FF2B5EF4-FFF2-40B4-BE49-F238E27FC236}">
                  <a16:creationId xmlns:a16="http://schemas.microsoft.com/office/drawing/2014/main" id="{5C81EB1A-A97D-FEF4-D9C6-80C1BC5F2525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6400000" y="4437824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7" name="Image 26" descr="Une image contenant typographie, léger&#10;&#10;Description générée automatiquement avec une confiance moyenne">
              <a:extLst>
                <a:ext uri="{FF2B5EF4-FFF2-40B4-BE49-F238E27FC236}">
                  <a16:creationId xmlns:a16="http://schemas.microsoft.com/office/drawing/2014/main" id="{AB66242E-F390-8F17-08FB-7FE0351AE3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9756272" y="275891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0" name="Image 29" descr="Une image contenant écriture manuscrite, Police, Graphique, typographie&#10;&#10;Description générée automatiquement">
              <a:extLst>
                <a:ext uri="{FF2B5EF4-FFF2-40B4-BE49-F238E27FC236}">
                  <a16:creationId xmlns:a16="http://schemas.microsoft.com/office/drawing/2014/main" id="{39DC23D9-F558-7FF5-C31C-A6140E25FB89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8080629" y="2758910"/>
              <a:ext cx="1600000" cy="160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pic>
        <p:nvPicPr>
          <p:cNvPr id="5" name="Image 4" descr="Une image contenant art, léger, typographie&#10;&#10;Description générée automatiquement avec une confiance moyenne">
            <a:extLst>
              <a:ext uri="{FF2B5EF4-FFF2-40B4-BE49-F238E27FC236}">
                <a16:creationId xmlns:a16="http://schemas.microsoft.com/office/drawing/2014/main" id="{1CD7E9F2-76F9-D353-722F-E990EDF68DC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158931" y="1264473"/>
            <a:ext cx="896400" cy="8964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9" name="Image 8" descr="Une image contenant art, léger, typographie&#10;&#10;Description générée automatiquement avec une confiance moyenne">
            <a:extLst>
              <a:ext uri="{FF2B5EF4-FFF2-40B4-BE49-F238E27FC236}">
                <a16:creationId xmlns:a16="http://schemas.microsoft.com/office/drawing/2014/main" id="{B39AB1F1-6F8A-0C4D-BAFE-FDF52BF16BA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102485" y="1264473"/>
            <a:ext cx="896400" cy="8964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1" name="Image 10" descr="Une image contenant art, léger&#10;&#10;Description générée automatiquement">
            <a:extLst>
              <a:ext uri="{FF2B5EF4-FFF2-40B4-BE49-F238E27FC236}">
                <a16:creationId xmlns:a16="http://schemas.microsoft.com/office/drawing/2014/main" id="{B24C3626-89EA-2CCE-DD76-95F2E9462DD4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046039" y="1257273"/>
            <a:ext cx="896400" cy="8964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5" name="Image 14" descr="Une image contenant Néon, léger, lampe, nuit&#10;&#10;Description générée automatiquement">
            <a:extLst>
              <a:ext uri="{FF2B5EF4-FFF2-40B4-BE49-F238E27FC236}">
                <a16:creationId xmlns:a16="http://schemas.microsoft.com/office/drawing/2014/main" id="{9498E709-8187-F250-6B86-5F902AD54912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036747" y="1257273"/>
            <a:ext cx="896400" cy="8964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8" name="Image 17" descr="Une image contenant Graphique, lampe, léger, typographie&#10;&#10;Description générée automatiquement">
            <a:extLst>
              <a:ext uri="{FF2B5EF4-FFF2-40B4-BE49-F238E27FC236}">
                <a16:creationId xmlns:a16="http://schemas.microsoft.com/office/drawing/2014/main" id="{F43ED84D-3179-229C-6EB4-A4EFD65BD8F2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985230" y="1257273"/>
            <a:ext cx="896400" cy="8964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1" name="Image 20" descr="Une image contenant léger&#10;&#10;Description générée automatiquement">
            <a:extLst>
              <a:ext uri="{FF2B5EF4-FFF2-40B4-BE49-F238E27FC236}">
                <a16:creationId xmlns:a16="http://schemas.microsoft.com/office/drawing/2014/main" id="{3D62F4B8-46CE-677A-1F18-BB0255E1440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925979" y="1257273"/>
            <a:ext cx="896400" cy="8964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5" name="CasellaDiTesto 3">
            <a:extLst>
              <a:ext uri="{FF2B5EF4-FFF2-40B4-BE49-F238E27FC236}">
                <a16:creationId xmlns:a16="http://schemas.microsoft.com/office/drawing/2014/main" id="{247DB5C8-55CC-A873-D645-03E9D7C115B4}"/>
              </a:ext>
            </a:extLst>
          </p:cNvPr>
          <p:cNvSpPr txBox="1"/>
          <p:nvPr/>
        </p:nvSpPr>
        <p:spPr>
          <a:xfrm>
            <a:off x="294421" y="1578607"/>
            <a:ext cx="560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err="1"/>
              <a:t>Loops</a:t>
            </a:r>
            <a:endParaRPr lang="fr-FR" sz="1200" b="1" dirty="0"/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3A92BE2C-C140-69FB-C296-2B08A78F1807}"/>
              </a:ext>
            </a:extLst>
          </p:cNvPr>
          <p:cNvSpPr txBox="1"/>
          <p:nvPr/>
        </p:nvSpPr>
        <p:spPr>
          <a:xfrm>
            <a:off x="1645703" y="5614743"/>
            <a:ext cx="3970369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200"/>
              </a:spcBef>
            </a:pPr>
            <a:r>
              <a:rPr lang="en-US" sz="1100" b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Prolongations of oscillating patterns. </a:t>
            </a:r>
            <a:r>
              <a:rPr lang="en-US" sz="1100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image presents all individual children’s drawings superposed one on each other, separately for the two age groups. </a:t>
            </a:r>
            <a:endParaRPr lang="it-FR" sz="1100" kern="15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310634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6A3C9D-E3C5-86F8-D13D-F65189CBA01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2B1EB2C-0779-36D3-75D8-724411C28549}"/>
              </a:ext>
            </a:extLst>
          </p:cNvPr>
          <p:cNvSpPr txBox="1"/>
          <p:nvPr/>
        </p:nvSpPr>
        <p:spPr>
          <a:xfrm>
            <a:off x="63126" y="9034032"/>
            <a:ext cx="677416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0. Percentage of chosen prolongations for oscillating functions varying in amplitude and frequency.  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case reports the percentage of trials in which participants chose that specific prolongation among the six available options, separately for 5- and 6-year-old children.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24" name="Image 323" descr="Une image contenant typographie, printemps, nature, ressort hélicoïdal&#10;&#10;Description générée automatiquement">
            <a:extLst>
              <a:ext uri="{FF2B5EF4-FFF2-40B4-BE49-F238E27FC236}">
                <a16:creationId xmlns:a16="http://schemas.microsoft.com/office/drawing/2014/main" id="{66FBF3AB-C325-EA06-A197-206324F593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0207" y="3831688"/>
            <a:ext cx="720000" cy="513939"/>
          </a:xfrm>
          <a:prstGeom prst="rect">
            <a:avLst/>
          </a:prstGeom>
        </p:spPr>
      </p:pic>
      <p:pic>
        <p:nvPicPr>
          <p:cNvPr id="326" name="Image 325" descr="Une image contenant typographie, printemps, nature, ressort hélicoïdal&#10;&#10;Description générée automatiquement">
            <a:extLst>
              <a:ext uri="{FF2B5EF4-FFF2-40B4-BE49-F238E27FC236}">
                <a16:creationId xmlns:a16="http://schemas.microsoft.com/office/drawing/2014/main" id="{CC0E16D6-B5F6-13C3-51E1-30B50C1910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0207" y="4350966"/>
            <a:ext cx="720000" cy="513939"/>
          </a:xfrm>
          <a:prstGeom prst="rect">
            <a:avLst/>
          </a:prstGeom>
        </p:spPr>
      </p:pic>
      <p:pic>
        <p:nvPicPr>
          <p:cNvPr id="328" name="Image 327" descr="Une image contenant printemps, nature, ressort hélicoïdal, typographie&#10;&#10;Description générée automatiquement">
            <a:extLst>
              <a:ext uri="{FF2B5EF4-FFF2-40B4-BE49-F238E27FC236}">
                <a16:creationId xmlns:a16="http://schemas.microsoft.com/office/drawing/2014/main" id="{F9325CE5-E51E-86F2-3502-6AC8B7A135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67311" y="4046556"/>
            <a:ext cx="720000" cy="513939"/>
          </a:xfrm>
          <a:prstGeom prst="rect">
            <a:avLst/>
          </a:prstGeom>
        </p:spPr>
      </p:pic>
      <p:pic>
        <p:nvPicPr>
          <p:cNvPr id="330" name="Image 329" descr="Une image contenant typographie, printemps, ressort hélicoïdal, nature&#10;&#10;Description générée automatiquement">
            <a:extLst>
              <a:ext uri="{FF2B5EF4-FFF2-40B4-BE49-F238E27FC236}">
                <a16:creationId xmlns:a16="http://schemas.microsoft.com/office/drawing/2014/main" id="{2A50ACC4-9941-D544-6607-830C8D19F9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34650" y="4046555"/>
            <a:ext cx="720000" cy="513939"/>
          </a:xfrm>
          <a:prstGeom prst="rect">
            <a:avLst/>
          </a:prstGeom>
        </p:spPr>
      </p:pic>
      <p:pic>
        <p:nvPicPr>
          <p:cNvPr id="332" name="Image 331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034485E9-D6AB-3188-2AB5-0F1CA0B287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30681" y="4350964"/>
            <a:ext cx="720000" cy="513939"/>
          </a:xfrm>
          <a:prstGeom prst="rect">
            <a:avLst/>
          </a:prstGeom>
        </p:spPr>
      </p:pic>
      <p:pic>
        <p:nvPicPr>
          <p:cNvPr id="334" name="Image 333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82E16665-1513-84ED-A370-9FED6D5ADD8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28259" y="3831687"/>
            <a:ext cx="720000" cy="513939"/>
          </a:xfrm>
          <a:prstGeom prst="rect">
            <a:avLst/>
          </a:prstGeom>
        </p:spPr>
      </p:pic>
      <p:pic>
        <p:nvPicPr>
          <p:cNvPr id="336" name="Image 335" descr="Une image contenant typographie, printemps, nature, ressort hélicoïdal&#10;&#10;Description générée automatiquement">
            <a:extLst>
              <a:ext uri="{FF2B5EF4-FFF2-40B4-BE49-F238E27FC236}">
                <a16:creationId xmlns:a16="http://schemas.microsoft.com/office/drawing/2014/main" id="{DC48C91A-187A-C208-A868-866BFA32AAF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22129" y="3831687"/>
            <a:ext cx="720000" cy="513939"/>
          </a:xfrm>
          <a:prstGeom prst="rect">
            <a:avLst/>
          </a:prstGeom>
        </p:spPr>
      </p:pic>
      <p:pic>
        <p:nvPicPr>
          <p:cNvPr id="338" name="Image 337" descr="Une image contenant typographie, Police, conception&#10;&#10;Description générée automatiquement">
            <a:extLst>
              <a:ext uri="{FF2B5EF4-FFF2-40B4-BE49-F238E27FC236}">
                <a16:creationId xmlns:a16="http://schemas.microsoft.com/office/drawing/2014/main" id="{80CC7F8E-FB6E-331C-8FFB-1D1C13B312F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22129" y="4350965"/>
            <a:ext cx="720000" cy="513939"/>
          </a:xfrm>
          <a:prstGeom prst="rect">
            <a:avLst/>
          </a:prstGeom>
        </p:spPr>
      </p:pic>
      <p:pic>
        <p:nvPicPr>
          <p:cNvPr id="340" name="Image 339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F3471C7F-86FA-19D1-01B5-0CF4F7DF752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56337" y="4046557"/>
            <a:ext cx="720000" cy="513939"/>
          </a:xfrm>
          <a:prstGeom prst="rect">
            <a:avLst/>
          </a:prstGeom>
        </p:spPr>
      </p:pic>
      <p:pic>
        <p:nvPicPr>
          <p:cNvPr id="342" name="Image 341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88391F0D-6A1D-2AE5-2A35-4A3B0E34B39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78285" y="4046558"/>
            <a:ext cx="720000" cy="513939"/>
          </a:xfrm>
          <a:prstGeom prst="rect">
            <a:avLst/>
          </a:prstGeom>
        </p:spPr>
      </p:pic>
      <p:pic>
        <p:nvPicPr>
          <p:cNvPr id="344" name="Image 343" descr="Une image contenant typographie, printemps, ressort hélicoïdal, nature&#10;&#10;Description générée automatiquement">
            <a:extLst>
              <a:ext uri="{FF2B5EF4-FFF2-40B4-BE49-F238E27FC236}">
                <a16:creationId xmlns:a16="http://schemas.microsoft.com/office/drawing/2014/main" id="{19D94AAC-0D4D-3A3D-AA4C-4A3A379678D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50207" y="2395930"/>
            <a:ext cx="720000" cy="513939"/>
          </a:xfrm>
          <a:prstGeom prst="rect">
            <a:avLst/>
          </a:prstGeom>
        </p:spPr>
      </p:pic>
      <p:pic>
        <p:nvPicPr>
          <p:cNvPr id="346" name="Image 345" descr="Une image contenant printemps, nature, ressort hélicoïdal, typographie&#10;&#10;Description générée automatiquement">
            <a:extLst>
              <a:ext uri="{FF2B5EF4-FFF2-40B4-BE49-F238E27FC236}">
                <a16:creationId xmlns:a16="http://schemas.microsoft.com/office/drawing/2014/main" id="{0FD63912-56A7-541D-57F1-302AFD70425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45089" y="2916703"/>
            <a:ext cx="720000" cy="513939"/>
          </a:xfrm>
          <a:prstGeom prst="rect">
            <a:avLst/>
          </a:prstGeom>
        </p:spPr>
      </p:pic>
      <p:pic>
        <p:nvPicPr>
          <p:cNvPr id="348" name="Image 347" descr="Une image contenant printemps, nature, typographie, ressort hélicoïdal&#10;&#10;Description générée automatiquement">
            <a:extLst>
              <a:ext uri="{FF2B5EF4-FFF2-40B4-BE49-F238E27FC236}">
                <a16:creationId xmlns:a16="http://schemas.microsoft.com/office/drawing/2014/main" id="{819D3718-29CC-D840-F6AD-1BBC9FAE2AD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862467" y="2659734"/>
            <a:ext cx="720000" cy="513939"/>
          </a:xfrm>
          <a:prstGeom prst="rect">
            <a:avLst/>
          </a:prstGeom>
        </p:spPr>
      </p:pic>
      <p:pic>
        <p:nvPicPr>
          <p:cNvPr id="350" name="Image 349" descr="Une image contenant printemps, nature, ressort hélicoïdal, typographie&#10;&#10;Description générée automatiquement">
            <a:extLst>
              <a:ext uri="{FF2B5EF4-FFF2-40B4-BE49-F238E27FC236}">
                <a16:creationId xmlns:a16="http://schemas.microsoft.com/office/drawing/2014/main" id="{73FBAEA8-E368-EE89-5713-DA5109845AE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36038" y="2659734"/>
            <a:ext cx="720000" cy="513939"/>
          </a:xfrm>
          <a:prstGeom prst="rect">
            <a:avLst/>
          </a:prstGeom>
        </p:spPr>
      </p:pic>
      <p:pic>
        <p:nvPicPr>
          <p:cNvPr id="352" name="Image 351" descr="Une image contenant Police, typographie, printemps, conception&#10;&#10;Description générée automatiquement">
            <a:extLst>
              <a:ext uri="{FF2B5EF4-FFF2-40B4-BE49-F238E27FC236}">
                <a16:creationId xmlns:a16="http://schemas.microsoft.com/office/drawing/2014/main" id="{9B4093B5-88AB-7469-D495-2C1D9725826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021869" y="2895004"/>
            <a:ext cx="720000" cy="513939"/>
          </a:xfrm>
          <a:prstGeom prst="rect">
            <a:avLst/>
          </a:prstGeom>
        </p:spPr>
      </p:pic>
      <p:pic>
        <p:nvPicPr>
          <p:cNvPr id="354" name="Image 353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07CFC8AF-0137-DE29-EABB-9B42104BB58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024227" y="2392493"/>
            <a:ext cx="720000" cy="513939"/>
          </a:xfrm>
          <a:prstGeom prst="rect">
            <a:avLst/>
          </a:prstGeom>
        </p:spPr>
      </p:pic>
      <p:pic>
        <p:nvPicPr>
          <p:cNvPr id="356" name="Image 355" descr="Une image contenant typographie, printemps, conception&#10;&#10;Description générée automatiquement">
            <a:extLst>
              <a:ext uri="{FF2B5EF4-FFF2-40B4-BE49-F238E27FC236}">
                <a16:creationId xmlns:a16="http://schemas.microsoft.com/office/drawing/2014/main" id="{5C93A029-A398-FDC3-0E99-786FBEEC175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814380" y="2392494"/>
            <a:ext cx="720000" cy="513939"/>
          </a:xfrm>
          <a:prstGeom prst="rect">
            <a:avLst/>
          </a:prstGeom>
        </p:spPr>
      </p:pic>
      <p:pic>
        <p:nvPicPr>
          <p:cNvPr id="358" name="Image 357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4292BDA3-2413-A92E-9663-05FF501E2F2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812978" y="2895003"/>
            <a:ext cx="720000" cy="513939"/>
          </a:xfrm>
          <a:prstGeom prst="rect">
            <a:avLst/>
          </a:prstGeom>
        </p:spPr>
      </p:pic>
      <p:pic>
        <p:nvPicPr>
          <p:cNvPr id="360" name="Image 359" descr="Une image contenant typographie, printemps, ressort hélicoïdal, conception&#10;&#10;Description générée automatiquement">
            <a:extLst>
              <a:ext uri="{FF2B5EF4-FFF2-40B4-BE49-F238E27FC236}">
                <a16:creationId xmlns:a16="http://schemas.microsoft.com/office/drawing/2014/main" id="{D56926A6-D62B-CACF-37D0-F8114066DF0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656337" y="2659734"/>
            <a:ext cx="720000" cy="513939"/>
          </a:xfrm>
          <a:prstGeom prst="rect">
            <a:avLst/>
          </a:prstGeom>
        </p:spPr>
      </p:pic>
      <p:pic>
        <p:nvPicPr>
          <p:cNvPr id="362" name="Image 361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BF5276EB-A247-1563-78A2-8A1078C77D3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075247" y="2659735"/>
            <a:ext cx="720000" cy="513939"/>
          </a:xfrm>
          <a:prstGeom prst="rect">
            <a:avLst/>
          </a:prstGeom>
        </p:spPr>
      </p:pic>
      <p:pic>
        <p:nvPicPr>
          <p:cNvPr id="364" name="Image 363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8649A307-EFFA-0142-7FEA-0252734ACFF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448643" y="5278876"/>
            <a:ext cx="720000" cy="513939"/>
          </a:xfrm>
          <a:prstGeom prst="rect">
            <a:avLst/>
          </a:prstGeom>
        </p:spPr>
      </p:pic>
      <p:pic>
        <p:nvPicPr>
          <p:cNvPr id="366" name="Image 365" descr="Une image contenant Police, typographie, conception, printemps&#10;&#10;Description générée automatiquement">
            <a:extLst>
              <a:ext uri="{FF2B5EF4-FFF2-40B4-BE49-F238E27FC236}">
                <a16:creationId xmlns:a16="http://schemas.microsoft.com/office/drawing/2014/main" id="{482F766E-58ED-75BC-53D8-3954284B68C3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444221" y="5797525"/>
            <a:ext cx="720000" cy="513939"/>
          </a:xfrm>
          <a:prstGeom prst="rect">
            <a:avLst/>
          </a:prstGeom>
        </p:spPr>
      </p:pic>
      <p:pic>
        <p:nvPicPr>
          <p:cNvPr id="368" name="Image 367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01B0DF15-C002-2648-BB33-5C1624C41E30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243942" y="5278875"/>
            <a:ext cx="720000" cy="513939"/>
          </a:xfrm>
          <a:prstGeom prst="rect">
            <a:avLst/>
          </a:prstGeom>
        </p:spPr>
      </p:pic>
      <p:pic>
        <p:nvPicPr>
          <p:cNvPr id="370" name="Image 369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FE776DF2-5455-6417-B1A1-2FFC6E99266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243942" y="5797525"/>
            <a:ext cx="720000" cy="513939"/>
          </a:xfrm>
          <a:prstGeom prst="rect">
            <a:avLst/>
          </a:prstGeom>
        </p:spPr>
      </p:pic>
      <p:pic>
        <p:nvPicPr>
          <p:cNvPr id="372" name="Image 371" descr="Une image contenant typographie, printemps, ressort hélicoïdal, conception&#10;&#10;Description générée automatiquement">
            <a:extLst>
              <a:ext uri="{FF2B5EF4-FFF2-40B4-BE49-F238E27FC236}">
                <a16:creationId xmlns:a16="http://schemas.microsoft.com/office/drawing/2014/main" id="{C4CDE3A8-2E55-5DB9-FDD5-3325103507F0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822129" y="5513387"/>
            <a:ext cx="720000" cy="513939"/>
          </a:xfrm>
          <a:prstGeom prst="rect">
            <a:avLst/>
          </a:prstGeom>
        </p:spPr>
      </p:pic>
      <p:pic>
        <p:nvPicPr>
          <p:cNvPr id="374" name="Image 373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B2AE7006-F62E-99A4-130A-51E9C7C7F11B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021869" y="5797525"/>
            <a:ext cx="720000" cy="513939"/>
          </a:xfrm>
          <a:prstGeom prst="rect">
            <a:avLst/>
          </a:prstGeom>
        </p:spPr>
      </p:pic>
      <p:pic>
        <p:nvPicPr>
          <p:cNvPr id="376" name="Image 375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C64B6934-1B85-6A5C-AA24-1ED6B0ED7D17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028259" y="5278875"/>
            <a:ext cx="720000" cy="513939"/>
          </a:xfrm>
          <a:prstGeom prst="rect">
            <a:avLst/>
          </a:prstGeom>
        </p:spPr>
      </p:pic>
      <p:pic>
        <p:nvPicPr>
          <p:cNvPr id="378" name="Image 377" descr="Une image contenant typographie, printemps, ressort hélicoïdal, conception&#10;&#10;Description générée automatiquement">
            <a:extLst>
              <a:ext uri="{FF2B5EF4-FFF2-40B4-BE49-F238E27FC236}">
                <a16:creationId xmlns:a16="http://schemas.microsoft.com/office/drawing/2014/main" id="{7A65C283-0E90-DA10-287A-1754C9048679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862467" y="5513388"/>
            <a:ext cx="720000" cy="513939"/>
          </a:xfrm>
          <a:prstGeom prst="rect">
            <a:avLst/>
          </a:prstGeom>
        </p:spPr>
      </p:pic>
      <p:pic>
        <p:nvPicPr>
          <p:cNvPr id="380" name="Image 379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FCB198D5-3AC2-8DAC-95B3-6872B70497D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653344" y="5513391"/>
            <a:ext cx="720000" cy="513939"/>
          </a:xfrm>
          <a:prstGeom prst="rect">
            <a:avLst/>
          </a:prstGeom>
        </p:spPr>
      </p:pic>
      <p:pic>
        <p:nvPicPr>
          <p:cNvPr id="382" name="Image 381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BB9599C6-872C-4FD9-1E8E-EB49E719C9C7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078285" y="5513391"/>
            <a:ext cx="720000" cy="513939"/>
          </a:xfrm>
          <a:prstGeom prst="rect">
            <a:avLst/>
          </a:prstGeom>
        </p:spPr>
      </p:pic>
      <p:pic>
        <p:nvPicPr>
          <p:cNvPr id="384" name="Image 383" descr="Une image contenant typographie&#10;&#10;Description générée automatiquement">
            <a:extLst>
              <a:ext uri="{FF2B5EF4-FFF2-40B4-BE49-F238E27FC236}">
                <a16:creationId xmlns:a16="http://schemas.microsoft.com/office/drawing/2014/main" id="{A93868F8-A098-6585-85B9-43260A81809A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822129" y="6972283"/>
            <a:ext cx="720000" cy="513939"/>
          </a:xfrm>
          <a:prstGeom prst="rect">
            <a:avLst/>
          </a:prstGeom>
        </p:spPr>
      </p:pic>
      <p:pic>
        <p:nvPicPr>
          <p:cNvPr id="386" name="Image 385" descr="Une image contenant typographie, conception&#10;&#10;Description générée automatiquement avec une confiance faible">
            <a:extLst>
              <a:ext uri="{FF2B5EF4-FFF2-40B4-BE49-F238E27FC236}">
                <a16:creationId xmlns:a16="http://schemas.microsoft.com/office/drawing/2014/main" id="{3959F04E-78DE-56C3-2F74-44BB174C298E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3445965" y="6711416"/>
            <a:ext cx="720000" cy="513939"/>
          </a:xfrm>
          <a:prstGeom prst="rect">
            <a:avLst/>
          </a:prstGeom>
        </p:spPr>
      </p:pic>
      <p:pic>
        <p:nvPicPr>
          <p:cNvPr id="388" name="Image 387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6C1DC51D-37C1-5FBE-23BB-6346A2A09106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3449034" y="7229249"/>
            <a:ext cx="720000" cy="513939"/>
          </a:xfrm>
          <a:prstGeom prst="rect">
            <a:avLst/>
          </a:prstGeom>
        </p:spPr>
      </p:pic>
      <p:pic>
        <p:nvPicPr>
          <p:cNvPr id="390" name="Image 389" descr="Une image contenant typographie, conception&#10;&#10;Description générée automatiquement avec une confiance moyenne">
            <a:extLst>
              <a:ext uri="{FF2B5EF4-FFF2-40B4-BE49-F238E27FC236}">
                <a16:creationId xmlns:a16="http://schemas.microsoft.com/office/drawing/2014/main" id="{7D598565-AB2D-A6A7-05B5-86A00F014C86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4240041" y="6711416"/>
            <a:ext cx="720000" cy="513939"/>
          </a:xfrm>
          <a:prstGeom prst="rect">
            <a:avLst/>
          </a:prstGeom>
        </p:spPr>
      </p:pic>
      <p:pic>
        <p:nvPicPr>
          <p:cNvPr id="392" name="Image 391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D23B3333-2CF9-6309-A64A-2FBC08BB3F06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4238718" y="7229250"/>
            <a:ext cx="720000" cy="513939"/>
          </a:xfrm>
          <a:prstGeom prst="rect">
            <a:avLst/>
          </a:prstGeom>
        </p:spPr>
      </p:pic>
      <p:pic>
        <p:nvPicPr>
          <p:cNvPr id="394" name="Image 393" descr="Une image contenant typographie, Police, printemps, conception&#10;&#10;Description générée automatiquement">
            <a:extLst>
              <a:ext uri="{FF2B5EF4-FFF2-40B4-BE49-F238E27FC236}">
                <a16:creationId xmlns:a16="http://schemas.microsoft.com/office/drawing/2014/main" id="{7C302F2F-ADEE-887C-8E0A-656958703DE0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5018836" y="7229249"/>
            <a:ext cx="720000" cy="513939"/>
          </a:xfrm>
          <a:prstGeom prst="rect">
            <a:avLst/>
          </a:prstGeom>
        </p:spPr>
      </p:pic>
      <p:pic>
        <p:nvPicPr>
          <p:cNvPr id="396" name="Image 395" descr="Une image contenant typographie, conception, peigne&#10;&#10;Description générée automatiquement">
            <a:extLst>
              <a:ext uri="{FF2B5EF4-FFF2-40B4-BE49-F238E27FC236}">
                <a16:creationId xmlns:a16="http://schemas.microsoft.com/office/drawing/2014/main" id="{D603C07F-F4BD-9D5C-2091-F0B3FD73EE7A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5028053" y="6711416"/>
            <a:ext cx="720000" cy="513939"/>
          </a:xfrm>
          <a:prstGeom prst="rect">
            <a:avLst/>
          </a:prstGeom>
        </p:spPr>
      </p:pic>
      <p:pic>
        <p:nvPicPr>
          <p:cNvPr id="398" name="Image 397" descr="Une image contenant typographie, printemps, conception&#10;&#10;Description générée automatiquement">
            <a:extLst>
              <a:ext uri="{FF2B5EF4-FFF2-40B4-BE49-F238E27FC236}">
                <a16:creationId xmlns:a16="http://schemas.microsoft.com/office/drawing/2014/main" id="{C64D821D-1D43-CA0B-611D-4A494E72CD7F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1860320" y="6972281"/>
            <a:ext cx="720000" cy="513939"/>
          </a:xfrm>
          <a:prstGeom prst="rect">
            <a:avLst/>
          </a:prstGeom>
        </p:spPr>
      </p:pic>
      <p:pic>
        <p:nvPicPr>
          <p:cNvPr id="402" name="Image 401" descr="Une image contenant conception, typographie&#10;&#10;Description générée automatiquement">
            <a:extLst>
              <a:ext uri="{FF2B5EF4-FFF2-40B4-BE49-F238E27FC236}">
                <a16:creationId xmlns:a16="http://schemas.microsoft.com/office/drawing/2014/main" id="{56FD7EA7-703A-A6D9-740C-D71E8B03A570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1069049" y="6972283"/>
            <a:ext cx="720000" cy="513939"/>
          </a:xfrm>
          <a:prstGeom prst="rect">
            <a:avLst/>
          </a:prstGeom>
        </p:spPr>
      </p:pic>
      <p:pic>
        <p:nvPicPr>
          <p:cNvPr id="404" name="Image 403" descr="Une image contenant printemps, nature, ressort hélicoïdal, typographie&#10;&#10;Description générée automatiquement">
            <a:extLst>
              <a:ext uri="{FF2B5EF4-FFF2-40B4-BE49-F238E27FC236}">
                <a16:creationId xmlns:a16="http://schemas.microsoft.com/office/drawing/2014/main" id="{E00A2303-D893-5F39-29BE-C784E3B9A67C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3443767" y="1503484"/>
            <a:ext cx="720000" cy="513939"/>
          </a:xfrm>
          <a:prstGeom prst="rect">
            <a:avLst/>
          </a:prstGeom>
        </p:spPr>
      </p:pic>
      <p:pic>
        <p:nvPicPr>
          <p:cNvPr id="406" name="Image 405" descr="Une image contenant typographie&#10;&#10;Description générée automatiquement">
            <a:extLst>
              <a:ext uri="{FF2B5EF4-FFF2-40B4-BE49-F238E27FC236}">
                <a16:creationId xmlns:a16="http://schemas.microsoft.com/office/drawing/2014/main" id="{6596EB6D-87A0-675A-DE33-1D550CA01EBD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3443294" y="939764"/>
            <a:ext cx="720000" cy="513939"/>
          </a:xfrm>
          <a:prstGeom prst="rect">
            <a:avLst/>
          </a:prstGeom>
        </p:spPr>
      </p:pic>
      <p:pic>
        <p:nvPicPr>
          <p:cNvPr id="408" name="Image 407" descr="Une image contenant printemps, nature, ressort hélicoïdal, typographie&#10;&#10;Description générée automatiquement">
            <a:extLst>
              <a:ext uri="{FF2B5EF4-FFF2-40B4-BE49-F238E27FC236}">
                <a16:creationId xmlns:a16="http://schemas.microsoft.com/office/drawing/2014/main" id="{04211E02-78E6-583E-CFEE-8B8275A50BCF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4236038" y="1500205"/>
            <a:ext cx="720000" cy="513939"/>
          </a:xfrm>
          <a:prstGeom prst="rect">
            <a:avLst/>
          </a:prstGeom>
        </p:spPr>
      </p:pic>
      <p:pic>
        <p:nvPicPr>
          <p:cNvPr id="410" name="Image 409" descr="Une image contenant typographie, printemps, ressort hélicoïdal, nature&#10;&#10;Description générée automatiquement">
            <a:extLst>
              <a:ext uri="{FF2B5EF4-FFF2-40B4-BE49-F238E27FC236}">
                <a16:creationId xmlns:a16="http://schemas.microsoft.com/office/drawing/2014/main" id="{5E4C31AD-90EA-C705-D0D4-236C6AEB27BF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4249887" y="945495"/>
            <a:ext cx="720000" cy="513939"/>
          </a:xfrm>
          <a:prstGeom prst="rect">
            <a:avLst/>
          </a:prstGeom>
        </p:spPr>
      </p:pic>
      <p:pic>
        <p:nvPicPr>
          <p:cNvPr id="412" name="Image 411" descr="Une image contenant typographie, printemps, ressort hélicoïdal, nature&#10;&#10;Description générée automatiquement">
            <a:extLst>
              <a:ext uri="{FF2B5EF4-FFF2-40B4-BE49-F238E27FC236}">
                <a16:creationId xmlns:a16="http://schemas.microsoft.com/office/drawing/2014/main" id="{F374D4AB-7692-792B-D2A5-E85EAFF3A5CB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1860320" y="1261482"/>
            <a:ext cx="720000" cy="513939"/>
          </a:xfrm>
          <a:prstGeom prst="rect">
            <a:avLst/>
          </a:prstGeom>
        </p:spPr>
      </p:pic>
      <p:pic>
        <p:nvPicPr>
          <p:cNvPr id="414" name="Image 413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5562E309-D65D-914F-C55C-A6B327FBFF48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5027214" y="1518449"/>
            <a:ext cx="720000" cy="513939"/>
          </a:xfrm>
          <a:prstGeom prst="rect">
            <a:avLst/>
          </a:prstGeom>
        </p:spPr>
      </p:pic>
      <p:pic>
        <p:nvPicPr>
          <p:cNvPr id="416" name="Image 415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5B97BD12-8608-98FA-D273-C174BFD4EE5C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5028053" y="939763"/>
            <a:ext cx="720000" cy="513939"/>
          </a:xfrm>
          <a:prstGeom prst="rect">
            <a:avLst/>
          </a:prstGeom>
        </p:spPr>
      </p:pic>
      <p:pic>
        <p:nvPicPr>
          <p:cNvPr id="418" name="Image 417" descr="Une image contenant typographie&#10;&#10;Description générée automatiquement">
            <a:extLst>
              <a:ext uri="{FF2B5EF4-FFF2-40B4-BE49-F238E27FC236}">
                <a16:creationId xmlns:a16="http://schemas.microsoft.com/office/drawing/2014/main" id="{A5FB9BAC-1D85-BE23-1B67-04E11FAAA4B5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5820845" y="939762"/>
            <a:ext cx="720000" cy="513939"/>
          </a:xfrm>
          <a:prstGeom prst="rect">
            <a:avLst/>
          </a:prstGeom>
        </p:spPr>
      </p:pic>
      <p:pic>
        <p:nvPicPr>
          <p:cNvPr id="420" name="Image 419" descr="Une image contenant Police, typographie, conception&#10;&#10;Description générée automatiquement">
            <a:extLst>
              <a:ext uri="{FF2B5EF4-FFF2-40B4-BE49-F238E27FC236}">
                <a16:creationId xmlns:a16="http://schemas.microsoft.com/office/drawing/2014/main" id="{D533A560-42E9-50C0-98ED-236F91AD1B07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5812702" y="1518448"/>
            <a:ext cx="720000" cy="513939"/>
          </a:xfrm>
          <a:prstGeom prst="rect">
            <a:avLst/>
          </a:prstGeom>
        </p:spPr>
      </p:pic>
      <p:pic>
        <p:nvPicPr>
          <p:cNvPr id="422" name="Image 421" descr="Une image contenant typographie&#10;&#10;Description générée automatiquement">
            <a:extLst>
              <a:ext uri="{FF2B5EF4-FFF2-40B4-BE49-F238E27FC236}">
                <a16:creationId xmlns:a16="http://schemas.microsoft.com/office/drawing/2014/main" id="{959ABB49-A744-F2DC-76C4-1150A43EEDB4}"/>
              </a:ext>
            </a:extLst>
          </p:cNvPr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2655194" y="1261480"/>
            <a:ext cx="720000" cy="513939"/>
          </a:xfrm>
          <a:prstGeom prst="rect">
            <a:avLst/>
          </a:prstGeom>
        </p:spPr>
      </p:pic>
      <p:pic>
        <p:nvPicPr>
          <p:cNvPr id="424" name="Image 423" descr="Une image contenant typographie, conception&#10;&#10;Description générée automatiquement">
            <a:extLst>
              <a:ext uri="{FF2B5EF4-FFF2-40B4-BE49-F238E27FC236}">
                <a16:creationId xmlns:a16="http://schemas.microsoft.com/office/drawing/2014/main" id="{97A1C937-7158-95A3-F216-E581BB960442}"/>
              </a:ext>
            </a:extLst>
          </p:cNvPr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1069049" y="1261482"/>
            <a:ext cx="720000" cy="513939"/>
          </a:xfrm>
          <a:prstGeom prst="rect">
            <a:avLst/>
          </a:prstGeom>
        </p:spPr>
      </p:pic>
      <p:pic>
        <p:nvPicPr>
          <p:cNvPr id="426" name="Image 425">
            <a:extLst>
              <a:ext uri="{FF2B5EF4-FFF2-40B4-BE49-F238E27FC236}">
                <a16:creationId xmlns:a16="http://schemas.microsoft.com/office/drawing/2014/main" id="{3D2D3127-4CBF-4EE3-70B2-4F6C085919FB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22922" t="13800" r="13708" b="75516"/>
          <a:stretch/>
        </p:blipFill>
        <p:spPr>
          <a:xfrm>
            <a:off x="1848465" y="2032281"/>
            <a:ext cx="4708800" cy="299354"/>
          </a:xfrm>
          <a:prstGeom prst="rect">
            <a:avLst/>
          </a:prstGeom>
        </p:spPr>
      </p:pic>
      <p:pic>
        <p:nvPicPr>
          <p:cNvPr id="427" name="Image 426">
            <a:extLst>
              <a:ext uri="{FF2B5EF4-FFF2-40B4-BE49-F238E27FC236}">
                <a16:creationId xmlns:a16="http://schemas.microsoft.com/office/drawing/2014/main" id="{B6B0DC03-A69E-65C7-BDCB-7C4BB6F34A46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22922" t="27271" r="13708" b="60157"/>
          <a:stretch/>
        </p:blipFill>
        <p:spPr>
          <a:xfrm>
            <a:off x="1848465" y="3422317"/>
            <a:ext cx="4708800" cy="352252"/>
          </a:xfrm>
          <a:prstGeom prst="rect">
            <a:avLst/>
          </a:prstGeom>
        </p:spPr>
      </p:pic>
      <p:pic>
        <p:nvPicPr>
          <p:cNvPr id="428" name="Image 427">
            <a:extLst>
              <a:ext uri="{FF2B5EF4-FFF2-40B4-BE49-F238E27FC236}">
                <a16:creationId xmlns:a16="http://schemas.microsoft.com/office/drawing/2014/main" id="{CEFA2B01-8815-338D-FCB3-90B7621822B5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22922" t="40218" r="13708" b="46868"/>
          <a:stretch/>
        </p:blipFill>
        <p:spPr>
          <a:xfrm>
            <a:off x="1848465" y="4842776"/>
            <a:ext cx="4708800" cy="361826"/>
          </a:xfrm>
          <a:prstGeom prst="rect">
            <a:avLst/>
          </a:prstGeom>
        </p:spPr>
      </p:pic>
      <p:pic>
        <p:nvPicPr>
          <p:cNvPr id="429" name="Image 428">
            <a:extLst>
              <a:ext uri="{FF2B5EF4-FFF2-40B4-BE49-F238E27FC236}">
                <a16:creationId xmlns:a16="http://schemas.microsoft.com/office/drawing/2014/main" id="{E34EDAE5-AB09-E9FF-202F-2BC4E5A085E6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22922" t="53947" r="13708" b="33480"/>
          <a:stretch/>
        </p:blipFill>
        <p:spPr>
          <a:xfrm>
            <a:off x="1848465" y="6304744"/>
            <a:ext cx="4708800" cy="352253"/>
          </a:xfrm>
          <a:prstGeom prst="rect">
            <a:avLst/>
          </a:prstGeom>
        </p:spPr>
      </p:pic>
      <p:pic>
        <p:nvPicPr>
          <p:cNvPr id="430" name="Image 429">
            <a:extLst>
              <a:ext uri="{FF2B5EF4-FFF2-40B4-BE49-F238E27FC236}">
                <a16:creationId xmlns:a16="http://schemas.microsoft.com/office/drawing/2014/main" id="{8117E347-F21D-D7AC-AA2E-8CB888E87466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22922" t="67219" r="13708" b="20208"/>
          <a:stretch/>
        </p:blipFill>
        <p:spPr>
          <a:xfrm>
            <a:off x="1848465" y="7796264"/>
            <a:ext cx="4708800" cy="352253"/>
          </a:xfrm>
          <a:prstGeom prst="rect">
            <a:avLst/>
          </a:prstGeom>
        </p:spPr>
      </p:pic>
      <p:sp>
        <p:nvSpPr>
          <p:cNvPr id="431" name="ZoneTexte 430">
            <a:extLst>
              <a:ext uri="{FF2B5EF4-FFF2-40B4-BE49-F238E27FC236}">
                <a16:creationId xmlns:a16="http://schemas.microsoft.com/office/drawing/2014/main" id="{2EE96570-ADB6-BB91-10C5-9DC1F936E633}"/>
              </a:ext>
            </a:extLst>
          </p:cNvPr>
          <p:cNvSpPr txBox="1"/>
          <p:nvPr/>
        </p:nvSpPr>
        <p:spPr>
          <a:xfrm rot="18848527">
            <a:off x="1833066" y="8396467"/>
            <a:ext cx="7768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/>
              <a:t>6 </a:t>
            </a:r>
            <a:r>
              <a:rPr lang="fr-FR" sz="1000" b="1" dirty="0" err="1"/>
              <a:t>year-old</a:t>
            </a:r>
            <a:endParaRPr lang="fr-FR" sz="1000" b="1" dirty="0"/>
          </a:p>
        </p:txBody>
      </p:sp>
      <p:sp>
        <p:nvSpPr>
          <p:cNvPr id="432" name="ZoneTexte 431">
            <a:extLst>
              <a:ext uri="{FF2B5EF4-FFF2-40B4-BE49-F238E27FC236}">
                <a16:creationId xmlns:a16="http://schemas.microsoft.com/office/drawing/2014/main" id="{2688A480-68F3-CF4F-6B9B-5C1BB50A8EA6}"/>
              </a:ext>
            </a:extLst>
          </p:cNvPr>
          <p:cNvSpPr txBox="1"/>
          <p:nvPr/>
        </p:nvSpPr>
        <p:spPr>
          <a:xfrm rot="18848527">
            <a:off x="1420169" y="8394637"/>
            <a:ext cx="7768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/>
              <a:t>5 </a:t>
            </a:r>
            <a:r>
              <a:rPr lang="fr-FR" sz="1000" b="1" dirty="0" err="1"/>
              <a:t>year-old</a:t>
            </a:r>
            <a:endParaRPr lang="fr-FR" sz="1000" b="1" dirty="0"/>
          </a:p>
        </p:txBody>
      </p:sp>
      <p:pic>
        <p:nvPicPr>
          <p:cNvPr id="16" name="Image 15" descr="Une image contenant Police, conception, typographie&#10;&#10;Le contenu généré par l’IA peut être incorrect.">
            <a:extLst>
              <a:ext uri="{FF2B5EF4-FFF2-40B4-BE49-F238E27FC236}">
                <a16:creationId xmlns:a16="http://schemas.microsoft.com/office/drawing/2014/main" id="{AB0E60C5-C94D-B8CE-79EE-481AE0346EB1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2610631" y="6967039"/>
            <a:ext cx="720000" cy="513939"/>
          </a:xfrm>
          <a:prstGeom prst="rect">
            <a:avLst/>
          </a:prstGeom>
        </p:spPr>
      </p:pic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4681A4BF-4067-4D43-68CA-7999FCF799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0009150"/>
              </p:ext>
            </p:extLst>
          </p:nvPr>
        </p:nvGraphicFramePr>
        <p:xfrm>
          <a:off x="247976" y="0"/>
          <a:ext cx="6325472" cy="8121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92000">
                  <a:extLst>
                    <a:ext uri="{9D8B030D-6E8A-4147-A177-3AD203B41FA5}">
                      <a16:colId xmlns:a16="http://schemas.microsoft.com/office/drawing/2014/main" val="2297954170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503350955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1292920254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2583124190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2623948246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4276354975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266536482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18515745"/>
                    </a:ext>
                  </a:extLst>
                </a:gridCol>
              </a:tblGrid>
              <a:tr h="298800">
                <a:tc rowSpan="2"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Stimulu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b="1" dirty="0"/>
                        <a:t>Correct </a:t>
                      </a:r>
                      <a:r>
                        <a:rPr lang="fr-FR" sz="1000" b="1" dirty="0" err="1"/>
                        <a:t>response</a:t>
                      </a:r>
                      <a:endParaRPr lang="fr-FR" sz="1000" b="1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Violation of…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8471700"/>
                  </a:ext>
                </a:extLst>
              </a:tr>
              <a:tr h="622840"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motif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 amplitude 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 amplitude tren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 </a:t>
                      </a:r>
                      <a:r>
                        <a:rPr lang="fr-FR" sz="1000" dirty="0" err="1"/>
                        <a:t>frequency</a:t>
                      </a:r>
                      <a:r>
                        <a:rPr lang="fr-FR" sz="1000" dirty="0"/>
                        <a:t> 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 </a:t>
                      </a:r>
                      <a:r>
                        <a:rPr lang="fr-FR" sz="1000" dirty="0" err="1"/>
                        <a:t>frequency</a:t>
                      </a:r>
                      <a:r>
                        <a:rPr lang="fr-FR" sz="1000" dirty="0"/>
                        <a:t> tren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59776533"/>
                  </a:ext>
                </a:extLst>
              </a:tr>
              <a:tr h="720000"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Sinusoïd</a:t>
                      </a:r>
                      <a:r>
                        <a:rPr lang="fr-FR" sz="1000" dirty="0"/>
                        <a:t> </a:t>
                      </a:r>
                      <a:r>
                        <a:rPr lang="fr-FR" sz="1000" b="1" dirty="0"/>
                        <a:t>constant</a:t>
                      </a:r>
                      <a:r>
                        <a:rPr lang="fr-FR" sz="1000" dirty="0"/>
                        <a:t> amplitude and </a:t>
                      </a:r>
                      <a:r>
                        <a:rPr lang="fr-FR" sz="1000" dirty="0" err="1"/>
                        <a:t>frequency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9745082"/>
                  </a:ext>
                </a:extLst>
              </a:tr>
              <a:tr h="720000">
                <a:tc vMerge="1">
                  <a:txBody>
                    <a:bodyPr/>
                    <a:lstStyle/>
                    <a:p>
                      <a:pPr algn="ctr"/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77649476"/>
                  </a:ext>
                </a:extLst>
              </a:tr>
              <a:tr h="720000"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Sinusoïd</a:t>
                      </a:r>
                      <a:r>
                        <a:rPr lang="fr-FR" sz="1000" dirty="0"/>
                        <a:t> </a:t>
                      </a:r>
                      <a:r>
                        <a:rPr lang="fr-FR" sz="1000" b="1" dirty="0" err="1"/>
                        <a:t>increasing</a:t>
                      </a:r>
                      <a:r>
                        <a:rPr lang="fr-FR" sz="1000" dirty="0"/>
                        <a:t> amplitude </a:t>
                      </a:r>
                      <a:r>
                        <a:rPr lang="fr-FR" sz="1000" b="1" dirty="0"/>
                        <a:t>constant </a:t>
                      </a:r>
                      <a:r>
                        <a:rPr lang="fr-FR" sz="1000" dirty="0" err="1"/>
                        <a:t>frequency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32748992"/>
                  </a:ext>
                </a:extLst>
              </a:tr>
              <a:tr h="720000">
                <a:tc vMerge="1">
                  <a:txBody>
                    <a:bodyPr/>
                    <a:lstStyle/>
                    <a:p>
                      <a:pPr algn="ctr"/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98360867"/>
                  </a:ext>
                </a:extLst>
              </a:tr>
              <a:tr h="720000"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Sinusoïd</a:t>
                      </a:r>
                      <a:r>
                        <a:rPr lang="fr-FR" sz="1000" dirty="0"/>
                        <a:t> </a:t>
                      </a:r>
                      <a:r>
                        <a:rPr lang="fr-FR" sz="1000" b="1" dirty="0" err="1"/>
                        <a:t>decreasing</a:t>
                      </a:r>
                      <a:r>
                        <a:rPr lang="fr-FR" sz="1000" dirty="0"/>
                        <a:t> amplitude </a:t>
                      </a:r>
                      <a:r>
                        <a:rPr lang="fr-FR" sz="1000" b="1" dirty="0"/>
                        <a:t>constant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frequency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9644528"/>
                  </a:ext>
                </a:extLst>
              </a:tr>
              <a:tr h="720000">
                <a:tc vMerge="1">
                  <a:txBody>
                    <a:bodyPr/>
                    <a:lstStyle/>
                    <a:p>
                      <a:pPr algn="ctr"/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77041870"/>
                  </a:ext>
                </a:extLst>
              </a:tr>
              <a:tr h="720000"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Sinusoïd</a:t>
                      </a:r>
                      <a:r>
                        <a:rPr lang="fr-FR" sz="1000" dirty="0"/>
                        <a:t> </a:t>
                      </a:r>
                      <a:r>
                        <a:rPr lang="fr-FR" sz="1000" b="1" dirty="0"/>
                        <a:t>constant</a:t>
                      </a:r>
                      <a:r>
                        <a:rPr lang="fr-FR" sz="1000" dirty="0"/>
                        <a:t> amplitude </a:t>
                      </a:r>
                      <a:r>
                        <a:rPr lang="fr-FR" sz="1000" b="1" dirty="0" err="1"/>
                        <a:t>increasing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frequency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78511350"/>
                  </a:ext>
                </a:extLst>
              </a:tr>
              <a:tr h="720000">
                <a:tc vMerge="1">
                  <a:txBody>
                    <a:bodyPr/>
                    <a:lstStyle/>
                    <a:p>
                      <a:pPr algn="ctr"/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4960566"/>
                  </a:ext>
                </a:extLst>
              </a:tr>
              <a:tr h="720000"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Sinusoïd</a:t>
                      </a:r>
                      <a:r>
                        <a:rPr lang="fr-FR" sz="1000" dirty="0"/>
                        <a:t> </a:t>
                      </a:r>
                      <a:r>
                        <a:rPr lang="fr-FR" sz="1000" b="1" dirty="0"/>
                        <a:t>constant</a:t>
                      </a:r>
                      <a:r>
                        <a:rPr lang="fr-FR" sz="1000" dirty="0"/>
                        <a:t> amplitude </a:t>
                      </a:r>
                      <a:r>
                        <a:rPr lang="fr-FR" sz="1000" b="1" dirty="0" err="1"/>
                        <a:t>decreasing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frequency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12796248"/>
                  </a:ext>
                </a:extLst>
              </a:tr>
              <a:tr h="720000">
                <a:tc vMerge="1">
                  <a:txBody>
                    <a:bodyPr/>
                    <a:lstStyle/>
                    <a:p>
                      <a:pPr algn="ctr"/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71605337"/>
                  </a:ext>
                </a:extLst>
              </a:tr>
            </a:tbl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B288C515-8001-84F0-B51C-9125AB41408F}"/>
              </a:ext>
            </a:extLst>
          </p:cNvPr>
          <p:cNvSpPr txBox="1"/>
          <p:nvPr/>
        </p:nvSpPr>
        <p:spPr>
          <a:xfrm>
            <a:off x="3631781" y="1380833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098DE14C-BAE9-9E00-CBE8-D131B647D085}"/>
              </a:ext>
            </a:extLst>
          </p:cNvPr>
          <p:cNvSpPr txBox="1"/>
          <p:nvPr/>
        </p:nvSpPr>
        <p:spPr>
          <a:xfrm>
            <a:off x="4438783" y="1378300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C4763A9B-E2E7-0A47-E7FA-2D49139CDB01}"/>
              </a:ext>
            </a:extLst>
          </p:cNvPr>
          <p:cNvSpPr txBox="1"/>
          <p:nvPr/>
        </p:nvSpPr>
        <p:spPr>
          <a:xfrm>
            <a:off x="5230398" y="1371530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9176E43C-2E7E-BF95-8649-C5FBE24D9557}"/>
              </a:ext>
            </a:extLst>
          </p:cNvPr>
          <p:cNvSpPr txBox="1"/>
          <p:nvPr/>
        </p:nvSpPr>
        <p:spPr>
          <a:xfrm>
            <a:off x="6003801" y="1363695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132EFDD-4BB9-679A-D9A8-6A24BF1C4622}"/>
              </a:ext>
            </a:extLst>
          </p:cNvPr>
          <p:cNvSpPr txBox="1"/>
          <p:nvPr/>
        </p:nvSpPr>
        <p:spPr>
          <a:xfrm>
            <a:off x="3661769" y="2823373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5BFD9426-1C3F-E24E-262B-630A9364DF71}"/>
              </a:ext>
            </a:extLst>
          </p:cNvPr>
          <p:cNvSpPr txBox="1"/>
          <p:nvPr/>
        </p:nvSpPr>
        <p:spPr>
          <a:xfrm>
            <a:off x="5238776" y="2814603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C2742DC0-5EDC-32D3-5159-791C9B672827}"/>
              </a:ext>
            </a:extLst>
          </p:cNvPr>
          <p:cNvSpPr txBox="1"/>
          <p:nvPr/>
        </p:nvSpPr>
        <p:spPr>
          <a:xfrm>
            <a:off x="6024264" y="2821668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2E129F04-AEB4-8682-60BB-3C18B3AFC6C6}"/>
              </a:ext>
            </a:extLst>
          </p:cNvPr>
          <p:cNvSpPr txBox="1"/>
          <p:nvPr/>
        </p:nvSpPr>
        <p:spPr>
          <a:xfrm>
            <a:off x="3631781" y="4235221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908CC8DB-9F0A-37B5-E6FC-3DA5F21FB81D}"/>
              </a:ext>
            </a:extLst>
          </p:cNvPr>
          <p:cNvSpPr txBox="1"/>
          <p:nvPr/>
        </p:nvSpPr>
        <p:spPr>
          <a:xfrm>
            <a:off x="5212701" y="4224869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8F6C9CE-C499-7ECF-1C96-D6F66E08F906}"/>
              </a:ext>
            </a:extLst>
          </p:cNvPr>
          <p:cNvSpPr txBox="1"/>
          <p:nvPr/>
        </p:nvSpPr>
        <p:spPr>
          <a:xfrm>
            <a:off x="6024264" y="4218190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01DB379-3508-C810-D2E5-2D7E5956DFF1}"/>
              </a:ext>
            </a:extLst>
          </p:cNvPr>
          <p:cNvSpPr txBox="1"/>
          <p:nvPr/>
        </p:nvSpPr>
        <p:spPr>
          <a:xfrm>
            <a:off x="3631781" y="5718826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B4516FD-1E51-D071-3957-B3B7D835A1AD}"/>
              </a:ext>
            </a:extLst>
          </p:cNvPr>
          <p:cNvSpPr txBox="1"/>
          <p:nvPr/>
        </p:nvSpPr>
        <p:spPr>
          <a:xfrm>
            <a:off x="4430079" y="5716792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8EB04E4C-881D-498E-94D5-0E0410FD7907}"/>
              </a:ext>
            </a:extLst>
          </p:cNvPr>
          <p:cNvSpPr txBox="1"/>
          <p:nvPr/>
        </p:nvSpPr>
        <p:spPr>
          <a:xfrm>
            <a:off x="5207612" y="5708937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B9442B0D-3E8C-9417-B7FD-91C581F3809C}"/>
              </a:ext>
            </a:extLst>
          </p:cNvPr>
          <p:cNvSpPr txBox="1"/>
          <p:nvPr/>
        </p:nvSpPr>
        <p:spPr>
          <a:xfrm>
            <a:off x="3654856" y="7155319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121BD4CB-177A-8DBD-CA0F-7DD7E312F5D6}"/>
              </a:ext>
            </a:extLst>
          </p:cNvPr>
          <p:cNvSpPr txBox="1"/>
          <p:nvPr/>
        </p:nvSpPr>
        <p:spPr>
          <a:xfrm>
            <a:off x="4445497" y="7155318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6AE3CAE0-E3D4-9A55-42D4-F47BF87E3972}"/>
              </a:ext>
            </a:extLst>
          </p:cNvPr>
          <p:cNvSpPr txBox="1"/>
          <p:nvPr/>
        </p:nvSpPr>
        <p:spPr>
          <a:xfrm>
            <a:off x="5227801" y="7143416"/>
            <a:ext cx="296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or</a:t>
            </a:r>
          </a:p>
        </p:txBody>
      </p:sp>
    </p:spTree>
    <p:extLst>
      <p:ext uri="{BB962C8B-B14F-4D97-AF65-F5344CB8AC3E}">
        <p14:creationId xmlns:p14="http://schemas.microsoft.com/office/powerpoint/2010/main" val="4060468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6071EE-B5D7-1C41-AB14-6EF8C54474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Forme libre 22">
            <a:extLst>
              <a:ext uri="{FF2B5EF4-FFF2-40B4-BE49-F238E27FC236}">
                <a16:creationId xmlns:a16="http://schemas.microsoft.com/office/drawing/2014/main" id="{2ABD985B-BDCB-EEAA-FC03-A2D2B0BB6EB2}"/>
              </a:ext>
            </a:extLst>
          </p:cNvPr>
          <p:cNvSpPr/>
          <p:nvPr/>
        </p:nvSpPr>
        <p:spPr>
          <a:xfrm>
            <a:off x="228600" y="2896013"/>
            <a:ext cx="6400800" cy="4115434"/>
          </a:xfrm>
          <a:custGeom>
            <a:avLst/>
            <a:gdLst>
              <a:gd name="connsiteX0" fmla="*/ 0 w 6400800"/>
              <a:gd name="connsiteY0" fmla="*/ 0 h 4115434"/>
              <a:gd name="connsiteX1" fmla="*/ 6400800 w 6400800"/>
              <a:gd name="connsiteY1" fmla="*/ 0 h 4115434"/>
              <a:gd name="connsiteX2" fmla="*/ 6400800 w 6400800"/>
              <a:gd name="connsiteY2" fmla="*/ 4115435 h 4115434"/>
              <a:gd name="connsiteX3" fmla="*/ 0 w 6400800"/>
              <a:gd name="connsiteY3" fmla="*/ 4115435 h 41154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400800" h="4115434">
                <a:moveTo>
                  <a:pt x="0" y="0"/>
                </a:moveTo>
                <a:lnTo>
                  <a:pt x="6400800" y="0"/>
                </a:lnTo>
                <a:lnTo>
                  <a:pt x="6400800" y="4115435"/>
                </a:lnTo>
                <a:lnTo>
                  <a:pt x="0" y="4115435"/>
                </a:lnTo>
                <a:close/>
              </a:path>
            </a:pathLst>
          </a:custGeom>
          <a:solidFill>
            <a:srgbClr val="FFFFFF"/>
          </a:solidFill>
          <a:ln w="13589" cap="rnd">
            <a:solidFill>
              <a:srgbClr val="FFFFFF"/>
            </a:solidFill>
            <a:prstDash val="solid"/>
            <a:round/>
          </a:ln>
        </p:spPr>
        <p:txBody>
          <a:bodyPr rtlCol="0" anchor="ctr"/>
          <a:lstStyle/>
          <a:p>
            <a:endParaRPr lang="fr-FR" dirty="0"/>
          </a:p>
        </p:txBody>
      </p:sp>
      <p:grpSp>
        <p:nvGrpSpPr>
          <p:cNvPr id="24" name="Graphique 19">
            <a:extLst>
              <a:ext uri="{FF2B5EF4-FFF2-40B4-BE49-F238E27FC236}">
                <a16:creationId xmlns:a16="http://schemas.microsoft.com/office/drawing/2014/main" id="{CD0E2437-8FEE-4C7F-A607-2DCD3CE1CC4E}"/>
              </a:ext>
            </a:extLst>
          </p:cNvPr>
          <p:cNvGrpSpPr/>
          <p:nvPr/>
        </p:nvGrpSpPr>
        <p:grpSpPr>
          <a:xfrm>
            <a:off x="511175" y="3867563"/>
            <a:ext cx="2750058" cy="2750058"/>
            <a:chOff x="511175" y="3867563"/>
            <a:chExt cx="2750058" cy="2750058"/>
          </a:xfrm>
        </p:grpSpPr>
        <p:sp>
          <p:nvSpPr>
            <p:cNvPr id="25" name="Forme libre 24">
              <a:extLst>
                <a:ext uri="{FF2B5EF4-FFF2-40B4-BE49-F238E27FC236}">
                  <a16:creationId xmlns:a16="http://schemas.microsoft.com/office/drawing/2014/main" id="{6922CF32-6BEA-4576-D89C-E7DDE23989EE}"/>
                </a:ext>
              </a:extLst>
            </p:cNvPr>
            <p:cNvSpPr/>
            <p:nvPr/>
          </p:nvSpPr>
          <p:spPr>
            <a:xfrm>
              <a:off x="511175" y="3867563"/>
              <a:ext cx="2750058" cy="2750058"/>
            </a:xfrm>
            <a:custGeom>
              <a:avLst/>
              <a:gdLst>
                <a:gd name="connsiteX0" fmla="*/ 0 w 2750058"/>
                <a:gd name="connsiteY0" fmla="*/ 0 h 2750058"/>
                <a:gd name="connsiteX1" fmla="*/ 2750058 w 2750058"/>
                <a:gd name="connsiteY1" fmla="*/ 0 h 2750058"/>
                <a:gd name="connsiteX2" fmla="*/ 2750058 w 2750058"/>
                <a:gd name="connsiteY2" fmla="*/ 2750058 h 2750058"/>
                <a:gd name="connsiteX3" fmla="*/ 0 w 2750058"/>
                <a:gd name="connsiteY3" fmla="*/ 2750058 h 27500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750058" h="2750058">
                  <a:moveTo>
                    <a:pt x="0" y="0"/>
                  </a:moveTo>
                  <a:lnTo>
                    <a:pt x="2750058" y="0"/>
                  </a:lnTo>
                  <a:lnTo>
                    <a:pt x="2750058" y="2750058"/>
                  </a:lnTo>
                  <a:lnTo>
                    <a:pt x="0" y="2750058"/>
                  </a:lnTo>
                  <a:close/>
                </a:path>
              </a:pathLst>
            </a:custGeom>
            <a:solidFill>
              <a:srgbClr val="FFFFFF"/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26" name="Forme libre 25">
              <a:extLst>
                <a:ext uri="{FF2B5EF4-FFF2-40B4-BE49-F238E27FC236}">
                  <a16:creationId xmlns:a16="http://schemas.microsoft.com/office/drawing/2014/main" id="{238C84FD-F055-19E2-4875-14D2A8516984}"/>
                </a:ext>
              </a:extLst>
            </p:cNvPr>
            <p:cNvSpPr/>
            <p:nvPr/>
          </p:nvSpPr>
          <p:spPr>
            <a:xfrm>
              <a:off x="636143" y="3992530"/>
              <a:ext cx="2499995" cy="998092"/>
            </a:xfrm>
            <a:custGeom>
              <a:avLst/>
              <a:gdLst>
                <a:gd name="connsiteX0" fmla="*/ 0 w 2499995"/>
                <a:gd name="connsiteY0" fmla="*/ 998093 h 998092"/>
                <a:gd name="connsiteX1" fmla="*/ 118999 w 2499995"/>
                <a:gd name="connsiteY1" fmla="*/ 998093 h 998092"/>
                <a:gd name="connsiteX2" fmla="*/ 121031 w 2499995"/>
                <a:gd name="connsiteY2" fmla="*/ 998093 h 998092"/>
                <a:gd name="connsiteX3" fmla="*/ 133223 w 2499995"/>
                <a:gd name="connsiteY3" fmla="*/ 998093 h 998092"/>
                <a:gd name="connsiteX4" fmla="*/ 159766 w 2499995"/>
                <a:gd name="connsiteY4" fmla="*/ 998093 h 998092"/>
                <a:gd name="connsiteX5" fmla="*/ 197866 w 2499995"/>
                <a:gd name="connsiteY5" fmla="*/ 998093 h 998092"/>
                <a:gd name="connsiteX6" fmla="*/ 240792 w 2499995"/>
                <a:gd name="connsiteY6" fmla="*/ 998093 h 998092"/>
                <a:gd name="connsiteX7" fmla="*/ 282829 w 2499995"/>
                <a:gd name="connsiteY7" fmla="*/ 998093 h 998092"/>
                <a:gd name="connsiteX8" fmla="*/ 321691 w 2499995"/>
                <a:gd name="connsiteY8" fmla="*/ 998093 h 998092"/>
                <a:gd name="connsiteX9" fmla="*/ 357378 w 2499995"/>
                <a:gd name="connsiteY9" fmla="*/ 998093 h 998092"/>
                <a:gd name="connsiteX10" fmla="*/ 391922 w 2499995"/>
                <a:gd name="connsiteY10" fmla="*/ 998093 h 998092"/>
                <a:gd name="connsiteX11" fmla="*/ 426974 w 2499995"/>
                <a:gd name="connsiteY11" fmla="*/ 998093 h 998092"/>
                <a:gd name="connsiteX12" fmla="*/ 431546 w 2499995"/>
                <a:gd name="connsiteY12" fmla="*/ 998093 h 998092"/>
                <a:gd name="connsiteX13" fmla="*/ 462915 w 2499995"/>
                <a:gd name="connsiteY13" fmla="*/ 998093 h 998092"/>
                <a:gd name="connsiteX14" fmla="*/ 496570 w 2499995"/>
                <a:gd name="connsiteY14" fmla="*/ 998093 h 998092"/>
                <a:gd name="connsiteX15" fmla="*/ 532638 w 2499995"/>
                <a:gd name="connsiteY15" fmla="*/ 998093 h 998092"/>
                <a:gd name="connsiteX16" fmla="*/ 571119 w 2499995"/>
                <a:gd name="connsiteY16" fmla="*/ 998093 h 998092"/>
                <a:gd name="connsiteX17" fmla="*/ 611378 w 2499995"/>
                <a:gd name="connsiteY17" fmla="*/ 998093 h 998092"/>
                <a:gd name="connsiteX18" fmla="*/ 652653 w 2499995"/>
                <a:gd name="connsiteY18" fmla="*/ 998093 h 998092"/>
                <a:gd name="connsiteX19" fmla="*/ 694055 w 2499995"/>
                <a:gd name="connsiteY19" fmla="*/ 998093 h 998092"/>
                <a:gd name="connsiteX20" fmla="*/ 734441 w 2499995"/>
                <a:gd name="connsiteY20" fmla="*/ 998093 h 998092"/>
                <a:gd name="connsiteX21" fmla="*/ 773049 w 2499995"/>
                <a:gd name="connsiteY21" fmla="*/ 998093 h 998092"/>
                <a:gd name="connsiteX22" fmla="*/ 809371 w 2499995"/>
                <a:gd name="connsiteY22" fmla="*/ 998093 h 998092"/>
                <a:gd name="connsiteX23" fmla="*/ 843280 w 2499995"/>
                <a:gd name="connsiteY23" fmla="*/ 998093 h 998092"/>
                <a:gd name="connsiteX24" fmla="*/ 874903 w 2499995"/>
                <a:gd name="connsiteY24" fmla="*/ 998093 h 998092"/>
                <a:gd name="connsiteX25" fmla="*/ 877951 w 2499995"/>
                <a:gd name="connsiteY25" fmla="*/ 998093 h 998092"/>
                <a:gd name="connsiteX26" fmla="*/ 913384 w 2499995"/>
                <a:gd name="connsiteY26" fmla="*/ 998093 h 998092"/>
                <a:gd name="connsiteX27" fmla="*/ 947801 w 2499995"/>
                <a:gd name="connsiteY27" fmla="*/ 998093 h 998092"/>
                <a:gd name="connsiteX28" fmla="*/ 983234 w 2499995"/>
                <a:gd name="connsiteY28" fmla="*/ 998093 h 998092"/>
                <a:gd name="connsiteX29" fmla="*/ 1021588 w 2499995"/>
                <a:gd name="connsiteY29" fmla="*/ 998093 h 998092"/>
                <a:gd name="connsiteX30" fmla="*/ 1063371 w 2499995"/>
                <a:gd name="connsiteY30" fmla="*/ 998093 h 998092"/>
                <a:gd name="connsiteX31" fmla="*/ 1106424 w 2499995"/>
                <a:gd name="connsiteY31" fmla="*/ 998093 h 998092"/>
                <a:gd name="connsiteX32" fmla="*/ 1145413 w 2499995"/>
                <a:gd name="connsiteY32" fmla="*/ 998093 h 998092"/>
                <a:gd name="connsiteX33" fmla="*/ 1173734 w 2499995"/>
                <a:gd name="connsiteY33" fmla="*/ 998093 h 998092"/>
                <a:gd name="connsiteX34" fmla="*/ 1187704 w 2499995"/>
                <a:gd name="connsiteY34" fmla="*/ 998093 h 998092"/>
                <a:gd name="connsiteX35" fmla="*/ 1190498 w 2499995"/>
                <a:gd name="connsiteY35" fmla="*/ 998093 h 998092"/>
                <a:gd name="connsiteX36" fmla="*/ 1190498 w 2499995"/>
                <a:gd name="connsiteY36" fmla="*/ 998093 h 998092"/>
                <a:gd name="connsiteX37" fmla="*/ 1309497 w 2499995"/>
                <a:gd name="connsiteY37" fmla="*/ 998093 h 998092"/>
                <a:gd name="connsiteX38" fmla="*/ 1311529 w 2499995"/>
                <a:gd name="connsiteY38" fmla="*/ 998093 h 998092"/>
                <a:gd name="connsiteX39" fmla="*/ 1323721 w 2499995"/>
                <a:gd name="connsiteY39" fmla="*/ 998093 h 998092"/>
                <a:gd name="connsiteX40" fmla="*/ 1350264 w 2499995"/>
                <a:gd name="connsiteY40" fmla="*/ 998093 h 998092"/>
                <a:gd name="connsiteX41" fmla="*/ 1388364 w 2499995"/>
                <a:gd name="connsiteY41" fmla="*/ 998093 h 998092"/>
                <a:gd name="connsiteX42" fmla="*/ 1431290 w 2499995"/>
                <a:gd name="connsiteY42" fmla="*/ 998093 h 998092"/>
                <a:gd name="connsiteX43" fmla="*/ 1473327 w 2499995"/>
                <a:gd name="connsiteY43" fmla="*/ 998093 h 998092"/>
                <a:gd name="connsiteX44" fmla="*/ 1512062 w 2499995"/>
                <a:gd name="connsiteY44" fmla="*/ 998093 h 998092"/>
                <a:gd name="connsiteX45" fmla="*/ 1547876 w 2499995"/>
                <a:gd name="connsiteY45" fmla="*/ 998093 h 998092"/>
                <a:gd name="connsiteX46" fmla="*/ 1582293 w 2499995"/>
                <a:gd name="connsiteY46" fmla="*/ 998093 h 998092"/>
                <a:gd name="connsiteX47" fmla="*/ 1617472 w 2499995"/>
                <a:gd name="connsiteY47" fmla="*/ 998093 h 998092"/>
                <a:gd name="connsiteX48" fmla="*/ 1622044 w 2499995"/>
                <a:gd name="connsiteY48" fmla="*/ 998093 h 998092"/>
                <a:gd name="connsiteX49" fmla="*/ 1653413 w 2499995"/>
                <a:gd name="connsiteY49" fmla="*/ 998093 h 998092"/>
                <a:gd name="connsiteX50" fmla="*/ 1687068 w 2499995"/>
                <a:gd name="connsiteY50" fmla="*/ 998093 h 998092"/>
                <a:gd name="connsiteX51" fmla="*/ 1723136 w 2499995"/>
                <a:gd name="connsiteY51" fmla="*/ 998093 h 998092"/>
                <a:gd name="connsiteX52" fmla="*/ 1761617 w 2499995"/>
                <a:gd name="connsiteY52" fmla="*/ 998093 h 998092"/>
                <a:gd name="connsiteX53" fmla="*/ 1801876 w 2499995"/>
                <a:gd name="connsiteY53" fmla="*/ 998093 h 998092"/>
                <a:gd name="connsiteX54" fmla="*/ 1843151 w 2499995"/>
                <a:gd name="connsiteY54" fmla="*/ 998093 h 998092"/>
                <a:gd name="connsiteX55" fmla="*/ 1884426 w 2499995"/>
                <a:gd name="connsiteY55" fmla="*/ 998093 h 998092"/>
                <a:gd name="connsiteX56" fmla="*/ 1924939 w 2499995"/>
                <a:gd name="connsiteY56" fmla="*/ 998093 h 998092"/>
                <a:gd name="connsiteX57" fmla="*/ 1963547 w 2499995"/>
                <a:gd name="connsiteY57" fmla="*/ 998093 h 998092"/>
                <a:gd name="connsiteX58" fmla="*/ 1999869 w 2499995"/>
                <a:gd name="connsiteY58" fmla="*/ 998093 h 998092"/>
                <a:gd name="connsiteX59" fmla="*/ 2033778 w 2499995"/>
                <a:gd name="connsiteY59" fmla="*/ 998093 h 998092"/>
                <a:gd name="connsiteX60" fmla="*/ 2065401 w 2499995"/>
                <a:gd name="connsiteY60" fmla="*/ 998093 h 998092"/>
                <a:gd name="connsiteX61" fmla="*/ 2068449 w 2499995"/>
                <a:gd name="connsiteY61" fmla="*/ 998093 h 998092"/>
                <a:gd name="connsiteX62" fmla="*/ 2103882 w 2499995"/>
                <a:gd name="connsiteY62" fmla="*/ 998093 h 998092"/>
                <a:gd name="connsiteX63" fmla="*/ 2138299 w 2499995"/>
                <a:gd name="connsiteY63" fmla="*/ 998093 h 998092"/>
                <a:gd name="connsiteX64" fmla="*/ 2173732 w 2499995"/>
                <a:gd name="connsiteY64" fmla="*/ 998093 h 998092"/>
                <a:gd name="connsiteX65" fmla="*/ 2212086 w 2499995"/>
                <a:gd name="connsiteY65" fmla="*/ 998093 h 998092"/>
                <a:gd name="connsiteX66" fmla="*/ 2253869 w 2499995"/>
                <a:gd name="connsiteY66" fmla="*/ 998093 h 998092"/>
                <a:gd name="connsiteX67" fmla="*/ 2296922 w 2499995"/>
                <a:gd name="connsiteY67" fmla="*/ 998093 h 998092"/>
                <a:gd name="connsiteX68" fmla="*/ 2335911 w 2499995"/>
                <a:gd name="connsiteY68" fmla="*/ 998093 h 998092"/>
                <a:gd name="connsiteX69" fmla="*/ 2364232 w 2499995"/>
                <a:gd name="connsiteY69" fmla="*/ 998093 h 998092"/>
                <a:gd name="connsiteX70" fmla="*/ 2378202 w 2499995"/>
                <a:gd name="connsiteY70" fmla="*/ 998093 h 998092"/>
                <a:gd name="connsiteX71" fmla="*/ 2380996 w 2499995"/>
                <a:gd name="connsiteY71" fmla="*/ 998093 h 998092"/>
                <a:gd name="connsiteX72" fmla="*/ 2380996 w 2499995"/>
                <a:gd name="connsiteY72" fmla="*/ 998093 h 998092"/>
                <a:gd name="connsiteX73" fmla="*/ 2499995 w 2499995"/>
                <a:gd name="connsiteY73" fmla="*/ 998093 h 998092"/>
                <a:gd name="connsiteX74" fmla="*/ 2499995 w 2499995"/>
                <a:gd name="connsiteY74" fmla="*/ 0 h 998092"/>
                <a:gd name="connsiteX75" fmla="*/ 2380996 w 2499995"/>
                <a:gd name="connsiteY75" fmla="*/ 0 h 998092"/>
                <a:gd name="connsiteX76" fmla="*/ 2378964 w 2499995"/>
                <a:gd name="connsiteY76" fmla="*/ 0 h 998092"/>
                <a:gd name="connsiteX77" fmla="*/ 2366772 w 2499995"/>
                <a:gd name="connsiteY77" fmla="*/ 0 h 998092"/>
                <a:gd name="connsiteX78" fmla="*/ 2340229 w 2499995"/>
                <a:gd name="connsiteY78" fmla="*/ 0 h 998092"/>
                <a:gd name="connsiteX79" fmla="*/ 2302129 w 2499995"/>
                <a:gd name="connsiteY79" fmla="*/ 0 h 998092"/>
                <a:gd name="connsiteX80" fmla="*/ 2259203 w 2499995"/>
                <a:gd name="connsiteY80" fmla="*/ 0 h 998092"/>
                <a:gd name="connsiteX81" fmla="*/ 2217166 w 2499995"/>
                <a:gd name="connsiteY81" fmla="*/ 0 h 998092"/>
                <a:gd name="connsiteX82" fmla="*/ 2178431 w 2499995"/>
                <a:gd name="connsiteY82" fmla="*/ 0 h 998092"/>
                <a:gd name="connsiteX83" fmla="*/ 2142617 w 2499995"/>
                <a:gd name="connsiteY83" fmla="*/ 0 h 998092"/>
                <a:gd name="connsiteX84" fmla="*/ 2108200 w 2499995"/>
                <a:gd name="connsiteY84" fmla="*/ 0 h 998092"/>
                <a:gd name="connsiteX85" fmla="*/ 2073021 w 2499995"/>
                <a:gd name="connsiteY85" fmla="*/ 0 h 998092"/>
                <a:gd name="connsiteX86" fmla="*/ 2068449 w 2499995"/>
                <a:gd name="connsiteY86" fmla="*/ 0 h 998092"/>
                <a:gd name="connsiteX87" fmla="*/ 2037080 w 2499995"/>
                <a:gd name="connsiteY87" fmla="*/ 0 h 998092"/>
                <a:gd name="connsiteX88" fmla="*/ 2003552 w 2499995"/>
                <a:gd name="connsiteY88" fmla="*/ 0 h 998092"/>
                <a:gd name="connsiteX89" fmla="*/ 1967357 w 2499995"/>
                <a:gd name="connsiteY89" fmla="*/ 0 h 998092"/>
                <a:gd name="connsiteX90" fmla="*/ 1929003 w 2499995"/>
                <a:gd name="connsiteY90" fmla="*/ 0 h 998092"/>
                <a:gd name="connsiteX91" fmla="*/ 1888744 w 2499995"/>
                <a:gd name="connsiteY91" fmla="*/ 0 h 998092"/>
                <a:gd name="connsiteX92" fmla="*/ 1847342 w 2499995"/>
                <a:gd name="connsiteY92" fmla="*/ 0 h 998092"/>
                <a:gd name="connsiteX93" fmla="*/ 1806067 w 2499995"/>
                <a:gd name="connsiteY93" fmla="*/ 0 h 998092"/>
                <a:gd name="connsiteX94" fmla="*/ 1765554 w 2499995"/>
                <a:gd name="connsiteY94" fmla="*/ 0 h 998092"/>
                <a:gd name="connsiteX95" fmla="*/ 1726946 w 2499995"/>
                <a:gd name="connsiteY95" fmla="*/ 0 h 998092"/>
                <a:gd name="connsiteX96" fmla="*/ 1690624 w 2499995"/>
                <a:gd name="connsiteY96" fmla="*/ 0 h 998092"/>
                <a:gd name="connsiteX97" fmla="*/ 1656715 w 2499995"/>
                <a:gd name="connsiteY97" fmla="*/ 0 h 998092"/>
                <a:gd name="connsiteX98" fmla="*/ 1625219 w 2499995"/>
                <a:gd name="connsiteY98" fmla="*/ 0 h 998092"/>
                <a:gd name="connsiteX99" fmla="*/ 1622044 w 2499995"/>
                <a:gd name="connsiteY99" fmla="*/ 0 h 998092"/>
                <a:gd name="connsiteX100" fmla="*/ 1586738 w 2499995"/>
                <a:gd name="connsiteY100" fmla="*/ 0 h 998092"/>
                <a:gd name="connsiteX101" fmla="*/ 1552321 w 2499995"/>
                <a:gd name="connsiteY101" fmla="*/ 0 h 998092"/>
                <a:gd name="connsiteX102" fmla="*/ 1516761 w 2499995"/>
                <a:gd name="connsiteY102" fmla="*/ 0 h 998092"/>
                <a:gd name="connsiteX103" fmla="*/ 1478407 w 2499995"/>
                <a:gd name="connsiteY103" fmla="*/ 0 h 998092"/>
                <a:gd name="connsiteX104" fmla="*/ 1436624 w 2499995"/>
                <a:gd name="connsiteY104" fmla="*/ 0 h 998092"/>
                <a:gd name="connsiteX105" fmla="*/ 1393571 w 2499995"/>
                <a:gd name="connsiteY105" fmla="*/ 0 h 998092"/>
                <a:gd name="connsiteX106" fmla="*/ 1354582 w 2499995"/>
                <a:gd name="connsiteY106" fmla="*/ 0 h 998092"/>
                <a:gd name="connsiteX107" fmla="*/ 1326261 w 2499995"/>
                <a:gd name="connsiteY107" fmla="*/ 0 h 998092"/>
                <a:gd name="connsiteX108" fmla="*/ 1312418 w 2499995"/>
                <a:gd name="connsiteY108" fmla="*/ 0 h 998092"/>
                <a:gd name="connsiteX109" fmla="*/ 1309497 w 2499995"/>
                <a:gd name="connsiteY109" fmla="*/ 0 h 998092"/>
                <a:gd name="connsiteX110" fmla="*/ 1309497 w 2499995"/>
                <a:gd name="connsiteY110" fmla="*/ 0 h 998092"/>
                <a:gd name="connsiteX111" fmla="*/ 1190498 w 2499995"/>
                <a:gd name="connsiteY111" fmla="*/ 0 h 998092"/>
                <a:gd name="connsiteX112" fmla="*/ 1188466 w 2499995"/>
                <a:gd name="connsiteY112" fmla="*/ 0 h 998092"/>
                <a:gd name="connsiteX113" fmla="*/ 1176274 w 2499995"/>
                <a:gd name="connsiteY113" fmla="*/ 0 h 998092"/>
                <a:gd name="connsiteX114" fmla="*/ 1149731 w 2499995"/>
                <a:gd name="connsiteY114" fmla="*/ 0 h 998092"/>
                <a:gd name="connsiteX115" fmla="*/ 1111631 w 2499995"/>
                <a:gd name="connsiteY115" fmla="*/ 0 h 998092"/>
                <a:gd name="connsiteX116" fmla="*/ 1068832 w 2499995"/>
                <a:gd name="connsiteY116" fmla="*/ 0 h 998092"/>
                <a:gd name="connsiteX117" fmla="*/ 1026668 w 2499995"/>
                <a:gd name="connsiteY117" fmla="*/ 0 h 998092"/>
                <a:gd name="connsiteX118" fmla="*/ 987933 w 2499995"/>
                <a:gd name="connsiteY118" fmla="*/ 0 h 998092"/>
                <a:gd name="connsiteX119" fmla="*/ 952119 w 2499995"/>
                <a:gd name="connsiteY119" fmla="*/ 0 h 998092"/>
                <a:gd name="connsiteX120" fmla="*/ 917702 w 2499995"/>
                <a:gd name="connsiteY120" fmla="*/ 0 h 998092"/>
                <a:gd name="connsiteX121" fmla="*/ 882523 w 2499995"/>
                <a:gd name="connsiteY121" fmla="*/ 0 h 998092"/>
                <a:gd name="connsiteX122" fmla="*/ 877951 w 2499995"/>
                <a:gd name="connsiteY122" fmla="*/ 0 h 998092"/>
                <a:gd name="connsiteX123" fmla="*/ 846582 w 2499995"/>
                <a:gd name="connsiteY123" fmla="*/ 0 h 998092"/>
                <a:gd name="connsiteX124" fmla="*/ 813054 w 2499995"/>
                <a:gd name="connsiteY124" fmla="*/ 0 h 998092"/>
                <a:gd name="connsiteX125" fmla="*/ 776859 w 2499995"/>
                <a:gd name="connsiteY125" fmla="*/ 0 h 998092"/>
                <a:gd name="connsiteX126" fmla="*/ 738505 w 2499995"/>
                <a:gd name="connsiteY126" fmla="*/ 0 h 998092"/>
                <a:gd name="connsiteX127" fmla="*/ 698246 w 2499995"/>
                <a:gd name="connsiteY127" fmla="*/ 0 h 998092"/>
                <a:gd name="connsiteX128" fmla="*/ 656844 w 2499995"/>
                <a:gd name="connsiteY128" fmla="*/ 0 h 998092"/>
                <a:gd name="connsiteX129" fmla="*/ 615569 w 2499995"/>
                <a:gd name="connsiteY129" fmla="*/ 0 h 998092"/>
                <a:gd name="connsiteX130" fmla="*/ 575183 w 2499995"/>
                <a:gd name="connsiteY130" fmla="*/ 0 h 998092"/>
                <a:gd name="connsiteX131" fmla="*/ 536448 w 2499995"/>
                <a:gd name="connsiteY131" fmla="*/ 0 h 998092"/>
                <a:gd name="connsiteX132" fmla="*/ 500126 w 2499995"/>
                <a:gd name="connsiteY132" fmla="*/ 0 h 998092"/>
                <a:gd name="connsiteX133" fmla="*/ 466217 w 2499995"/>
                <a:gd name="connsiteY133" fmla="*/ 0 h 998092"/>
                <a:gd name="connsiteX134" fmla="*/ 434721 w 2499995"/>
                <a:gd name="connsiteY134" fmla="*/ 0 h 998092"/>
                <a:gd name="connsiteX135" fmla="*/ 431546 w 2499995"/>
                <a:gd name="connsiteY135" fmla="*/ 0 h 998092"/>
                <a:gd name="connsiteX136" fmla="*/ 396240 w 2499995"/>
                <a:gd name="connsiteY136" fmla="*/ 0 h 998092"/>
                <a:gd name="connsiteX137" fmla="*/ 361823 w 2499995"/>
                <a:gd name="connsiteY137" fmla="*/ 0 h 998092"/>
                <a:gd name="connsiteX138" fmla="*/ 326263 w 2499995"/>
                <a:gd name="connsiteY138" fmla="*/ 0 h 998092"/>
                <a:gd name="connsiteX139" fmla="*/ 287909 w 2499995"/>
                <a:gd name="connsiteY139" fmla="*/ 0 h 998092"/>
                <a:gd name="connsiteX140" fmla="*/ 246253 w 2499995"/>
                <a:gd name="connsiteY140" fmla="*/ 0 h 998092"/>
                <a:gd name="connsiteX141" fmla="*/ 203200 w 2499995"/>
                <a:gd name="connsiteY141" fmla="*/ 0 h 998092"/>
                <a:gd name="connsiteX142" fmla="*/ 164084 w 2499995"/>
                <a:gd name="connsiteY142" fmla="*/ 0 h 998092"/>
                <a:gd name="connsiteX143" fmla="*/ 135763 w 2499995"/>
                <a:gd name="connsiteY143" fmla="*/ 0 h 998092"/>
                <a:gd name="connsiteX144" fmla="*/ 121920 w 2499995"/>
                <a:gd name="connsiteY144" fmla="*/ 0 h 998092"/>
                <a:gd name="connsiteX145" fmla="*/ 119126 w 2499995"/>
                <a:gd name="connsiteY145" fmla="*/ 0 h 998092"/>
                <a:gd name="connsiteX146" fmla="*/ 118999 w 2499995"/>
                <a:gd name="connsiteY146" fmla="*/ 0 h 998092"/>
                <a:gd name="connsiteX147" fmla="*/ 0 w 2499995"/>
                <a:gd name="connsiteY147" fmla="*/ 0 h 9980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998092">
                  <a:moveTo>
                    <a:pt x="0" y="998093"/>
                  </a:moveTo>
                  <a:lnTo>
                    <a:pt x="118999" y="998093"/>
                  </a:lnTo>
                  <a:lnTo>
                    <a:pt x="121031" y="998093"/>
                  </a:lnTo>
                  <a:lnTo>
                    <a:pt x="133223" y="998093"/>
                  </a:lnTo>
                  <a:lnTo>
                    <a:pt x="159766" y="998093"/>
                  </a:lnTo>
                  <a:lnTo>
                    <a:pt x="197866" y="998093"/>
                  </a:lnTo>
                  <a:lnTo>
                    <a:pt x="240792" y="998093"/>
                  </a:lnTo>
                  <a:lnTo>
                    <a:pt x="282829" y="998093"/>
                  </a:lnTo>
                  <a:lnTo>
                    <a:pt x="321691" y="998093"/>
                  </a:lnTo>
                  <a:lnTo>
                    <a:pt x="357378" y="998093"/>
                  </a:lnTo>
                  <a:lnTo>
                    <a:pt x="391922" y="998093"/>
                  </a:lnTo>
                  <a:lnTo>
                    <a:pt x="426974" y="998093"/>
                  </a:lnTo>
                  <a:lnTo>
                    <a:pt x="431546" y="998093"/>
                  </a:lnTo>
                  <a:lnTo>
                    <a:pt x="462915" y="998093"/>
                  </a:lnTo>
                  <a:lnTo>
                    <a:pt x="496570" y="998093"/>
                  </a:lnTo>
                  <a:lnTo>
                    <a:pt x="532638" y="998093"/>
                  </a:lnTo>
                  <a:lnTo>
                    <a:pt x="571119" y="998093"/>
                  </a:lnTo>
                  <a:lnTo>
                    <a:pt x="611378" y="998093"/>
                  </a:lnTo>
                  <a:lnTo>
                    <a:pt x="652653" y="998093"/>
                  </a:lnTo>
                  <a:lnTo>
                    <a:pt x="694055" y="998093"/>
                  </a:lnTo>
                  <a:lnTo>
                    <a:pt x="734441" y="998093"/>
                  </a:lnTo>
                  <a:lnTo>
                    <a:pt x="773049" y="998093"/>
                  </a:lnTo>
                  <a:lnTo>
                    <a:pt x="809371" y="998093"/>
                  </a:lnTo>
                  <a:lnTo>
                    <a:pt x="843280" y="998093"/>
                  </a:lnTo>
                  <a:lnTo>
                    <a:pt x="874903" y="998093"/>
                  </a:lnTo>
                  <a:lnTo>
                    <a:pt x="877951" y="998093"/>
                  </a:lnTo>
                  <a:lnTo>
                    <a:pt x="913384" y="998093"/>
                  </a:lnTo>
                  <a:lnTo>
                    <a:pt x="947801" y="998093"/>
                  </a:lnTo>
                  <a:lnTo>
                    <a:pt x="983234" y="998093"/>
                  </a:lnTo>
                  <a:lnTo>
                    <a:pt x="1021588" y="998093"/>
                  </a:lnTo>
                  <a:lnTo>
                    <a:pt x="1063371" y="998093"/>
                  </a:lnTo>
                  <a:lnTo>
                    <a:pt x="1106424" y="998093"/>
                  </a:lnTo>
                  <a:lnTo>
                    <a:pt x="1145413" y="998093"/>
                  </a:lnTo>
                  <a:lnTo>
                    <a:pt x="1173734" y="998093"/>
                  </a:lnTo>
                  <a:lnTo>
                    <a:pt x="1187704" y="998093"/>
                  </a:lnTo>
                  <a:lnTo>
                    <a:pt x="1190498" y="998093"/>
                  </a:lnTo>
                  <a:lnTo>
                    <a:pt x="1190498" y="998093"/>
                  </a:lnTo>
                  <a:lnTo>
                    <a:pt x="1309497" y="998093"/>
                  </a:lnTo>
                  <a:lnTo>
                    <a:pt x="1311529" y="998093"/>
                  </a:lnTo>
                  <a:lnTo>
                    <a:pt x="1323721" y="998093"/>
                  </a:lnTo>
                  <a:lnTo>
                    <a:pt x="1350264" y="998093"/>
                  </a:lnTo>
                  <a:lnTo>
                    <a:pt x="1388364" y="998093"/>
                  </a:lnTo>
                  <a:lnTo>
                    <a:pt x="1431290" y="998093"/>
                  </a:lnTo>
                  <a:lnTo>
                    <a:pt x="1473327" y="998093"/>
                  </a:lnTo>
                  <a:lnTo>
                    <a:pt x="1512062" y="998093"/>
                  </a:lnTo>
                  <a:lnTo>
                    <a:pt x="1547876" y="998093"/>
                  </a:lnTo>
                  <a:lnTo>
                    <a:pt x="1582293" y="998093"/>
                  </a:lnTo>
                  <a:lnTo>
                    <a:pt x="1617472" y="998093"/>
                  </a:lnTo>
                  <a:lnTo>
                    <a:pt x="1622044" y="998093"/>
                  </a:lnTo>
                  <a:lnTo>
                    <a:pt x="1653413" y="998093"/>
                  </a:lnTo>
                  <a:lnTo>
                    <a:pt x="1687068" y="998093"/>
                  </a:lnTo>
                  <a:lnTo>
                    <a:pt x="1723136" y="998093"/>
                  </a:lnTo>
                  <a:lnTo>
                    <a:pt x="1761617" y="998093"/>
                  </a:lnTo>
                  <a:lnTo>
                    <a:pt x="1801876" y="998093"/>
                  </a:lnTo>
                  <a:lnTo>
                    <a:pt x="1843151" y="998093"/>
                  </a:lnTo>
                  <a:lnTo>
                    <a:pt x="1884426" y="998093"/>
                  </a:lnTo>
                  <a:lnTo>
                    <a:pt x="1924939" y="998093"/>
                  </a:lnTo>
                  <a:lnTo>
                    <a:pt x="1963547" y="998093"/>
                  </a:lnTo>
                  <a:lnTo>
                    <a:pt x="1999869" y="998093"/>
                  </a:lnTo>
                  <a:lnTo>
                    <a:pt x="2033778" y="998093"/>
                  </a:lnTo>
                  <a:lnTo>
                    <a:pt x="2065401" y="998093"/>
                  </a:lnTo>
                  <a:lnTo>
                    <a:pt x="2068449" y="998093"/>
                  </a:lnTo>
                  <a:lnTo>
                    <a:pt x="2103882" y="998093"/>
                  </a:lnTo>
                  <a:lnTo>
                    <a:pt x="2138299" y="998093"/>
                  </a:lnTo>
                  <a:lnTo>
                    <a:pt x="2173732" y="998093"/>
                  </a:lnTo>
                  <a:lnTo>
                    <a:pt x="2212086" y="998093"/>
                  </a:lnTo>
                  <a:lnTo>
                    <a:pt x="2253869" y="998093"/>
                  </a:lnTo>
                  <a:lnTo>
                    <a:pt x="2296922" y="998093"/>
                  </a:lnTo>
                  <a:lnTo>
                    <a:pt x="2335911" y="998093"/>
                  </a:lnTo>
                  <a:lnTo>
                    <a:pt x="2364232" y="998093"/>
                  </a:lnTo>
                  <a:lnTo>
                    <a:pt x="2378202" y="998093"/>
                  </a:lnTo>
                  <a:lnTo>
                    <a:pt x="2380996" y="998093"/>
                  </a:lnTo>
                  <a:lnTo>
                    <a:pt x="2380996" y="998093"/>
                  </a:lnTo>
                  <a:lnTo>
                    <a:pt x="2499995" y="998093"/>
                  </a:lnTo>
                  <a:lnTo>
                    <a:pt x="2499995" y="0"/>
                  </a:lnTo>
                  <a:lnTo>
                    <a:pt x="2380996" y="0"/>
                  </a:lnTo>
                  <a:lnTo>
                    <a:pt x="2378964" y="0"/>
                  </a:lnTo>
                  <a:lnTo>
                    <a:pt x="2366772" y="0"/>
                  </a:lnTo>
                  <a:lnTo>
                    <a:pt x="2340229" y="0"/>
                  </a:lnTo>
                  <a:lnTo>
                    <a:pt x="2302129" y="0"/>
                  </a:lnTo>
                  <a:lnTo>
                    <a:pt x="2259203" y="0"/>
                  </a:lnTo>
                  <a:lnTo>
                    <a:pt x="2217166" y="0"/>
                  </a:lnTo>
                  <a:lnTo>
                    <a:pt x="2178431" y="0"/>
                  </a:lnTo>
                  <a:lnTo>
                    <a:pt x="2142617" y="0"/>
                  </a:lnTo>
                  <a:lnTo>
                    <a:pt x="2108200" y="0"/>
                  </a:lnTo>
                  <a:lnTo>
                    <a:pt x="2073021" y="0"/>
                  </a:lnTo>
                  <a:lnTo>
                    <a:pt x="2068449" y="0"/>
                  </a:lnTo>
                  <a:lnTo>
                    <a:pt x="2037080" y="0"/>
                  </a:lnTo>
                  <a:lnTo>
                    <a:pt x="2003552" y="0"/>
                  </a:lnTo>
                  <a:lnTo>
                    <a:pt x="1967357" y="0"/>
                  </a:lnTo>
                  <a:lnTo>
                    <a:pt x="1929003" y="0"/>
                  </a:lnTo>
                  <a:lnTo>
                    <a:pt x="1888744" y="0"/>
                  </a:lnTo>
                  <a:lnTo>
                    <a:pt x="1847342" y="0"/>
                  </a:lnTo>
                  <a:lnTo>
                    <a:pt x="1806067" y="0"/>
                  </a:lnTo>
                  <a:lnTo>
                    <a:pt x="1765554" y="0"/>
                  </a:lnTo>
                  <a:lnTo>
                    <a:pt x="1726946" y="0"/>
                  </a:lnTo>
                  <a:lnTo>
                    <a:pt x="1690624" y="0"/>
                  </a:lnTo>
                  <a:lnTo>
                    <a:pt x="1656715" y="0"/>
                  </a:lnTo>
                  <a:lnTo>
                    <a:pt x="1625219" y="0"/>
                  </a:lnTo>
                  <a:lnTo>
                    <a:pt x="1622044" y="0"/>
                  </a:lnTo>
                  <a:lnTo>
                    <a:pt x="1586738" y="0"/>
                  </a:lnTo>
                  <a:lnTo>
                    <a:pt x="1552321" y="0"/>
                  </a:lnTo>
                  <a:lnTo>
                    <a:pt x="1516761" y="0"/>
                  </a:lnTo>
                  <a:lnTo>
                    <a:pt x="1478407" y="0"/>
                  </a:lnTo>
                  <a:lnTo>
                    <a:pt x="1436624" y="0"/>
                  </a:lnTo>
                  <a:lnTo>
                    <a:pt x="1393571" y="0"/>
                  </a:lnTo>
                  <a:lnTo>
                    <a:pt x="1354582" y="0"/>
                  </a:lnTo>
                  <a:lnTo>
                    <a:pt x="1326261" y="0"/>
                  </a:lnTo>
                  <a:lnTo>
                    <a:pt x="1312418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832" y="0"/>
                  </a:lnTo>
                  <a:lnTo>
                    <a:pt x="1026668" y="0"/>
                  </a:lnTo>
                  <a:lnTo>
                    <a:pt x="987933" y="0"/>
                  </a:lnTo>
                  <a:lnTo>
                    <a:pt x="952119" y="0"/>
                  </a:lnTo>
                  <a:lnTo>
                    <a:pt x="917702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3054" y="0"/>
                  </a:lnTo>
                  <a:lnTo>
                    <a:pt x="776859" y="0"/>
                  </a:lnTo>
                  <a:lnTo>
                    <a:pt x="738505" y="0"/>
                  </a:lnTo>
                  <a:lnTo>
                    <a:pt x="698246" y="0"/>
                  </a:lnTo>
                  <a:lnTo>
                    <a:pt x="656844" y="0"/>
                  </a:lnTo>
                  <a:lnTo>
                    <a:pt x="615569" y="0"/>
                  </a:lnTo>
                  <a:lnTo>
                    <a:pt x="575183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721" y="0"/>
                  </a:lnTo>
                  <a:lnTo>
                    <a:pt x="431546" y="0"/>
                  </a:lnTo>
                  <a:lnTo>
                    <a:pt x="396240" y="0"/>
                  </a:lnTo>
                  <a:lnTo>
                    <a:pt x="361823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253" y="0"/>
                  </a:lnTo>
                  <a:lnTo>
                    <a:pt x="203200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920" y="0"/>
                  </a:lnTo>
                  <a:lnTo>
                    <a:pt x="119126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1A9641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27" name="Forme libre 26">
              <a:extLst>
                <a:ext uri="{FF2B5EF4-FFF2-40B4-BE49-F238E27FC236}">
                  <a16:creationId xmlns:a16="http://schemas.microsoft.com/office/drawing/2014/main" id="{76424404-CBA4-893B-911B-AD29B63326B9}"/>
                </a:ext>
              </a:extLst>
            </p:cNvPr>
            <p:cNvSpPr/>
            <p:nvPr/>
          </p:nvSpPr>
          <p:spPr>
            <a:xfrm>
              <a:off x="636143" y="4990623"/>
              <a:ext cx="2499995" cy="1056259"/>
            </a:xfrm>
            <a:custGeom>
              <a:avLst/>
              <a:gdLst>
                <a:gd name="connsiteX0" fmla="*/ 0 w 2499995"/>
                <a:gd name="connsiteY0" fmla="*/ 755777 h 1056259"/>
                <a:gd name="connsiteX1" fmla="*/ 118999 w 2499995"/>
                <a:gd name="connsiteY1" fmla="*/ 755777 h 1056259"/>
                <a:gd name="connsiteX2" fmla="*/ 121031 w 2499995"/>
                <a:gd name="connsiteY2" fmla="*/ 755777 h 1056259"/>
                <a:gd name="connsiteX3" fmla="*/ 133223 w 2499995"/>
                <a:gd name="connsiteY3" fmla="*/ 755777 h 1056259"/>
                <a:gd name="connsiteX4" fmla="*/ 159766 w 2499995"/>
                <a:gd name="connsiteY4" fmla="*/ 755777 h 1056259"/>
                <a:gd name="connsiteX5" fmla="*/ 197866 w 2499995"/>
                <a:gd name="connsiteY5" fmla="*/ 755777 h 1056259"/>
                <a:gd name="connsiteX6" fmla="*/ 240792 w 2499995"/>
                <a:gd name="connsiteY6" fmla="*/ 755777 h 1056259"/>
                <a:gd name="connsiteX7" fmla="*/ 282829 w 2499995"/>
                <a:gd name="connsiteY7" fmla="*/ 755777 h 1056259"/>
                <a:gd name="connsiteX8" fmla="*/ 321691 w 2499995"/>
                <a:gd name="connsiteY8" fmla="*/ 755777 h 1056259"/>
                <a:gd name="connsiteX9" fmla="*/ 357378 w 2499995"/>
                <a:gd name="connsiteY9" fmla="*/ 755777 h 1056259"/>
                <a:gd name="connsiteX10" fmla="*/ 391922 w 2499995"/>
                <a:gd name="connsiteY10" fmla="*/ 755777 h 1056259"/>
                <a:gd name="connsiteX11" fmla="*/ 426974 w 2499995"/>
                <a:gd name="connsiteY11" fmla="*/ 755777 h 1056259"/>
                <a:gd name="connsiteX12" fmla="*/ 431546 w 2499995"/>
                <a:gd name="connsiteY12" fmla="*/ 755777 h 1056259"/>
                <a:gd name="connsiteX13" fmla="*/ 462915 w 2499995"/>
                <a:gd name="connsiteY13" fmla="*/ 755777 h 1056259"/>
                <a:gd name="connsiteX14" fmla="*/ 496570 w 2499995"/>
                <a:gd name="connsiteY14" fmla="*/ 755777 h 1056259"/>
                <a:gd name="connsiteX15" fmla="*/ 532638 w 2499995"/>
                <a:gd name="connsiteY15" fmla="*/ 755777 h 1056259"/>
                <a:gd name="connsiteX16" fmla="*/ 571119 w 2499995"/>
                <a:gd name="connsiteY16" fmla="*/ 755777 h 1056259"/>
                <a:gd name="connsiteX17" fmla="*/ 611378 w 2499995"/>
                <a:gd name="connsiteY17" fmla="*/ 755777 h 1056259"/>
                <a:gd name="connsiteX18" fmla="*/ 652653 w 2499995"/>
                <a:gd name="connsiteY18" fmla="*/ 755777 h 1056259"/>
                <a:gd name="connsiteX19" fmla="*/ 694055 w 2499995"/>
                <a:gd name="connsiteY19" fmla="*/ 755777 h 1056259"/>
                <a:gd name="connsiteX20" fmla="*/ 734441 w 2499995"/>
                <a:gd name="connsiteY20" fmla="*/ 755777 h 1056259"/>
                <a:gd name="connsiteX21" fmla="*/ 773049 w 2499995"/>
                <a:gd name="connsiteY21" fmla="*/ 755777 h 1056259"/>
                <a:gd name="connsiteX22" fmla="*/ 809371 w 2499995"/>
                <a:gd name="connsiteY22" fmla="*/ 755777 h 1056259"/>
                <a:gd name="connsiteX23" fmla="*/ 843280 w 2499995"/>
                <a:gd name="connsiteY23" fmla="*/ 755777 h 1056259"/>
                <a:gd name="connsiteX24" fmla="*/ 874903 w 2499995"/>
                <a:gd name="connsiteY24" fmla="*/ 755777 h 1056259"/>
                <a:gd name="connsiteX25" fmla="*/ 877951 w 2499995"/>
                <a:gd name="connsiteY25" fmla="*/ 755777 h 1056259"/>
                <a:gd name="connsiteX26" fmla="*/ 913384 w 2499995"/>
                <a:gd name="connsiteY26" fmla="*/ 755777 h 1056259"/>
                <a:gd name="connsiteX27" fmla="*/ 947801 w 2499995"/>
                <a:gd name="connsiteY27" fmla="*/ 755777 h 1056259"/>
                <a:gd name="connsiteX28" fmla="*/ 983234 w 2499995"/>
                <a:gd name="connsiteY28" fmla="*/ 755777 h 1056259"/>
                <a:gd name="connsiteX29" fmla="*/ 1021588 w 2499995"/>
                <a:gd name="connsiteY29" fmla="*/ 755777 h 1056259"/>
                <a:gd name="connsiteX30" fmla="*/ 1063371 w 2499995"/>
                <a:gd name="connsiteY30" fmla="*/ 755777 h 1056259"/>
                <a:gd name="connsiteX31" fmla="*/ 1106424 w 2499995"/>
                <a:gd name="connsiteY31" fmla="*/ 755777 h 1056259"/>
                <a:gd name="connsiteX32" fmla="*/ 1145413 w 2499995"/>
                <a:gd name="connsiteY32" fmla="*/ 755777 h 1056259"/>
                <a:gd name="connsiteX33" fmla="*/ 1173734 w 2499995"/>
                <a:gd name="connsiteY33" fmla="*/ 755777 h 1056259"/>
                <a:gd name="connsiteX34" fmla="*/ 1187704 w 2499995"/>
                <a:gd name="connsiteY34" fmla="*/ 755777 h 1056259"/>
                <a:gd name="connsiteX35" fmla="*/ 1190498 w 2499995"/>
                <a:gd name="connsiteY35" fmla="*/ 755777 h 1056259"/>
                <a:gd name="connsiteX36" fmla="*/ 1190498 w 2499995"/>
                <a:gd name="connsiteY36" fmla="*/ 755777 h 1056259"/>
                <a:gd name="connsiteX37" fmla="*/ 1309497 w 2499995"/>
                <a:gd name="connsiteY37" fmla="*/ 755777 h 1056259"/>
                <a:gd name="connsiteX38" fmla="*/ 1311529 w 2499995"/>
                <a:gd name="connsiteY38" fmla="*/ 755904 h 1056259"/>
                <a:gd name="connsiteX39" fmla="*/ 1323467 w 2499995"/>
                <a:gd name="connsiteY39" fmla="*/ 756412 h 1056259"/>
                <a:gd name="connsiteX40" fmla="*/ 1349629 w 2499995"/>
                <a:gd name="connsiteY40" fmla="*/ 757809 h 1056259"/>
                <a:gd name="connsiteX41" fmla="*/ 1387348 w 2499995"/>
                <a:gd name="connsiteY41" fmla="*/ 760349 h 1056259"/>
                <a:gd name="connsiteX42" fmla="*/ 1429893 w 2499995"/>
                <a:gd name="connsiteY42" fmla="*/ 764032 h 1056259"/>
                <a:gd name="connsiteX43" fmla="*/ 1471803 w 2499995"/>
                <a:gd name="connsiteY43" fmla="*/ 768858 h 1056259"/>
                <a:gd name="connsiteX44" fmla="*/ 1510538 w 2499995"/>
                <a:gd name="connsiteY44" fmla="*/ 774827 h 1056259"/>
                <a:gd name="connsiteX45" fmla="*/ 1546098 w 2499995"/>
                <a:gd name="connsiteY45" fmla="*/ 782320 h 1056259"/>
                <a:gd name="connsiteX46" fmla="*/ 1580388 w 2499995"/>
                <a:gd name="connsiteY46" fmla="*/ 791591 h 1056259"/>
                <a:gd name="connsiteX47" fmla="*/ 1615186 w 2499995"/>
                <a:gd name="connsiteY47" fmla="*/ 803402 h 1056259"/>
                <a:gd name="connsiteX48" fmla="*/ 1622044 w 2499995"/>
                <a:gd name="connsiteY48" fmla="*/ 805815 h 1056259"/>
                <a:gd name="connsiteX49" fmla="*/ 1652016 w 2499995"/>
                <a:gd name="connsiteY49" fmla="*/ 817626 h 1056259"/>
                <a:gd name="connsiteX50" fmla="*/ 1683893 w 2499995"/>
                <a:gd name="connsiteY50" fmla="*/ 831088 h 1056259"/>
                <a:gd name="connsiteX51" fmla="*/ 1718183 w 2499995"/>
                <a:gd name="connsiteY51" fmla="*/ 846201 h 1056259"/>
                <a:gd name="connsiteX52" fmla="*/ 1754505 w 2499995"/>
                <a:gd name="connsiteY52" fmla="*/ 862965 h 1056259"/>
                <a:gd name="connsiteX53" fmla="*/ 1792732 w 2499995"/>
                <a:gd name="connsiteY53" fmla="*/ 880999 h 1056259"/>
                <a:gd name="connsiteX54" fmla="*/ 1831975 w 2499995"/>
                <a:gd name="connsiteY54" fmla="*/ 899668 h 1056259"/>
                <a:gd name="connsiteX55" fmla="*/ 1871599 w 2499995"/>
                <a:gd name="connsiteY55" fmla="*/ 918591 h 1056259"/>
                <a:gd name="connsiteX56" fmla="*/ 1910588 w 2499995"/>
                <a:gd name="connsiteY56" fmla="*/ 937133 h 1056259"/>
                <a:gd name="connsiteX57" fmla="*/ 1948180 w 2499995"/>
                <a:gd name="connsiteY57" fmla="*/ 954659 h 1056259"/>
                <a:gd name="connsiteX58" fmla="*/ 1983994 w 2499995"/>
                <a:gd name="connsiteY58" fmla="*/ 970915 h 1056259"/>
                <a:gd name="connsiteX59" fmla="*/ 2017395 w 2499995"/>
                <a:gd name="connsiteY59" fmla="*/ 985647 h 1056259"/>
                <a:gd name="connsiteX60" fmla="*/ 2048637 w 2499995"/>
                <a:gd name="connsiteY60" fmla="*/ 998474 h 1056259"/>
                <a:gd name="connsiteX61" fmla="*/ 2068449 w 2499995"/>
                <a:gd name="connsiteY61" fmla="*/ 1006094 h 1056259"/>
                <a:gd name="connsiteX62" fmla="*/ 2103628 w 2499995"/>
                <a:gd name="connsiteY62" fmla="*/ 1018286 h 1056259"/>
                <a:gd name="connsiteX63" fmla="*/ 2137791 w 2499995"/>
                <a:gd name="connsiteY63" fmla="*/ 1028065 h 1056259"/>
                <a:gd name="connsiteX64" fmla="*/ 2173097 w 2499995"/>
                <a:gd name="connsiteY64" fmla="*/ 1035939 h 1056259"/>
                <a:gd name="connsiteX65" fmla="*/ 2211070 w 2499995"/>
                <a:gd name="connsiteY65" fmla="*/ 1042162 h 1056259"/>
                <a:gd name="connsiteX66" fmla="*/ 2252472 w 2499995"/>
                <a:gd name="connsiteY66" fmla="*/ 1047115 h 1056259"/>
                <a:gd name="connsiteX67" fmla="*/ 2295271 w 2499995"/>
                <a:gd name="connsiteY67" fmla="*/ 1051052 h 1056259"/>
                <a:gd name="connsiteX68" fmla="*/ 2334387 w 2499995"/>
                <a:gd name="connsiteY68" fmla="*/ 1053846 h 1056259"/>
                <a:gd name="connsiteX69" fmla="*/ 2363089 w 2499995"/>
                <a:gd name="connsiteY69" fmla="*/ 1055370 h 1056259"/>
                <a:gd name="connsiteX70" fmla="*/ 2377694 w 2499995"/>
                <a:gd name="connsiteY70" fmla="*/ 1056132 h 1056259"/>
                <a:gd name="connsiteX71" fmla="*/ 2380996 w 2499995"/>
                <a:gd name="connsiteY71" fmla="*/ 1056259 h 1056259"/>
                <a:gd name="connsiteX72" fmla="*/ 2380996 w 2499995"/>
                <a:gd name="connsiteY72" fmla="*/ 1056259 h 1056259"/>
                <a:gd name="connsiteX73" fmla="*/ 2499995 w 2499995"/>
                <a:gd name="connsiteY73" fmla="*/ 1056259 h 1056259"/>
                <a:gd name="connsiteX74" fmla="*/ 2499995 w 2499995"/>
                <a:gd name="connsiteY74" fmla="*/ 300355 h 1056259"/>
                <a:gd name="connsiteX75" fmla="*/ 2380996 w 2499995"/>
                <a:gd name="connsiteY75" fmla="*/ 300355 h 1056259"/>
                <a:gd name="connsiteX76" fmla="*/ 2378964 w 2499995"/>
                <a:gd name="connsiteY76" fmla="*/ 300355 h 1056259"/>
                <a:gd name="connsiteX77" fmla="*/ 2367026 w 2499995"/>
                <a:gd name="connsiteY77" fmla="*/ 299720 h 1056259"/>
                <a:gd name="connsiteX78" fmla="*/ 2340864 w 2499995"/>
                <a:gd name="connsiteY78" fmla="*/ 298323 h 1056259"/>
                <a:gd name="connsiteX79" fmla="*/ 2303145 w 2499995"/>
                <a:gd name="connsiteY79" fmla="*/ 295783 h 1056259"/>
                <a:gd name="connsiteX80" fmla="*/ 2260600 w 2499995"/>
                <a:gd name="connsiteY80" fmla="*/ 292227 h 1056259"/>
                <a:gd name="connsiteX81" fmla="*/ 2218690 w 2499995"/>
                <a:gd name="connsiteY81" fmla="*/ 287401 h 1056259"/>
                <a:gd name="connsiteX82" fmla="*/ 2180082 w 2499995"/>
                <a:gd name="connsiteY82" fmla="*/ 281305 h 1056259"/>
                <a:gd name="connsiteX83" fmla="*/ 2144395 w 2499995"/>
                <a:gd name="connsiteY83" fmla="*/ 273939 h 1056259"/>
                <a:gd name="connsiteX84" fmla="*/ 2110105 w 2499995"/>
                <a:gd name="connsiteY84" fmla="*/ 264541 h 1056259"/>
                <a:gd name="connsiteX85" fmla="*/ 2075307 w 2499995"/>
                <a:gd name="connsiteY85" fmla="*/ 252857 h 1056259"/>
                <a:gd name="connsiteX86" fmla="*/ 2068449 w 2499995"/>
                <a:gd name="connsiteY86" fmla="*/ 250317 h 1056259"/>
                <a:gd name="connsiteX87" fmla="*/ 2038604 w 2499995"/>
                <a:gd name="connsiteY87" fmla="*/ 238633 h 1056259"/>
                <a:gd name="connsiteX88" fmla="*/ 2006600 w 2499995"/>
                <a:gd name="connsiteY88" fmla="*/ 225171 h 1056259"/>
                <a:gd name="connsiteX89" fmla="*/ 1972437 w 2499995"/>
                <a:gd name="connsiteY89" fmla="*/ 209931 h 1056259"/>
                <a:gd name="connsiteX90" fmla="*/ 1935988 w 2499995"/>
                <a:gd name="connsiteY90" fmla="*/ 193167 h 1056259"/>
                <a:gd name="connsiteX91" fmla="*/ 1897888 w 2499995"/>
                <a:gd name="connsiteY91" fmla="*/ 175260 h 1056259"/>
                <a:gd name="connsiteX92" fmla="*/ 1858518 w 2499995"/>
                <a:gd name="connsiteY92" fmla="*/ 156591 h 1056259"/>
                <a:gd name="connsiteX93" fmla="*/ 1818894 w 2499995"/>
                <a:gd name="connsiteY93" fmla="*/ 137668 h 1056259"/>
                <a:gd name="connsiteX94" fmla="*/ 1779905 w 2499995"/>
                <a:gd name="connsiteY94" fmla="*/ 119126 h 1056259"/>
                <a:gd name="connsiteX95" fmla="*/ 1742313 w 2499995"/>
                <a:gd name="connsiteY95" fmla="*/ 101473 h 1056259"/>
                <a:gd name="connsiteX96" fmla="*/ 1706626 w 2499995"/>
                <a:gd name="connsiteY96" fmla="*/ 85217 h 1056259"/>
                <a:gd name="connsiteX97" fmla="*/ 1673098 w 2499995"/>
                <a:gd name="connsiteY97" fmla="*/ 70612 h 1056259"/>
                <a:gd name="connsiteX98" fmla="*/ 1641856 w 2499995"/>
                <a:gd name="connsiteY98" fmla="*/ 57658 h 1056259"/>
                <a:gd name="connsiteX99" fmla="*/ 1622044 w 2499995"/>
                <a:gd name="connsiteY99" fmla="*/ 50038 h 1056259"/>
                <a:gd name="connsiteX100" fmla="*/ 1586865 w 2499995"/>
                <a:gd name="connsiteY100" fmla="*/ 37846 h 1056259"/>
                <a:gd name="connsiteX101" fmla="*/ 1552702 w 2499995"/>
                <a:gd name="connsiteY101" fmla="*/ 28067 h 1056259"/>
                <a:gd name="connsiteX102" fmla="*/ 1517396 w 2499995"/>
                <a:gd name="connsiteY102" fmla="*/ 20320 h 1056259"/>
                <a:gd name="connsiteX103" fmla="*/ 1479423 w 2499995"/>
                <a:gd name="connsiteY103" fmla="*/ 14097 h 1056259"/>
                <a:gd name="connsiteX104" fmla="*/ 1438021 w 2499995"/>
                <a:gd name="connsiteY104" fmla="*/ 9017 h 1056259"/>
                <a:gd name="connsiteX105" fmla="*/ 1395222 w 2499995"/>
                <a:gd name="connsiteY105" fmla="*/ 5080 h 1056259"/>
                <a:gd name="connsiteX106" fmla="*/ 1356106 w 2499995"/>
                <a:gd name="connsiteY106" fmla="*/ 2413 h 1056259"/>
                <a:gd name="connsiteX107" fmla="*/ 1327404 w 2499995"/>
                <a:gd name="connsiteY107" fmla="*/ 762 h 1056259"/>
                <a:gd name="connsiteX108" fmla="*/ 1312799 w 2499995"/>
                <a:gd name="connsiteY108" fmla="*/ 127 h 1056259"/>
                <a:gd name="connsiteX109" fmla="*/ 1309497 w 2499995"/>
                <a:gd name="connsiteY109" fmla="*/ 0 h 1056259"/>
                <a:gd name="connsiteX110" fmla="*/ 1309497 w 2499995"/>
                <a:gd name="connsiteY110" fmla="*/ 0 h 1056259"/>
                <a:gd name="connsiteX111" fmla="*/ 1190498 w 2499995"/>
                <a:gd name="connsiteY111" fmla="*/ 0 h 1056259"/>
                <a:gd name="connsiteX112" fmla="*/ 1188466 w 2499995"/>
                <a:gd name="connsiteY112" fmla="*/ 0 h 1056259"/>
                <a:gd name="connsiteX113" fmla="*/ 1176274 w 2499995"/>
                <a:gd name="connsiteY113" fmla="*/ 0 h 1056259"/>
                <a:gd name="connsiteX114" fmla="*/ 1149731 w 2499995"/>
                <a:gd name="connsiteY114" fmla="*/ 0 h 1056259"/>
                <a:gd name="connsiteX115" fmla="*/ 1111631 w 2499995"/>
                <a:gd name="connsiteY115" fmla="*/ 0 h 1056259"/>
                <a:gd name="connsiteX116" fmla="*/ 1068832 w 2499995"/>
                <a:gd name="connsiteY116" fmla="*/ 0 h 1056259"/>
                <a:gd name="connsiteX117" fmla="*/ 1026668 w 2499995"/>
                <a:gd name="connsiteY117" fmla="*/ 0 h 1056259"/>
                <a:gd name="connsiteX118" fmla="*/ 987933 w 2499995"/>
                <a:gd name="connsiteY118" fmla="*/ 0 h 1056259"/>
                <a:gd name="connsiteX119" fmla="*/ 952119 w 2499995"/>
                <a:gd name="connsiteY119" fmla="*/ 0 h 1056259"/>
                <a:gd name="connsiteX120" fmla="*/ 917702 w 2499995"/>
                <a:gd name="connsiteY120" fmla="*/ 0 h 1056259"/>
                <a:gd name="connsiteX121" fmla="*/ 882523 w 2499995"/>
                <a:gd name="connsiteY121" fmla="*/ 0 h 1056259"/>
                <a:gd name="connsiteX122" fmla="*/ 877951 w 2499995"/>
                <a:gd name="connsiteY122" fmla="*/ 0 h 1056259"/>
                <a:gd name="connsiteX123" fmla="*/ 846582 w 2499995"/>
                <a:gd name="connsiteY123" fmla="*/ 0 h 1056259"/>
                <a:gd name="connsiteX124" fmla="*/ 813054 w 2499995"/>
                <a:gd name="connsiteY124" fmla="*/ 0 h 1056259"/>
                <a:gd name="connsiteX125" fmla="*/ 776859 w 2499995"/>
                <a:gd name="connsiteY125" fmla="*/ 0 h 1056259"/>
                <a:gd name="connsiteX126" fmla="*/ 738505 w 2499995"/>
                <a:gd name="connsiteY126" fmla="*/ 0 h 1056259"/>
                <a:gd name="connsiteX127" fmla="*/ 698246 w 2499995"/>
                <a:gd name="connsiteY127" fmla="*/ 0 h 1056259"/>
                <a:gd name="connsiteX128" fmla="*/ 656844 w 2499995"/>
                <a:gd name="connsiteY128" fmla="*/ 0 h 1056259"/>
                <a:gd name="connsiteX129" fmla="*/ 615569 w 2499995"/>
                <a:gd name="connsiteY129" fmla="*/ 0 h 1056259"/>
                <a:gd name="connsiteX130" fmla="*/ 575183 w 2499995"/>
                <a:gd name="connsiteY130" fmla="*/ 0 h 1056259"/>
                <a:gd name="connsiteX131" fmla="*/ 536448 w 2499995"/>
                <a:gd name="connsiteY131" fmla="*/ 0 h 1056259"/>
                <a:gd name="connsiteX132" fmla="*/ 500126 w 2499995"/>
                <a:gd name="connsiteY132" fmla="*/ 0 h 1056259"/>
                <a:gd name="connsiteX133" fmla="*/ 466217 w 2499995"/>
                <a:gd name="connsiteY133" fmla="*/ 0 h 1056259"/>
                <a:gd name="connsiteX134" fmla="*/ 434721 w 2499995"/>
                <a:gd name="connsiteY134" fmla="*/ 0 h 1056259"/>
                <a:gd name="connsiteX135" fmla="*/ 431546 w 2499995"/>
                <a:gd name="connsiteY135" fmla="*/ 0 h 1056259"/>
                <a:gd name="connsiteX136" fmla="*/ 396240 w 2499995"/>
                <a:gd name="connsiteY136" fmla="*/ 0 h 1056259"/>
                <a:gd name="connsiteX137" fmla="*/ 361823 w 2499995"/>
                <a:gd name="connsiteY137" fmla="*/ 0 h 1056259"/>
                <a:gd name="connsiteX138" fmla="*/ 326263 w 2499995"/>
                <a:gd name="connsiteY138" fmla="*/ 0 h 1056259"/>
                <a:gd name="connsiteX139" fmla="*/ 287909 w 2499995"/>
                <a:gd name="connsiteY139" fmla="*/ 0 h 1056259"/>
                <a:gd name="connsiteX140" fmla="*/ 246253 w 2499995"/>
                <a:gd name="connsiteY140" fmla="*/ 0 h 1056259"/>
                <a:gd name="connsiteX141" fmla="*/ 203200 w 2499995"/>
                <a:gd name="connsiteY141" fmla="*/ 0 h 1056259"/>
                <a:gd name="connsiteX142" fmla="*/ 164084 w 2499995"/>
                <a:gd name="connsiteY142" fmla="*/ 0 h 1056259"/>
                <a:gd name="connsiteX143" fmla="*/ 135763 w 2499995"/>
                <a:gd name="connsiteY143" fmla="*/ 0 h 1056259"/>
                <a:gd name="connsiteX144" fmla="*/ 121920 w 2499995"/>
                <a:gd name="connsiteY144" fmla="*/ 0 h 1056259"/>
                <a:gd name="connsiteX145" fmla="*/ 119126 w 2499995"/>
                <a:gd name="connsiteY145" fmla="*/ 0 h 1056259"/>
                <a:gd name="connsiteX146" fmla="*/ 118999 w 2499995"/>
                <a:gd name="connsiteY146" fmla="*/ 0 h 1056259"/>
                <a:gd name="connsiteX147" fmla="*/ 0 w 2499995"/>
                <a:gd name="connsiteY147" fmla="*/ 0 h 1056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1056259">
                  <a:moveTo>
                    <a:pt x="0" y="755777"/>
                  </a:moveTo>
                  <a:lnTo>
                    <a:pt x="118999" y="755777"/>
                  </a:lnTo>
                  <a:lnTo>
                    <a:pt x="121031" y="755777"/>
                  </a:lnTo>
                  <a:lnTo>
                    <a:pt x="133223" y="755777"/>
                  </a:lnTo>
                  <a:lnTo>
                    <a:pt x="159766" y="755777"/>
                  </a:lnTo>
                  <a:lnTo>
                    <a:pt x="197866" y="755777"/>
                  </a:lnTo>
                  <a:lnTo>
                    <a:pt x="240792" y="755777"/>
                  </a:lnTo>
                  <a:lnTo>
                    <a:pt x="282829" y="755777"/>
                  </a:lnTo>
                  <a:lnTo>
                    <a:pt x="321691" y="755777"/>
                  </a:lnTo>
                  <a:lnTo>
                    <a:pt x="357378" y="755777"/>
                  </a:lnTo>
                  <a:lnTo>
                    <a:pt x="391922" y="755777"/>
                  </a:lnTo>
                  <a:lnTo>
                    <a:pt x="426974" y="755777"/>
                  </a:lnTo>
                  <a:lnTo>
                    <a:pt x="431546" y="755777"/>
                  </a:lnTo>
                  <a:lnTo>
                    <a:pt x="462915" y="755777"/>
                  </a:lnTo>
                  <a:lnTo>
                    <a:pt x="496570" y="755777"/>
                  </a:lnTo>
                  <a:lnTo>
                    <a:pt x="532638" y="755777"/>
                  </a:lnTo>
                  <a:lnTo>
                    <a:pt x="571119" y="755777"/>
                  </a:lnTo>
                  <a:lnTo>
                    <a:pt x="611378" y="755777"/>
                  </a:lnTo>
                  <a:lnTo>
                    <a:pt x="652653" y="755777"/>
                  </a:lnTo>
                  <a:lnTo>
                    <a:pt x="694055" y="755777"/>
                  </a:lnTo>
                  <a:lnTo>
                    <a:pt x="734441" y="755777"/>
                  </a:lnTo>
                  <a:lnTo>
                    <a:pt x="773049" y="755777"/>
                  </a:lnTo>
                  <a:lnTo>
                    <a:pt x="809371" y="755777"/>
                  </a:lnTo>
                  <a:lnTo>
                    <a:pt x="843280" y="755777"/>
                  </a:lnTo>
                  <a:lnTo>
                    <a:pt x="874903" y="755777"/>
                  </a:lnTo>
                  <a:lnTo>
                    <a:pt x="877951" y="755777"/>
                  </a:lnTo>
                  <a:lnTo>
                    <a:pt x="913384" y="755777"/>
                  </a:lnTo>
                  <a:lnTo>
                    <a:pt x="947801" y="755777"/>
                  </a:lnTo>
                  <a:lnTo>
                    <a:pt x="983234" y="755777"/>
                  </a:lnTo>
                  <a:lnTo>
                    <a:pt x="1021588" y="755777"/>
                  </a:lnTo>
                  <a:lnTo>
                    <a:pt x="1063371" y="755777"/>
                  </a:lnTo>
                  <a:lnTo>
                    <a:pt x="1106424" y="755777"/>
                  </a:lnTo>
                  <a:lnTo>
                    <a:pt x="1145413" y="755777"/>
                  </a:lnTo>
                  <a:lnTo>
                    <a:pt x="1173734" y="755777"/>
                  </a:lnTo>
                  <a:lnTo>
                    <a:pt x="1187704" y="755777"/>
                  </a:lnTo>
                  <a:lnTo>
                    <a:pt x="1190498" y="755777"/>
                  </a:lnTo>
                  <a:lnTo>
                    <a:pt x="1190498" y="755777"/>
                  </a:lnTo>
                  <a:lnTo>
                    <a:pt x="1309497" y="755777"/>
                  </a:lnTo>
                  <a:lnTo>
                    <a:pt x="1311529" y="755904"/>
                  </a:lnTo>
                  <a:lnTo>
                    <a:pt x="1323467" y="756412"/>
                  </a:lnTo>
                  <a:lnTo>
                    <a:pt x="1349629" y="757809"/>
                  </a:lnTo>
                  <a:lnTo>
                    <a:pt x="1387348" y="760349"/>
                  </a:lnTo>
                  <a:lnTo>
                    <a:pt x="1429893" y="764032"/>
                  </a:lnTo>
                  <a:lnTo>
                    <a:pt x="1471803" y="768858"/>
                  </a:lnTo>
                  <a:lnTo>
                    <a:pt x="1510538" y="774827"/>
                  </a:lnTo>
                  <a:lnTo>
                    <a:pt x="1546098" y="782320"/>
                  </a:lnTo>
                  <a:lnTo>
                    <a:pt x="1580388" y="791591"/>
                  </a:lnTo>
                  <a:lnTo>
                    <a:pt x="1615186" y="803402"/>
                  </a:lnTo>
                  <a:lnTo>
                    <a:pt x="1622044" y="805815"/>
                  </a:lnTo>
                  <a:lnTo>
                    <a:pt x="1652016" y="817626"/>
                  </a:lnTo>
                  <a:lnTo>
                    <a:pt x="1683893" y="831088"/>
                  </a:lnTo>
                  <a:lnTo>
                    <a:pt x="1718183" y="846201"/>
                  </a:lnTo>
                  <a:lnTo>
                    <a:pt x="1754505" y="862965"/>
                  </a:lnTo>
                  <a:lnTo>
                    <a:pt x="1792732" y="880999"/>
                  </a:lnTo>
                  <a:lnTo>
                    <a:pt x="1831975" y="899668"/>
                  </a:lnTo>
                  <a:lnTo>
                    <a:pt x="1871599" y="918591"/>
                  </a:lnTo>
                  <a:lnTo>
                    <a:pt x="1910588" y="937133"/>
                  </a:lnTo>
                  <a:lnTo>
                    <a:pt x="1948180" y="954659"/>
                  </a:lnTo>
                  <a:lnTo>
                    <a:pt x="1983994" y="970915"/>
                  </a:lnTo>
                  <a:lnTo>
                    <a:pt x="2017395" y="985647"/>
                  </a:lnTo>
                  <a:lnTo>
                    <a:pt x="2048637" y="998474"/>
                  </a:lnTo>
                  <a:lnTo>
                    <a:pt x="2068449" y="1006094"/>
                  </a:lnTo>
                  <a:lnTo>
                    <a:pt x="2103628" y="1018286"/>
                  </a:lnTo>
                  <a:lnTo>
                    <a:pt x="2137791" y="1028065"/>
                  </a:lnTo>
                  <a:lnTo>
                    <a:pt x="2173097" y="1035939"/>
                  </a:lnTo>
                  <a:lnTo>
                    <a:pt x="2211070" y="1042162"/>
                  </a:lnTo>
                  <a:lnTo>
                    <a:pt x="2252472" y="1047115"/>
                  </a:lnTo>
                  <a:lnTo>
                    <a:pt x="2295271" y="1051052"/>
                  </a:lnTo>
                  <a:lnTo>
                    <a:pt x="2334387" y="1053846"/>
                  </a:lnTo>
                  <a:lnTo>
                    <a:pt x="2363089" y="1055370"/>
                  </a:lnTo>
                  <a:lnTo>
                    <a:pt x="2377694" y="1056132"/>
                  </a:lnTo>
                  <a:lnTo>
                    <a:pt x="2380996" y="1056259"/>
                  </a:lnTo>
                  <a:lnTo>
                    <a:pt x="2380996" y="1056259"/>
                  </a:lnTo>
                  <a:lnTo>
                    <a:pt x="2499995" y="1056259"/>
                  </a:lnTo>
                  <a:lnTo>
                    <a:pt x="2499995" y="300355"/>
                  </a:lnTo>
                  <a:lnTo>
                    <a:pt x="2380996" y="300355"/>
                  </a:lnTo>
                  <a:lnTo>
                    <a:pt x="2378964" y="300355"/>
                  </a:lnTo>
                  <a:lnTo>
                    <a:pt x="2367026" y="299720"/>
                  </a:lnTo>
                  <a:lnTo>
                    <a:pt x="2340864" y="298323"/>
                  </a:lnTo>
                  <a:lnTo>
                    <a:pt x="2303145" y="295783"/>
                  </a:lnTo>
                  <a:lnTo>
                    <a:pt x="2260600" y="292227"/>
                  </a:lnTo>
                  <a:lnTo>
                    <a:pt x="2218690" y="287401"/>
                  </a:lnTo>
                  <a:lnTo>
                    <a:pt x="2180082" y="281305"/>
                  </a:lnTo>
                  <a:lnTo>
                    <a:pt x="2144395" y="273939"/>
                  </a:lnTo>
                  <a:lnTo>
                    <a:pt x="2110105" y="264541"/>
                  </a:lnTo>
                  <a:lnTo>
                    <a:pt x="2075307" y="252857"/>
                  </a:lnTo>
                  <a:lnTo>
                    <a:pt x="2068449" y="250317"/>
                  </a:lnTo>
                  <a:lnTo>
                    <a:pt x="2038604" y="238633"/>
                  </a:lnTo>
                  <a:lnTo>
                    <a:pt x="2006600" y="225171"/>
                  </a:lnTo>
                  <a:lnTo>
                    <a:pt x="1972437" y="209931"/>
                  </a:lnTo>
                  <a:lnTo>
                    <a:pt x="1935988" y="193167"/>
                  </a:lnTo>
                  <a:lnTo>
                    <a:pt x="1897888" y="175260"/>
                  </a:lnTo>
                  <a:lnTo>
                    <a:pt x="1858518" y="156591"/>
                  </a:lnTo>
                  <a:lnTo>
                    <a:pt x="1818894" y="137668"/>
                  </a:lnTo>
                  <a:lnTo>
                    <a:pt x="1779905" y="119126"/>
                  </a:lnTo>
                  <a:lnTo>
                    <a:pt x="1742313" y="101473"/>
                  </a:lnTo>
                  <a:lnTo>
                    <a:pt x="1706626" y="85217"/>
                  </a:lnTo>
                  <a:lnTo>
                    <a:pt x="1673098" y="70612"/>
                  </a:lnTo>
                  <a:lnTo>
                    <a:pt x="1641856" y="57658"/>
                  </a:lnTo>
                  <a:lnTo>
                    <a:pt x="1622044" y="50038"/>
                  </a:lnTo>
                  <a:lnTo>
                    <a:pt x="1586865" y="37846"/>
                  </a:lnTo>
                  <a:lnTo>
                    <a:pt x="1552702" y="28067"/>
                  </a:lnTo>
                  <a:lnTo>
                    <a:pt x="1517396" y="20320"/>
                  </a:lnTo>
                  <a:lnTo>
                    <a:pt x="1479423" y="14097"/>
                  </a:lnTo>
                  <a:lnTo>
                    <a:pt x="1438021" y="9017"/>
                  </a:lnTo>
                  <a:lnTo>
                    <a:pt x="1395222" y="5080"/>
                  </a:lnTo>
                  <a:lnTo>
                    <a:pt x="1356106" y="2413"/>
                  </a:lnTo>
                  <a:lnTo>
                    <a:pt x="1327404" y="762"/>
                  </a:lnTo>
                  <a:lnTo>
                    <a:pt x="1312799" y="127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832" y="0"/>
                  </a:lnTo>
                  <a:lnTo>
                    <a:pt x="1026668" y="0"/>
                  </a:lnTo>
                  <a:lnTo>
                    <a:pt x="987933" y="0"/>
                  </a:lnTo>
                  <a:lnTo>
                    <a:pt x="952119" y="0"/>
                  </a:lnTo>
                  <a:lnTo>
                    <a:pt x="917702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3054" y="0"/>
                  </a:lnTo>
                  <a:lnTo>
                    <a:pt x="776859" y="0"/>
                  </a:lnTo>
                  <a:lnTo>
                    <a:pt x="738505" y="0"/>
                  </a:lnTo>
                  <a:lnTo>
                    <a:pt x="698246" y="0"/>
                  </a:lnTo>
                  <a:lnTo>
                    <a:pt x="656844" y="0"/>
                  </a:lnTo>
                  <a:lnTo>
                    <a:pt x="615569" y="0"/>
                  </a:lnTo>
                  <a:lnTo>
                    <a:pt x="575183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721" y="0"/>
                  </a:lnTo>
                  <a:lnTo>
                    <a:pt x="431546" y="0"/>
                  </a:lnTo>
                  <a:lnTo>
                    <a:pt x="396240" y="0"/>
                  </a:lnTo>
                  <a:lnTo>
                    <a:pt x="361823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253" y="0"/>
                  </a:lnTo>
                  <a:lnTo>
                    <a:pt x="203200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920" y="0"/>
                  </a:lnTo>
                  <a:lnTo>
                    <a:pt x="119126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6D96A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28" name="Forme libre 27">
              <a:extLst>
                <a:ext uri="{FF2B5EF4-FFF2-40B4-BE49-F238E27FC236}">
                  <a16:creationId xmlns:a16="http://schemas.microsoft.com/office/drawing/2014/main" id="{67823F86-5159-661B-F1AB-681479228A23}"/>
                </a:ext>
              </a:extLst>
            </p:cNvPr>
            <p:cNvSpPr/>
            <p:nvPr/>
          </p:nvSpPr>
          <p:spPr>
            <a:xfrm>
              <a:off x="636143" y="4990623"/>
              <a:ext cx="2499995" cy="1056259"/>
            </a:xfrm>
            <a:custGeom>
              <a:avLst/>
              <a:gdLst>
                <a:gd name="connsiteX0" fmla="*/ 0 w 2499995"/>
                <a:gd name="connsiteY0" fmla="*/ 1056259 h 1056259"/>
                <a:gd name="connsiteX1" fmla="*/ 118999 w 2499995"/>
                <a:gd name="connsiteY1" fmla="*/ 1056259 h 1056259"/>
                <a:gd name="connsiteX2" fmla="*/ 121031 w 2499995"/>
                <a:gd name="connsiteY2" fmla="*/ 1056259 h 1056259"/>
                <a:gd name="connsiteX3" fmla="*/ 133223 w 2499995"/>
                <a:gd name="connsiteY3" fmla="*/ 1056259 h 1056259"/>
                <a:gd name="connsiteX4" fmla="*/ 159766 w 2499995"/>
                <a:gd name="connsiteY4" fmla="*/ 1056259 h 1056259"/>
                <a:gd name="connsiteX5" fmla="*/ 197866 w 2499995"/>
                <a:gd name="connsiteY5" fmla="*/ 1056259 h 1056259"/>
                <a:gd name="connsiteX6" fmla="*/ 240792 w 2499995"/>
                <a:gd name="connsiteY6" fmla="*/ 1056259 h 1056259"/>
                <a:gd name="connsiteX7" fmla="*/ 282829 w 2499995"/>
                <a:gd name="connsiteY7" fmla="*/ 1056259 h 1056259"/>
                <a:gd name="connsiteX8" fmla="*/ 321691 w 2499995"/>
                <a:gd name="connsiteY8" fmla="*/ 1056259 h 1056259"/>
                <a:gd name="connsiteX9" fmla="*/ 357378 w 2499995"/>
                <a:gd name="connsiteY9" fmla="*/ 1056259 h 1056259"/>
                <a:gd name="connsiteX10" fmla="*/ 391922 w 2499995"/>
                <a:gd name="connsiteY10" fmla="*/ 1056259 h 1056259"/>
                <a:gd name="connsiteX11" fmla="*/ 426974 w 2499995"/>
                <a:gd name="connsiteY11" fmla="*/ 1056259 h 1056259"/>
                <a:gd name="connsiteX12" fmla="*/ 431546 w 2499995"/>
                <a:gd name="connsiteY12" fmla="*/ 1056259 h 1056259"/>
                <a:gd name="connsiteX13" fmla="*/ 462915 w 2499995"/>
                <a:gd name="connsiteY13" fmla="*/ 1056259 h 1056259"/>
                <a:gd name="connsiteX14" fmla="*/ 496570 w 2499995"/>
                <a:gd name="connsiteY14" fmla="*/ 1056259 h 1056259"/>
                <a:gd name="connsiteX15" fmla="*/ 532638 w 2499995"/>
                <a:gd name="connsiteY15" fmla="*/ 1056259 h 1056259"/>
                <a:gd name="connsiteX16" fmla="*/ 571119 w 2499995"/>
                <a:gd name="connsiteY16" fmla="*/ 1056259 h 1056259"/>
                <a:gd name="connsiteX17" fmla="*/ 611378 w 2499995"/>
                <a:gd name="connsiteY17" fmla="*/ 1056259 h 1056259"/>
                <a:gd name="connsiteX18" fmla="*/ 652653 w 2499995"/>
                <a:gd name="connsiteY18" fmla="*/ 1056259 h 1056259"/>
                <a:gd name="connsiteX19" fmla="*/ 694055 w 2499995"/>
                <a:gd name="connsiteY19" fmla="*/ 1056259 h 1056259"/>
                <a:gd name="connsiteX20" fmla="*/ 734441 w 2499995"/>
                <a:gd name="connsiteY20" fmla="*/ 1056259 h 1056259"/>
                <a:gd name="connsiteX21" fmla="*/ 773049 w 2499995"/>
                <a:gd name="connsiteY21" fmla="*/ 1056259 h 1056259"/>
                <a:gd name="connsiteX22" fmla="*/ 809371 w 2499995"/>
                <a:gd name="connsiteY22" fmla="*/ 1056259 h 1056259"/>
                <a:gd name="connsiteX23" fmla="*/ 843280 w 2499995"/>
                <a:gd name="connsiteY23" fmla="*/ 1056259 h 1056259"/>
                <a:gd name="connsiteX24" fmla="*/ 874903 w 2499995"/>
                <a:gd name="connsiteY24" fmla="*/ 1056259 h 1056259"/>
                <a:gd name="connsiteX25" fmla="*/ 877951 w 2499995"/>
                <a:gd name="connsiteY25" fmla="*/ 1056259 h 1056259"/>
                <a:gd name="connsiteX26" fmla="*/ 913384 w 2499995"/>
                <a:gd name="connsiteY26" fmla="*/ 1056259 h 1056259"/>
                <a:gd name="connsiteX27" fmla="*/ 947801 w 2499995"/>
                <a:gd name="connsiteY27" fmla="*/ 1056259 h 1056259"/>
                <a:gd name="connsiteX28" fmla="*/ 983234 w 2499995"/>
                <a:gd name="connsiteY28" fmla="*/ 1056259 h 1056259"/>
                <a:gd name="connsiteX29" fmla="*/ 1021588 w 2499995"/>
                <a:gd name="connsiteY29" fmla="*/ 1056259 h 1056259"/>
                <a:gd name="connsiteX30" fmla="*/ 1063371 w 2499995"/>
                <a:gd name="connsiteY30" fmla="*/ 1056259 h 1056259"/>
                <a:gd name="connsiteX31" fmla="*/ 1106424 w 2499995"/>
                <a:gd name="connsiteY31" fmla="*/ 1056259 h 1056259"/>
                <a:gd name="connsiteX32" fmla="*/ 1145413 w 2499995"/>
                <a:gd name="connsiteY32" fmla="*/ 1056259 h 1056259"/>
                <a:gd name="connsiteX33" fmla="*/ 1173734 w 2499995"/>
                <a:gd name="connsiteY33" fmla="*/ 1056259 h 1056259"/>
                <a:gd name="connsiteX34" fmla="*/ 1187704 w 2499995"/>
                <a:gd name="connsiteY34" fmla="*/ 1056259 h 1056259"/>
                <a:gd name="connsiteX35" fmla="*/ 1190498 w 2499995"/>
                <a:gd name="connsiteY35" fmla="*/ 1056259 h 1056259"/>
                <a:gd name="connsiteX36" fmla="*/ 1190498 w 2499995"/>
                <a:gd name="connsiteY36" fmla="*/ 1056259 h 1056259"/>
                <a:gd name="connsiteX37" fmla="*/ 1309497 w 2499995"/>
                <a:gd name="connsiteY37" fmla="*/ 1056259 h 1056259"/>
                <a:gd name="connsiteX38" fmla="*/ 1311402 w 2499995"/>
                <a:gd name="connsiteY38" fmla="*/ 1056005 h 1056259"/>
                <a:gd name="connsiteX39" fmla="*/ 1322324 w 2499995"/>
                <a:gd name="connsiteY39" fmla="*/ 1054862 h 1056259"/>
                <a:gd name="connsiteX40" fmla="*/ 1346708 w 2499995"/>
                <a:gd name="connsiteY40" fmla="*/ 1051560 h 1056259"/>
                <a:gd name="connsiteX41" fmla="*/ 1382268 w 2499995"/>
                <a:gd name="connsiteY41" fmla="*/ 1045718 h 1056259"/>
                <a:gd name="connsiteX42" fmla="*/ 1423289 w 2499995"/>
                <a:gd name="connsiteY42" fmla="*/ 1037082 h 1056259"/>
                <a:gd name="connsiteX43" fmla="*/ 1464310 w 2499995"/>
                <a:gd name="connsiteY43" fmla="*/ 1025906 h 1056259"/>
                <a:gd name="connsiteX44" fmla="*/ 1502410 w 2499995"/>
                <a:gd name="connsiteY44" fmla="*/ 1011936 h 1056259"/>
                <a:gd name="connsiteX45" fmla="*/ 1537589 w 2499995"/>
                <a:gd name="connsiteY45" fmla="*/ 994537 h 1056259"/>
                <a:gd name="connsiteX46" fmla="*/ 1570863 w 2499995"/>
                <a:gd name="connsiteY46" fmla="*/ 973074 h 1056259"/>
                <a:gd name="connsiteX47" fmla="*/ 1604264 w 2499995"/>
                <a:gd name="connsiteY47" fmla="*/ 946404 h 1056259"/>
                <a:gd name="connsiteX48" fmla="*/ 1622044 w 2499995"/>
                <a:gd name="connsiteY48" fmla="*/ 930275 h 1056259"/>
                <a:gd name="connsiteX49" fmla="*/ 1647444 w 2499995"/>
                <a:gd name="connsiteY49" fmla="*/ 905383 h 1056259"/>
                <a:gd name="connsiteX50" fmla="*/ 1674241 w 2499995"/>
                <a:gd name="connsiteY50" fmla="*/ 877316 h 1056259"/>
                <a:gd name="connsiteX51" fmla="*/ 1702689 w 2499995"/>
                <a:gd name="connsiteY51" fmla="*/ 846074 h 1056259"/>
                <a:gd name="connsiteX52" fmla="*/ 1732788 w 2499995"/>
                <a:gd name="connsiteY52" fmla="*/ 811784 h 1056259"/>
                <a:gd name="connsiteX53" fmla="*/ 1764411 w 2499995"/>
                <a:gd name="connsiteY53" fmla="*/ 774954 h 1056259"/>
                <a:gd name="connsiteX54" fmla="*/ 1797177 w 2499995"/>
                <a:gd name="connsiteY54" fmla="*/ 735965 h 1056259"/>
                <a:gd name="connsiteX55" fmla="*/ 1830705 w 2499995"/>
                <a:gd name="connsiteY55" fmla="*/ 695833 h 1056259"/>
                <a:gd name="connsiteX56" fmla="*/ 1864487 w 2499995"/>
                <a:gd name="connsiteY56" fmla="*/ 655193 h 1056259"/>
                <a:gd name="connsiteX57" fmla="*/ 1897888 w 2499995"/>
                <a:gd name="connsiteY57" fmla="*/ 615061 h 1056259"/>
                <a:gd name="connsiteX58" fmla="*/ 1930527 w 2499995"/>
                <a:gd name="connsiteY58" fmla="*/ 576453 h 1056259"/>
                <a:gd name="connsiteX59" fmla="*/ 1962023 w 2499995"/>
                <a:gd name="connsiteY59" fmla="*/ 539877 h 1056259"/>
                <a:gd name="connsiteX60" fmla="*/ 1991868 w 2499995"/>
                <a:gd name="connsiteY60" fmla="*/ 505968 h 1056259"/>
                <a:gd name="connsiteX61" fmla="*/ 2020062 w 2499995"/>
                <a:gd name="connsiteY61" fmla="*/ 475234 h 1056259"/>
                <a:gd name="connsiteX62" fmla="*/ 2046732 w 2499995"/>
                <a:gd name="connsiteY62" fmla="*/ 447548 h 1056259"/>
                <a:gd name="connsiteX63" fmla="*/ 2068449 w 2499995"/>
                <a:gd name="connsiteY63" fmla="*/ 426339 h 1056259"/>
                <a:gd name="connsiteX64" fmla="*/ 2102612 w 2499995"/>
                <a:gd name="connsiteY64" fmla="*/ 396494 h 1056259"/>
                <a:gd name="connsiteX65" fmla="*/ 2135759 w 2499995"/>
                <a:gd name="connsiteY65" fmla="*/ 372364 h 1056259"/>
                <a:gd name="connsiteX66" fmla="*/ 2169668 w 2499995"/>
                <a:gd name="connsiteY66" fmla="*/ 353060 h 1056259"/>
                <a:gd name="connsiteX67" fmla="*/ 2206244 w 2499995"/>
                <a:gd name="connsiteY67" fmla="*/ 337566 h 1056259"/>
                <a:gd name="connsiteX68" fmla="*/ 2245995 w 2499995"/>
                <a:gd name="connsiteY68" fmla="*/ 324866 h 1056259"/>
                <a:gd name="connsiteX69" fmla="*/ 2287397 w 2499995"/>
                <a:gd name="connsiteY69" fmla="*/ 314960 h 1056259"/>
                <a:gd name="connsiteX70" fmla="*/ 2326640 w 2499995"/>
                <a:gd name="connsiteY70" fmla="*/ 307721 h 1056259"/>
                <a:gd name="connsiteX71" fmla="*/ 2357374 w 2499995"/>
                <a:gd name="connsiteY71" fmla="*/ 303149 h 1056259"/>
                <a:gd name="connsiteX72" fmla="*/ 2375027 w 2499995"/>
                <a:gd name="connsiteY72" fmla="*/ 300990 h 1056259"/>
                <a:gd name="connsiteX73" fmla="*/ 2380742 w 2499995"/>
                <a:gd name="connsiteY73" fmla="*/ 300355 h 1056259"/>
                <a:gd name="connsiteX74" fmla="*/ 2380996 w 2499995"/>
                <a:gd name="connsiteY74" fmla="*/ 300355 h 1056259"/>
                <a:gd name="connsiteX75" fmla="*/ 2499995 w 2499995"/>
                <a:gd name="connsiteY75" fmla="*/ 300355 h 1056259"/>
                <a:gd name="connsiteX76" fmla="*/ 2499995 w 2499995"/>
                <a:gd name="connsiteY76" fmla="*/ 0 h 1056259"/>
                <a:gd name="connsiteX77" fmla="*/ 2380996 w 2499995"/>
                <a:gd name="connsiteY77" fmla="*/ 0 h 1056259"/>
                <a:gd name="connsiteX78" fmla="*/ 2379218 w 2499995"/>
                <a:gd name="connsiteY78" fmla="*/ 127 h 1056259"/>
                <a:gd name="connsiteX79" fmla="*/ 2368169 w 2499995"/>
                <a:gd name="connsiteY79" fmla="*/ 1397 h 1056259"/>
                <a:gd name="connsiteX80" fmla="*/ 2343785 w 2499995"/>
                <a:gd name="connsiteY80" fmla="*/ 4572 h 1056259"/>
                <a:gd name="connsiteX81" fmla="*/ 2308225 w 2499995"/>
                <a:gd name="connsiteY81" fmla="*/ 10414 h 1056259"/>
                <a:gd name="connsiteX82" fmla="*/ 2267204 w 2499995"/>
                <a:gd name="connsiteY82" fmla="*/ 19050 h 1056259"/>
                <a:gd name="connsiteX83" fmla="*/ 2226310 w 2499995"/>
                <a:gd name="connsiteY83" fmla="*/ 30353 h 1056259"/>
                <a:gd name="connsiteX84" fmla="*/ 2188083 w 2499995"/>
                <a:gd name="connsiteY84" fmla="*/ 44323 h 1056259"/>
                <a:gd name="connsiteX85" fmla="*/ 2152904 w 2499995"/>
                <a:gd name="connsiteY85" fmla="*/ 61595 h 1056259"/>
                <a:gd name="connsiteX86" fmla="*/ 2119630 w 2499995"/>
                <a:gd name="connsiteY86" fmla="*/ 83058 h 1056259"/>
                <a:gd name="connsiteX87" fmla="*/ 2086229 w 2499995"/>
                <a:gd name="connsiteY87" fmla="*/ 109855 h 1056259"/>
                <a:gd name="connsiteX88" fmla="*/ 2068449 w 2499995"/>
                <a:gd name="connsiteY88" fmla="*/ 125984 h 1056259"/>
                <a:gd name="connsiteX89" fmla="*/ 2043049 w 2499995"/>
                <a:gd name="connsiteY89" fmla="*/ 150876 h 1056259"/>
                <a:gd name="connsiteX90" fmla="*/ 2016252 w 2499995"/>
                <a:gd name="connsiteY90" fmla="*/ 178943 h 1056259"/>
                <a:gd name="connsiteX91" fmla="*/ 1987804 w 2499995"/>
                <a:gd name="connsiteY91" fmla="*/ 210185 h 1056259"/>
                <a:gd name="connsiteX92" fmla="*/ 1957705 w 2499995"/>
                <a:gd name="connsiteY92" fmla="*/ 244348 h 1056259"/>
                <a:gd name="connsiteX93" fmla="*/ 1926082 w 2499995"/>
                <a:gd name="connsiteY93" fmla="*/ 281305 h 1056259"/>
                <a:gd name="connsiteX94" fmla="*/ 1893316 w 2499995"/>
                <a:gd name="connsiteY94" fmla="*/ 320167 h 1056259"/>
                <a:gd name="connsiteX95" fmla="*/ 1859788 w 2499995"/>
                <a:gd name="connsiteY95" fmla="*/ 360426 h 1056259"/>
                <a:gd name="connsiteX96" fmla="*/ 1826006 w 2499995"/>
                <a:gd name="connsiteY96" fmla="*/ 400939 h 1056259"/>
                <a:gd name="connsiteX97" fmla="*/ 1792605 w 2499995"/>
                <a:gd name="connsiteY97" fmla="*/ 441071 h 1056259"/>
                <a:gd name="connsiteX98" fmla="*/ 1759966 w 2499995"/>
                <a:gd name="connsiteY98" fmla="*/ 479806 h 1056259"/>
                <a:gd name="connsiteX99" fmla="*/ 1728597 w 2499995"/>
                <a:gd name="connsiteY99" fmla="*/ 516255 h 1056259"/>
                <a:gd name="connsiteX100" fmla="*/ 1698625 w 2499995"/>
                <a:gd name="connsiteY100" fmla="*/ 550164 h 1056259"/>
                <a:gd name="connsiteX101" fmla="*/ 1670431 w 2499995"/>
                <a:gd name="connsiteY101" fmla="*/ 581025 h 1056259"/>
                <a:gd name="connsiteX102" fmla="*/ 1643888 w 2499995"/>
                <a:gd name="connsiteY102" fmla="*/ 608584 h 1056259"/>
                <a:gd name="connsiteX103" fmla="*/ 1622044 w 2499995"/>
                <a:gd name="connsiteY103" fmla="*/ 629793 h 1056259"/>
                <a:gd name="connsiteX104" fmla="*/ 1588008 w 2499995"/>
                <a:gd name="connsiteY104" fmla="*/ 659765 h 1056259"/>
                <a:gd name="connsiteX105" fmla="*/ 1554861 w 2499995"/>
                <a:gd name="connsiteY105" fmla="*/ 683768 h 1056259"/>
                <a:gd name="connsiteX106" fmla="*/ 1520825 w 2499995"/>
                <a:gd name="connsiteY106" fmla="*/ 703072 h 1056259"/>
                <a:gd name="connsiteX107" fmla="*/ 1484249 w 2499995"/>
                <a:gd name="connsiteY107" fmla="*/ 718693 h 1056259"/>
                <a:gd name="connsiteX108" fmla="*/ 1444625 w 2499995"/>
                <a:gd name="connsiteY108" fmla="*/ 731266 h 1056259"/>
                <a:gd name="connsiteX109" fmla="*/ 1403096 w 2499995"/>
                <a:gd name="connsiteY109" fmla="*/ 741299 h 1056259"/>
                <a:gd name="connsiteX110" fmla="*/ 1363853 w 2499995"/>
                <a:gd name="connsiteY110" fmla="*/ 748538 h 1056259"/>
                <a:gd name="connsiteX111" fmla="*/ 1333246 w 2499995"/>
                <a:gd name="connsiteY111" fmla="*/ 753110 h 1056259"/>
                <a:gd name="connsiteX112" fmla="*/ 1315466 w 2499995"/>
                <a:gd name="connsiteY112" fmla="*/ 755269 h 1056259"/>
                <a:gd name="connsiteX113" fmla="*/ 1309751 w 2499995"/>
                <a:gd name="connsiteY113" fmla="*/ 755777 h 1056259"/>
                <a:gd name="connsiteX114" fmla="*/ 1309497 w 2499995"/>
                <a:gd name="connsiteY114" fmla="*/ 755777 h 1056259"/>
                <a:gd name="connsiteX115" fmla="*/ 1190498 w 2499995"/>
                <a:gd name="connsiteY115" fmla="*/ 755777 h 1056259"/>
                <a:gd name="connsiteX116" fmla="*/ 1188466 w 2499995"/>
                <a:gd name="connsiteY116" fmla="*/ 755777 h 1056259"/>
                <a:gd name="connsiteX117" fmla="*/ 1176274 w 2499995"/>
                <a:gd name="connsiteY117" fmla="*/ 755777 h 1056259"/>
                <a:gd name="connsiteX118" fmla="*/ 1149731 w 2499995"/>
                <a:gd name="connsiteY118" fmla="*/ 755777 h 1056259"/>
                <a:gd name="connsiteX119" fmla="*/ 1111631 w 2499995"/>
                <a:gd name="connsiteY119" fmla="*/ 755777 h 1056259"/>
                <a:gd name="connsiteX120" fmla="*/ 1068832 w 2499995"/>
                <a:gd name="connsiteY120" fmla="*/ 755777 h 1056259"/>
                <a:gd name="connsiteX121" fmla="*/ 1026668 w 2499995"/>
                <a:gd name="connsiteY121" fmla="*/ 755777 h 1056259"/>
                <a:gd name="connsiteX122" fmla="*/ 987933 w 2499995"/>
                <a:gd name="connsiteY122" fmla="*/ 755777 h 1056259"/>
                <a:gd name="connsiteX123" fmla="*/ 952119 w 2499995"/>
                <a:gd name="connsiteY123" fmla="*/ 755777 h 1056259"/>
                <a:gd name="connsiteX124" fmla="*/ 917702 w 2499995"/>
                <a:gd name="connsiteY124" fmla="*/ 755777 h 1056259"/>
                <a:gd name="connsiteX125" fmla="*/ 882523 w 2499995"/>
                <a:gd name="connsiteY125" fmla="*/ 755777 h 1056259"/>
                <a:gd name="connsiteX126" fmla="*/ 877951 w 2499995"/>
                <a:gd name="connsiteY126" fmla="*/ 755777 h 1056259"/>
                <a:gd name="connsiteX127" fmla="*/ 846582 w 2499995"/>
                <a:gd name="connsiteY127" fmla="*/ 755777 h 1056259"/>
                <a:gd name="connsiteX128" fmla="*/ 813054 w 2499995"/>
                <a:gd name="connsiteY128" fmla="*/ 755777 h 1056259"/>
                <a:gd name="connsiteX129" fmla="*/ 776859 w 2499995"/>
                <a:gd name="connsiteY129" fmla="*/ 755777 h 1056259"/>
                <a:gd name="connsiteX130" fmla="*/ 738505 w 2499995"/>
                <a:gd name="connsiteY130" fmla="*/ 755777 h 1056259"/>
                <a:gd name="connsiteX131" fmla="*/ 698246 w 2499995"/>
                <a:gd name="connsiteY131" fmla="*/ 755777 h 1056259"/>
                <a:gd name="connsiteX132" fmla="*/ 656844 w 2499995"/>
                <a:gd name="connsiteY132" fmla="*/ 755777 h 1056259"/>
                <a:gd name="connsiteX133" fmla="*/ 615569 w 2499995"/>
                <a:gd name="connsiteY133" fmla="*/ 755777 h 1056259"/>
                <a:gd name="connsiteX134" fmla="*/ 575183 w 2499995"/>
                <a:gd name="connsiteY134" fmla="*/ 755777 h 1056259"/>
                <a:gd name="connsiteX135" fmla="*/ 536448 w 2499995"/>
                <a:gd name="connsiteY135" fmla="*/ 755777 h 1056259"/>
                <a:gd name="connsiteX136" fmla="*/ 500126 w 2499995"/>
                <a:gd name="connsiteY136" fmla="*/ 755777 h 1056259"/>
                <a:gd name="connsiteX137" fmla="*/ 466217 w 2499995"/>
                <a:gd name="connsiteY137" fmla="*/ 755777 h 1056259"/>
                <a:gd name="connsiteX138" fmla="*/ 434721 w 2499995"/>
                <a:gd name="connsiteY138" fmla="*/ 755777 h 1056259"/>
                <a:gd name="connsiteX139" fmla="*/ 431546 w 2499995"/>
                <a:gd name="connsiteY139" fmla="*/ 755777 h 1056259"/>
                <a:gd name="connsiteX140" fmla="*/ 396240 w 2499995"/>
                <a:gd name="connsiteY140" fmla="*/ 755777 h 1056259"/>
                <a:gd name="connsiteX141" fmla="*/ 361823 w 2499995"/>
                <a:gd name="connsiteY141" fmla="*/ 755777 h 1056259"/>
                <a:gd name="connsiteX142" fmla="*/ 326263 w 2499995"/>
                <a:gd name="connsiteY142" fmla="*/ 755777 h 1056259"/>
                <a:gd name="connsiteX143" fmla="*/ 287909 w 2499995"/>
                <a:gd name="connsiteY143" fmla="*/ 755777 h 1056259"/>
                <a:gd name="connsiteX144" fmla="*/ 246253 w 2499995"/>
                <a:gd name="connsiteY144" fmla="*/ 755777 h 1056259"/>
                <a:gd name="connsiteX145" fmla="*/ 203200 w 2499995"/>
                <a:gd name="connsiteY145" fmla="*/ 755777 h 1056259"/>
                <a:gd name="connsiteX146" fmla="*/ 164084 w 2499995"/>
                <a:gd name="connsiteY146" fmla="*/ 755777 h 1056259"/>
                <a:gd name="connsiteX147" fmla="*/ 135763 w 2499995"/>
                <a:gd name="connsiteY147" fmla="*/ 755777 h 1056259"/>
                <a:gd name="connsiteX148" fmla="*/ 121920 w 2499995"/>
                <a:gd name="connsiteY148" fmla="*/ 755777 h 1056259"/>
                <a:gd name="connsiteX149" fmla="*/ 119126 w 2499995"/>
                <a:gd name="connsiteY149" fmla="*/ 755777 h 1056259"/>
                <a:gd name="connsiteX150" fmla="*/ 118999 w 2499995"/>
                <a:gd name="connsiteY150" fmla="*/ 755777 h 1056259"/>
                <a:gd name="connsiteX151" fmla="*/ 0 w 2499995"/>
                <a:gd name="connsiteY151" fmla="*/ 755777 h 1056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</a:cxnLst>
              <a:rect l="l" t="t" r="r" b="b"/>
              <a:pathLst>
                <a:path w="2499995" h="1056259">
                  <a:moveTo>
                    <a:pt x="0" y="1056259"/>
                  </a:moveTo>
                  <a:lnTo>
                    <a:pt x="118999" y="1056259"/>
                  </a:lnTo>
                  <a:lnTo>
                    <a:pt x="121031" y="1056259"/>
                  </a:lnTo>
                  <a:lnTo>
                    <a:pt x="133223" y="1056259"/>
                  </a:lnTo>
                  <a:lnTo>
                    <a:pt x="159766" y="1056259"/>
                  </a:lnTo>
                  <a:lnTo>
                    <a:pt x="197866" y="1056259"/>
                  </a:lnTo>
                  <a:lnTo>
                    <a:pt x="240792" y="1056259"/>
                  </a:lnTo>
                  <a:lnTo>
                    <a:pt x="282829" y="1056259"/>
                  </a:lnTo>
                  <a:lnTo>
                    <a:pt x="321691" y="1056259"/>
                  </a:lnTo>
                  <a:lnTo>
                    <a:pt x="357378" y="1056259"/>
                  </a:lnTo>
                  <a:lnTo>
                    <a:pt x="391922" y="1056259"/>
                  </a:lnTo>
                  <a:lnTo>
                    <a:pt x="426974" y="1056259"/>
                  </a:lnTo>
                  <a:lnTo>
                    <a:pt x="431546" y="1056259"/>
                  </a:lnTo>
                  <a:lnTo>
                    <a:pt x="462915" y="1056259"/>
                  </a:lnTo>
                  <a:lnTo>
                    <a:pt x="496570" y="1056259"/>
                  </a:lnTo>
                  <a:lnTo>
                    <a:pt x="532638" y="1056259"/>
                  </a:lnTo>
                  <a:lnTo>
                    <a:pt x="571119" y="1056259"/>
                  </a:lnTo>
                  <a:lnTo>
                    <a:pt x="611378" y="1056259"/>
                  </a:lnTo>
                  <a:lnTo>
                    <a:pt x="652653" y="1056259"/>
                  </a:lnTo>
                  <a:lnTo>
                    <a:pt x="694055" y="1056259"/>
                  </a:lnTo>
                  <a:lnTo>
                    <a:pt x="734441" y="1056259"/>
                  </a:lnTo>
                  <a:lnTo>
                    <a:pt x="773049" y="1056259"/>
                  </a:lnTo>
                  <a:lnTo>
                    <a:pt x="809371" y="1056259"/>
                  </a:lnTo>
                  <a:lnTo>
                    <a:pt x="843280" y="1056259"/>
                  </a:lnTo>
                  <a:lnTo>
                    <a:pt x="874903" y="1056259"/>
                  </a:lnTo>
                  <a:lnTo>
                    <a:pt x="877951" y="1056259"/>
                  </a:lnTo>
                  <a:lnTo>
                    <a:pt x="913384" y="1056259"/>
                  </a:lnTo>
                  <a:lnTo>
                    <a:pt x="947801" y="1056259"/>
                  </a:lnTo>
                  <a:lnTo>
                    <a:pt x="983234" y="1056259"/>
                  </a:lnTo>
                  <a:lnTo>
                    <a:pt x="1021588" y="1056259"/>
                  </a:lnTo>
                  <a:lnTo>
                    <a:pt x="1063371" y="1056259"/>
                  </a:lnTo>
                  <a:lnTo>
                    <a:pt x="1106424" y="1056259"/>
                  </a:lnTo>
                  <a:lnTo>
                    <a:pt x="1145413" y="1056259"/>
                  </a:lnTo>
                  <a:lnTo>
                    <a:pt x="1173734" y="1056259"/>
                  </a:lnTo>
                  <a:lnTo>
                    <a:pt x="1187704" y="1056259"/>
                  </a:lnTo>
                  <a:lnTo>
                    <a:pt x="1190498" y="1056259"/>
                  </a:lnTo>
                  <a:lnTo>
                    <a:pt x="1190498" y="1056259"/>
                  </a:lnTo>
                  <a:lnTo>
                    <a:pt x="1309497" y="1056259"/>
                  </a:lnTo>
                  <a:lnTo>
                    <a:pt x="1311402" y="1056005"/>
                  </a:lnTo>
                  <a:lnTo>
                    <a:pt x="1322324" y="1054862"/>
                  </a:lnTo>
                  <a:lnTo>
                    <a:pt x="1346708" y="1051560"/>
                  </a:lnTo>
                  <a:lnTo>
                    <a:pt x="1382268" y="1045718"/>
                  </a:lnTo>
                  <a:lnTo>
                    <a:pt x="1423289" y="1037082"/>
                  </a:lnTo>
                  <a:lnTo>
                    <a:pt x="1464310" y="1025906"/>
                  </a:lnTo>
                  <a:lnTo>
                    <a:pt x="1502410" y="1011936"/>
                  </a:lnTo>
                  <a:lnTo>
                    <a:pt x="1537589" y="994537"/>
                  </a:lnTo>
                  <a:lnTo>
                    <a:pt x="1570863" y="973074"/>
                  </a:lnTo>
                  <a:lnTo>
                    <a:pt x="1604264" y="946404"/>
                  </a:lnTo>
                  <a:lnTo>
                    <a:pt x="1622044" y="930275"/>
                  </a:lnTo>
                  <a:lnTo>
                    <a:pt x="1647444" y="905383"/>
                  </a:lnTo>
                  <a:lnTo>
                    <a:pt x="1674241" y="877316"/>
                  </a:lnTo>
                  <a:lnTo>
                    <a:pt x="1702689" y="846074"/>
                  </a:lnTo>
                  <a:lnTo>
                    <a:pt x="1732788" y="811784"/>
                  </a:lnTo>
                  <a:lnTo>
                    <a:pt x="1764411" y="774954"/>
                  </a:lnTo>
                  <a:lnTo>
                    <a:pt x="1797177" y="735965"/>
                  </a:lnTo>
                  <a:lnTo>
                    <a:pt x="1830705" y="695833"/>
                  </a:lnTo>
                  <a:lnTo>
                    <a:pt x="1864487" y="655193"/>
                  </a:lnTo>
                  <a:lnTo>
                    <a:pt x="1897888" y="615061"/>
                  </a:lnTo>
                  <a:lnTo>
                    <a:pt x="1930527" y="576453"/>
                  </a:lnTo>
                  <a:lnTo>
                    <a:pt x="1962023" y="539877"/>
                  </a:lnTo>
                  <a:lnTo>
                    <a:pt x="1991868" y="505968"/>
                  </a:lnTo>
                  <a:lnTo>
                    <a:pt x="2020062" y="475234"/>
                  </a:lnTo>
                  <a:lnTo>
                    <a:pt x="2046732" y="447548"/>
                  </a:lnTo>
                  <a:lnTo>
                    <a:pt x="2068449" y="426339"/>
                  </a:lnTo>
                  <a:lnTo>
                    <a:pt x="2102612" y="396494"/>
                  </a:lnTo>
                  <a:lnTo>
                    <a:pt x="2135759" y="372364"/>
                  </a:lnTo>
                  <a:lnTo>
                    <a:pt x="2169668" y="353060"/>
                  </a:lnTo>
                  <a:lnTo>
                    <a:pt x="2206244" y="337566"/>
                  </a:lnTo>
                  <a:lnTo>
                    <a:pt x="2245995" y="324866"/>
                  </a:lnTo>
                  <a:lnTo>
                    <a:pt x="2287397" y="314960"/>
                  </a:lnTo>
                  <a:lnTo>
                    <a:pt x="2326640" y="307721"/>
                  </a:lnTo>
                  <a:lnTo>
                    <a:pt x="2357374" y="303149"/>
                  </a:lnTo>
                  <a:lnTo>
                    <a:pt x="2375027" y="300990"/>
                  </a:lnTo>
                  <a:lnTo>
                    <a:pt x="2380742" y="300355"/>
                  </a:lnTo>
                  <a:lnTo>
                    <a:pt x="2380996" y="300355"/>
                  </a:lnTo>
                  <a:lnTo>
                    <a:pt x="2499995" y="300355"/>
                  </a:lnTo>
                  <a:lnTo>
                    <a:pt x="2499995" y="0"/>
                  </a:lnTo>
                  <a:lnTo>
                    <a:pt x="2380996" y="0"/>
                  </a:lnTo>
                  <a:lnTo>
                    <a:pt x="2379218" y="127"/>
                  </a:lnTo>
                  <a:lnTo>
                    <a:pt x="2368169" y="1397"/>
                  </a:lnTo>
                  <a:lnTo>
                    <a:pt x="2343785" y="4572"/>
                  </a:lnTo>
                  <a:lnTo>
                    <a:pt x="2308225" y="10414"/>
                  </a:lnTo>
                  <a:lnTo>
                    <a:pt x="2267204" y="19050"/>
                  </a:lnTo>
                  <a:lnTo>
                    <a:pt x="2226310" y="30353"/>
                  </a:lnTo>
                  <a:lnTo>
                    <a:pt x="2188083" y="44323"/>
                  </a:lnTo>
                  <a:lnTo>
                    <a:pt x="2152904" y="61595"/>
                  </a:lnTo>
                  <a:lnTo>
                    <a:pt x="2119630" y="83058"/>
                  </a:lnTo>
                  <a:lnTo>
                    <a:pt x="2086229" y="109855"/>
                  </a:lnTo>
                  <a:lnTo>
                    <a:pt x="2068449" y="125984"/>
                  </a:lnTo>
                  <a:lnTo>
                    <a:pt x="2043049" y="150876"/>
                  </a:lnTo>
                  <a:lnTo>
                    <a:pt x="2016252" y="178943"/>
                  </a:lnTo>
                  <a:lnTo>
                    <a:pt x="1987804" y="210185"/>
                  </a:lnTo>
                  <a:lnTo>
                    <a:pt x="1957705" y="244348"/>
                  </a:lnTo>
                  <a:lnTo>
                    <a:pt x="1926082" y="281305"/>
                  </a:lnTo>
                  <a:lnTo>
                    <a:pt x="1893316" y="320167"/>
                  </a:lnTo>
                  <a:lnTo>
                    <a:pt x="1859788" y="360426"/>
                  </a:lnTo>
                  <a:lnTo>
                    <a:pt x="1826006" y="400939"/>
                  </a:lnTo>
                  <a:lnTo>
                    <a:pt x="1792605" y="441071"/>
                  </a:lnTo>
                  <a:lnTo>
                    <a:pt x="1759966" y="479806"/>
                  </a:lnTo>
                  <a:lnTo>
                    <a:pt x="1728597" y="516255"/>
                  </a:lnTo>
                  <a:lnTo>
                    <a:pt x="1698625" y="550164"/>
                  </a:lnTo>
                  <a:lnTo>
                    <a:pt x="1670431" y="581025"/>
                  </a:lnTo>
                  <a:lnTo>
                    <a:pt x="1643888" y="608584"/>
                  </a:lnTo>
                  <a:lnTo>
                    <a:pt x="1622044" y="629793"/>
                  </a:lnTo>
                  <a:lnTo>
                    <a:pt x="1588008" y="659765"/>
                  </a:lnTo>
                  <a:lnTo>
                    <a:pt x="1554861" y="683768"/>
                  </a:lnTo>
                  <a:lnTo>
                    <a:pt x="1520825" y="703072"/>
                  </a:lnTo>
                  <a:lnTo>
                    <a:pt x="1484249" y="718693"/>
                  </a:lnTo>
                  <a:lnTo>
                    <a:pt x="1444625" y="731266"/>
                  </a:lnTo>
                  <a:lnTo>
                    <a:pt x="1403096" y="741299"/>
                  </a:lnTo>
                  <a:lnTo>
                    <a:pt x="1363853" y="748538"/>
                  </a:lnTo>
                  <a:lnTo>
                    <a:pt x="1333246" y="753110"/>
                  </a:lnTo>
                  <a:lnTo>
                    <a:pt x="1315466" y="755269"/>
                  </a:lnTo>
                  <a:lnTo>
                    <a:pt x="1309751" y="755777"/>
                  </a:lnTo>
                  <a:lnTo>
                    <a:pt x="1309497" y="755777"/>
                  </a:lnTo>
                  <a:lnTo>
                    <a:pt x="1190498" y="755777"/>
                  </a:lnTo>
                  <a:lnTo>
                    <a:pt x="1188466" y="755777"/>
                  </a:lnTo>
                  <a:lnTo>
                    <a:pt x="1176274" y="755777"/>
                  </a:lnTo>
                  <a:lnTo>
                    <a:pt x="1149731" y="755777"/>
                  </a:lnTo>
                  <a:lnTo>
                    <a:pt x="1111631" y="755777"/>
                  </a:lnTo>
                  <a:lnTo>
                    <a:pt x="1068832" y="755777"/>
                  </a:lnTo>
                  <a:lnTo>
                    <a:pt x="1026668" y="755777"/>
                  </a:lnTo>
                  <a:lnTo>
                    <a:pt x="987933" y="755777"/>
                  </a:lnTo>
                  <a:lnTo>
                    <a:pt x="952119" y="755777"/>
                  </a:lnTo>
                  <a:lnTo>
                    <a:pt x="917702" y="755777"/>
                  </a:lnTo>
                  <a:lnTo>
                    <a:pt x="882523" y="755777"/>
                  </a:lnTo>
                  <a:lnTo>
                    <a:pt x="877951" y="755777"/>
                  </a:lnTo>
                  <a:lnTo>
                    <a:pt x="846582" y="755777"/>
                  </a:lnTo>
                  <a:lnTo>
                    <a:pt x="813054" y="755777"/>
                  </a:lnTo>
                  <a:lnTo>
                    <a:pt x="776859" y="755777"/>
                  </a:lnTo>
                  <a:lnTo>
                    <a:pt x="738505" y="755777"/>
                  </a:lnTo>
                  <a:lnTo>
                    <a:pt x="698246" y="755777"/>
                  </a:lnTo>
                  <a:lnTo>
                    <a:pt x="656844" y="755777"/>
                  </a:lnTo>
                  <a:lnTo>
                    <a:pt x="615569" y="755777"/>
                  </a:lnTo>
                  <a:lnTo>
                    <a:pt x="575183" y="755777"/>
                  </a:lnTo>
                  <a:lnTo>
                    <a:pt x="536448" y="755777"/>
                  </a:lnTo>
                  <a:lnTo>
                    <a:pt x="500126" y="755777"/>
                  </a:lnTo>
                  <a:lnTo>
                    <a:pt x="466217" y="755777"/>
                  </a:lnTo>
                  <a:lnTo>
                    <a:pt x="434721" y="755777"/>
                  </a:lnTo>
                  <a:lnTo>
                    <a:pt x="431546" y="755777"/>
                  </a:lnTo>
                  <a:lnTo>
                    <a:pt x="396240" y="755777"/>
                  </a:lnTo>
                  <a:lnTo>
                    <a:pt x="361823" y="755777"/>
                  </a:lnTo>
                  <a:lnTo>
                    <a:pt x="326263" y="755777"/>
                  </a:lnTo>
                  <a:lnTo>
                    <a:pt x="287909" y="755777"/>
                  </a:lnTo>
                  <a:lnTo>
                    <a:pt x="246253" y="755777"/>
                  </a:lnTo>
                  <a:lnTo>
                    <a:pt x="203200" y="755777"/>
                  </a:lnTo>
                  <a:lnTo>
                    <a:pt x="164084" y="755777"/>
                  </a:lnTo>
                  <a:lnTo>
                    <a:pt x="135763" y="755777"/>
                  </a:lnTo>
                  <a:lnTo>
                    <a:pt x="121920" y="755777"/>
                  </a:lnTo>
                  <a:lnTo>
                    <a:pt x="119126" y="755777"/>
                  </a:lnTo>
                  <a:lnTo>
                    <a:pt x="118999" y="755777"/>
                  </a:lnTo>
                  <a:lnTo>
                    <a:pt x="0" y="755777"/>
                  </a:lnTo>
                  <a:close/>
                </a:path>
              </a:pathLst>
            </a:custGeom>
            <a:solidFill>
              <a:srgbClr val="FFFFBF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29" name="Forme libre 28">
              <a:extLst>
                <a:ext uri="{FF2B5EF4-FFF2-40B4-BE49-F238E27FC236}">
                  <a16:creationId xmlns:a16="http://schemas.microsoft.com/office/drawing/2014/main" id="{DC260D12-AF85-7022-72E0-BD0A2AD0EF4C}"/>
                </a:ext>
              </a:extLst>
            </p:cNvPr>
            <p:cNvSpPr/>
            <p:nvPr/>
          </p:nvSpPr>
          <p:spPr>
            <a:xfrm>
              <a:off x="636143" y="6046883"/>
              <a:ext cx="2499995" cy="251840"/>
            </a:xfrm>
            <a:custGeom>
              <a:avLst/>
              <a:gdLst>
                <a:gd name="connsiteX0" fmla="*/ 0 w 2499995"/>
                <a:gd name="connsiteY0" fmla="*/ 251841 h 251840"/>
                <a:gd name="connsiteX1" fmla="*/ 118999 w 2499995"/>
                <a:gd name="connsiteY1" fmla="*/ 251841 h 251840"/>
                <a:gd name="connsiteX2" fmla="*/ 121031 w 2499995"/>
                <a:gd name="connsiteY2" fmla="*/ 251841 h 251840"/>
                <a:gd name="connsiteX3" fmla="*/ 133223 w 2499995"/>
                <a:gd name="connsiteY3" fmla="*/ 251841 h 251840"/>
                <a:gd name="connsiteX4" fmla="*/ 159766 w 2499995"/>
                <a:gd name="connsiteY4" fmla="*/ 251841 h 251840"/>
                <a:gd name="connsiteX5" fmla="*/ 197866 w 2499995"/>
                <a:gd name="connsiteY5" fmla="*/ 251841 h 251840"/>
                <a:gd name="connsiteX6" fmla="*/ 240792 w 2499995"/>
                <a:gd name="connsiteY6" fmla="*/ 251841 h 251840"/>
                <a:gd name="connsiteX7" fmla="*/ 282829 w 2499995"/>
                <a:gd name="connsiteY7" fmla="*/ 251841 h 251840"/>
                <a:gd name="connsiteX8" fmla="*/ 321691 w 2499995"/>
                <a:gd name="connsiteY8" fmla="*/ 251841 h 251840"/>
                <a:gd name="connsiteX9" fmla="*/ 357378 w 2499995"/>
                <a:gd name="connsiteY9" fmla="*/ 251841 h 251840"/>
                <a:gd name="connsiteX10" fmla="*/ 391922 w 2499995"/>
                <a:gd name="connsiteY10" fmla="*/ 251841 h 251840"/>
                <a:gd name="connsiteX11" fmla="*/ 426974 w 2499995"/>
                <a:gd name="connsiteY11" fmla="*/ 251841 h 251840"/>
                <a:gd name="connsiteX12" fmla="*/ 431546 w 2499995"/>
                <a:gd name="connsiteY12" fmla="*/ 251841 h 251840"/>
                <a:gd name="connsiteX13" fmla="*/ 462915 w 2499995"/>
                <a:gd name="connsiteY13" fmla="*/ 251841 h 251840"/>
                <a:gd name="connsiteX14" fmla="*/ 496570 w 2499995"/>
                <a:gd name="connsiteY14" fmla="*/ 251841 h 251840"/>
                <a:gd name="connsiteX15" fmla="*/ 532638 w 2499995"/>
                <a:gd name="connsiteY15" fmla="*/ 251841 h 251840"/>
                <a:gd name="connsiteX16" fmla="*/ 571119 w 2499995"/>
                <a:gd name="connsiteY16" fmla="*/ 251841 h 251840"/>
                <a:gd name="connsiteX17" fmla="*/ 611378 w 2499995"/>
                <a:gd name="connsiteY17" fmla="*/ 251841 h 251840"/>
                <a:gd name="connsiteX18" fmla="*/ 652653 w 2499995"/>
                <a:gd name="connsiteY18" fmla="*/ 251841 h 251840"/>
                <a:gd name="connsiteX19" fmla="*/ 694055 w 2499995"/>
                <a:gd name="connsiteY19" fmla="*/ 251841 h 251840"/>
                <a:gd name="connsiteX20" fmla="*/ 734441 w 2499995"/>
                <a:gd name="connsiteY20" fmla="*/ 251841 h 251840"/>
                <a:gd name="connsiteX21" fmla="*/ 773049 w 2499995"/>
                <a:gd name="connsiteY21" fmla="*/ 251841 h 251840"/>
                <a:gd name="connsiteX22" fmla="*/ 809371 w 2499995"/>
                <a:gd name="connsiteY22" fmla="*/ 251841 h 251840"/>
                <a:gd name="connsiteX23" fmla="*/ 843280 w 2499995"/>
                <a:gd name="connsiteY23" fmla="*/ 251841 h 251840"/>
                <a:gd name="connsiteX24" fmla="*/ 874903 w 2499995"/>
                <a:gd name="connsiteY24" fmla="*/ 251841 h 251840"/>
                <a:gd name="connsiteX25" fmla="*/ 877951 w 2499995"/>
                <a:gd name="connsiteY25" fmla="*/ 251841 h 251840"/>
                <a:gd name="connsiteX26" fmla="*/ 913384 w 2499995"/>
                <a:gd name="connsiteY26" fmla="*/ 251841 h 251840"/>
                <a:gd name="connsiteX27" fmla="*/ 947801 w 2499995"/>
                <a:gd name="connsiteY27" fmla="*/ 251841 h 251840"/>
                <a:gd name="connsiteX28" fmla="*/ 983234 w 2499995"/>
                <a:gd name="connsiteY28" fmla="*/ 251841 h 251840"/>
                <a:gd name="connsiteX29" fmla="*/ 1021588 w 2499995"/>
                <a:gd name="connsiteY29" fmla="*/ 251841 h 251840"/>
                <a:gd name="connsiteX30" fmla="*/ 1063371 w 2499995"/>
                <a:gd name="connsiteY30" fmla="*/ 251841 h 251840"/>
                <a:gd name="connsiteX31" fmla="*/ 1106424 w 2499995"/>
                <a:gd name="connsiteY31" fmla="*/ 251841 h 251840"/>
                <a:gd name="connsiteX32" fmla="*/ 1145413 w 2499995"/>
                <a:gd name="connsiteY32" fmla="*/ 251841 h 251840"/>
                <a:gd name="connsiteX33" fmla="*/ 1173734 w 2499995"/>
                <a:gd name="connsiteY33" fmla="*/ 251841 h 251840"/>
                <a:gd name="connsiteX34" fmla="*/ 1187704 w 2499995"/>
                <a:gd name="connsiteY34" fmla="*/ 251841 h 251840"/>
                <a:gd name="connsiteX35" fmla="*/ 1190498 w 2499995"/>
                <a:gd name="connsiteY35" fmla="*/ 251841 h 251840"/>
                <a:gd name="connsiteX36" fmla="*/ 1190498 w 2499995"/>
                <a:gd name="connsiteY36" fmla="*/ 251841 h 251840"/>
                <a:gd name="connsiteX37" fmla="*/ 1309497 w 2499995"/>
                <a:gd name="connsiteY37" fmla="*/ 251841 h 251840"/>
                <a:gd name="connsiteX38" fmla="*/ 1311529 w 2499995"/>
                <a:gd name="connsiteY38" fmla="*/ 251841 h 251840"/>
                <a:gd name="connsiteX39" fmla="*/ 1323721 w 2499995"/>
                <a:gd name="connsiteY39" fmla="*/ 251841 h 251840"/>
                <a:gd name="connsiteX40" fmla="*/ 1350264 w 2499995"/>
                <a:gd name="connsiteY40" fmla="*/ 251841 h 251840"/>
                <a:gd name="connsiteX41" fmla="*/ 1388364 w 2499995"/>
                <a:gd name="connsiteY41" fmla="*/ 251841 h 251840"/>
                <a:gd name="connsiteX42" fmla="*/ 1431290 w 2499995"/>
                <a:gd name="connsiteY42" fmla="*/ 251841 h 251840"/>
                <a:gd name="connsiteX43" fmla="*/ 1473327 w 2499995"/>
                <a:gd name="connsiteY43" fmla="*/ 251841 h 251840"/>
                <a:gd name="connsiteX44" fmla="*/ 1512062 w 2499995"/>
                <a:gd name="connsiteY44" fmla="*/ 251841 h 251840"/>
                <a:gd name="connsiteX45" fmla="*/ 1547876 w 2499995"/>
                <a:gd name="connsiteY45" fmla="*/ 251841 h 251840"/>
                <a:gd name="connsiteX46" fmla="*/ 1582293 w 2499995"/>
                <a:gd name="connsiteY46" fmla="*/ 251841 h 251840"/>
                <a:gd name="connsiteX47" fmla="*/ 1617472 w 2499995"/>
                <a:gd name="connsiteY47" fmla="*/ 251841 h 251840"/>
                <a:gd name="connsiteX48" fmla="*/ 1622044 w 2499995"/>
                <a:gd name="connsiteY48" fmla="*/ 251841 h 251840"/>
                <a:gd name="connsiteX49" fmla="*/ 1653413 w 2499995"/>
                <a:gd name="connsiteY49" fmla="*/ 251841 h 251840"/>
                <a:gd name="connsiteX50" fmla="*/ 1687068 w 2499995"/>
                <a:gd name="connsiteY50" fmla="*/ 251841 h 251840"/>
                <a:gd name="connsiteX51" fmla="*/ 1723136 w 2499995"/>
                <a:gd name="connsiteY51" fmla="*/ 251841 h 251840"/>
                <a:gd name="connsiteX52" fmla="*/ 1761617 w 2499995"/>
                <a:gd name="connsiteY52" fmla="*/ 251841 h 251840"/>
                <a:gd name="connsiteX53" fmla="*/ 1801876 w 2499995"/>
                <a:gd name="connsiteY53" fmla="*/ 251841 h 251840"/>
                <a:gd name="connsiteX54" fmla="*/ 1843151 w 2499995"/>
                <a:gd name="connsiteY54" fmla="*/ 251841 h 251840"/>
                <a:gd name="connsiteX55" fmla="*/ 1884426 w 2499995"/>
                <a:gd name="connsiteY55" fmla="*/ 251841 h 251840"/>
                <a:gd name="connsiteX56" fmla="*/ 1924939 w 2499995"/>
                <a:gd name="connsiteY56" fmla="*/ 251841 h 251840"/>
                <a:gd name="connsiteX57" fmla="*/ 1963547 w 2499995"/>
                <a:gd name="connsiteY57" fmla="*/ 251841 h 251840"/>
                <a:gd name="connsiteX58" fmla="*/ 1999869 w 2499995"/>
                <a:gd name="connsiteY58" fmla="*/ 251841 h 251840"/>
                <a:gd name="connsiteX59" fmla="*/ 2033778 w 2499995"/>
                <a:gd name="connsiteY59" fmla="*/ 251841 h 251840"/>
                <a:gd name="connsiteX60" fmla="*/ 2065401 w 2499995"/>
                <a:gd name="connsiteY60" fmla="*/ 251841 h 251840"/>
                <a:gd name="connsiteX61" fmla="*/ 2068449 w 2499995"/>
                <a:gd name="connsiteY61" fmla="*/ 251841 h 251840"/>
                <a:gd name="connsiteX62" fmla="*/ 2103882 w 2499995"/>
                <a:gd name="connsiteY62" fmla="*/ 251841 h 251840"/>
                <a:gd name="connsiteX63" fmla="*/ 2138299 w 2499995"/>
                <a:gd name="connsiteY63" fmla="*/ 251841 h 251840"/>
                <a:gd name="connsiteX64" fmla="*/ 2173732 w 2499995"/>
                <a:gd name="connsiteY64" fmla="*/ 251841 h 251840"/>
                <a:gd name="connsiteX65" fmla="*/ 2212086 w 2499995"/>
                <a:gd name="connsiteY65" fmla="*/ 251841 h 251840"/>
                <a:gd name="connsiteX66" fmla="*/ 2253869 w 2499995"/>
                <a:gd name="connsiteY66" fmla="*/ 251841 h 251840"/>
                <a:gd name="connsiteX67" fmla="*/ 2296922 w 2499995"/>
                <a:gd name="connsiteY67" fmla="*/ 251841 h 251840"/>
                <a:gd name="connsiteX68" fmla="*/ 2335911 w 2499995"/>
                <a:gd name="connsiteY68" fmla="*/ 251841 h 251840"/>
                <a:gd name="connsiteX69" fmla="*/ 2364232 w 2499995"/>
                <a:gd name="connsiteY69" fmla="*/ 251841 h 251840"/>
                <a:gd name="connsiteX70" fmla="*/ 2378202 w 2499995"/>
                <a:gd name="connsiteY70" fmla="*/ 251841 h 251840"/>
                <a:gd name="connsiteX71" fmla="*/ 2380996 w 2499995"/>
                <a:gd name="connsiteY71" fmla="*/ 251841 h 251840"/>
                <a:gd name="connsiteX72" fmla="*/ 2380996 w 2499995"/>
                <a:gd name="connsiteY72" fmla="*/ 251841 h 251840"/>
                <a:gd name="connsiteX73" fmla="*/ 2499995 w 2499995"/>
                <a:gd name="connsiteY73" fmla="*/ 251841 h 251840"/>
                <a:gd name="connsiteX74" fmla="*/ 2499995 w 2499995"/>
                <a:gd name="connsiteY74" fmla="*/ 0 h 251840"/>
                <a:gd name="connsiteX75" fmla="*/ 2380996 w 2499995"/>
                <a:gd name="connsiteY75" fmla="*/ 0 h 251840"/>
                <a:gd name="connsiteX76" fmla="*/ 2378964 w 2499995"/>
                <a:gd name="connsiteY76" fmla="*/ 0 h 251840"/>
                <a:gd name="connsiteX77" fmla="*/ 2366772 w 2499995"/>
                <a:gd name="connsiteY77" fmla="*/ 0 h 251840"/>
                <a:gd name="connsiteX78" fmla="*/ 2340229 w 2499995"/>
                <a:gd name="connsiteY78" fmla="*/ 0 h 251840"/>
                <a:gd name="connsiteX79" fmla="*/ 2302129 w 2499995"/>
                <a:gd name="connsiteY79" fmla="*/ 0 h 251840"/>
                <a:gd name="connsiteX80" fmla="*/ 2259203 w 2499995"/>
                <a:gd name="connsiteY80" fmla="*/ 0 h 251840"/>
                <a:gd name="connsiteX81" fmla="*/ 2217166 w 2499995"/>
                <a:gd name="connsiteY81" fmla="*/ 0 h 251840"/>
                <a:gd name="connsiteX82" fmla="*/ 2178431 w 2499995"/>
                <a:gd name="connsiteY82" fmla="*/ 0 h 251840"/>
                <a:gd name="connsiteX83" fmla="*/ 2142617 w 2499995"/>
                <a:gd name="connsiteY83" fmla="*/ 0 h 251840"/>
                <a:gd name="connsiteX84" fmla="*/ 2108200 w 2499995"/>
                <a:gd name="connsiteY84" fmla="*/ 0 h 251840"/>
                <a:gd name="connsiteX85" fmla="*/ 2073021 w 2499995"/>
                <a:gd name="connsiteY85" fmla="*/ 0 h 251840"/>
                <a:gd name="connsiteX86" fmla="*/ 2068449 w 2499995"/>
                <a:gd name="connsiteY86" fmla="*/ 0 h 251840"/>
                <a:gd name="connsiteX87" fmla="*/ 2037080 w 2499995"/>
                <a:gd name="connsiteY87" fmla="*/ 0 h 251840"/>
                <a:gd name="connsiteX88" fmla="*/ 2003552 w 2499995"/>
                <a:gd name="connsiteY88" fmla="*/ 0 h 251840"/>
                <a:gd name="connsiteX89" fmla="*/ 1967357 w 2499995"/>
                <a:gd name="connsiteY89" fmla="*/ 0 h 251840"/>
                <a:gd name="connsiteX90" fmla="*/ 1929003 w 2499995"/>
                <a:gd name="connsiteY90" fmla="*/ 0 h 251840"/>
                <a:gd name="connsiteX91" fmla="*/ 1888744 w 2499995"/>
                <a:gd name="connsiteY91" fmla="*/ 0 h 251840"/>
                <a:gd name="connsiteX92" fmla="*/ 1847342 w 2499995"/>
                <a:gd name="connsiteY92" fmla="*/ 0 h 251840"/>
                <a:gd name="connsiteX93" fmla="*/ 1806067 w 2499995"/>
                <a:gd name="connsiteY93" fmla="*/ 0 h 251840"/>
                <a:gd name="connsiteX94" fmla="*/ 1765554 w 2499995"/>
                <a:gd name="connsiteY94" fmla="*/ 0 h 251840"/>
                <a:gd name="connsiteX95" fmla="*/ 1726946 w 2499995"/>
                <a:gd name="connsiteY95" fmla="*/ 0 h 251840"/>
                <a:gd name="connsiteX96" fmla="*/ 1690624 w 2499995"/>
                <a:gd name="connsiteY96" fmla="*/ 0 h 251840"/>
                <a:gd name="connsiteX97" fmla="*/ 1656715 w 2499995"/>
                <a:gd name="connsiteY97" fmla="*/ 0 h 251840"/>
                <a:gd name="connsiteX98" fmla="*/ 1625219 w 2499995"/>
                <a:gd name="connsiteY98" fmla="*/ 0 h 251840"/>
                <a:gd name="connsiteX99" fmla="*/ 1622044 w 2499995"/>
                <a:gd name="connsiteY99" fmla="*/ 0 h 251840"/>
                <a:gd name="connsiteX100" fmla="*/ 1586738 w 2499995"/>
                <a:gd name="connsiteY100" fmla="*/ 0 h 251840"/>
                <a:gd name="connsiteX101" fmla="*/ 1552321 w 2499995"/>
                <a:gd name="connsiteY101" fmla="*/ 0 h 251840"/>
                <a:gd name="connsiteX102" fmla="*/ 1516761 w 2499995"/>
                <a:gd name="connsiteY102" fmla="*/ 0 h 251840"/>
                <a:gd name="connsiteX103" fmla="*/ 1478407 w 2499995"/>
                <a:gd name="connsiteY103" fmla="*/ 0 h 251840"/>
                <a:gd name="connsiteX104" fmla="*/ 1436624 w 2499995"/>
                <a:gd name="connsiteY104" fmla="*/ 0 h 251840"/>
                <a:gd name="connsiteX105" fmla="*/ 1393571 w 2499995"/>
                <a:gd name="connsiteY105" fmla="*/ 0 h 251840"/>
                <a:gd name="connsiteX106" fmla="*/ 1354582 w 2499995"/>
                <a:gd name="connsiteY106" fmla="*/ 0 h 251840"/>
                <a:gd name="connsiteX107" fmla="*/ 1326261 w 2499995"/>
                <a:gd name="connsiteY107" fmla="*/ 0 h 251840"/>
                <a:gd name="connsiteX108" fmla="*/ 1312418 w 2499995"/>
                <a:gd name="connsiteY108" fmla="*/ 0 h 251840"/>
                <a:gd name="connsiteX109" fmla="*/ 1309497 w 2499995"/>
                <a:gd name="connsiteY109" fmla="*/ 0 h 251840"/>
                <a:gd name="connsiteX110" fmla="*/ 1309497 w 2499995"/>
                <a:gd name="connsiteY110" fmla="*/ 0 h 251840"/>
                <a:gd name="connsiteX111" fmla="*/ 1190498 w 2499995"/>
                <a:gd name="connsiteY111" fmla="*/ 0 h 251840"/>
                <a:gd name="connsiteX112" fmla="*/ 1188466 w 2499995"/>
                <a:gd name="connsiteY112" fmla="*/ 0 h 251840"/>
                <a:gd name="connsiteX113" fmla="*/ 1176274 w 2499995"/>
                <a:gd name="connsiteY113" fmla="*/ 0 h 251840"/>
                <a:gd name="connsiteX114" fmla="*/ 1149731 w 2499995"/>
                <a:gd name="connsiteY114" fmla="*/ 0 h 251840"/>
                <a:gd name="connsiteX115" fmla="*/ 1111631 w 2499995"/>
                <a:gd name="connsiteY115" fmla="*/ 0 h 251840"/>
                <a:gd name="connsiteX116" fmla="*/ 1068832 w 2499995"/>
                <a:gd name="connsiteY116" fmla="*/ 0 h 251840"/>
                <a:gd name="connsiteX117" fmla="*/ 1026668 w 2499995"/>
                <a:gd name="connsiteY117" fmla="*/ 0 h 251840"/>
                <a:gd name="connsiteX118" fmla="*/ 987933 w 2499995"/>
                <a:gd name="connsiteY118" fmla="*/ 0 h 251840"/>
                <a:gd name="connsiteX119" fmla="*/ 952119 w 2499995"/>
                <a:gd name="connsiteY119" fmla="*/ 0 h 251840"/>
                <a:gd name="connsiteX120" fmla="*/ 917702 w 2499995"/>
                <a:gd name="connsiteY120" fmla="*/ 0 h 251840"/>
                <a:gd name="connsiteX121" fmla="*/ 882523 w 2499995"/>
                <a:gd name="connsiteY121" fmla="*/ 0 h 251840"/>
                <a:gd name="connsiteX122" fmla="*/ 877951 w 2499995"/>
                <a:gd name="connsiteY122" fmla="*/ 0 h 251840"/>
                <a:gd name="connsiteX123" fmla="*/ 846582 w 2499995"/>
                <a:gd name="connsiteY123" fmla="*/ 0 h 251840"/>
                <a:gd name="connsiteX124" fmla="*/ 813054 w 2499995"/>
                <a:gd name="connsiteY124" fmla="*/ 0 h 251840"/>
                <a:gd name="connsiteX125" fmla="*/ 776859 w 2499995"/>
                <a:gd name="connsiteY125" fmla="*/ 0 h 251840"/>
                <a:gd name="connsiteX126" fmla="*/ 738505 w 2499995"/>
                <a:gd name="connsiteY126" fmla="*/ 0 h 251840"/>
                <a:gd name="connsiteX127" fmla="*/ 698246 w 2499995"/>
                <a:gd name="connsiteY127" fmla="*/ 0 h 251840"/>
                <a:gd name="connsiteX128" fmla="*/ 656844 w 2499995"/>
                <a:gd name="connsiteY128" fmla="*/ 0 h 251840"/>
                <a:gd name="connsiteX129" fmla="*/ 615569 w 2499995"/>
                <a:gd name="connsiteY129" fmla="*/ 0 h 251840"/>
                <a:gd name="connsiteX130" fmla="*/ 575183 w 2499995"/>
                <a:gd name="connsiteY130" fmla="*/ 0 h 251840"/>
                <a:gd name="connsiteX131" fmla="*/ 536448 w 2499995"/>
                <a:gd name="connsiteY131" fmla="*/ 0 h 251840"/>
                <a:gd name="connsiteX132" fmla="*/ 500126 w 2499995"/>
                <a:gd name="connsiteY132" fmla="*/ 0 h 251840"/>
                <a:gd name="connsiteX133" fmla="*/ 466217 w 2499995"/>
                <a:gd name="connsiteY133" fmla="*/ 0 h 251840"/>
                <a:gd name="connsiteX134" fmla="*/ 434721 w 2499995"/>
                <a:gd name="connsiteY134" fmla="*/ 0 h 251840"/>
                <a:gd name="connsiteX135" fmla="*/ 431546 w 2499995"/>
                <a:gd name="connsiteY135" fmla="*/ 0 h 251840"/>
                <a:gd name="connsiteX136" fmla="*/ 396240 w 2499995"/>
                <a:gd name="connsiteY136" fmla="*/ 0 h 251840"/>
                <a:gd name="connsiteX137" fmla="*/ 361823 w 2499995"/>
                <a:gd name="connsiteY137" fmla="*/ 0 h 251840"/>
                <a:gd name="connsiteX138" fmla="*/ 326263 w 2499995"/>
                <a:gd name="connsiteY138" fmla="*/ 0 h 251840"/>
                <a:gd name="connsiteX139" fmla="*/ 287909 w 2499995"/>
                <a:gd name="connsiteY139" fmla="*/ 0 h 251840"/>
                <a:gd name="connsiteX140" fmla="*/ 246253 w 2499995"/>
                <a:gd name="connsiteY140" fmla="*/ 0 h 251840"/>
                <a:gd name="connsiteX141" fmla="*/ 203200 w 2499995"/>
                <a:gd name="connsiteY141" fmla="*/ 0 h 251840"/>
                <a:gd name="connsiteX142" fmla="*/ 164084 w 2499995"/>
                <a:gd name="connsiteY142" fmla="*/ 0 h 251840"/>
                <a:gd name="connsiteX143" fmla="*/ 135763 w 2499995"/>
                <a:gd name="connsiteY143" fmla="*/ 0 h 251840"/>
                <a:gd name="connsiteX144" fmla="*/ 121920 w 2499995"/>
                <a:gd name="connsiteY144" fmla="*/ 0 h 251840"/>
                <a:gd name="connsiteX145" fmla="*/ 119126 w 2499995"/>
                <a:gd name="connsiteY145" fmla="*/ 0 h 251840"/>
                <a:gd name="connsiteX146" fmla="*/ 118999 w 2499995"/>
                <a:gd name="connsiteY146" fmla="*/ 0 h 251840"/>
                <a:gd name="connsiteX147" fmla="*/ 0 w 2499995"/>
                <a:gd name="connsiteY147" fmla="*/ 0 h 2518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251840">
                  <a:moveTo>
                    <a:pt x="0" y="251841"/>
                  </a:moveTo>
                  <a:lnTo>
                    <a:pt x="118999" y="251841"/>
                  </a:lnTo>
                  <a:lnTo>
                    <a:pt x="121031" y="251841"/>
                  </a:lnTo>
                  <a:lnTo>
                    <a:pt x="133223" y="251841"/>
                  </a:lnTo>
                  <a:lnTo>
                    <a:pt x="159766" y="251841"/>
                  </a:lnTo>
                  <a:lnTo>
                    <a:pt x="197866" y="251841"/>
                  </a:lnTo>
                  <a:lnTo>
                    <a:pt x="240792" y="251841"/>
                  </a:lnTo>
                  <a:lnTo>
                    <a:pt x="282829" y="251841"/>
                  </a:lnTo>
                  <a:lnTo>
                    <a:pt x="321691" y="251841"/>
                  </a:lnTo>
                  <a:lnTo>
                    <a:pt x="357378" y="251841"/>
                  </a:lnTo>
                  <a:lnTo>
                    <a:pt x="391922" y="251841"/>
                  </a:lnTo>
                  <a:lnTo>
                    <a:pt x="426974" y="251841"/>
                  </a:lnTo>
                  <a:lnTo>
                    <a:pt x="431546" y="251841"/>
                  </a:lnTo>
                  <a:lnTo>
                    <a:pt x="462915" y="251841"/>
                  </a:lnTo>
                  <a:lnTo>
                    <a:pt x="496570" y="251841"/>
                  </a:lnTo>
                  <a:lnTo>
                    <a:pt x="532638" y="251841"/>
                  </a:lnTo>
                  <a:lnTo>
                    <a:pt x="571119" y="251841"/>
                  </a:lnTo>
                  <a:lnTo>
                    <a:pt x="611378" y="251841"/>
                  </a:lnTo>
                  <a:lnTo>
                    <a:pt x="652653" y="251841"/>
                  </a:lnTo>
                  <a:lnTo>
                    <a:pt x="694055" y="251841"/>
                  </a:lnTo>
                  <a:lnTo>
                    <a:pt x="734441" y="251841"/>
                  </a:lnTo>
                  <a:lnTo>
                    <a:pt x="773049" y="251841"/>
                  </a:lnTo>
                  <a:lnTo>
                    <a:pt x="809371" y="251841"/>
                  </a:lnTo>
                  <a:lnTo>
                    <a:pt x="843280" y="251841"/>
                  </a:lnTo>
                  <a:lnTo>
                    <a:pt x="874903" y="251841"/>
                  </a:lnTo>
                  <a:lnTo>
                    <a:pt x="877951" y="251841"/>
                  </a:lnTo>
                  <a:lnTo>
                    <a:pt x="913384" y="251841"/>
                  </a:lnTo>
                  <a:lnTo>
                    <a:pt x="947801" y="251841"/>
                  </a:lnTo>
                  <a:lnTo>
                    <a:pt x="983234" y="251841"/>
                  </a:lnTo>
                  <a:lnTo>
                    <a:pt x="1021588" y="251841"/>
                  </a:lnTo>
                  <a:lnTo>
                    <a:pt x="1063371" y="251841"/>
                  </a:lnTo>
                  <a:lnTo>
                    <a:pt x="1106424" y="251841"/>
                  </a:lnTo>
                  <a:lnTo>
                    <a:pt x="1145413" y="251841"/>
                  </a:lnTo>
                  <a:lnTo>
                    <a:pt x="1173734" y="251841"/>
                  </a:lnTo>
                  <a:lnTo>
                    <a:pt x="1187704" y="251841"/>
                  </a:lnTo>
                  <a:lnTo>
                    <a:pt x="1190498" y="251841"/>
                  </a:lnTo>
                  <a:lnTo>
                    <a:pt x="1190498" y="251841"/>
                  </a:lnTo>
                  <a:lnTo>
                    <a:pt x="1309497" y="251841"/>
                  </a:lnTo>
                  <a:lnTo>
                    <a:pt x="1311529" y="251841"/>
                  </a:lnTo>
                  <a:lnTo>
                    <a:pt x="1323721" y="251841"/>
                  </a:lnTo>
                  <a:lnTo>
                    <a:pt x="1350264" y="251841"/>
                  </a:lnTo>
                  <a:lnTo>
                    <a:pt x="1388364" y="251841"/>
                  </a:lnTo>
                  <a:lnTo>
                    <a:pt x="1431290" y="251841"/>
                  </a:lnTo>
                  <a:lnTo>
                    <a:pt x="1473327" y="251841"/>
                  </a:lnTo>
                  <a:lnTo>
                    <a:pt x="1512062" y="251841"/>
                  </a:lnTo>
                  <a:lnTo>
                    <a:pt x="1547876" y="251841"/>
                  </a:lnTo>
                  <a:lnTo>
                    <a:pt x="1582293" y="251841"/>
                  </a:lnTo>
                  <a:lnTo>
                    <a:pt x="1617472" y="251841"/>
                  </a:lnTo>
                  <a:lnTo>
                    <a:pt x="1622044" y="251841"/>
                  </a:lnTo>
                  <a:lnTo>
                    <a:pt x="1653413" y="251841"/>
                  </a:lnTo>
                  <a:lnTo>
                    <a:pt x="1687068" y="251841"/>
                  </a:lnTo>
                  <a:lnTo>
                    <a:pt x="1723136" y="251841"/>
                  </a:lnTo>
                  <a:lnTo>
                    <a:pt x="1761617" y="251841"/>
                  </a:lnTo>
                  <a:lnTo>
                    <a:pt x="1801876" y="251841"/>
                  </a:lnTo>
                  <a:lnTo>
                    <a:pt x="1843151" y="251841"/>
                  </a:lnTo>
                  <a:lnTo>
                    <a:pt x="1884426" y="251841"/>
                  </a:lnTo>
                  <a:lnTo>
                    <a:pt x="1924939" y="251841"/>
                  </a:lnTo>
                  <a:lnTo>
                    <a:pt x="1963547" y="251841"/>
                  </a:lnTo>
                  <a:lnTo>
                    <a:pt x="1999869" y="251841"/>
                  </a:lnTo>
                  <a:lnTo>
                    <a:pt x="2033778" y="251841"/>
                  </a:lnTo>
                  <a:lnTo>
                    <a:pt x="2065401" y="251841"/>
                  </a:lnTo>
                  <a:lnTo>
                    <a:pt x="2068449" y="251841"/>
                  </a:lnTo>
                  <a:lnTo>
                    <a:pt x="2103882" y="251841"/>
                  </a:lnTo>
                  <a:lnTo>
                    <a:pt x="2138299" y="251841"/>
                  </a:lnTo>
                  <a:lnTo>
                    <a:pt x="2173732" y="251841"/>
                  </a:lnTo>
                  <a:lnTo>
                    <a:pt x="2212086" y="251841"/>
                  </a:lnTo>
                  <a:lnTo>
                    <a:pt x="2253869" y="251841"/>
                  </a:lnTo>
                  <a:lnTo>
                    <a:pt x="2296922" y="251841"/>
                  </a:lnTo>
                  <a:lnTo>
                    <a:pt x="2335911" y="251841"/>
                  </a:lnTo>
                  <a:lnTo>
                    <a:pt x="2364232" y="251841"/>
                  </a:lnTo>
                  <a:lnTo>
                    <a:pt x="2378202" y="251841"/>
                  </a:lnTo>
                  <a:lnTo>
                    <a:pt x="2380996" y="251841"/>
                  </a:lnTo>
                  <a:lnTo>
                    <a:pt x="2380996" y="251841"/>
                  </a:lnTo>
                  <a:lnTo>
                    <a:pt x="2499995" y="251841"/>
                  </a:lnTo>
                  <a:lnTo>
                    <a:pt x="2499995" y="0"/>
                  </a:lnTo>
                  <a:lnTo>
                    <a:pt x="2380996" y="0"/>
                  </a:lnTo>
                  <a:lnTo>
                    <a:pt x="2378964" y="0"/>
                  </a:lnTo>
                  <a:lnTo>
                    <a:pt x="2366772" y="0"/>
                  </a:lnTo>
                  <a:lnTo>
                    <a:pt x="2340229" y="0"/>
                  </a:lnTo>
                  <a:lnTo>
                    <a:pt x="2302129" y="0"/>
                  </a:lnTo>
                  <a:lnTo>
                    <a:pt x="2259203" y="0"/>
                  </a:lnTo>
                  <a:lnTo>
                    <a:pt x="2217166" y="0"/>
                  </a:lnTo>
                  <a:lnTo>
                    <a:pt x="2178431" y="0"/>
                  </a:lnTo>
                  <a:lnTo>
                    <a:pt x="2142617" y="0"/>
                  </a:lnTo>
                  <a:lnTo>
                    <a:pt x="2108200" y="0"/>
                  </a:lnTo>
                  <a:lnTo>
                    <a:pt x="2073021" y="0"/>
                  </a:lnTo>
                  <a:lnTo>
                    <a:pt x="2068449" y="0"/>
                  </a:lnTo>
                  <a:lnTo>
                    <a:pt x="2037080" y="0"/>
                  </a:lnTo>
                  <a:lnTo>
                    <a:pt x="2003552" y="0"/>
                  </a:lnTo>
                  <a:lnTo>
                    <a:pt x="1967357" y="0"/>
                  </a:lnTo>
                  <a:lnTo>
                    <a:pt x="1929003" y="0"/>
                  </a:lnTo>
                  <a:lnTo>
                    <a:pt x="1888744" y="0"/>
                  </a:lnTo>
                  <a:lnTo>
                    <a:pt x="1847342" y="0"/>
                  </a:lnTo>
                  <a:lnTo>
                    <a:pt x="1806067" y="0"/>
                  </a:lnTo>
                  <a:lnTo>
                    <a:pt x="1765554" y="0"/>
                  </a:lnTo>
                  <a:lnTo>
                    <a:pt x="1726946" y="0"/>
                  </a:lnTo>
                  <a:lnTo>
                    <a:pt x="1690624" y="0"/>
                  </a:lnTo>
                  <a:lnTo>
                    <a:pt x="1656715" y="0"/>
                  </a:lnTo>
                  <a:lnTo>
                    <a:pt x="1625219" y="0"/>
                  </a:lnTo>
                  <a:lnTo>
                    <a:pt x="1622044" y="0"/>
                  </a:lnTo>
                  <a:lnTo>
                    <a:pt x="1586738" y="0"/>
                  </a:lnTo>
                  <a:lnTo>
                    <a:pt x="1552321" y="0"/>
                  </a:lnTo>
                  <a:lnTo>
                    <a:pt x="1516761" y="0"/>
                  </a:lnTo>
                  <a:lnTo>
                    <a:pt x="1478407" y="0"/>
                  </a:lnTo>
                  <a:lnTo>
                    <a:pt x="1436624" y="0"/>
                  </a:lnTo>
                  <a:lnTo>
                    <a:pt x="1393571" y="0"/>
                  </a:lnTo>
                  <a:lnTo>
                    <a:pt x="1354582" y="0"/>
                  </a:lnTo>
                  <a:lnTo>
                    <a:pt x="1326261" y="0"/>
                  </a:lnTo>
                  <a:lnTo>
                    <a:pt x="1312418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832" y="0"/>
                  </a:lnTo>
                  <a:lnTo>
                    <a:pt x="1026668" y="0"/>
                  </a:lnTo>
                  <a:lnTo>
                    <a:pt x="987933" y="0"/>
                  </a:lnTo>
                  <a:lnTo>
                    <a:pt x="952119" y="0"/>
                  </a:lnTo>
                  <a:lnTo>
                    <a:pt x="917702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3054" y="0"/>
                  </a:lnTo>
                  <a:lnTo>
                    <a:pt x="776859" y="0"/>
                  </a:lnTo>
                  <a:lnTo>
                    <a:pt x="738505" y="0"/>
                  </a:lnTo>
                  <a:lnTo>
                    <a:pt x="698246" y="0"/>
                  </a:lnTo>
                  <a:lnTo>
                    <a:pt x="656844" y="0"/>
                  </a:lnTo>
                  <a:lnTo>
                    <a:pt x="615569" y="0"/>
                  </a:lnTo>
                  <a:lnTo>
                    <a:pt x="575183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721" y="0"/>
                  </a:lnTo>
                  <a:lnTo>
                    <a:pt x="431546" y="0"/>
                  </a:lnTo>
                  <a:lnTo>
                    <a:pt x="396240" y="0"/>
                  </a:lnTo>
                  <a:lnTo>
                    <a:pt x="361823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253" y="0"/>
                  </a:lnTo>
                  <a:lnTo>
                    <a:pt x="203200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920" y="0"/>
                  </a:lnTo>
                  <a:lnTo>
                    <a:pt x="119126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DAE61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0" name="Forme libre 29">
              <a:extLst>
                <a:ext uri="{FF2B5EF4-FFF2-40B4-BE49-F238E27FC236}">
                  <a16:creationId xmlns:a16="http://schemas.microsoft.com/office/drawing/2014/main" id="{24353C3B-F59A-930F-130A-947297E31372}"/>
                </a:ext>
              </a:extLst>
            </p:cNvPr>
            <p:cNvSpPr/>
            <p:nvPr/>
          </p:nvSpPr>
          <p:spPr>
            <a:xfrm>
              <a:off x="636143" y="6298723"/>
              <a:ext cx="2499995" cy="193802"/>
            </a:xfrm>
            <a:custGeom>
              <a:avLst/>
              <a:gdLst>
                <a:gd name="connsiteX0" fmla="*/ 0 w 2499995"/>
                <a:gd name="connsiteY0" fmla="*/ 193802 h 193802"/>
                <a:gd name="connsiteX1" fmla="*/ 118999 w 2499995"/>
                <a:gd name="connsiteY1" fmla="*/ 193802 h 193802"/>
                <a:gd name="connsiteX2" fmla="*/ 121031 w 2499995"/>
                <a:gd name="connsiteY2" fmla="*/ 193802 h 193802"/>
                <a:gd name="connsiteX3" fmla="*/ 133223 w 2499995"/>
                <a:gd name="connsiteY3" fmla="*/ 193802 h 193802"/>
                <a:gd name="connsiteX4" fmla="*/ 159766 w 2499995"/>
                <a:gd name="connsiteY4" fmla="*/ 193802 h 193802"/>
                <a:gd name="connsiteX5" fmla="*/ 197866 w 2499995"/>
                <a:gd name="connsiteY5" fmla="*/ 193802 h 193802"/>
                <a:gd name="connsiteX6" fmla="*/ 240792 w 2499995"/>
                <a:gd name="connsiteY6" fmla="*/ 193802 h 193802"/>
                <a:gd name="connsiteX7" fmla="*/ 282829 w 2499995"/>
                <a:gd name="connsiteY7" fmla="*/ 193802 h 193802"/>
                <a:gd name="connsiteX8" fmla="*/ 321691 w 2499995"/>
                <a:gd name="connsiteY8" fmla="*/ 193802 h 193802"/>
                <a:gd name="connsiteX9" fmla="*/ 357378 w 2499995"/>
                <a:gd name="connsiteY9" fmla="*/ 193802 h 193802"/>
                <a:gd name="connsiteX10" fmla="*/ 391922 w 2499995"/>
                <a:gd name="connsiteY10" fmla="*/ 193802 h 193802"/>
                <a:gd name="connsiteX11" fmla="*/ 426974 w 2499995"/>
                <a:gd name="connsiteY11" fmla="*/ 193802 h 193802"/>
                <a:gd name="connsiteX12" fmla="*/ 431546 w 2499995"/>
                <a:gd name="connsiteY12" fmla="*/ 193802 h 193802"/>
                <a:gd name="connsiteX13" fmla="*/ 462915 w 2499995"/>
                <a:gd name="connsiteY13" fmla="*/ 193802 h 193802"/>
                <a:gd name="connsiteX14" fmla="*/ 496570 w 2499995"/>
                <a:gd name="connsiteY14" fmla="*/ 193802 h 193802"/>
                <a:gd name="connsiteX15" fmla="*/ 532638 w 2499995"/>
                <a:gd name="connsiteY15" fmla="*/ 193802 h 193802"/>
                <a:gd name="connsiteX16" fmla="*/ 571119 w 2499995"/>
                <a:gd name="connsiteY16" fmla="*/ 193802 h 193802"/>
                <a:gd name="connsiteX17" fmla="*/ 611378 w 2499995"/>
                <a:gd name="connsiteY17" fmla="*/ 193802 h 193802"/>
                <a:gd name="connsiteX18" fmla="*/ 652653 w 2499995"/>
                <a:gd name="connsiteY18" fmla="*/ 193802 h 193802"/>
                <a:gd name="connsiteX19" fmla="*/ 694055 w 2499995"/>
                <a:gd name="connsiteY19" fmla="*/ 193802 h 193802"/>
                <a:gd name="connsiteX20" fmla="*/ 734441 w 2499995"/>
                <a:gd name="connsiteY20" fmla="*/ 193802 h 193802"/>
                <a:gd name="connsiteX21" fmla="*/ 773049 w 2499995"/>
                <a:gd name="connsiteY21" fmla="*/ 193802 h 193802"/>
                <a:gd name="connsiteX22" fmla="*/ 809371 w 2499995"/>
                <a:gd name="connsiteY22" fmla="*/ 193802 h 193802"/>
                <a:gd name="connsiteX23" fmla="*/ 843280 w 2499995"/>
                <a:gd name="connsiteY23" fmla="*/ 193802 h 193802"/>
                <a:gd name="connsiteX24" fmla="*/ 874903 w 2499995"/>
                <a:gd name="connsiteY24" fmla="*/ 193802 h 193802"/>
                <a:gd name="connsiteX25" fmla="*/ 877951 w 2499995"/>
                <a:gd name="connsiteY25" fmla="*/ 193802 h 193802"/>
                <a:gd name="connsiteX26" fmla="*/ 913384 w 2499995"/>
                <a:gd name="connsiteY26" fmla="*/ 193802 h 193802"/>
                <a:gd name="connsiteX27" fmla="*/ 947801 w 2499995"/>
                <a:gd name="connsiteY27" fmla="*/ 193802 h 193802"/>
                <a:gd name="connsiteX28" fmla="*/ 983234 w 2499995"/>
                <a:gd name="connsiteY28" fmla="*/ 193802 h 193802"/>
                <a:gd name="connsiteX29" fmla="*/ 1021588 w 2499995"/>
                <a:gd name="connsiteY29" fmla="*/ 193802 h 193802"/>
                <a:gd name="connsiteX30" fmla="*/ 1063371 w 2499995"/>
                <a:gd name="connsiteY30" fmla="*/ 193802 h 193802"/>
                <a:gd name="connsiteX31" fmla="*/ 1106424 w 2499995"/>
                <a:gd name="connsiteY31" fmla="*/ 193802 h 193802"/>
                <a:gd name="connsiteX32" fmla="*/ 1145413 w 2499995"/>
                <a:gd name="connsiteY32" fmla="*/ 193802 h 193802"/>
                <a:gd name="connsiteX33" fmla="*/ 1173734 w 2499995"/>
                <a:gd name="connsiteY33" fmla="*/ 193802 h 193802"/>
                <a:gd name="connsiteX34" fmla="*/ 1187704 w 2499995"/>
                <a:gd name="connsiteY34" fmla="*/ 193802 h 193802"/>
                <a:gd name="connsiteX35" fmla="*/ 1190498 w 2499995"/>
                <a:gd name="connsiteY35" fmla="*/ 193802 h 193802"/>
                <a:gd name="connsiteX36" fmla="*/ 1190498 w 2499995"/>
                <a:gd name="connsiteY36" fmla="*/ 193802 h 193802"/>
                <a:gd name="connsiteX37" fmla="*/ 1309497 w 2499995"/>
                <a:gd name="connsiteY37" fmla="*/ 193802 h 193802"/>
                <a:gd name="connsiteX38" fmla="*/ 1311529 w 2499995"/>
                <a:gd name="connsiteY38" fmla="*/ 193802 h 193802"/>
                <a:gd name="connsiteX39" fmla="*/ 1323721 w 2499995"/>
                <a:gd name="connsiteY39" fmla="*/ 193802 h 193802"/>
                <a:gd name="connsiteX40" fmla="*/ 1350264 w 2499995"/>
                <a:gd name="connsiteY40" fmla="*/ 193802 h 193802"/>
                <a:gd name="connsiteX41" fmla="*/ 1388364 w 2499995"/>
                <a:gd name="connsiteY41" fmla="*/ 193802 h 193802"/>
                <a:gd name="connsiteX42" fmla="*/ 1431290 w 2499995"/>
                <a:gd name="connsiteY42" fmla="*/ 193802 h 193802"/>
                <a:gd name="connsiteX43" fmla="*/ 1473327 w 2499995"/>
                <a:gd name="connsiteY43" fmla="*/ 193802 h 193802"/>
                <a:gd name="connsiteX44" fmla="*/ 1512062 w 2499995"/>
                <a:gd name="connsiteY44" fmla="*/ 193802 h 193802"/>
                <a:gd name="connsiteX45" fmla="*/ 1547876 w 2499995"/>
                <a:gd name="connsiteY45" fmla="*/ 193802 h 193802"/>
                <a:gd name="connsiteX46" fmla="*/ 1582293 w 2499995"/>
                <a:gd name="connsiteY46" fmla="*/ 193802 h 193802"/>
                <a:gd name="connsiteX47" fmla="*/ 1617472 w 2499995"/>
                <a:gd name="connsiteY47" fmla="*/ 193802 h 193802"/>
                <a:gd name="connsiteX48" fmla="*/ 1622044 w 2499995"/>
                <a:gd name="connsiteY48" fmla="*/ 193802 h 193802"/>
                <a:gd name="connsiteX49" fmla="*/ 1653413 w 2499995"/>
                <a:gd name="connsiteY49" fmla="*/ 193802 h 193802"/>
                <a:gd name="connsiteX50" fmla="*/ 1687068 w 2499995"/>
                <a:gd name="connsiteY50" fmla="*/ 193802 h 193802"/>
                <a:gd name="connsiteX51" fmla="*/ 1723136 w 2499995"/>
                <a:gd name="connsiteY51" fmla="*/ 193802 h 193802"/>
                <a:gd name="connsiteX52" fmla="*/ 1761617 w 2499995"/>
                <a:gd name="connsiteY52" fmla="*/ 193802 h 193802"/>
                <a:gd name="connsiteX53" fmla="*/ 1801876 w 2499995"/>
                <a:gd name="connsiteY53" fmla="*/ 193802 h 193802"/>
                <a:gd name="connsiteX54" fmla="*/ 1843151 w 2499995"/>
                <a:gd name="connsiteY54" fmla="*/ 193802 h 193802"/>
                <a:gd name="connsiteX55" fmla="*/ 1884426 w 2499995"/>
                <a:gd name="connsiteY55" fmla="*/ 193802 h 193802"/>
                <a:gd name="connsiteX56" fmla="*/ 1924939 w 2499995"/>
                <a:gd name="connsiteY56" fmla="*/ 193802 h 193802"/>
                <a:gd name="connsiteX57" fmla="*/ 1963547 w 2499995"/>
                <a:gd name="connsiteY57" fmla="*/ 193802 h 193802"/>
                <a:gd name="connsiteX58" fmla="*/ 1999869 w 2499995"/>
                <a:gd name="connsiteY58" fmla="*/ 193802 h 193802"/>
                <a:gd name="connsiteX59" fmla="*/ 2033778 w 2499995"/>
                <a:gd name="connsiteY59" fmla="*/ 193802 h 193802"/>
                <a:gd name="connsiteX60" fmla="*/ 2065401 w 2499995"/>
                <a:gd name="connsiteY60" fmla="*/ 193802 h 193802"/>
                <a:gd name="connsiteX61" fmla="*/ 2068449 w 2499995"/>
                <a:gd name="connsiteY61" fmla="*/ 193802 h 193802"/>
                <a:gd name="connsiteX62" fmla="*/ 2103882 w 2499995"/>
                <a:gd name="connsiteY62" fmla="*/ 193802 h 193802"/>
                <a:gd name="connsiteX63" fmla="*/ 2138299 w 2499995"/>
                <a:gd name="connsiteY63" fmla="*/ 193802 h 193802"/>
                <a:gd name="connsiteX64" fmla="*/ 2173732 w 2499995"/>
                <a:gd name="connsiteY64" fmla="*/ 193802 h 193802"/>
                <a:gd name="connsiteX65" fmla="*/ 2212086 w 2499995"/>
                <a:gd name="connsiteY65" fmla="*/ 193802 h 193802"/>
                <a:gd name="connsiteX66" fmla="*/ 2253869 w 2499995"/>
                <a:gd name="connsiteY66" fmla="*/ 193802 h 193802"/>
                <a:gd name="connsiteX67" fmla="*/ 2296922 w 2499995"/>
                <a:gd name="connsiteY67" fmla="*/ 193802 h 193802"/>
                <a:gd name="connsiteX68" fmla="*/ 2335911 w 2499995"/>
                <a:gd name="connsiteY68" fmla="*/ 193802 h 193802"/>
                <a:gd name="connsiteX69" fmla="*/ 2364232 w 2499995"/>
                <a:gd name="connsiteY69" fmla="*/ 193802 h 193802"/>
                <a:gd name="connsiteX70" fmla="*/ 2378202 w 2499995"/>
                <a:gd name="connsiteY70" fmla="*/ 193802 h 193802"/>
                <a:gd name="connsiteX71" fmla="*/ 2380996 w 2499995"/>
                <a:gd name="connsiteY71" fmla="*/ 193802 h 193802"/>
                <a:gd name="connsiteX72" fmla="*/ 2380996 w 2499995"/>
                <a:gd name="connsiteY72" fmla="*/ 193802 h 193802"/>
                <a:gd name="connsiteX73" fmla="*/ 2499995 w 2499995"/>
                <a:gd name="connsiteY73" fmla="*/ 193802 h 193802"/>
                <a:gd name="connsiteX74" fmla="*/ 2499995 w 2499995"/>
                <a:gd name="connsiteY74" fmla="*/ 0 h 193802"/>
                <a:gd name="connsiteX75" fmla="*/ 2380996 w 2499995"/>
                <a:gd name="connsiteY75" fmla="*/ 0 h 193802"/>
                <a:gd name="connsiteX76" fmla="*/ 2378964 w 2499995"/>
                <a:gd name="connsiteY76" fmla="*/ 0 h 193802"/>
                <a:gd name="connsiteX77" fmla="*/ 2366772 w 2499995"/>
                <a:gd name="connsiteY77" fmla="*/ 0 h 193802"/>
                <a:gd name="connsiteX78" fmla="*/ 2340229 w 2499995"/>
                <a:gd name="connsiteY78" fmla="*/ 0 h 193802"/>
                <a:gd name="connsiteX79" fmla="*/ 2302129 w 2499995"/>
                <a:gd name="connsiteY79" fmla="*/ 0 h 193802"/>
                <a:gd name="connsiteX80" fmla="*/ 2259203 w 2499995"/>
                <a:gd name="connsiteY80" fmla="*/ 0 h 193802"/>
                <a:gd name="connsiteX81" fmla="*/ 2217166 w 2499995"/>
                <a:gd name="connsiteY81" fmla="*/ 0 h 193802"/>
                <a:gd name="connsiteX82" fmla="*/ 2178431 w 2499995"/>
                <a:gd name="connsiteY82" fmla="*/ 0 h 193802"/>
                <a:gd name="connsiteX83" fmla="*/ 2142617 w 2499995"/>
                <a:gd name="connsiteY83" fmla="*/ 0 h 193802"/>
                <a:gd name="connsiteX84" fmla="*/ 2108200 w 2499995"/>
                <a:gd name="connsiteY84" fmla="*/ 0 h 193802"/>
                <a:gd name="connsiteX85" fmla="*/ 2073021 w 2499995"/>
                <a:gd name="connsiteY85" fmla="*/ 0 h 193802"/>
                <a:gd name="connsiteX86" fmla="*/ 2068449 w 2499995"/>
                <a:gd name="connsiteY86" fmla="*/ 0 h 193802"/>
                <a:gd name="connsiteX87" fmla="*/ 2037080 w 2499995"/>
                <a:gd name="connsiteY87" fmla="*/ 0 h 193802"/>
                <a:gd name="connsiteX88" fmla="*/ 2003552 w 2499995"/>
                <a:gd name="connsiteY88" fmla="*/ 0 h 193802"/>
                <a:gd name="connsiteX89" fmla="*/ 1967357 w 2499995"/>
                <a:gd name="connsiteY89" fmla="*/ 0 h 193802"/>
                <a:gd name="connsiteX90" fmla="*/ 1929003 w 2499995"/>
                <a:gd name="connsiteY90" fmla="*/ 0 h 193802"/>
                <a:gd name="connsiteX91" fmla="*/ 1888744 w 2499995"/>
                <a:gd name="connsiteY91" fmla="*/ 0 h 193802"/>
                <a:gd name="connsiteX92" fmla="*/ 1847342 w 2499995"/>
                <a:gd name="connsiteY92" fmla="*/ 0 h 193802"/>
                <a:gd name="connsiteX93" fmla="*/ 1806067 w 2499995"/>
                <a:gd name="connsiteY93" fmla="*/ 0 h 193802"/>
                <a:gd name="connsiteX94" fmla="*/ 1765554 w 2499995"/>
                <a:gd name="connsiteY94" fmla="*/ 0 h 193802"/>
                <a:gd name="connsiteX95" fmla="*/ 1726946 w 2499995"/>
                <a:gd name="connsiteY95" fmla="*/ 0 h 193802"/>
                <a:gd name="connsiteX96" fmla="*/ 1690624 w 2499995"/>
                <a:gd name="connsiteY96" fmla="*/ 0 h 193802"/>
                <a:gd name="connsiteX97" fmla="*/ 1656715 w 2499995"/>
                <a:gd name="connsiteY97" fmla="*/ 0 h 193802"/>
                <a:gd name="connsiteX98" fmla="*/ 1625219 w 2499995"/>
                <a:gd name="connsiteY98" fmla="*/ 0 h 193802"/>
                <a:gd name="connsiteX99" fmla="*/ 1622044 w 2499995"/>
                <a:gd name="connsiteY99" fmla="*/ 0 h 193802"/>
                <a:gd name="connsiteX100" fmla="*/ 1586738 w 2499995"/>
                <a:gd name="connsiteY100" fmla="*/ 0 h 193802"/>
                <a:gd name="connsiteX101" fmla="*/ 1552321 w 2499995"/>
                <a:gd name="connsiteY101" fmla="*/ 0 h 193802"/>
                <a:gd name="connsiteX102" fmla="*/ 1516761 w 2499995"/>
                <a:gd name="connsiteY102" fmla="*/ 0 h 193802"/>
                <a:gd name="connsiteX103" fmla="*/ 1478407 w 2499995"/>
                <a:gd name="connsiteY103" fmla="*/ 0 h 193802"/>
                <a:gd name="connsiteX104" fmla="*/ 1436624 w 2499995"/>
                <a:gd name="connsiteY104" fmla="*/ 0 h 193802"/>
                <a:gd name="connsiteX105" fmla="*/ 1393571 w 2499995"/>
                <a:gd name="connsiteY105" fmla="*/ 0 h 193802"/>
                <a:gd name="connsiteX106" fmla="*/ 1354582 w 2499995"/>
                <a:gd name="connsiteY106" fmla="*/ 0 h 193802"/>
                <a:gd name="connsiteX107" fmla="*/ 1326261 w 2499995"/>
                <a:gd name="connsiteY107" fmla="*/ 0 h 193802"/>
                <a:gd name="connsiteX108" fmla="*/ 1312418 w 2499995"/>
                <a:gd name="connsiteY108" fmla="*/ 0 h 193802"/>
                <a:gd name="connsiteX109" fmla="*/ 1309497 w 2499995"/>
                <a:gd name="connsiteY109" fmla="*/ 0 h 193802"/>
                <a:gd name="connsiteX110" fmla="*/ 1309497 w 2499995"/>
                <a:gd name="connsiteY110" fmla="*/ 0 h 193802"/>
                <a:gd name="connsiteX111" fmla="*/ 1190498 w 2499995"/>
                <a:gd name="connsiteY111" fmla="*/ 0 h 193802"/>
                <a:gd name="connsiteX112" fmla="*/ 1188466 w 2499995"/>
                <a:gd name="connsiteY112" fmla="*/ 0 h 193802"/>
                <a:gd name="connsiteX113" fmla="*/ 1176274 w 2499995"/>
                <a:gd name="connsiteY113" fmla="*/ 0 h 193802"/>
                <a:gd name="connsiteX114" fmla="*/ 1149731 w 2499995"/>
                <a:gd name="connsiteY114" fmla="*/ 0 h 193802"/>
                <a:gd name="connsiteX115" fmla="*/ 1111631 w 2499995"/>
                <a:gd name="connsiteY115" fmla="*/ 0 h 193802"/>
                <a:gd name="connsiteX116" fmla="*/ 1068832 w 2499995"/>
                <a:gd name="connsiteY116" fmla="*/ 0 h 193802"/>
                <a:gd name="connsiteX117" fmla="*/ 1026668 w 2499995"/>
                <a:gd name="connsiteY117" fmla="*/ 0 h 193802"/>
                <a:gd name="connsiteX118" fmla="*/ 987933 w 2499995"/>
                <a:gd name="connsiteY118" fmla="*/ 0 h 193802"/>
                <a:gd name="connsiteX119" fmla="*/ 952119 w 2499995"/>
                <a:gd name="connsiteY119" fmla="*/ 0 h 193802"/>
                <a:gd name="connsiteX120" fmla="*/ 917702 w 2499995"/>
                <a:gd name="connsiteY120" fmla="*/ 0 h 193802"/>
                <a:gd name="connsiteX121" fmla="*/ 882523 w 2499995"/>
                <a:gd name="connsiteY121" fmla="*/ 0 h 193802"/>
                <a:gd name="connsiteX122" fmla="*/ 877951 w 2499995"/>
                <a:gd name="connsiteY122" fmla="*/ 0 h 193802"/>
                <a:gd name="connsiteX123" fmla="*/ 846582 w 2499995"/>
                <a:gd name="connsiteY123" fmla="*/ 0 h 193802"/>
                <a:gd name="connsiteX124" fmla="*/ 813054 w 2499995"/>
                <a:gd name="connsiteY124" fmla="*/ 0 h 193802"/>
                <a:gd name="connsiteX125" fmla="*/ 776859 w 2499995"/>
                <a:gd name="connsiteY125" fmla="*/ 0 h 193802"/>
                <a:gd name="connsiteX126" fmla="*/ 738505 w 2499995"/>
                <a:gd name="connsiteY126" fmla="*/ 0 h 193802"/>
                <a:gd name="connsiteX127" fmla="*/ 698246 w 2499995"/>
                <a:gd name="connsiteY127" fmla="*/ 0 h 193802"/>
                <a:gd name="connsiteX128" fmla="*/ 656844 w 2499995"/>
                <a:gd name="connsiteY128" fmla="*/ 0 h 193802"/>
                <a:gd name="connsiteX129" fmla="*/ 615569 w 2499995"/>
                <a:gd name="connsiteY129" fmla="*/ 0 h 193802"/>
                <a:gd name="connsiteX130" fmla="*/ 575183 w 2499995"/>
                <a:gd name="connsiteY130" fmla="*/ 0 h 193802"/>
                <a:gd name="connsiteX131" fmla="*/ 536448 w 2499995"/>
                <a:gd name="connsiteY131" fmla="*/ 0 h 193802"/>
                <a:gd name="connsiteX132" fmla="*/ 500126 w 2499995"/>
                <a:gd name="connsiteY132" fmla="*/ 0 h 193802"/>
                <a:gd name="connsiteX133" fmla="*/ 466217 w 2499995"/>
                <a:gd name="connsiteY133" fmla="*/ 0 h 193802"/>
                <a:gd name="connsiteX134" fmla="*/ 434721 w 2499995"/>
                <a:gd name="connsiteY134" fmla="*/ 0 h 193802"/>
                <a:gd name="connsiteX135" fmla="*/ 431546 w 2499995"/>
                <a:gd name="connsiteY135" fmla="*/ 0 h 193802"/>
                <a:gd name="connsiteX136" fmla="*/ 396240 w 2499995"/>
                <a:gd name="connsiteY136" fmla="*/ 0 h 193802"/>
                <a:gd name="connsiteX137" fmla="*/ 361823 w 2499995"/>
                <a:gd name="connsiteY137" fmla="*/ 0 h 193802"/>
                <a:gd name="connsiteX138" fmla="*/ 326263 w 2499995"/>
                <a:gd name="connsiteY138" fmla="*/ 0 h 193802"/>
                <a:gd name="connsiteX139" fmla="*/ 287909 w 2499995"/>
                <a:gd name="connsiteY139" fmla="*/ 0 h 193802"/>
                <a:gd name="connsiteX140" fmla="*/ 246253 w 2499995"/>
                <a:gd name="connsiteY140" fmla="*/ 0 h 193802"/>
                <a:gd name="connsiteX141" fmla="*/ 203200 w 2499995"/>
                <a:gd name="connsiteY141" fmla="*/ 0 h 193802"/>
                <a:gd name="connsiteX142" fmla="*/ 164084 w 2499995"/>
                <a:gd name="connsiteY142" fmla="*/ 0 h 193802"/>
                <a:gd name="connsiteX143" fmla="*/ 135763 w 2499995"/>
                <a:gd name="connsiteY143" fmla="*/ 0 h 193802"/>
                <a:gd name="connsiteX144" fmla="*/ 121920 w 2499995"/>
                <a:gd name="connsiteY144" fmla="*/ 0 h 193802"/>
                <a:gd name="connsiteX145" fmla="*/ 119126 w 2499995"/>
                <a:gd name="connsiteY145" fmla="*/ 0 h 193802"/>
                <a:gd name="connsiteX146" fmla="*/ 118999 w 2499995"/>
                <a:gd name="connsiteY146" fmla="*/ 0 h 193802"/>
                <a:gd name="connsiteX147" fmla="*/ 0 w 2499995"/>
                <a:gd name="connsiteY147" fmla="*/ 0 h 1938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193802">
                  <a:moveTo>
                    <a:pt x="0" y="193802"/>
                  </a:moveTo>
                  <a:lnTo>
                    <a:pt x="118999" y="193802"/>
                  </a:lnTo>
                  <a:lnTo>
                    <a:pt x="121031" y="193802"/>
                  </a:lnTo>
                  <a:lnTo>
                    <a:pt x="133223" y="193802"/>
                  </a:lnTo>
                  <a:lnTo>
                    <a:pt x="159766" y="193802"/>
                  </a:lnTo>
                  <a:lnTo>
                    <a:pt x="197866" y="193802"/>
                  </a:lnTo>
                  <a:lnTo>
                    <a:pt x="240792" y="193802"/>
                  </a:lnTo>
                  <a:lnTo>
                    <a:pt x="282829" y="193802"/>
                  </a:lnTo>
                  <a:lnTo>
                    <a:pt x="321691" y="193802"/>
                  </a:lnTo>
                  <a:lnTo>
                    <a:pt x="357378" y="193802"/>
                  </a:lnTo>
                  <a:lnTo>
                    <a:pt x="391922" y="193802"/>
                  </a:lnTo>
                  <a:lnTo>
                    <a:pt x="426974" y="193802"/>
                  </a:lnTo>
                  <a:lnTo>
                    <a:pt x="431546" y="193802"/>
                  </a:lnTo>
                  <a:lnTo>
                    <a:pt x="462915" y="193802"/>
                  </a:lnTo>
                  <a:lnTo>
                    <a:pt x="496570" y="193802"/>
                  </a:lnTo>
                  <a:lnTo>
                    <a:pt x="532638" y="193802"/>
                  </a:lnTo>
                  <a:lnTo>
                    <a:pt x="571119" y="193802"/>
                  </a:lnTo>
                  <a:lnTo>
                    <a:pt x="611378" y="193802"/>
                  </a:lnTo>
                  <a:lnTo>
                    <a:pt x="652653" y="193802"/>
                  </a:lnTo>
                  <a:lnTo>
                    <a:pt x="694055" y="193802"/>
                  </a:lnTo>
                  <a:lnTo>
                    <a:pt x="734441" y="193802"/>
                  </a:lnTo>
                  <a:lnTo>
                    <a:pt x="773049" y="193802"/>
                  </a:lnTo>
                  <a:lnTo>
                    <a:pt x="809371" y="193802"/>
                  </a:lnTo>
                  <a:lnTo>
                    <a:pt x="843280" y="193802"/>
                  </a:lnTo>
                  <a:lnTo>
                    <a:pt x="874903" y="193802"/>
                  </a:lnTo>
                  <a:lnTo>
                    <a:pt x="877951" y="193802"/>
                  </a:lnTo>
                  <a:lnTo>
                    <a:pt x="913384" y="193802"/>
                  </a:lnTo>
                  <a:lnTo>
                    <a:pt x="947801" y="193802"/>
                  </a:lnTo>
                  <a:lnTo>
                    <a:pt x="983234" y="193802"/>
                  </a:lnTo>
                  <a:lnTo>
                    <a:pt x="1021588" y="193802"/>
                  </a:lnTo>
                  <a:lnTo>
                    <a:pt x="1063371" y="193802"/>
                  </a:lnTo>
                  <a:lnTo>
                    <a:pt x="1106424" y="193802"/>
                  </a:lnTo>
                  <a:lnTo>
                    <a:pt x="1145413" y="193802"/>
                  </a:lnTo>
                  <a:lnTo>
                    <a:pt x="1173734" y="193802"/>
                  </a:lnTo>
                  <a:lnTo>
                    <a:pt x="1187704" y="193802"/>
                  </a:lnTo>
                  <a:lnTo>
                    <a:pt x="1190498" y="193802"/>
                  </a:lnTo>
                  <a:lnTo>
                    <a:pt x="1190498" y="193802"/>
                  </a:lnTo>
                  <a:lnTo>
                    <a:pt x="1309497" y="193802"/>
                  </a:lnTo>
                  <a:lnTo>
                    <a:pt x="1311529" y="193802"/>
                  </a:lnTo>
                  <a:lnTo>
                    <a:pt x="1323721" y="193802"/>
                  </a:lnTo>
                  <a:lnTo>
                    <a:pt x="1350264" y="193802"/>
                  </a:lnTo>
                  <a:lnTo>
                    <a:pt x="1388364" y="193802"/>
                  </a:lnTo>
                  <a:lnTo>
                    <a:pt x="1431290" y="193802"/>
                  </a:lnTo>
                  <a:lnTo>
                    <a:pt x="1473327" y="193802"/>
                  </a:lnTo>
                  <a:lnTo>
                    <a:pt x="1512062" y="193802"/>
                  </a:lnTo>
                  <a:lnTo>
                    <a:pt x="1547876" y="193802"/>
                  </a:lnTo>
                  <a:lnTo>
                    <a:pt x="1582293" y="193802"/>
                  </a:lnTo>
                  <a:lnTo>
                    <a:pt x="1617472" y="193802"/>
                  </a:lnTo>
                  <a:lnTo>
                    <a:pt x="1622044" y="193802"/>
                  </a:lnTo>
                  <a:lnTo>
                    <a:pt x="1653413" y="193802"/>
                  </a:lnTo>
                  <a:lnTo>
                    <a:pt x="1687068" y="193802"/>
                  </a:lnTo>
                  <a:lnTo>
                    <a:pt x="1723136" y="193802"/>
                  </a:lnTo>
                  <a:lnTo>
                    <a:pt x="1761617" y="193802"/>
                  </a:lnTo>
                  <a:lnTo>
                    <a:pt x="1801876" y="193802"/>
                  </a:lnTo>
                  <a:lnTo>
                    <a:pt x="1843151" y="193802"/>
                  </a:lnTo>
                  <a:lnTo>
                    <a:pt x="1884426" y="193802"/>
                  </a:lnTo>
                  <a:lnTo>
                    <a:pt x="1924939" y="193802"/>
                  </a:lnTo>
                  <a:lnTo>
                    <a:pt x="1963547" y="193802"/>
                  </a:lnTo>
                  <a:lnTo>
                    <a:pt x="1999869" y="193802"/>
                  </a:lnTo>
                  <a:lnTo>
                    <a:pt x="2033778" y="193802"/>
                  </a:lnTo>
                  <a:lnTo>
                    <a:pt x="2065401" y="193802"/>
                  </a:lnTo>
                  <a:lnTo>
                    <a:pt x="2068449" y="193802"/>
                  </a:lnTo>
                  <a:lnTo>
                    <a:pt x="2103882" y="193802"/>
                  </a:lnTo>
                  <a:lnTo>
                    <a:pt x="2138299" y="193802"/>
                  </a:lnTo>
                  <a:lnTo>
                    <a:pt x="2173732" y="193802"/>
                  </a:lnTo>
                  <a:lnTo>
                    <a:pt x="2212086" y="193802"/>
                  </a:lnTo>
                  <a:lnTo>
                    <a:pt x="2253869" y="193802"/>
                  </a:lnTo>
                  <a:lnTo>
                    <a:pt x="2296922" y="193802"/>
                  </a:lnTo>
                  <a:lnTo>
                    <a:pt x="2335911" y="193802"/>
                  </a:lnTo>
                  <a:lnTo>
                    <a:pt x="2364232" y="193802"/>
                  </a:lnTo>
                  <a:lnTo>
                    <a:pt x="2378202" y="193802"/>
                  </a:lnTo>
                  <a:lnTo>
                    <a:pt x="2380996" y="193802"/>
                  </a:lnTo>
                  <a:lnTo>
                    <a:pt x="2380996" y="193802"/>
                  </a:lnTo>
                  <a:lnTo>
                    <a:pt x="2499995" y="193802"/>
                  </a:lnTo>
                  <a:lnTo>
                    <a:pt x="2499995" y="0"/>
                  </a:lnTo>
                  <a:lnTo>
                    <a:pt x="2380996" y="0"/>
                  </a:lnTo>
                  <a:lnTo>
                    <a:pt x="2378964" y="0"/>
                  </a:lnTo>
                  <a:lnTo>
                    <a:pt x="2366772" y="0"/>
                  </a:lnTo>
                  <a:lnTo>
                    <a:pt x="2340229" y="0"/>
                  </a:lnTo>
                  <a:lnTo>
                    <a:pt x="2302129" y="0"/>
                  </a:lnTo>
                  <a:lnTo>
                    <a:pt x="2259203" y="0"/>
                  </a:lnTo>
                  <a:lnTo>
                    <a:pt x="2217166" y="0"/>
                  </a:lnTo>
                  <a:lnTo>
                    <a:pt x="2178431" y="0"/>
                  </a:lnTo>
                  <a:lnTo>
                    <a:pt x="2142617" y="0"/>
                  </a:lnTo>
                  <a:lnTo>
                    <a:pt x="2108200" y="0"/>
                  </a:lnTo>
                  <a:lnTo>
                    <a:pt x="2073021" y="0"/>
                  </a:lnTo>
                  <a:lnTo>
                    <a:pt x="2068449" y="0"/>
                  </a:lnTo>
                  <a:lnTo>
                    <a:pt x="2037080" y="0"/>
                  </a:lnTo>
                  <a:lnTo>
                    <a:pt x="2003552" y="0"/>
                  </a:lnTo>
                  <a:lnTo>
                    <a:pt x="1967357" y="0"/>
                  </a:lnTo>
                  <a:lnTo>
                    <a:pt x="1929003" y="0"/>
                  </a:lnTo>
                  <a:lnTo>
                    <a:pt x="1888744" y="0"/>
                  </a:lnTo>
                  <a:lnTo>
                    <a:pt x="1847342" y="0"/>
                  </a:lnTo>
                  <a:lnTo>
                    <a:pt x="1806067" y="0"/>
                  </a:lnTo>
                  <a:lnTo>
                    <a:pt x="1765554" y="0"/>
                  </a:lnTo>
                  <a:lnTo>
                    <a:pt x="1726946" y="0"/>
                  </a:lnTo>
                  <a:lnTo>
                    <a:pt x="1690624" y="0"/>
                  </a:lnTo>
                  <a:lnTo>
                    <a:pt x="1656715" y="0"/>
                  </a:lnTo>
                  <a:lnTo>
                    <a:pt x="1625219" y="0"/>
                  </a:lnTo>
                  <a:lnTo>
                    <a:pt x="1622044" y="0"/>
                  </a:lnTo>
                  <a:lnTo>
                    <a:pt x="1586738" y="0"/>
                  </a:lnTo>
                  <a:lnTo>
                    <a:pt x="1552321" y="0"/>
                  </a:lnTo>
                  <a:lnTo>
                    <a:pt x="1516761" y="0"/>
                  </a:lnTo>
                  <a:lnTo>
                    <a:pt x="1478407" y="0"/>
                  </a:lnTo>
                  <a:lnTo>
                    <a:pt x="1436624" y="0"/>
                  </a:lnTo>
                  <a:lnTo>
                    <a:pt x="1393571" y="0"/>
                  </a:lnTo>
                  <a:lnTo>
                    <a:pt x="1354582" y="0"/>
                  </a:lnTo>
                  <a:lnTo>
                    <a:pt x="1326261" y="0"/>
                  </a:lnTo>
                  <a:lnTo>
                    <a:pt x="1312418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832" y="0"/>
                  </a:lnTo>
                  <a:lnTo>
                    <a:pt x="1026668" y="0"/>
                  </a:lnTo>
                  <a:lnTo>
                    <a:pt x="987933" y="0"/>
                  </a:lnTo>
                  <a:lnTo>
                    <a:pt x="952119" y="0"/>
                  </a:lnTo>
                  <a:lnTo>
                    <a:pt x="917702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3054" y="0"/>
                  </a:lnTo>
                  <a:lnTo>
                    <a:pt x="776859" y="0"/>
                  </a:lnTo>
                  <a:lnTo>
                    <a:pt x="738505" y="0"/>
                  </a:lnTo>
                  <a:lnTo>
                    <a:pt x="698246" y="0"/>
                  </a:lnTo>
                  <a:lnTo>
                    <a:pt x="656844" y="0"/>
                  </a:lnTo>
                  <a:lnTo>
                    <a:pt x="615569" y="0"/>
                  </a:lnTo>
                  <a:lnTo>
                    <a:pt x="575183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721" y="0"/>
                  </a:lnTo>
                  <a:lnTo>
                    <a:pt x="431546" y="0"/>
                  </a:lnTo>
                  <a:lnTo>
                    <a:pt x="396240" y="0"/>
                  </a:lnTo>
                  <a:lnTo>
                    <a:pt x="361823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253" y="0"/>
                  </a:lnTo>
                  <a:lnTo>
                    <a:pt x="203200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920" y="0"/>
                  </a:lnTo>
                  <a:lnTo>
                    <a:pt x="119126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7191C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1" name="Forme libre 30">
              <a:extLst>
                <a:ext uri="{FF2B5EF4-FFF2-40B4-BE49-F238E27FC236}">
                  <a16:creationId xmlns:a16="http://schemas.microsoft.com/office/drawing/2014/main" id="{ED43163B-22FB-CCBD-8ED2-E3B601BB451E}"/>
                </a:ext>
              </a:extLst>
            </p:cNvPr>
            <p:cNvSpPr/>
            <p:nvPr/>
          </p:nvSpPr>
          <p:spPr>
            <a:xfrm>
              <a:off x="636143" y="6298723"/>
              <a:ext cx="118998" cy="193802"/>
            </a:xfrm>
            <a:custGeom>
              <a:avLst/>
              <a:gdLst>
                <a:gd name="connsiteX0" fmla="*/ 0 w 118998"/>
                <a:gd name="connsiteY0" fmla="*/ 0 h 193802"/>
                <a:gd name="connsiteX1" fmla="*/ 118999 w 118998"/>
                <a:gd name="connsiteY1" fmla="*/ 0 h 193802"/>
                <a:gd name="connsiteX2" fmla="*/ 118999 w 118998"/>
                <a:gd name="connsiteY2" fmla="*/ 193802 h 193802"/>
                <a:gd name="connsiteX3" fmla="*/ 0 w 118998"/>
                <a:gd name="connsiteY3" fmla="*/ 193802 h 193802"/>
                <a:gd name="connsiteX4" fmla="*/ 0 w 118998"/>
                <a:gd name="connsiteY4" fmla="*/ 0 h 1938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193802">
                  <a:moveTo>
                    <a:pt x="0" y="0"/>
                  </a:moveTo>
                  <a:lnTo>
                    <a:pt x="118999" y="0"/>
                  </a:lnTo>
                  <a:lnTo>
                    <a:pt x="118999" y="193802"/>
                  </a:lnTo>
                  <a:lnTo>
                    <a:pt x="0" y="19380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2" name="Forme libre 31">
              <a:extLst>
                <a:ext uri="{FF2B5EF4-FFF2-40B4-BE49-F238E27FC236}">
                  <a16:creationId xmlns:a16="http://schemas.microsoft.com/office/drawing/2014/main" id="{2B36DFB7-D077-722C-E4E0-474069156D99}"/>
                </a:ext>
              </a:extLst>
            </p:cNvPr>
            <p:cNvSpPr/>
            <p:nvPr/>
          </p:nvSpPr>
          <p:spPr>
            <a:xfrm>
              <a:off x="636143" y="3992530"/>
              <a:ext cx="118998" cy="2306192"/>
            </a:xfrm>
            <a:custGeom>
              <a:avLst/>
              <a:gdLst>
                <a:gd name="connsiteX0" fmla="*/ 0 w 118998"/>
                <a:gd name="connsiteY0" fmla="*/ 0 h 2306192"/>
                <a:gd name="connsiteX1" fmla="*/ 118999 w 118998"/>
                <a:gd name="connsiteY1" fmla="*/ 0 h 2306192"/>
                <a:gd name="connsiteX2" fmla="*/ 118999 w 118998"/>
                <a:gd name="connsiteY2" fmla="*/ 2306193 h 2306192"/>
                <a:gd name="connsiteX3" fmla="*/ 0 w 118998"/>
                <a:gd name="connsiteY3" fmla="*/ 2306193 h 2306192"/>
                <a:gd name="connsiteX4" fmla="*/ 0 w 118998"/>
                <a:gd name="connsiteY4" fmla="*/ 0 h 23061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2306192">
                  <a:moveTo>
                    <a:pt x="0" y="0"/>
                  </a:moveTo>
                  <a:lnTo>
                    <a:pt x="118999" y="0"/>
                  </a:lnTo>
                  <a:lnTo>
                    <a:pt x="118999" y="2306193"/>
                  </a:lnTo>
                  <a:lnTo>
                    <a:pt x="0" y="230619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3" name="Forme libre 32">
              <a:extLst>
                <a:ext uri="{FF2B5EF4-FFF2-40B4-BE49-F238E27FC236}">
                  <a16:creationId xmlns:a16="http://schemas.microsoft.com/office/drawing/2014/main" id="{FD7439F6-3A5F-31DB-6FDF-6B17D36CDA17}"/>
                </a:ext>
              </a:extLst>
            </p:cNvPr>
            <p:cNvSpPr/>
            <p:nvPr/>
          </p:nvSpPr>
          <p:spPr>
            <a:xfrm>
              <a:off x="1826641" y="5746401"/>
              <a:ext cx="118998" cy="746125"/>
            </a:xfrm>
            <a:custGeom>
              <a:avLst/>
              <a:gdLst>
                <a:gd name="connsiteX0" fmla="*/ 0 w 118998"/>
                <a:gd name="connsiteY0" fmla="*/ 0 h 746125"/>
                <a:gd name="connsiteX1" fmla="*/ 118999 w 118998"/>
                <a:gd name="connsiteY1" fmla="*/ 0 h 746125"/>
                <a:gd name="connsiteX2" fmla="*/ 118999 w 118998"/>
                <a:gd name="connsiteY2" fmla="*/ 746125 h 746125"/>
                <a:gd name="connsiteX3" fmla="*/ 0 w 118998"/>
                <a:gd name="connsiteY3" fmla="*/ 746125 h 746125"/>
                <a:gd name="connsiteX4" fmla="*/ 0 w 118998"/>
                <a:gd name="connsiteY4" fmla="*/ 0 h 7461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746125">
                  <a:moveTo>
                    <a:pt x="0" y="0"/>
                  </a:moveTo>
                  <a:lnTo>
                    <a:pt x="118999" y="0"/>
                  </a:lnTo>
                  <a:lnTo>
                    <a:pt x="118999" y="746125"/>
                  </a:lnTo>
                  <a:lnTo>
                    <a:pt x="0" y="74612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4" name="Forme libre 33">
              <a:extLst>
                <a:ext uri="{FF2B5EF4-FFF2-40B4-BE49-F238E27FC236}">
                  <a16:creationId xmlns:a16="http://schemas.microsoft.com/office/drawing/2014/main" id="{BEF38389-6E8F-9E79-B26F-E998CA6C40D0}"/>
                </a:ext>
              </a:extLst>
            </p:cNvPr>
            <p:cNvSpPr/>
            <p:nvPr/>
          </p:nvSpPr>
          <p:spPr>
            <a:xfrm>
              <a:off x="1826641" y="3992530"/>
              <a:ext cx="118998" cy="1753870"/>
            </a:xfrm>
            <a:custGeom>
              <a:avLst/>
              <a:gdLst>
                <a:gd name="connsiteX0" fmla="*/ 0 w 118998"/>
                <a:gd name="connsiteY0" fmla="*/ 0 h 1753870"/>
                <a:gd name="connsiteX1" fmla="*/ 118999 w 118998"/>
                <a:gd name="connsiteY1" fmla="*/ 0 h 1753870"/>
                <a:gd name="connsiteX2" fmla="*/ 118999 w 118998"/>
                <a:gd name="connsiteY2" fmla="*/ 1753870 h 1753870"/>
                <a:gd name="connsiteX3" fmla="*/ 0 w 118998"/>
                <a:gd name="connsiteY3" fmla="*/ 1753870 h 1753870"/>
                <a:gd name="connsiteX4" fmla="*/ 0 w 118998"/>
                <a:gd name="connsiteY4" fmla="*/ 0 h 17538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1753870">
                  <a:moveTo>
                    <a:pt x="0" y="0"/>
                  </a:moveTo>
                  <a:lnTo>
                    <a:pt x="118999" y="0"/>
                  </a:lnTo>
                  <a:lnTo>
                    <a:pt x="118999" y="1753870"/>
                  </a:lnTo>
                  <a:lnTo>
                    <a:pt x="0" y="17538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5" name="Forme libre 34">
              <a:extLst>
                <a:ext uri="{FF2B5EF4-FFF2-40B4-BE49-F238E27FC236}">
                  <a16:creationId xmlns:a16="http://schemas.microsoft.com/office/drawing/2014/main" id="{42DE20E9-4901-35C5-E208-893E0DCCC354}"/>
                </a:ext>
              </a:extLst>
            </p:cNvPr>
            <p:cNvSpPr/>
            <p:nvPr/>
          </p:nvSpPr>
          <p:spPr>
            <a:xfrm>
              <a:off x="3017139" y="5290978"/>
              <a:ext cx="118998" cy="1201547"/>
            </a:xfrm>
            <a:custGeom>
              <a:avLst/>
              <a:gdLst>
                <a:gd name="connsiteX0" fmla="*/ 0 w 118998"/>
                <a:gd name="connsiteY0" fmla="*/ 0 h 1201547"/>
                <a:gd name="connsiteX1" fmla="*/ 118999 w 118998"/>
                <a:gd name="connsiteY1" fmla="*/ 0 h 1201547"/>
                <a:gd name="connsiteX2" fmla="*/ 118999 w 118998"/>
                <a:gd name="connsiteY2" fmla="*/ 1201547 h 1201547"/>
                <a:gd name="connsiteX3" fmla="*/ 0 w 118998"/>
                <a:gd name="connsiteY3" fmla="*/ 1201547 h 1201547"/>
                <a:gd name="connsiteX4" fmla="*/ 0 w 118998"/>
                <a:gd name="connsiteY4" fmla="*/ 0 h 12015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1201547">
                  <a:moveTo>
                    <a:pt x="0" y="0"/>
                  </a:moveTo>
                  <a:lnTo>
                    <a:pt x="118999" y="0"/>
                  </a:lnTo>
                  <a:lnTo>
                    <a:pt x="118999" y="1201547"/>
                  </a:lnTo>
                  <a:lnTo>
                    <a:pt x="0" y="12015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6" name="Forme libre 35">
              <a:extLst>
                <a:ext uri="{FF2B5EF4-FFF2-40B4-BE49-F238E27FC236}">
                  <a16:creationId xmlns:a16="http://schemas.microsoft.com/office/drawing/2014/main" id="{045C76F7-F9B8-83F5-058F-C9006E1B1BFD}"/>
                </a:ext>
              </a:extLst>
            </p:cNvPr>
            <p:cNvSpPr/>
            <p:nvPr/>
          </p:nvSpPr>
          <p:spPr>
            <a:xfrm>
              <a:off x="3017139" y="3992530"/>
              <a:ext cx="118998" cy="1298447"/>
            </a:xfrm>
            <a:custGeom>
              <a:avLst/>
              <a:gdLst>
                <a:gd name="connsiteX0" fmla="*/ 0 w 118998"/>
                <a:gd name="connsiteY0" fmla="*/ 0 h 1298447"/>
                <a:gd name="connsiteX1" fmla="*/ 118999 w 118998"/>
                <a:gd name="connsiteY1" fmla="*/ 0 h 1298447"/>
                <a:gd name="connsiteX2" fmla="*/ 118999 w 118998"/>
                <a:gd name="connsiteY2" fmla="*/ 1298448 h 1298447"/>
                <a:gd name="connsiteX3" fmla="*/ 0 w 118998"/>
                <a:gd name="connsiteY3" fmla="*/ 1298448 h 1298447"/>
                <a:gd name="connsiteX4" fmla="*/ 0 w 118998"/>
                <a:gd name="connsiteY4" fmla="*/ 0 h 12984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1298447">
                  <a:moveTo>
                    <a:pt x="0" y="0"/>
                  </a:moveTo>
                  <a:lnTo>
                    <a:pt x="118999" y="0"/>
                  </a:lnTo>
                  <a:lnTo>
                    <a:pt x="118999" y="1298448"/>
                  </a:lnTo>
                  <a:lnTo>
                    <a:pt x="0" y="12984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grpSp>
        <p:nvGrpSpPr>
          <p:cNvPr id="37" name="Graphique 19">
            <a:extLst>
              <a:ext uri="{FF2B5EF4-FFF2-40B4-BE49-F238E27FC236}">
                <a16:creationId xmlns:a16="http://schemas.microsoft.com/office/drawing/2014/main" id="{9D3DBA77-2491-7D57-2385-56AFA5210C84}"/>
              </a:ext>
            </a:extLst>
          </p:cNvPr>
          <p:cNvGrpSpPr/>
          <p:nvPr/>
        </p:nvGrpSpPr>
        <p:grpSpPr>
          <a:xfrm>
            <a:off x="3809746" y="3867563"/>
            <a:ext cx="2750057" cy="2750058"/>
            <a:chOff x="3809746" y="3867563"/>
            <a:chExt cx="2750057" cy="2750058"/>
          </a:xfrm>
        </p:grpSpPr>
        <p:sp>
          <p:nvSpPr>
            <p:cNvPr id="38" name="Forme libre 37">
              <a:extLst>
                <a:ext uri="{FF2B5EF4-FFF2-40B4-BE49-F238E27FC236}">
                  <a16:creationId xmlns:a16="http://schemas.microsoft.com/office/drawing/2014/main" id="{FA932DE4-EF81-69A7-97FA-D00EBA608284}"/>
                </a:ext>
              </a:extLst>
            </p:cNvPr>
            <p:cNvSpPr/>
            <p:nvPr/>
          </p:nvSpPr>
          <p:spPr>
            <a:xfrm>
              <a:off x="3809746" y="3867563"/>
              <a:ext cx="2750057" cy="2750058"/>
            </a:xfrm>
            <a:custGeom>
              <a:avLst/>
              <a:gdLst>
                <a:gd name="connsiteX0" fmla="*/ 0 w 2750057"/>
                <a:gd name="connsiteY0" fmla="*/ 0 h 2750058"/>
                <a:gd name="connsiteX1" fmla="*/ 2750058 w 2750057"/>
                <a:gd name="connsiteY1" fmla="*/ 0 h 2750058"/>
                <a:gd name="connsiteX2" fmla="*/ 2750058 w 2750057"/>
                <a:gd name="connsiteY2" fmla="*/ 2750058 h 2750058"/>
                <a:gd name="connsiteX3" fmla="*/ 0 w 2750057"/>
                <a:gd name="connsiteY3" fmla="*/ 2750058 h 27500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750057" h="2750058">
                  <a:moveTo>
                    <a:pt x="0" y="0"/>
                  </a:moveTo>
                  <a:lnTo>
                    <a:pt x="2750058" y="0"/>
                  </a:lnTo>
                  <a:lnTo>
                    <a:pt x="2750058" y="2750058"/>
                  </a:lnTo>
                  <a:lnTo>
                    <a:pt x="0" y="2750058"/>
                  </a:lnTo>
                  <a:close/>
                </a:path>
              </a:pathLst>
            </a:custGeom>
            <a:solidFill>
              <a:srgbClr val="FFFFFF"/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39" name="Forme libre 38">
              <a:extLst>
                <a:ext uri="{FF2B5EF4-FFF2-40B4-BE49-F238E27FC236}">
                  <a16:creationId xmlns:a16="http://schemas.microsoft.com/office/drawing/2014/main" id="{7FF6A40F-B36B-B90D-7648-063D9FC4E22E}"/>
                </a:ext>
              </a:extLst>
            </p:cNvPr>
            <p:cNvSpPr/>
            <p:nvPr/>
          </p:nvSpPr>
          <p:spPr>
            <a:xfrm>
              <a:off x="3934840" y="3992530"/>
              <a:ext cx="2499995" cy="1089786"/>
            </a:xfrm>
            <a:custGeom>
              <a:avLst/>
              <a:gdLst>
                <a:gd name="connsiteX0" fmla="*/ 0 w 2499995"/>
                <a:gd name="connsiteY0" fmla="*/ 1089787 h 1089786"/>
                <a:gd name="connsiteX1" fmla="*/ 118999 w 2499995"/>
                <a:gd name="connsiteY1" fmla="*/ 1089787 h 1089786"/>
                <a:gd name="connsiteX2" fmla="*/ 121031 w 2499995"/>
                <a:gd name="connsiteY2" fmla="*/ 1089787 h 1089786"/>
                <a:gd name="connsiteX3" fmla="*/ 133223 w 2499995"/>
                <a:gd name="connsiteY3" fmla="*/ 1089787 h 1089786"/>
                <a:gd name="connsiteX4" fmla="*/ 159766 w 2499995"/>
                <a:gd name="connsiteY4" fmla="*/ 1089787 h 1089786"/>
                <a:gd name="connsiteX5" fmla="*/ 197866 w 2499995"/>
                <a:gd name="connsiteY5" fmla="*/ 1089787 h 1089786"/>
                <a:gd name="connsiteX6" fmla="*/ 240792 w 2499995"/>
                <a:gd name="connsiteY6" fmla="*/ 1089787 h 1089786"/>
                <a:gd name="connsiteX7" fmla="*/ 282829 w 2499995"/>
                <a:gd name="connsiteY7" fmla="*/ 1089787 h 1089786"/>
                <a:gd name="connsiteX8" fmla="*/ 321564 w 2499995"/>
                <a:gd name="connsiteY8" fmla="*/ 1089787 h 1089786"/>
                <a:gd name="connsiteX9" fmla="*/ 357378 w 2499995"/>
                <a:gd name="connsiteY9" fmla="*/ 1089787 h 1089786"/>
                <a:gd name="connsiteX10" fmla="*/ 391795 w 2499995"/>
                <a:gd name="connsiteY10" fmla="*/ 1089787 h 1089786"/>
                <a:gd name="connsiteX11" fmla="*/ 426974 w 2499995"/>
                <a:gd name="connsiteY11" fmla="*/ 1089787 h 1089786"/>
                <a:gd name="connsiteX12" fmla="*/ 431546 w 2499995"/>
                <a:gd name="connsiteY12" fmla="*/ 1089787 h 1089786"/>
                <a:gd name="connsiteX13" fmla="*/ 462915 w 2499995"/>
                <a:gd name="connsiteY13" fmla="*/ 1089787 h 1089786"/>
                <a:gd name="connsiteX14" fmla="*/ 496443 w 2499995"/>
                <a:gd name="connsiteY14" fmla="*/ 1089787 h 1089786"/>
                <a:gd name="connsiteX15" fmla="*/ 532638 w 2499995"/>
                <a:gd name="connsiteY15" fmla="*/ 1089787 h 1089786"/>
                <a:gd name="connsiteX16" fmla="*/ 570992 w 2499995"/>
                <a:gd name="connsiteY16" fmla="*/ 1089787 h 1089786"/>
                <a:gd name="connsiteX17" fmla="*/ 611251 w 2499995"/>
                <a:gd name="connsiteY17" fmla="*/ 1089787 h 1089786"/>
                <a:gd name="connsiteX18" fmla="*/ 652653 w 2499995"/>
                <a:gd name="connsiteY18" fmla="*/ 1089787 h 1089786"/>
                <a:gd name="connsiteX19" fmla="*/ 693928 w 2499995"/>
                <a:gd name="connsiteY19" fmla="*/ 1089787 h 1089786"/>
                <a:gd name="connsiteX20" fmla="*/ 734314 w 2499995"/>
                <a:gd name="connsiteY20" fmla="*/ 1089787 h 1089786"/>
                <a:gd name="connsiteX21" fmla="*/ 773049 w 2499995"/>
                <a:gd name="connsiteY21" fmla="*/ 1089787 h 1089786"/>
                <a:gd name="connsiteX22" fmla="*/ 809371 w 2499995"/>
                <a:gd name="connsiteY22" fmla="*/ 1089787 h 1089786"/>
                <a:gd name="connsiteX23" fmla="*/ 843280 w 2499995"/>
                <a:gd name="connsiteY23" fmla="*/ 1089787 h 1089786"/>
                <a:gd name="connsiteX24" fmla="*/ 874776 w 2499995"/>
                <a:gd name="connsiteY24" fmla="*/ 1089787 h 1089786"/>
                <a:gd name="connsiteX25" fmla="*/ 877951 w 2499995"/>
                <a:gd name="connsiteY25" fmla="*/ 1089787 h 1089786"/>
                <a:gd name="connsiteX26" fmla="*/ 913257 w 2499995"/>
                <a:gd name="connsiteY26" fmla="*/ 1089787 h 1089786"/>
                <a:gd name="connsiteX27" fmla="*/ 947674 w 2499995"/>
                <a:gd name="connsiteY27" fmla="*/ 1089787 h 1089786"/>
                <a:gd name="connsiteX28" fmla="*/ 983234 w 2499995"/>
                <a:gd name="connsiteY28" fmla="*/ 1089787 h 1089786"/>
                <a:gd name="connsiteX29" fmla="*/ 1021588 w 2499995"/>
                <a:gd name="connsiteY29" fmla="*/ 1089787 h 1089786"/>
                <a:gd name="connsiteX30" fmla="*/ 1063371 w 2499995"/>
                <a:gd name="connsiteY30" fmla="*/ 1089787 h 1089786"/>
                <a:gd name="connsiteX31" fmla="*/ 1106297 w 2499995"/>
                <a:gd name="connsiteY31" fmla="*/ 1089787 h 1089786"/>
                <a:gd name="connsiteX32" fmla="*/ 1145413 w 2499995"/>
                <a:gd name="connsiteY32" fmla="*/ 1089787 h 1089786"/>
                <a:gd name="connsiteX33" fmla="*/ 1173734 w 2499995"/>
                <a:gd name="connsiteY33" fmla="*/ 1089787 h 1089786"/>
                <a:gd name="connsiteX34" fmla="*/ 1187577 w 2499995"/>
                <a:gd name="connsiteY34" fmla="*/ 1089787 h 1089786"/>
                <a:gd name="connsiteX35" fmla="*/ 1190498 w 2499995"/>
                <a:gd name="connsiteY35" fmla="*/ 1089787 h 1089786"/>
                <a:gd name="connsiteX36" fmla="*/ 1190498 w 2499995"/>
                <a:gd name="connsiteY36" fmla="*/ 1089787 h 1089786"/>
                <a:gd name="connsiteX37" fmla="*/ 1309497 w 2499995"/>
                <a:gd name="connsiteY37" fmla="*/ 1089787 h 1089786"/>
                <a:gd name="connsiteX38" fmla="*/ 1311529 w 2499995"/>
                <a:gd name="connsiteY38" fmla="*/ 1089787 h 1089786"/>
                <a:gd name="connsiteX39" fmla="*/ 1323721 w 2499995"/>
                <a:gd name="connsiteY39" fmla="*/ 1089787 h 1089786"/>
                <a:gd name="connsiteX40" fmla="*/ 1350264 w 2499995"/>
                <a:gd name="connsiteY40" fmla="*/ 1089787 h 1089786"/>
                <a:gd name="connsiteX41" fmla="*/ 1388364 w 2499995"/>
                <a:gd name="connsiteY41" fmla="*/ 1089787 h 1089786"/>
                <a:gd name="connsiteX42" fmla="*/ 1431163 w 2499995"/>
                <a:gd name="connsiteY42" fmla="*/ 1089787 h 1089786"/>
                <a:gd name="connsiteX43" fmla="*/ 1473327 w 2499995"/>
                <a:gd name="connsiteY43" fmla="*/ 1089787 h 1089786"/>
                <a:gd name="connsiteX44" fmla="*/ 1512062 w 2499995"/>
                <a:gd name="connsiteY44" fmla="*/ 1089787 h 1089786"/>
                <a:gd name="connsiteX45" fmla="*/ 1547876 w 2499995"/>
                <a:gd name="connsiteY45" fmla="*/ 1089787 h 1089786"/>
                <a:gd name="connsiteX46" fmla="*/ 1582293 w 2499995"/>
                <a:gd name="connsiteY46" fmla="*/ 1089787 h 1089786"/>
                <a:gd name="connsiteX47" fmla="*/ 1617472 w 2499995"/>
                <a:gd name="connsiteY47" fmla="*/ 1089787 h 1089786"/>
                <a:gd name="connsiteX48" fmla="*/ 1622044 w 2499995"/>
                <a:gd name="connsiteY48" fmla="*/ 1089787 h 1089786"/>
                <a:gd name="connsiteX49" fmla="*/ 1653413 w 2499995"/>
                <a:gd name="connsiteY49" fmla="*/ 1089787 h 1089786"/>
                <a:gd name="connsiteX50" fmla="*/ 1686941 w 2499995"/>
                <a:gd name="connsiteY50" fmla="*/ 1089787 h 1089786"/>
                <a:gd name="connsiteX51" fmla="*/ 1723009 w 2499995"/>
                <a:gd name="connsiteY51" fmla="*/ 1089787 h 1089786"/>
                <a:gd name="connsiteX52" fmla="*/ 1761490 w 2499995"/>
                <a:gd name="connsiteY52" fmla="*/ 1089787 h 1089786"/>
                <a:gd name="connsiteX53" fmla="*/ 1801749 w 2499995"/>
                <a:gd name="connsiteY53" fmla="*/ 1089787 h 1089786"/>
                <a:gd name="connsiteX54" fmla="*/ 1843024 w 2499995"/>
                <a:gd name="connsiteY54" fmla="*/ 1089787 h 1089786"/>
                <a:gd name="connsiteX55" fmla="*/ 1884426 w 2499995"/>
                <a:gd name="connsiteY55" fmla="*/ 1089787 h 1089786"/>
                <a:gd name="connsiteX56" fmla="*/ 1924812 w 2499995"/>
                <a:gd name="connsiteY56" fmla="*/ 1089787 h 1089786"/>
                <a:gd name="connsiteX57" fmla="*/ 1963547 w 2499995"/>
                <a:gd name="connsiteY57" fmla="*/ 1089787 h 1089786"/>
                <a:gd name="connsiteX58" fmla="*/ 1999869 w 2499995"/>
                <a:gd name="connsiteY58" fmla="*/ 1089787 h 1089786"/>
                <a:gd name="connsiteX59" fmla="*/ 2033778 w 2499995"/>
                <a:gd name="connsiteY59" fmla="*/ 1089787 h 1089786"/>
                <a:gd name="connsiteX60" fmla="*/ 2065274 w 2499995"/>
                <a:gd name="connsiteY60" fmla="*/ 1089787 h 1089786"/>
                <a:gd name="connsiteX61" fmla="*/ 2068449 w 2499995"/>
                <a:gd name="connsiteY61" fmla="*/ 1089787 h 1089786"/>
                <a:gd name="connsiteX62" fmla="*/ 2103755 w 2499995"/>
                <a:gd name="connsiteY62" fmla="*/ 1089787 h 1089786"/>
                <a:gd name="connsiteX63" fmla="*/ 2138172 w 2499995"/>
                <a:gd name="connsiteY63" fmla="*/ 1089787 h 1089786"/>
                <a:gd name="connsiteX64" fmla="*/ 2173732 w 2499995"/>
                <a:gd name="connsiteY64" fmla="*/ 1089787 h 1089786"/>
                <a:gd name="connsiteX65" fmla="*/ 2212086 w 2499995"/>
                <a:gd name="connsiteY65" fmla="*/ 1089787 h 1089786"/>
                <a:gd name="connsiteX66" fmla="*/ 2253742 w 2499995"/>
                <a:gd name="connsiteY66" fmla="*/ 1089787 h 1089786"/>
                <a:gd name="connsiteX67" fmla="*/ 2296795 w 2499995"/>
                <a:gd name="connsiteY67" fmla="*/ 1089787 h 1089786"/>
                <a:gd name="connsiteX68" fmla="*/ 2335911 w 2499995"/>
                <a:gd name="connsiteY68" fmla="*/ 1089787 h 1089786"/>
                <a:gd name="connsiteX69" fmla="*/ 2364232 w 2499995"/>
                <a:gd name="connsiteY69" fmla="*/ 1089787 h 1089786"/>
                <a:gd name="connsiteX70" fmla="*/ 2378075 w 2499995"/>
                <a:gd name="connsiteY70" fmla="*/ 1089787 h 1089786"/>
                <a:gd name="connsiteX71" fmla="*/ 2380869 w 2499995"/>
                <a:gd name="connsiteY71" fmla="*/ 1089787 h 1089786"/>
                <a:gd name="connsiteX72" fmla="*/ 2380869 w 2499995"/>
                <a:gd name="connsiteY72" fmla="*/ 1089787 h 1089786"/>
                <a:gd name="connsiteX73" fmla="*/ 2499995 w 2499995"/>
                <a:gd name="connsiteY73" fmla="*/ 1089787 h 1089786"/>
                <a:gd name="connsiteX74" fmla="*/ 2499995 w 2499995"/>
                <a:gd name="connsiteY74" fmla="*/ 0 h 1089786"/>
                <a:gd name="connsiteX75" fmla="*/ 2380869 w 2499995"/>
                <a:gd name="connsiteY75" fmla="*/ 0 h 1089786"/>
                <a:gd name="connsiteX76" fmla="*/ 2378964 w 2499995"/>
                <a:gd name="connsiteY76" fmla="*/ 0 h 1089786"/>
                <a:gd name="connsiteX77" fmla="*/ 2366772 w 2499995"/>
                <a:gd name="connsiteY77" fmla="*/ 0 h 1089786"/>
                <a:gd name="connsiteX78" fmla="*/ 2340102 w 2499995"/>
                <a:gd name="connsiteY78" fmla="*/ 0 h 1089786"/>
                <a:gd name="connsiteX79" fmla="*/ 2302129 w 2499995"/>
                <a:gd name="connsiteY79" fmla="*/ 0 h 1089786"/>
                <a:gd name="connsiteX80" fmla="*/ 2259203 w 2499995"/>
                <a:gd name="connsiteY80" fmla="*/ 0 h 1089786"/>
                <a:gd name="connsiteX81" fmla="*/ 2217166 w 2499995"/>
                <a:gd name="connsiteY81" fmla="*/ 0 h 1089786"/>
                <a:gd name="connsiteX82" fmla="*/ 2178304 w 2499995"/>
                <a:gd name="connsiteY82" fmla="*/ 0 h 1089786"/>
                <a:gd name="connsiteX83" fmla="*/ 2142617 w 2499995"/>
                <a:gd name="connsiteY83" fmla="*/ 0 h 1089786"/>
                <a:gd name="connsiteX84" fmla="*/ 2108073 w 2499995"/>
                <a:gd name="connsiteY84" fmla="*/ 0 h 1089786"/>
                <a:gd name="connsiteX85" fmla="*/ 2073021 w 2499995"/>
                <a:gd name="connsiteY85" fmla="*/ 0 h 1089786"/>
                <a:gd name="connsiteX86" fmla="*/ 2068449 w 2499995"/>
                <a:gd name="connsiteY86" fmla="*/ 0 h 1089786"/>
                <a:gd name="connsiteX87" fmla="*/ 2037080 w 2499995"/>
                <a:gd name="connsiteY87" fmla="*/ 0 h 1089786"/>
                <a:gd name="connsiteX88" fmla="*/ 2003425 w 2499995"/>
                <a:gd name="connsiteY88" fmla="*/ 0 h 1089786"/>
                <a:gd name="connsiteX89" fmla="*/ 1967357 w 2499995"/>
                <a:gd name="connsiteY89" fmla="*/ 0 h 1089786"/>
                <a:gd name="connsiteX90" fmla="*/ 1928876 w 2499995"/>
                <a:gd name="connsiteY90" fmla="*/ 0 h 1089786"/>
                <a:gd name="connsiteX91" fmla="*/ 1888617 w 2499995"/>
                <a:gd name="connsiteY91" fmla="*/ 0 h 1089786"/>
                <a:gd name="connsiteX92" fmla="*/ 1847342 w 2499995"/>
                <a:gd name="connsiteY92" fmla="*/ 0 h 1089786"/>
                <a:gd name="connsiteX93" fmla="*/ 1805940 w 2499995"/>
                <a:gd name="connsiteY93" fmla="*/ 0 h 1089786"/>
                <a:gd name="connsiteX94" fmla="*/ 1765554 w 2499995"/>
                <a:gd name="connsiteY94" fmla="*/ 0 h 1089786"/>
                <a:gd name="connsiteX95" fmla="*/ 1726946 w 2499995"/>
                <a:gd name="connsiteY95" fmla="*/ 0 h 1089786"/>
                <a:gd name="connsiteX96" fmla="*/ 1690497 w 2499995"/>
                <a:gd name="connsiteY96" fmla="*/ 0 h 1089786"/>
                <a:gd name="connsiteX97" fmla="*/ 1656715 w 2499995"/>
                <a:gd name="connsiteY97" fmla="*/ 0 h 1089786"/>
                <a:gd name="connsiteX98" fmla="*/ 1625092 w 2499995"/>
                <a:gd name="connsiteY98" fmla="*/ 0 h 1089786"/>
                <a:gd name="connsiteX99" fmla="*/ 1622044 w 2499995"/>
                <a:gd name="connsiteY99" fmla="*/ 0 h 1089786"/>
                <a:gd name="connsiteX100" fmla="*/ 1586611 w 2499995"/>
                <a:gd name="connsiteY100" fmla="*/ 0 h 1089786"/>
                <a:gd name="connsiteX101" fmla="*/ 1552194 w 2499995"/>
                <a:gd name="connsiteY101" fmla="*/ 0 h 1089786"/>
                <a:gd name="connsiteX102" fmla="*/ 1516761 w 2499995"/>
                <a:gd name="connsiteY102" fmla="*/ 0 h 1089786"/>
                <a:gd name="connsiteX103" fmla="*/ 1478280 w 2499995"/>
                <a:gd name="connsiteY103" fmla="*/ 0 h 1089786"/>
                <a:gd name="connsiteX104" fmla="*/ 1436624 w 2499995"/>
                <a:gd name="connsiteY104" fmla="*/ 0 h 1089786"/>
                <a:gd name="connsiteX105" fmla="*/ 1393571 w 2499995"/>
                <a:gd name="connsiteY105" fmla="*/ 0 h 1089786"/>
                <a:gd name="connsiteX106" fmla="*/ 1354582 w 2499995"/>
                <a:gd name="connsiteY106" fmla="*/ 0 h 1089786"/>
                <a:gd name="connsiteX107" fmla="*/ 1326261 w 2499995"/>
                <a:gd name="connsiteY107" fmla="*/ 0 h 1089786"/>
                <a:gd name="connsiteX108" fmla="*/ 1312291 w 2499995"/>
                <a:gd name="connsiteY108" fmla="*/ 0 h 1089786"/>
                <a:gd name="connsiteX109" fmla="*/ 1309497 w 2499995"/>
                <a:gd name="connsiteY109" fmla="*/ 0 h 1089786"/>
                <a:gd name="connsiteX110" fmla="*/ 1309497 w 2499995"/>
                <a:gd name="connsiteY110" fmla="*/ 0 h 1089786"/>
                <a:gd name="connsiteX111" fmla="*/ 1190498 w 2499995"/>
                <a:gd name="connsiteY111" fmla="*/ 0 h 1089786"/>
                <a:gd name="connsiteX112" fmla="*/ 1188466 w 2499995"/>
                <a:gd name="connsiteY112" fmla="*/ 0 h 1089786"/>
                <a:gd name="connsiteX113" fmla="*/ 1176274 w 2499995"/>
                <a:gd name="connsiteY113" fmla="*/ 0 h 1089786"/>
                <a:gd name="connsiteX114" fmla="*/ 1149731 w 2499995"/>
                <a:gd name="connsiteY114" fmla="*/ 0 h 1089786"/>
                <a:gd name="connsiteX115" fmla="*/ 1111631 w 2499995"/>
                <a:gd name="connsiteY115" fmla="*/ 0 h 1089786"/>
                <a:gd name="connsiteX116" fmla="*/ 1068705 w 2499995"/>
                <a:gd name="connsiteY116" fmla="*/ 0 h 1089786"/>
                <a:gd name="connsiteX117" fmla="*/ 1026668 w 2499995"/>
                <a:gd name="connsiteY117" fmla="*/ 0 h 1089786"/>
                <a:gd name="connsiteX118" fmla="*/ 987806 w 2499995"/>
                <a:gd name="connsiteY118" fmla="*/ 0 h 1089786"/>
                <a:gd name="connsiteX119" fmla="*/ 952119 w 2499995"/>
                <a:gd name="connsiteY119" fmla="*/ 0 h 1089786"/>
                <a:gd name="connsiteX120" fmla="*/ 917575 w 2499995"/>
                <a:gd name="connsiteY120" fmla="*/ 0 h 1089786"/>
                <a:gd name="connsiteX121" fmla="*/ 882523 w 2499995"/>
                <a:gd name="connsiteY121" fmla="*/ 0 h 1089786"/>
                <a:gd name="connsiteX122" fmla="*/ 877951 w 2499995"/>
                <a:gd name="connsiteY122" fmla="*/ 0 h 1089786"/>
                <a:gd name="connsiteX123" fmla="*/ 846582 w 2499995"/>
                <a:gd name="connsiteY123" fmla="*/ 0 h 1089786"/>
                <a:gd name="connsiteX124" fmla="*/ 812927 w 2499995"/>
                <a:gd name="connsiteY124" fmla="*/ 0 h 1089786"/>
                <a:gd name="connsiteX125" fmla="*/ 776859 w 2499995"/>
                <a:gd name="connsiteY125" fmla="*/ 0 h 1089786"/>
                <a:gd name="connsiteX126" fmla="*/ 738378 w 2499995"/>
                <a:gd name="connsiteY126" fmla="*/ 0 h 1089786"/>
                <a:gd name="connsiteX127" fmla="*/ 698119 w 2499995"/>
                <a:gd name="connsiteY127" fmla="*/ 0 h 1089786"/>
                <a:gd name="connsiteX128" fmla="*/ 656844 w 2499995"/>
                <a:gd name="connsiteY128" fmla="*/ 0 h 1089786"/>
                <a:gd name="connsiteX129" fmla="*/ 615442 w 2499995"/>
                <a:gd name="connsiteY129" fmla="*/ 0 h 1089786"/>
                <a:gd name="connsiteX130" fmla="*/ 575056 w 2499995"/>
                <a:gd name="connsiteY130" fmla="*/ 0 h 1089786"/>
                <a:gd name="connsiteX131" fmla="*/ 536448 w 2499995"/>
                <a:gd name="connsiteY131" fmla="*/ 0 h 1089786"/>
                <a:gd name="connsiteX132" fmla="*/ 500126 w 2499995"/>
                <a:gd name="connsiteY132" fmla="*/ 0 h 1089786"/>
                <a:gd name="connsiteX133" fmla="*/ 466217 w 2499995"/>
                <a:gd name="connsiteY133" fmla="*/ 0 h 1089786"/>
                <a:gd name="connsiteX134" fmla="*/ 434594 w 2499995"/>
                <a:gd name="connsiteY134" fmla="*/ 0 h 1089786"/>
                <a:gd name="connsiteX135" fmla="*/ 431546 w 2499995"/>
                <a:gd name="connsiteY135" fmla="*/ 0 h 1089786"/>
                <a:gd name="connsiteX136" fmla="*/ 396113 w 2499995"/>
                <a:gd name="connsiteY136" fmla="*/ 0 h 1089786"/>
                <a:gd name="connsiteX137" fmla="*/ 361696 w 2499995"/>
                <a:gd name="connsiteY137" fmla="*/ 0 h 1089786"/>
                <a:gd name="connsiteX138" fmla="*/ 326263 w 2499995"/>
                <a:gd name="connsiteY138" fmla="*/ 0 h 1089786"/>
                <a:gd name="connsiteX139" fmla="*/ 287909 w 2499995"/>
                <a:gd name="connsiteY139" fmla="*/ 0 h 1089786"/>
                <a:gd name="connsiteX140" fmla="*/ 246126 w 2499995"/>
                <a:gd name="connsiteY140" fmla="*/ 0 h 1089786"/>
                <a:gd name="connsiteX141" fmla="*/ 203073 w 2499995"/>
                <a:gd name="connsiteY141" fmla="*/ 0 h 1089786"/>
                <a:gd name="connsiteX142" fmla="*/ 164084 w 2499995"/>
                <a:gd name="connsiteY142" fmla="*/ 0 h 1089786"/>
                <a:gd name="connsiteX143" fmla="*/ 135763 w 2499995"/>
                <a:gd name="connsiteY143" fmla="*/ 0 h 1089786"/>
                <a:gd name="connsiteX144" fmla="*/ 121793 w 2499995"/>
                <a:gd name="connsiteY144" fmla="*/ 0 h 1089786"/>
                <a:gd name="connsiteX145" fmla="*/ 118999 w 2499995"/>
                <a:gd name="connsiteY145" fmla="*/ 0 h 1089786"/>
                <a:gd name="connsiteX146" fmla="*/ 118999 w 2499995"/>
                <a:gd name="connsiteY146" fmla="*/ 0 h 1089786"/>
                <a:gd name="connsiteX147" fmla="*/ 0 w 2499995"/>
                <a:gd name="connsiteY147" fmla="*/ 0 h 10897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1089786">
                  <a:moveTo>
                    <a:pt x="0" y="1089787"/>
                  </a:moveTo>
                  <a:lnTo>
                    <a:pt x="118999" y="1089787"/>
                  </a:lnTo>
                  <a:lnTo>
                    <a:pt x="121031" y="1089787"/>
                  </a:lnTo>
                  <a:lnTo>
                    <a:pt x="133223" y="1089787"/>
                  </a:lnTo>
                  <a:lnTo>
                    <a:pt x="159766" y="1089787"/>
                  </a:lnTo>
                  <a:lnTo>
                    <a:pt x="197866" y="1089787"/>
                  </a:lnTo>
                  <a:lnTo>
                    <a:pt x="240792" y="1089787"/>
                  </a:lnTo>
                  <a:lnTo>
                    <a:pt x="282829" y="1089787"/>
                  </a:lnTo>
                  <a:lnTo>
                    <a:pt x="321564" y="1089787"/>
                  </a:lnTo>
                  <a:lnTo>
                    <a:pt x="357378" y="1089787"/>
                  </a:lnTo>
                  <a:lnTo>
                    <a:pt x="391795" y="1089787"/>
                  </a:lnTo>
                  <a:lnTo>
                    <a:pt x="426974" y="1089787"/>
                  </a:lnTo>
                  <a:lnTo>
                    <a:pt x="431546" y="1089787"/>
                  </a:lnTo>
                  <a:lnTo>
                    <a:pt x="462915" y="1089787"/>
                  </a:lnTo>
                  <a:lnTo>
                    <a:pt x="496443" y="1089787"/>
                  </a:lnTo>
                  <a:lnTo>
                    <a:pt x="532638" y="1089787"/>
                  </a:lnTo>
                  <a:lnTo>
                    <a:pt x="570992" y="1089787"/>
                  </a:lnTo>
                  <a:lnTo>
                    <a:pt x="611251" y="1089787"/>
                  </a:lnTo>
                  <a:lnTo>
                    <a:pt x="652653" y="1089787"/>
                  </a:lnTo>
                  <a:lnTo>
                    <a:pt x="693928" y="1089787"/>
                  </a:lnTo>
                  <a:lnTo>
                    <a:pt x="734314" y="1089787"/>
                  </a:lnTo>
                  <a:lnTo>
                    <a:pt x="773049" y="1089787"/>
                  </a:lnTo>
                  <a:lnTo>
                    <a:pt x="809371" y="1089787"/>
                  </a:lnTo>
                  <a:lnTo>
                    <a:pt x="843280" y="1089787"/>
                  </a:lnTo>
                  <a:lnTo>
                    <a:pt x="874776" y="1089787"/>
                  </a:lnTo>
                  <a:lnTo>
                    <a:pt x="877951" y="1089787"/>
                  </a:lnTo>
                  <a:lnTo>
                    <a:pt x="913257" y="1089787"/>
                  </a:lnTo>
                  <a:lnTo>
                    <a:pt x="947674" y="1089787"/>
                  </a:lnTo>
                  <a:lnTo>
                    <a:pt x="983234" y="1089787"/>
                  </a:lnTo>
                  <a:lnTo>
                    <a:pt x="1021588" y="1089787"/>
                  </a:lnTo>
                  <a:lnTo>
                    <a:pt x="1063371" y="1089787"/>
                  </a:lnTo>
                  <a:lnTo>
                    <a:pt x="1106297" y="1089787"/>
                  </a:lnTo>
                  <a:lnTo>
                    <a:pt x="1145413" y="1089787"/>
                  </a:lnTo>
                  <a:lnTo>
                    <a:pt x="1173734" y="1089787"/>
                  </a:lnTo>
                  <a:lnTo>
                    <a:pt x="1187577" y="1089787"/>
                  </a:lnTo>
                  <a:lnTo>
                    <a:pt x="1190498" y="1089787"/>
                  </a:lnTo>
                  <a:lnTo>
                    <a:pt x="1190498" y="1089787"/>
                  </a:lnTo>
                  <a:lnTo>
                    <a:pt x="1309497" y="1089787"/>
                  </a:lnTo>
                  <a:lnTo>
                    <a:pt x="1311529" y="1089787"/>
                  </a:lnTo>
                  <a:lnTo>
                    <a:pt x="1323721" y="1089787"/>
                  </a:lnTo>
                  <a:lnTo>
                    <a:pt x="1350264" y="1089787"/>
                  </a:lnTo>
                  <a:lnTo>
                    <a:pt x="1388364" y="1089787"/>
                  </a:lnTo>
                  <a:lnTo>
                    <a:pt x="1431163" y="1089787"/>
                  </a:lnTo>
                  <a:lnTo>
                    <a:pt x="1473327" y="1089787"/>
                  </a:lnTo>
                  <a:lnTo>
                    <a:pt x="1512062" y="1089787"/>
                  </a:lnTo>
                  <a:lnTo>
                    <a:pt x="1547876" y="1089787"/>
                  </a:lnTo>
                  <a:lnTo>
                    <a:pt x="1582293" y="1089787"/>
                  </a:lnTo>
                  <a:lnTo>
                    <a:pt x="1617472" y="1089787"/>
                  </a:lnTo>
                  <a:lnTo>
                    <a:pt x="1622044" y="1089787"/>
                  </a:lnTo>
                  <a:lnTo>
                    <a:pt x="1653413" y="1089787"/>
                  </a:lnTo>
                  <a:lnTo>
                    <a:pt x="1686941" y="1089787"/>
                  </a:lnTo>
                  <a:lnTo>
                    <a:pt x="1723009" y="1089787"/>
                  </a:lnTo>
                  <a:lnTo>
                    <a:pt x="1761490" y="1089787"/>
                  </a:lnTo>
                  <a:lnTo>
                    <a:pt x="1801749" y="1089787"/>
                  </a:lnTo>
                  <a:lnTo>
                    <a:pt x="1843024" y="1089787"/>
                  </a:lnTo>
                  <a:lnTo>
                    <a:pt x="1884426" y="1089787"/>
                  </a:lnTo>
                  <a:lnTo>
                    <a:pt x="1924812" y="1089787"/>
                  </a:lnTo>
                  <a:lnTo>
                    <a:pt x="1963547" y="1089787"/>
                  </a:lnTo>
                  <a:lnTo>
                    <a:pt x="1999869" y="1089787"/>
                  </a:lnTo>
                  <a:lnTo>
                    <a:pt x="2033778" y="1089787"/>
                  </a:lnTo>
                  <a:lnTo>
                    <a:pt x="2065274" y="1089787"/>
                  </a:lnTo>
                  <a:lnTo>
                    <a:pt x="2068449" y="1089787"/>
                  </a:lnTo>
                  <a:lnTo>
                    <a:pt x="2103755" y="1089787"/>
                  </a:lnTo>
                  <a:lnTo>
                    <a:pt x="2138172" y="1089787"/>
                  </a:lnTo>
                  <a:lnTo>
                    <a:pt x="2173732" y="1089787"/>
                  </a:lnTo>
                  <a:lnTo>
                    <a:pt x="2212086" y="1089787"/>
                  </a:lnTo>
                  <a:lnTo>
                    <a:pt x="2253742" y="1089787"/>
                  </a:lnTo>
                  <a:lnTo>
                    <a:pt x="2296795" y="1089787"/>
                  </a:lnTo>
                  <a:lnTo>
                    <a:pt x="2335911" y="1089787"/>
                  </a:lnTo>
                  <a:lnTo>
                    <a:pt x="2364232" y="1089787"/>
                  </a:lnTo>
                  <a:lnTo>
                    <a:pt x="2378075" y="1089787"/>
                  </a:lnTo>
                  <a:lnTo>
                    <a:pt x="2380869" y="1089787"/>
                  </a:lnTo>
                  <a:lnTo>
                    <a:pt x="2380869" y="1089787"/>
                  </a:lnTo>
                  <a:lnTo>
                    <a:pt x="2499995" y="1089787"/>
                  </a:lnTo>
                  <a:lnTo>
                    <a:pt x="2499995" y="0"/>
                  </a:lnTo>
                  <a:lnTo>
                    <a:pt x="2380869" y="0"/>
                  </a:lnTo>
                  <a:lnTo>
                    <a:pt x="2378964" y="0"/>
                  </a:lnTo>
                  <a:lnTo>
                    <a:pt x="2366772" y="0"/>
                  </a:lnTo>
                  <a:lnTo>
                    <a:pt x="2340102" y="0"/>
                  </a:lnTo>
                  <a:lnTo>
                    <a:pt x="2302129" y="0"/>
                  </a:lnTo>
                  <a:lnTo>
                    <a:pt x="2259203" y="0"/>
                  </a:lnTo>
                  <a:lnTo>
                    <a:pt x="2217166" y="0"/>
                  </a:lnTo>
                  <a:lnTo>
                    <a:pt x="2178304" y="0"/>
                  </a:lnTo>
                  <a:lnTo>
                    <a:pt x="2142617" y="0"/>
                  </a:lnTo>
                  <a:lnTo>
                    <a:pt x="2108073" y="0"/>
                  </a:lnTo>
                  <a:lnTo>
                    <a:pt x="2073021" y="0"/>
                  </a:lnTo>
                  <a:lnTo>
                    <a:pt x="2068449" y="0"/>
                  </a:lnTo>
                  <a:lnTo>
                    <a:pt x="2037080" y="0"/>
                  </a:lnTo>
                  <a:lnTo>
                    <a:pt x="2003425" y="0"/>
                  </a:lnTo>
                  <a:lnTo>
                    <a:pt x="1967357" y="0"/>
                  </a:lnTo>
                  <a:lnTo>
                    <a:pt x="1928876" y="0"/>
                  </a:lnTo>
                  <a:lnTo>
                    <a:pt x="1888617" y="0"/>
                  </a:lnTo>
                  <a:lnTo>
                    <a:pt x="1847342" y="0"/>
                  </a:lnTo>
                  <a:lnTo>
                    <a:pt x="1805940" y="0"/>
                  </a:lnTo>
                  <a:lnTo>
                    <a:pt x="1765554" y="0"/>
                  </a:lnTo>
                  <a:lnTo>
                    <a:pt x="1726946" y="0"/>
                  </a:lnTo>
                  <a:lnTo>
                    <a:pt x="1690497" y="0"/>
                  </a:lnTo>
                  <a:lnTo>
                    <a:pt x="1656715" y="0"/>
                  </a:lnTo>
                  <a:lnTo>
                    <a:pt x="1625092" y="0"/>
                  </a:lnTo>
                  <a:lnTo>
                    <a:pt x="1622044" y="0"/>
                  </a:lnTo>
                  <a:lnTo>
                    <a:pt x="1586611" y="0"/>
                  </a:lnTo>
                  <a:lnTo>
                    <a:pt x="1552194" y="0"/>
                  </a:lnTo>
                  <a:lnTo>
                    <a:pt x="1516761" y="0"/>
                  </a:lnTo>
                  <a:lnTo>
                    <a:pt x="1478280" y="0"/>
                  </a:lnTo>
                  <a:lnTo>
                    <a:pt x="1436624" y="0"/>
                  </a:lnTo>
                  <a:lnTo>
                    <a:pt x="1393571" y="0"/>
                  </a:lnTo>
                  <a:lnTo>
                    <a:pt x="1354582" y="0"/>
                  </a:lnTo>
                  <a:lnTo>
                    <a:pt x="1326261" y="0"/>
                  </a:lnTo>
                  <a:lnTo>
                    <a:pt x="1312291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705" y="0"/>
                  </a:lnTo>
                  <a:lnTo>
                    <a:pt x="1026668" y="0"/>
                  </a:lnTo>
                  <a:lnTo>
                    <a:pt x="987806" y="0"/>
                  </a:lnTo>
                  <a:lnTo>
                    <a:pt x="952119" y="0"/>
                  </a:lnTo>
                  <a:lnTo>
                    <a:pt x="917575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2927" y="0"/>
                  </a:lnTo>
                  <a:lnTo>
                    <a:pt x="776859" y="0"/>
                  </a:lnTo>
                  <a:lnTo>
                    <a:pt x="738378" y="0"/>
                  </a:lnTo>
                  <a:lnTo>
                    <a:pt x="698119" y="0"/>
                  </a:lnTo>
                  <a:lnTo>
                    <a:pt x="656844" y="0"/>
                  </a:lnTo>
                  <a:lnTo>
                    <a:pt x="615442" y="0"/>
                  </a:lnTo>
                  <a:lnTo>
                    <a:pt x="575056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594" y="0"/>
                  </a:lnTo>
                  <a:lnTo>
                    <a:pt x="431546" y="0"/>
                  </a:lnTo>
                  <a:lnTo>
                    <a:pt x="396113" y="0"/>
                  </a:lnTo>
                  <a:lnTo>
                    <a:pt x="361696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126" y="0"/>
                  </a:lnTo>
                  <a:lnTo>
                    <a:pt x="203073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793" y="0"/>
                  </a:lnTo>
                  <a:lnTo>
                    <a:pt x="118999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1A9641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0" name="Forme libre 39">
              <a:extLst>
                <a:ext uri="{FF2B5EF4-FFF2-40B4-BE49-F238E27FC236}">
                  <a16:creationId xmlns:a16="http://schemas.microsoft.com/office/drawing/2014/main" id="{F6CA17D9-C34A-D598-96E9-873AA107D034}"/>
                </a:ext>
              </a:extLst>
            </p:cNvPr>
            <p:cNvSpPr/>
            <p:nvPr/>
          </p:nvSpPr>
          <p:spPr>
            <a:xfrm>
              <a:off x="3934840" y="5082317"/>
              <a:ext cx="2499995" cy="1249934"/>
            </a:xfrm>
            <a:custGeom>
              <a:avLst/>
              <a:gdLst>
                <a:gd name="connsiteX0" fmla="*/ 0 w 2499995"/>
                <a:gd name="connsiteY0" fmla="*/ 1164463 h 1249934"/>
                <a:gd name="connsiteX1" fmla="*/ 118999 w 2499995"/>
                <a:gd name="connsiteY1" fmla="*/ 1164463 h 1249934"/>
                <a:gd name="connsiteX2" fmla="*/ 121031 w 2499995"/>
                <a:gd name="connsiteY2" fmla="*/ 1164463 h 1249934"/>
                <a:gd name="connsiteX3" fmla="*/ 133223 w 2499995"/>
                <a:gd name="connsiteY3" fmla="*/ 1164463 h 1249934"/>
                <a:gd name="connsiteX4" fmla="*/ 159766 w 2499995"/>
                <a:gd name="connsiteY4" fmla="*/ 1164463 h 1249934"/>
                <a:gd name="connsiteX5" fmla="*/ 197866 w 2499995"/>
                <a:gd name="connsiteY5" fmla="*/ 1164463 h 1249934"/>
                <a:gd name="connsiteX6" fmla="*/ 240792 w 2499995"/>
                <a:gd name="connsiteY6" fmla="*/ 1164463 h 1249934"/>
                <a:gd name="connsiteX7" fmla="*/ 282829 w 2499995"/>
                <a:gd name="connsiteY7" fmla="*/ 1164463 h 1249934"/>
                <a:gd name="connsiteX8" fmla="*/ 321564 w 2499995"/>
                <a:gd name="connsiteY8" fmla="*/ 1164463 h 1249934"/>
                <a:gd name="connsiteX9" fmla="*/ 357378 w 2499995"/>
                <a:gd name="connsiteY9" fmla="*/ 1164463 h 1249934"/>
                <a:gd name="connsiteX10" fmla="*/ 391795 w 2499995"/>
                <a:gd name="connsiteY10" fmla="*/ 1164463 h 1249934"/>
                <a:gd name="connsiteX11" fmla="*/ 426974 w 2499995"/>
                <a:gd name="connsiteY11" fmla="*/ 1164463 h 1249934"/>
                <a:gd name="connsiteX12" fmla="*/ 431546 w 2499995"/>
                <a:gd name="connsiteY12" fmla="*/ 1164463 h 1249934"/>
                <a:gd name="connsiteX13" fmla="*/ 462915 w 2499995"/>
                <a:gd name="connsiteY13" fmla="*/ 1164463 h 1249934"/>
                <a:gd name="connsiteX14" fmla="*/ 496443 w 2499995"/>
                <a:gd name="connsiteY14" fmla="*/ 1164463 h 1249934"/>
                <a:gd name="connsiteX15" fmla="*/ 532638 w 2499995"/>
                <a:gd name="connsiteY15" fmla="*/ 1164463 h 1249934"/>
                <a:gd name="connsiteX16" fmla="*/ 570992 w 2499995"/>
                <a:gd name="connsiteY16" fmla="*/ 1164463 h 1249934"/>
                <a:gd name="connsiteX17" fmla="*/ 611251 w 2499995"/>
                <a:gd name="connsiteY17" fmla="*/ 1164463 h 1249934"/>
                <a:gd name="connsiteX18" fmla="*/ 652653 w 2499995"/>
                <a:gd name="connsiteY18" fmla="*/ 1164463 h 1249934"/>
                <a:gd name="connsiteX19" fmla="*/ 693928 w 2499995"/>
                <a:gd name="connsiteY19" fmla="*/ 1164463 h 1249934"/>
                <a:gd name="connsiteX20" fmla="*/ 734314 w 2499995"/>
                <a:gd name="connsiteY20" fmla="*/ 1164463 h 1249934"/>
                <a:gd name="connsiteX21" fmla="*/ 773049 w 2499995"/>
                <a:gd name="connsiteY21" fmla="*/ 1164463 h 1249934"/>
                <a:gd name="connsiteX22" fmla="*/ 809371 w 2499995"/>
                <a:gd name="connsiteY22" fmla="*/ 1164463 h 1249934"/>
                <a:gd name="connsiteX23" fmla="*/ 843280 w 2499995"/>
                <a:gd name="connsiteY23" fmla="*/ 1164463 h 1249934"/>
                <a:gd name="connsiteX24" fmla="*/ 874776 w 2499995"/>
                <a:gd name="connsiteY24" fmla="*/ 1164463 h 1249934"/>
                <a:gd name="connsiteX25" fmla="*/ 877951 w 2499995"/>
                <a:gd name="connsiteY25" fmla="*/ 1164463 h 1249934"/>
                <a:gd name="connsiteX26" fmla="*/ 913257 w 2499995"/>
                <a:gd name="connsiteY26" fmla="*/ 1164463 h 1249934"/>
                <a:gd name="connsiteX27" fmla="*/ 947674 w 2499995"/>
                <a:gd name="connsiteY27" fmla="*/ 1164463 h 1249934"/>
                <a:gd name="connsiteX28" fmla="*/ 983234 w 2499995"/>
                <a:gd name="connsiteY28" fmla="*/ 1164463 h 1249934"/>
                <a:gd name="connsiteX29" fmla="*/ 1021588 w 2499995"/>
                <a:gd name="connsiteY29" fmla="*/ 1164463 h 1249934"/>
                <a:gd name="connsiteX30" fmla="*/ 1063371 w 2499995"/>
                <a:gd name="connsiteY30" fmla="*/ 1164463 h 1249934"/>
                <a:gd name="connsiteX31" fmla="*/ 1106297 w 2499995"/>
                <a:gd name="connsiteY31" fmla="*/ 1164463 h 1249934"/>
                <a:gd name="connsiteX32" fmla="*/ 1145413 w 2499995"/>
                <a:gd name="connsiteY32" fmla="*/ 1164463 h 1249934"/>
                <a:gd name="connsiteX33" fmla="*/ 1173734 w 2499995"/>
                <a:gd name="connsiteY33" fmla="*/ 1164463 h 1249934"/>
                <a:gd name="connsiteX34" fmla="*/ 1187577 w 2499995"/>
                <a:gd name="connsiteY34" fmla="*/ 1164463 h 1249934"/>
                <a:gd name="connsiteX35" fmla="*/ 1190498 w 2499995"/>
                <a:gd name="connsiteY35" fmla="*/ 1164463 h 1249934"/>
                <a:gd name="connsiteX36" fmla="*/ 1190498 w 2499995"/>
                <a:gd name="connsiteY36" fmla="*/ 1164463 h 1249934"/>
                <a:gd name="connsiteX37" fmla="*/ 1309497 w 2499995"/>
                <a:gd name="connsiteY37" fmla="*/ 1164463 h 1249934"/>
                <a:gd name="connsiteX38" fmla="*/ 1311529 w 2499995"/>
                <a:gd name="connsiteY38" fmla="*/ 1164590 h 1249934"/>
                <a:gd name="connsiteX39" fmla="*/ 1323721 w 2499995"/>
                <a:gd name="connsiteY39" fmla="*/ 1164717 h 1249934"/>
                <a:gd name="connsiteX40" fmla="*/ 1350264 w 2499995"/>
                <a:gd name="connsiteY40" fmla="*/ 1165098 h 1249934"/>
                <a:gd name="connsiteX41" fmla="*/ 1388237 w 2499995"/>
                <a:gd name="connsiteY41" fmla="*/ 1165860 h 1249934"/>
                <a:gd name="connsiteX42" fmla="*/ 1431036 w 2499995"/>
                <a:gd name="connsiteY42" fmla="*/ 1166876 h 1249934"/>
                <a:gd name="connsiteX43" fmla="*/ 1473200 w 2499995"/>
                <a:gd name="connsiteY43" fmla="*/ 1168273 h 1249934"/>
                <a:gd name="connsiteX44" fmla="*/ 1511935 w 2499995"/>
                <a:gd name="connsiteY44" fmla="*/ 1170051 h 1249934"/>
                <a:gd name="connsiteX45" fmla="*/ 1547749 w 2499995"/>
                <a:gd name="connsiteY45" fmla="*/ 1172210 h 1249934"/>
                <a:gd name="connsiteX46" fmla="*/ 1582166 w 2499995"/>
                <a:gd name="connsiteY46" fmla="*/ 1174877 h 1249934"/>
                <a:gd name="connsiteX47" fmla="*/ 1617218 w 2499995"/>
                <a:gd name="connsiteY47" fmla="*/ 1178306 h 1249934"/>
                <a:gd name="connsiteX48" fmla="*/ 1622044 w 2499995"/>
                <a:gd name="connsiteY48" fmla="*/ 1178814 h 1249934"/>
                <a:gd name="connsiteX49" fmla="*/ 1653286 w 2499995"/>
                <a:gd name="connsiteY49" fmla="*/ 1182243 h 1249934"/>
                <a:gd name="connsiteX50" fmla="*/ 1686687 w 2499995"/>
                <a:gd name="connsiteY50" fmla="*/ 1186307 h 1249934"/>
                <a:gd name="connsiteX51" fmla="*/ 1722628 w 2499995"/>
                <a:gd name="connsiteY51" fmla="*/ 1190879 h 1249934"/>
                <a:gd name="connsiteX52" fmla="*/ 1760855 w 2499995"/>
                <a:gd name="connsiteY52" fmla="*/ 1195832 h 1249934"/>
                <a:gd name="connsiteX53" fmla="*/ 1800987 w 2499995"/>
                <a:gd name="connsiteY53" fmla="*/ 1201293 h 1249934"/>
                <a:gd name="connsiteX54" fmla="*/ 1842135 w 2499995"/>
                <a:gd name="connsiteY54" fmla="*/ 1206881 h 1249934"/>
                <a:gd name="connsiteX55" fmla="*/ 1883283 w 2499995"/>
                <a:gd name="connsiteY55" fmla="*/ 1212469 h 1249934"/>
                <a:gd name="connsiteX56" fmla="*/ 1923542 w 2499995"/>
                <a:gd name="connsiteY56" fmla="*/ 1217803 h 1249934"/>
                <a:gd name="connsiteX57" fmla="*/ 1962150 w 2499995"/>
                <a:gd name="connsiteY57" fmla="*/ 1222883 h 1249934"/>
                <a:gd name="connsiteX58" fmla="*/ 1998472 w 2499995"/>
                <a:gd name="connsiteY58" fmla="*/ 1227582 h 1249934"/>
                <a:gd name="connsiteX59" fmla="*/ 2032254 w 2499995"/>
                <a:gd name="connsiteY59" fmla="*/ 1231646 h 1249934"/>
                <a:gd name="connsiteX60" fmla="*/ 2063877 w 2499995"/>
                <a:gd name="connsiteY60" fmla="*/ 1235202 h 1249934"/>
                <a:gd name="connsiteX61" fmla="*/ 2068449 w 2499995"/>
                <a:gd name="connsiteY61" fmla="*/ 1235710 h 1249934"/>
                <a:gd name="connsiteX62" fmla="*/ 2103755 w 2499995"/>
                <a:gd name="connsiteY62" fmla="*/ 1239266 h 1249934"/>
                <a:gd name="connsiteX63" fmla="*/ 2138172 w 2499995"/>
                <a:gd name="connsiteY63" fmla="*/ 1242060 h 1249934"/>
                <a:gd name="connsiteX64" fmla="*/ 2173605 w 2499995"/>
                <a:gd name="connsiteY64" fmla="*/ 1244219 h 1249934"/>
                <a:gd name="connsiteX65" fmla="*/ 2211959 w 2499995"/>
                <a:gd name="connsiteY65" fmla="*/ 1245997 h 1249934"/>
                <a:gd name="connsiteX66" fmla="*/ 2253742 w 2499995"/>
                <a:gd name="connsiteY66" fmla="*/ 1247394 h 1249934"/>
                <a:gd name="connsiteX67" fmla="*/ 2296668 w 2499995"/>
                <a:gd name="connsiteY67" fmla="*/ 1248537 h 1249934"/>
                <a:gd name="connsiteX68" fmla="*/ 2335784 w 2499995"/>
                <a:gd name="connsiteY68" fmla="*/ 1249299 h 1249934"/>
                <a:gd name="connsiteX69" fmla="*/ 2364105 w 2499995"/>
                <a:gd name="connsiteY69" fmla="*/ 1249807 h 1249934"/>
                <a:gd name="connsiteX70" fmla="*/ 2378075 w 2499995"/>
                <a:gd name="connsiteY70" fmla="*/ 1249934 h 1249934"/>
                <a:gd name="connsiteX71" fmla="*/ 2380869 w 2499995"/>
                <a:gd name="connsiteY71" fmla="*/ 1249934 h 1249934"/>
                <a:gd name="connsiteX72" fmla="*/ 2380869 w 2499995"/>
                <a:gd name="connsiteY72" fmla="*/ 1249934 h 1249934"/>
                <a:gd name="connsiteX73" fmla="*/ 2499995 w 2499995"/>
                <a:gd name="connsiteY73" fmla="*/ 1249934 h 1249934"/>
                <a:gd name="connsiteX74" fmla="*/ 2499995 w 2499995"/>
                <a:gd name="connsiteY74" fmla="*/ 85471 h 1249934"/>
                <a:gd name="connsiteX75" fmla="*/ 2380869 w 2499995"/>
                <a:gd name="connsiteY75" fmla="*/ 85471 h 1249934"/>
                <a:gd name="connsiteX76" fmla="*/ 2378964 w 2499995"/>
                <a:gd name="connsiteY76" fmla="*/ 85471 h 1249934"/>
                <a:gd name="connsiteX77" fmla="*/ 2366772 w 2499995"/>
                <a:gd name="connsiteY77" fmla="*/ 85217 h 1249934"/>
                <a:gd name="connsiteX78" fmla="*/ 2340229 w 2499995"/>
                <a:gd name="connsiteY78" fmla="*/ 84836 h 1249934"/>
                <a:gd name="connsiteX79" fmla="*/ 2302129 w 2499995"/>
                <a:gd name="connsiteY79" fmla="*/ 84201 h 1249934"/>
                <a:gd name="connsiteX80" fmla="*/ 2259330 w 2499995"/>
                <a:gd name="connsiteY80" fmla="*/ 83058 h 1249934"/>
                <a:gd name="connsiteX81" fmla="*/ 2217293 w 2499995"/>
                <a:gd name="connsiteY81" fmla="*/ 81661 h 1249934"/>
                <a:gd name="connsiteX82" fmla="*/ 2178431 w 2499995"/>
                <a:gd name="connsiteY82" fmla="*/ 80010 h 1249934"/>
                <a:gd name="connsiteX83" fmla="*/ 2142744 w 2499995"/>
                <a:gd name="connsiteY83" fmla="*/ 77851 h 1249934"/>
                <a:gd name="connsiteX84" fmla="*/ 2108327 w 2499995"/>
                <a:gd name="connsiteY84" fmla="*/ 75057 h 1249934"/>
                <a:gd name="connsiteX85" fmla="*/ 2073148 w 2499995"/>
                <a:gd name="connsiteY85" fmla="*/ 71755 h 1249934"/>
                <a:gd name="connsiteX86" fmla="*/ 2068449 w 2499995"/>
                <a:gd name="connsiteY86" fmla="*/ 71247 h 1249934"/>
                <a:gd name="connsiteX87" fmla="*/ 2037207 w 2499995"/>
                <a:gd name="connsiteY87" fmla="*/ 67691 h 1249934"/>
                <a:gd name="connsiteX88" fmla="*/ 2003679 w 2499995"/>
                <a:gd name="connsiteY88" fmla="*/ 63627 h 1249934"/>
                <a:gd name="connsiteX89" fmla="*/ 1967738 w 2499995"/>
                <a:gd name="connsiteY89" fmla="*/ 59182 h 1249934"/>
                <a:gd name="connsiteX90" fmla="*/ 1929511 w 2499995"/>
                <a:gd name="connsiteY90" fmla="*/ 54102 h 1249934"/>
                <a:gd name="connsiteX91" fmla="*/ 1889506 w 2499995"/>
                <a:gd name="connsiteY91" fmla="*/ 48768 h 1249934"/>
                <a:gd name="connsiteX92" fmla="*/ 1848358 w 2499995"/>
                <a:gd name="connsiteY92" fmla="*/ 43180 h 1249934"/>
                <a:gd name="connsiteX93" fmla="*/ 1807083 w 2499995"/>
                <a:gd name="connsiteY93" fmla="*/ 37592 h 1249934"/>
                <a:gd name="connsiteX94" fmla="*/ 1766824 w 2499995"/>
                <a:gd name="connsiteY94" fmla="*/ 32131 h 1249934"/>
                <a:gd name="connsiteX95" fmla="*/ 1728216 w 2499995"/>
                <a:gd name="connsiteY95" fmla="*/ 27051 h 1249934"/>
                <a:gd name="connsiteX96" fmla="*/ 1692021 w 2499995"/>
                <a:gd name="connsiteY96" fmla="*/ 22352 h 1249934"/>
                <a:gd name="connsiteX97" fmla="*/ 1658112 w 2499995"/>
                <a:gd name="connsiteY97" fmla="*/ 18288 h 1249934"/>
                <a:gd name="connsiteX98" fmla="*/ 1626616 w 2499995"/>
                <a:gd name="connsiteY98" fmla="*/ 14732 h 1249934"/>
                <a:gd name="connsiteX99" fmla="*/ 1622044 w 2499995"/>
                <a:gd name="connsiteY99" fmla="*/ 14224 h 1249934"/>
                <a:gd name="connsiteX100" fmla="*/ 1586611 w 2499995"/>
                <a:gd name="connsiteY100" fmla="*/ 10795 h 1249934"/>
                <a:gd name="connsiteX101" fmla="*/ 1552194 w 2499995"/>
                <a:gd name="connsiteY101" fmla="*/ 8001 h 1249934"/>
                <a:gd name="connsiteX102" fmla="*/ 1516761 w 2499995"/>
                <a:gd name="connsiteY102" fmla="*/ 5715 h 1249934"/>
                <a:gd name="connsiteX103" fmla="*/ 1478407 w 2499995"/>
                <a:gd name="connsiteY103" fmla="*/ 3937 h 1249934"/>
                <a:gd name="connsiteX104" fmla="*/ 1436751 w 2499995"/>
                <a:gd name="connsiteY104" fmla="*/ 2540 h 1249934"/>
                <a:gd name="connsiteX105" fmla="*/ 1393698 w 2499995"/>
                <a:gd name="connsiteY105" fmla="*/ 1397 h 1249934"/>
                <a:gd name="connsiteX106" fmla="*/ 1354709 w 2499995"/>
                <a:gd name="connsiteY106" fmla="*/ 635 h 1249934"/>
                <a:gd name="connsiteX107" fmla="*/ 1326261 w 2499995"/>
                <a:gd name="connsiteY107" fmla="*/ 254 h 1249934"/>
                <a:gd name="connsiteX108" fmla="*/ 1312291 w 2499995"/>
                <a:gd name="connsiteY108" fmla="*/ 0 h 1249934"/>
                <a:gd name="connsiteX109" fmla="*/ 1309497 w 2499995"/>
                <a:gd name="connsiteY109" fmla="*/ 0 h 1249934"/>
                <a:gd name="connsiteX110" fmla="*/ 1309497 w 2499995"/>
                <a:gd name="connsiteY110" fmla="*/ 0 h 1249934"/>
                <a:gd name="connsiteX111" fmla="*/ 1190498 w 2499995"/>
                <a:gd name="connsiteY111" fmla="*/ 0 h 1249934"/>
                <a:gd name="connsiteX112" fmla="*/ 1188466 w 2499995"/>
                <a:gd name="connsiteY112" fmla="*/ 0 h 1249934"/>
                <a:gd name="connsiteX113" fmla="*/ 1176274 w 2499995"/>
                <a:gd name="connsiteY113" fmla="*/ 0 h 1249934"/>
                <a:gd name="connsiteX114" fmla="*/ 1149731 w 2499995"/>
                <a:gd name="connsiteY114" fmla="*/ 0 h 1249934"/>
                <a:gd name="connsiteX115" fmla="*/ 1111631 w 2499995"/>
                <a:gd name="connsiteY115" fmla="*/ 0 h 1249934"/>
                <a:gd name="connsiteX116" fmla="*/ 1068705 w 2499995"/>
                <a:gd name="connsiteY116" fmla="*/ 0 h 1249934"/>
                <a:gd name="connsiteX117" fmla="*/ 1026668 w 2499995"/>
                <a:gd name="connsiteY117" fmla="*/ 0 h 1249934"/>
                <a:gd name="connsiteX118" fmla="*/ 987806 w 2499995"/>
                <a:gd name="connsiteY118" fmla="*/ 0 h 1249934"/>
                <a:gd name="connsiteX119" fmla="*/ 952119 w 2499995"/>
                <a:gd name="connsiteY119" fmla="*/ 0 h 1249934"/>
                <a:gd name="connsiteX120" fmla="*/ 917575 w 2499995"/>
                <a:gd name="connsiteY120" fmla="*/ 0 h 1249934"/>
                <a:gd name="connsiteX121" fmla="*/ 882523 w 2499995"/>
                <a:gd name="connsiteY121" fmla="*/ 0 h 1249934"/>
                <a:gd name="connsiteX122" fmla="*/ 877951 w 2499995"/>
                <a:gd name="connsiteY122" fmla="*/ 0 h 1249934"/>
                <a:gd name="connsiteX123" fmla="*/ 846582 w 2499995"/>
                <a:gd name="connsiteY123" fmla="*/ 0 h 1249934"/>
                <a:gd name="connsiteX124" fmla="*/ 812927 w 2499995"/>
                <a:gd name="connsiteY124" fmla="*/ 0 h 1249934"/>
                <a:gd name="connsiteX125" fmla="*/ 776859 w 2499995"/>
                <a:gd name="connsiteY125" fmla="*/ 0 h 1249934"/>
                <a:gd name="connsiteX126" fmla="*/ 738378 w 2499995"/>
                <a:gd name="connsiteY126" fmla="*/ 0 h 1249934"/>
                <a:gd name="connsiteX127" fmla="*/ 698119 w 2499995"/>
                <a:gd name="connsiteY127" fmla="*/ 0 h 1249934"/>
                <a:gd name="connsiteX128" fmla="*/ 656844 w 2499995"/>
                <a:gd name="connsiteY128" fmla="*/ 0 h 1249934"/>
                <a:gd name="connsiteX129" fmla="*/ 615442 w 2499995"/>
                <a:gd name="connsiteY129" fmla="*/ 0 h 1249934"/>
                <a:gd name="connsiteX130" fmla="*/ 575056 w 2499995"/>
                <a:gd name="connsiteY130" fmla="*/ 0 h 1249934"/>
                <a:gd name="connsiteX131" fmla="*/ 536448 w 2499995"/>
                <a:gd name="connsiteY131" fmla="*/ 0 h 1249934"/>
                <a:gd name="connsiteX132" fmla="*/ 500126 w 2499995"/>
                <a:gd name="connsiteY132" fmla="*/ 0 h 1249934"/>
                <a:gd name="connsiteX133" fmla="*/ 466217 w 2499995"/>
                <a:gd name="connsiteY133" fmla="*/ 0 h 1249934"/>
                <a:gd name="connsiteX134" fmla="*/ 434594 w 2499995"/>
                <a:gd name="connsiteY134" fmla="*/ 0 h 1249934"/>
                <a:gd name="connsiteX135" fmla="*/ 431546 w 2499995"/>
                <a:gd name="connsiteY135" fmla="*/ 0 h 1249934"/>
                <a:gd name="connsiteX136" fmla="*/ 396113 w 2499995"/>
                <a:gd name="connsiteY136" fmla="*/ 0 h 1249934"/>
                <a:gd name="connsiteX137" fmla="*/ 361696 w 2499995"/>
                <a:gd name="connsiteY137" fmla="*/ 0 h 1249934"/>
                <a:gd name="connsiteX138" fmla="*/ 326263 w 2499995"/>
                <a:gd name="connsiteY138" fmla="*/ 0 h 1249934"/>
                <a:gd name="connsiteX139" fmla="*/ 287909 w 2499995"/>
                <a:gd name="connsiteY139" fmla="*/ 0 h 1249934"/>
                <a:gd name="connsiteX140" fmla="*/ 246126 w 2499995"/>
                <a:gd name="connsiteY140" fmla="*/ 0 h 1249934"/>
                <a:gd name="connsiteX141" fmla="*/ 203073 w 2499995"/>
                <a:gd name="connsiteY141" fmla="*/ 0 h 1249934"/>
                <a:gd name="connsiteX142" fmla="*/ 164084 w 2499995"/>
                <a:gd name="connsiteY142" fmla="*/ 0 h 1249934"/>
                <a:gd name="connsiteX143" fmla="*/ 135763 w 2499995"/>
                <a:gd name="connsiteY143" fmla="*/ 0 h 1249934"/>
                <a:gd name="connsiteX144" fmla="*/ 121793 w 2499995"/>
                <a:gd name="connsiteY144" fmla="*/ 0 h 1249934"/>
                <a:gd name="connsiteX145" fmla="*/ 118999 w 2499995"/>
                <a:gd name="connsiteY145" fmla="*/ 0 h 1249934"/>
                <a:gd name="connsiteX146" fmla="*/ 118999 w 2499995"/>
                <a:gd name="connsiteY146" fmla="*/ 0 h 1249934"/>
                <a:gd name="connsiteX147" fmla="*/ 0 w 2499995"/>
                <a:gd name="connsiteY147" fmla="*/ 0 h 124993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1249934">
                  <a:moveTo>
                    <a:pt x="0" y="1164463"/>
                  </a:moveTo>
                  <a:lnTo>
                    <a:pt x="118999" y="1164463"/>
                  </a:lnTo>
                  <a:lnTo>
                    <a:pt x="121031" y="1164463"/>
                  </a:lnTo>
                  <a:lnTo>
                    <a:pt x="133223" y="1164463"/>
                  </a:lnTo>
                  <a:lnTo>
                    <a:pt x="159766" y="1164463"/>
                  </a:lnTo>
                  <a:lnTo>
                    <a:pt x="197866" y="1164463"/>
                  </a:lnTo>
                  <a:lnTo>
                    <a:pt x="240792" y="1164463"/>
                  </a:lnTo>
                  <a:lnTo>
                    <a:pt x="282829" y="1164463"/>
                  </a:lnTo>
                  <a:lnTo>
                    <a:pt x="321564" y="1164463"/>
                  </a:lnTo>
                  <a:lnTo>
                    <a:pt x="357378" y="1164463"/>
                  </a:lnTo>
                  <a:lnTo>
                    <a:pt x="391795" y="1164463"/>
                  </a:lnTo>
                  <a:lnTo>
                    <a:pt x="426974" y="1164463"/>
                  </a:lnTo>
                  <a:lnTo>
                    <a:pt x="431546" y="1164463"/>
                  </a:lnTo>
                  <a:lnTo>
                    <a:pt x="462915" y="1164463"/>
                  </a:lnTo>
                  <a:lnTo>
                    <a:pt x="496443" y="1164463"/>
                  </a:lnTo>
                  <a:lnTo>
                    <a:pt x="532638" y="1164463"/>
                  </a:lnTo>
                  <a:lnTo>
                    <a:pt x="570992" y="1164463"/>
                  </a:lnTo>
                  <a:lnTo>
                    <a:pt x="611251" y="1164463"/>
                  </a:lnTo>
                  <a:lnTo>
                    <a:pt x="652653" y="1164463"/>
                  </a:lnTo>
                  <a:lnTo>
                    <a:pt x="693928" y="1164463"/>
                  </a:lnTo>
                  <a:lnTo>
                    <a:pt x="734314" y="1164463"/>
                  </a:lnTo>
                  <a:lnTo>
                    <a:pt x="773049" y="1164463"/>
                  </a:lnTo>
                  <a:lnTo>
                    <a:pt x="809371" y="1164463"/>
                  </a:lnTo>
                  <a:lnTo>
                    <a:pt x="843280" y="1164463"/>
                  </a:lnTo>
                  <a:lnTo>
                    <a:pt x="874776" y="1164463"/>
                  </a:lnTo>
                  <a:lnTo>
                    <a:pt x="877951" y="1164463"/>
                  </a:lnTo>
                  <a:lnTo>
                    <a:pt x="913257" y="1164463"/>
                  </a:lnTo>
                  <a:lnTo>
                    <a:pt x="947674" y="1164463"/>
                  </a:lnTo>
                  <a:lnTo>
                    <a:pt x="983234" y="1164463"/>
                  </a:lnTo>
                  <a:lnTo>
                    <a:pt x="1021588" y="1164463"/>
                  </a:lnTo>
                  <a:lnTo>
                    <a:pt x="1063371" y="1164463"/>
                  </a:lnTo>
                  <a:lnTo>
                    <a:pt x="1106297" y="1164463"/>
                  </a:lnTo>
                  <a:lnTo>
                    <a:pt x="1145413" y="1164463"/>
                  </a:lnTo>
                  <a:lnTo>
                    <a:pt x="1173734" y="1164463"/>
                  </a:lnTo>
                  <a:lnTo>
                    <a:pt x="1187577" y="1164463"/>
                  </a:lnTo>
                  <a:lnTo>
                    <a:pt x="1190498" y="1164463"/>
                  </a:lnTo>
                  <a:lnTo>
                    <a:pt x="1190498" y="1164463"/>
                  </a:lnTo>
                  <a:lnTo>
                    <a:pt x="1309497" y="1164463"/>
                  </a:lnTo>
                  <a:lnTo>
                    <a:pt x="1311529" y="1164590"/>
                  </a:lnTo>
                  <a:lnTo>
                    <a:pt x="1323721" y="1164717"/>
                  </a:lnTo>
                  <a:lnTo>
                    <a:pt x="1350264" y="1165098"/>
                  </a:lnTo>
                  <a:lnTo>
                    <a:pt x="1388237" y="1165860"/>
                  </a:lnTo>
                  <a:lnTo>
                    <a:pt x="1431036" y="1166876"/>
                  </a:lnTo>
                  <a:lnTo>
                    <a:pt x="1473200" y="1168273"/>
                  </a:lnTo>
                  <a:lnTo>
                    <a:pt x="1511935" y="1170051"/>
                  </a:lnTo>
                  <a:lnTo>
                    <a:pt x="1547749" y="1172210"/>
                  </a:lnTo>
                  <a:lnTo>
                    <a:pt x="1582166" y="1174877"/>
                  </a:lnTo>
                  <a:lnTo>
                    <a:pt x="1617218" y="1178306"/>
                  </a:lnTo>
                  <a:lnTo>
                    <a:pt x="1622044" y="1178814"/>
                  </a:lnTo>
                  <a:lnTo>
                    <a:pt x="1653286" y="1182243"/>
                  </a:lnTo>
                  <a:lnTo>
                    <a:pt x="1686687" y="1186307"/>
                  </a:lnTo>
                  <a:lnTo>
                    <a:pt x="1722628" y="1190879"/>
                  </a:lnTo>
                  <a:lnTo>
                    <a:pt x="1760855" y="1195832"/>
                  </a:lnTo>
                  <a:lnTo>
                    <a:pt x="1800987" y="1201293"/>
                  </a:lnTo>
                  <a:lnTo>
                    <a:pt x="1842135" y="1206881"/>
                  </a:lnTo>
                  <a:lnTo>
                    <a:pt x="1883283" y="1212469"/>
                  </a:lnTo>
                  <a:lnTo>
                    <a:pt x="1923542" y="1217803"/>
                  </a:lnTo>
                  <a:lnTo>
                    <a:pt x="1962150" y="1222883"/>
                  </a:lnTo>
                  <a:lnTo>
                    <a:pt x="1998472" y="1227582"/>
                  </a:lnTo>
                  <a:lnTo>
                    <a:pt x="2032254" y="1231646"/>
                  </a:lnTo>
                  <a:lnTo>
                    <a:pt x="2063877" y="1235202"/>
                  </a:lnTo>
                  <a:lnTo>
                    <a:pt x="2068449" y="1235710"/>
                  </a:lnTo>
                  <a:lnTo>
                    <a:pt x="2103755" y="1239266"/>
                  </a:lnTo>
                  <a:lnTo>
                    <a:pt x="2138172" y="1242060"/>
                  </a:lnTo>
                  <a:lnTo>
                    <a:pt x="2173605" y="1244219"/>
                  </a:lnTo>
                  <a:lnTo>
                    <a:pt x="2211959" y="1245997"/>
                  </a:lnTo>
                  <a:lnTo>
                    <a:pt x="2253742" y="1247394"/>
                  </a:lnTo>
                  <a:lnTo>
                    <a:pt x="2296668" y="1248537"/>
                  </a:lnTo>
                  <a:lnTo>
                    <a:pt x="2335784" y="1249299"/>
                  </a:lnTo>
                  <a:lnTo>
                    <a:pt x="2364105" y="1249807"/>
                  </a:lnTo>
                  <a:lnTo>
                    <a:pt x="2378075" y="1249934"/>
                  </a:lnTo>
                  <a:lnTo>
                    <a:pt x="2380869" y="1249934"/>
                  </a:lnTo>
                  <a:lnTo>
                    <a:pt x="2380869" y="1249934"/>
                  </a:lnTo>
                  <a:lnTo>
                    <a:pt x="2499995" y="1249934"/>
                  </a:lnTo>
                  <a:lnTo>
                    <a:pt x="2499995" y="85471"/>
                  </a:lnTo>
                  <a:lnTo>
                    <a:pt x="2380869" y="85471"/>
                  </a:lnTo>
                  <a:lnTo>
                    <a:pt x="2378964" y="85471"/>
                  </a:lnTo>
                  <a:lnTo>
                    <a:pt x="2366772" y="85217"/>
                  </a:lnTo>
                  <a:lnTo>
                    <a:pt x="2340229" y="84836"/>
                  </a:lnTo>
                  <a:lnTo>
                    <a:pt x="2302129" y="84201"/>
                  </a:lnTo>
                  <a:lnTo>
                    <a:pt x="2259330" y="83058"/>
                  </a:lnTo>
                  <a:lnTo>
                    <a:pt x="2217293" y="81661"/>
                  </a:lnTo>
                  <a:lnTo>
                    <a:pt x="2178431" y="80010"/>
                  </a:lnTo>
                  <a:lnTo>
                    <a:pt x="2142744" y="77851"/>
                  </a:lnTo>
                  <a:lnTo>
                    <a:pt x="2108327" y="75057"/>
                  </a:lnTo>
                  <a:lnTo>
                    <a:pt x="2073148" y="71755"/>
                  </a:lnTo>
                  <a:lnTo>
                    <a:pt x="2068449" y="71247"/>
                  </a:lnTo>
                  <a:lnTo>
                    <a:pt x="2037207" y="67691"/>
                  </a:lnTo>
                  <a:lnTo>
                    <a:pt x="2003679" y="63627"/>
                  </a:lnTo>
                  <a:lnTo>
                    <a:pt x="1967738" y="59182"/>
                  </a:lnTo>
                  <a:lnTo>
                    <a:pt x="1929511" y="54102"/>
                  </a:lnTo>
                  <a:lnTo>
                    <a:pt x="1889506" y="48768"/>
                  </a:lnTo>
                  <a:lnTo>
                    <a:pt x="1848358" y="43180"/>
                  </a:lnTo>
                  <a:lnTo>
                    <a:pt x="1807083" y="37592"/>
                  </a:lnTo>
                  <a:lnTo>
                    <a:pt x="1766824" y="32131"/>
                  </a:lnTo>
                  <a:lnTo>
                    <a:pt x="1728216" y="27051"/>
                  </a:lnTo>
                  <a:lnTo>
                    <a:pt x="1692021" y="22352"/>
                  </a:lnTo>
                  <a:lnTo>
                    <a:pt x="1658112" y="18288"/>
                  </a:lnTo>
                  <a:lnTo>
                    <a:pt x="1626616" y="14732"/>
                  </a:lnTo>
                  <a:lnTo>
                    <a:pt x="1622044" y="14224"/>
                  </a:lnTo>
                  <a:lnTo>
                    <a:pt x="1586611" y="10795"/>
                  </a:lnTo>
                  <a:lnTo>
                    <a:pt x="1552194" y="8001"/>
                  </a:lnTo>
                  <a:lnTo>
                    <a:pt x="1516761" y="5715"/>
                  </a:lnTo>
                  <a:lnTo>
                    <a:pt x="1478407" y="3937"/>
                  </a:lnTo>
                  <a:lnTo>
                    <a:pt x="1436751" y="2540"/>
                  </a:lnTo>
                  <a:lnTo>
                    <a:pt x="1393698" y="1397"/>
                  </a:lnTo>
                  <a:lnTo>
                    <a:pt x="1354709" y="635"/>
                  </a:lnTo>
                  <a:lnTo>
                    <a:pt x="1326261" y="254"/>
                  </a:lnTo>
                  <a:lnTo>
                    <a:pt x="1312291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705" y="0"/>
                  </a:lnTo>
                  <a:lnTo>
                    <a:pt x="1026668" y="0"/>
                  </a:lnTo>
                  <a:lnTo>
                    <a:pt x="987806" y="0"/>
                  </a:lnTo>
                  <a:lnTo>
                    <a:pt x="952119" y="0"/>
                  </a:lnTo>
                  <a:lnTo>
                    <a:pt x="917575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2927" y="0"/>
                  </a:lnTo>
                  <a:lnTo>
                    <a:pt x="776859" y="0"/>
                  </a:lnTo>
                  <a:lnTo>
                    <a:pt x="738378" y="0"/>
                  </a:lnTo>
                  <a:lnTo>
                    <a:pt x="698119" y="0"/>
                  </a:lnTo>
                  <a:lnTo>
                    <a:pt x="656844" y="0"/>
                  </a:lnTo>
                  <a:lnTo>
                    <a:pt x="615442" y="0"/>
                  </a:lnTo>
                  <a:lnTo>
                    <a:pt x="575056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594" y="0"/>
                  </a:lnTo>
                  <a:lnTo>
                    <a:pt x="431546" y="0"/>
                  </a:lnTo>
                  <a:lnTo>
                    <a:pt x="396113" y="0"/>
                  </a:lnTo>
                  <a:lnTo>
                    <a:pt x="361696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126" y="0"/>
                  </a:lnTo>
                  <a:lnTo>
                    <a:pt x="203073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793" y="0"/>
                  </a:lnTo>
                  <a:lnTo>
                    <a:pt x="118999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6D96A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1" name="Forme libre 40">
              <a:extLst>
                <a:ext uri="{FF2B5EF4-FFF2-40B4-BE49-F238E27FC236}">
                  <a16:creationId xmlns:a16="http://schemas.microsoft.com/office/drawing/2014/main" id="{703061AC-64C1-E9F0-803D-2E8805EFF2C5}"/>
                </a:ext>
              </a:extLst>
            </p:cNvPr>
            <p:cNvSpPr/>
            <p:nvPr/>
          </p:nvSpPr>
          <p:spPr>
            <a:xfrm>
              <a:off x="3934840" y="5082317"/>
              <a:ext cx="2499995" cy="1249934"/>
            </a:xfrm>
            <a:custGeom>
              <a:avLst/>
              <a:gdLst>
                <a:gd name="connsiteX0" fmla="*/ 0 w 2499995"/>
                <a:gd name="connsiteY0" fmla="*/ 1249934 h 1249934"/>
                <a:gd name="connsiteX1" fmla="*/ 118999 w 2499995"/>
                <a:gd name="connsiteY1" fmla="*/ 1249934 h 1249934"/>
                <a:gd name="connsiteX2" fmla="*/ 121031 w 2499995"/>
                <a:gd name="connsiteY2" fmla="*/ 1249934 h 1249934"/>
                <a:gd name="connsiteX3" fmla="*/ 133223 w 2499995"/>
                <a:gd name="connsiteY3" fmla="*/ 1249934 h 1249934"/>
                <a:gd name="connsiteX4" fmla="*/ 159766 w 2499995"/>
                <a:gd name="connsiteY4" fmla="*/ 1249934 h 1249934"/>
                <a:gd name="connsiteX5" fmla="*/ 197866 w 2499995"/>
                <a:gd name="connsiteY5" fmla="*/ 1249934 h 1249934"/>
                <a:gd name="connsiteX6" fmla="*/ 240792 w 2499995"/>
                <a:gd name="connsiteY6" fmla="*/ 1249934 h 1249934"/>
                <a:gd name="connsiteX7" fmla="*/ 282829 w 2499995"/>
                <a:gd name="connsiteY7" fmla="*/ 1249934 h 1249934"/>
                <a:gd name="connsiteX8" fmla="*/ 321564 w 2499995"/>
                <a:gd name="connsiteY8" fmla="*/ 1249934 h 1249934"/>
                <a:gd name="connsiteX9" fmla="*/ 357378 w 2499995"/>
                <a:gd name="connsiteY9" fmla="*/ 1249934 h 1249934"/>
                <a:gd name="connsiteX10" fmla="*/ 391795 w 2499995"/>
                <a:gd name="connsiteY10" fmla="*/ 1249934 h 1249934"/>
                <a:gd name="connsiteX11" fmla="*/ 426974 w 2499995"/>
                <a:gd name="connsiteY11" fmla="*/ 1249934 h 1249934"/>
                <a:gd name="connsiteX12" fmla="*/ 431546 w 2499995"/>
                <a:gd name="connsiteY12" fmla="*/ 1249934 h 1249934"/>
                <a:gd name="connsiteX13" fmla="*/ 462915 w 2499995"/>
                <a:gd name="connsiteY13" fmla="*/ 1249934 h 1249934"/>
                <a:gd name="connsiteX14" fmla="*/ 496443 w 2499995"/>
                <a:gd name="connsiteY14" fmla="*/ 1249934 h 1249934"/>
                <a:gd name="connsiteX15" fmla="*/ 532638 w 2499995"/>
                <a:gd name="connsiteY15" fmla="*/ 1249934 h 1249934"/>
                <a:gd name="connsiteX16" fmla="*/ 570992 w 2499995"/>
                <a:gd name="connsiteY16" fmla="*/ 1249934 h 1249934"/>
                <a:gd name="connsiteX17" fmla="*/ 611251 w 2499995"/>
                <a:gd name="connsiteY17" fmla="*/ 1249934 h 1249934"/>
                <a:gd name="connsiteX18" fmla="*/ 652653 w 2499995"/>
                <a:gd name="connsiteY18" fmla="*/ 1249934 h 1249934"/>
                <a:gd name="connsiteX19" fmla="*/ 693928 w 2499995"/>
                <a:gd name="connsiteY19" fmla="*/ 1249934 h 1249934"/>
                <a:gd name="connsiteX20" fmla="*/ 734314 w 2499995"/>
                <a:gd name="connsiteY20" fmla="*/ 1249934 h 1249934"/>
                <a:gd name="connsiteX21" fmla="*/ 773049 w 2499995"/>
                <a:gd name="connsiteY21" fmla="*/ 1249934 h 1249934"/>
                <a:gd name="connsiteX22" fmla="*/ 809371 w 2499995"/>
                <a:gd name="connsiteY22" fmla="*/ 1249934 h 1249934"/>
                <a:gd name="connsiteX23" fmla="*/ 843280 w 2499995"/>
                <a:gd name="connsiteY23" fmla="*/ 1249934 h 1249934"/>
                <a:gd name="connsiteX24" fmla="*/ 874776 w 2499995"/>
                <a:gd name="connsiteY24" fmla="*/ 1249934 h 1249934"/>
                <a:gd name="connsiteX25" fmla="*/ 877951 w 2499995"/>
                <a:gd name="connsiteY25" fmla="*/ 1249934 h 1249934"/>
                <a:gd name="connsiteX26" fmla="*/ 913257 w 2499995"/>
                <a:gd name="connsiteY26" fmla="*/ 1249934 h 1249934"/>
                <a:gd name="connsiteX27" fmla="*/ 947674 w 2499995"/>
                <a:gd name="connsiteY27" fmla="*/ 1249934 h 1249934"/>
                <a:gd name="connsiteX28" fmla="*/ 983234 w 2499995"/>
                <a:gd name="connsiteY28" fmla="*/ 1249934 h 1249934"/>
                <a:gd name="connsiteX29" fmla="*/ 1021588 w 2499995"/>
                <a:gd name="connsiteY29" fmla="*/ 1249934 h 1249934"/>
                <a:gd name="connsiteX30" fmla="*/ 1063371 w 2499995"/>
                <a:gd name="connsiteY30" fmla="*/ 1249934 h 1249934"/>
                <a:gd name="connsiteX31" fmla="*/ 1106297 w 2499995"/>
                <a:gd name="connsiteY31" fmla="*/ 1249934 h 1249934"/>
                <a:gd name="connsiteX32" fmla="*/ 1145413 w 2499995"/>
                <a:gd name="connsiteY32" fmla="*/ 1249934 h 1249934"/>
                <a:gd name="connsiteX33" fmla="*/ 1173734 w 2499995"/>
                <a:gd name="connsiteY33" fmla="*/ 1249934 h 1249934"/>
                <a:gd name="connsiteX34" fmla="*/ 1187577 w 2499995"/>
                <a:gd name="connsiteY34" fmla="*/ 1249934 h 1249934"/>
                <a:gd name="connsiteX35" fmla="*/ 1190498 w 2499995"/>
                <a:gd name="connsiteY35" fmla="*/ 1249934 h 1249934"/>
                <a:gd name="connsiteX36" fmla="*/ 1190498 w 2499995"/>
                <a:gd name="connsiteY36" fmla="*/ 1249934 h 1249934"/>
                <a:gd name="connsiteX37" fmla="*/ 1309497 w 2499995"/>
                <a:gd name="connsiteY37" fmla="*/ 1249934 h 1249934"/>
                <a:gd name="connsiteX38" fmla="*/ 1311021 w 2499995"/>
                <a:gd name="connsiteY38" fmla="*/ 1249807 h 1249934"/>
                <a:gd name="connsiteX39" fmla="*/ 1320800 w 2499995"/>
                <a:gd name="connsiteY39" fmla="*/ 1248156 h 1249934"/>
                <a:gd name="connsiteX40" fmla="*/ 1342771 w 2499995"/>
                <a:gd name="connsiteY40" fmla="*/ 1243711 h 1249934"/>
                <a:gd name="connsiteX41" fmla="*/ 1375537 w 2499995"/>
                <a:gd name="connsiteY41" fmla="*/ 1235710 h 1249934"/>
                <a:gd name="connsiteX42" fmla="*/ 1414272 w 2499995"/>
                <a:gd name="connsiteY42" fmla="*/ 1223772 h 1249934"/>
                <a:gd name="connsiteX43" fmla="*/ 1453896 w 2499995"/>
                <a:gd name="connsiteY43" fmla="*/ 1208151 h 1249934"/>
                <a:gd name="connsiteX44" fmla="*/ 1491234 w 2499995"/>
                <a:gd name="connsiteY44" fmla="*/ 1188720 h 1249934"/>
                <a:gd name="connsiteX45" fmla="*/ 1525778 w 2499995"/>
                <a:gd name="connsiteY45" fmla="*/ 1164844 h 1249934"/>
                <a:gd name="connsiteX46" fmla="*/ 1558036 w 2499995"/>
                <a:gd name="connsiteY46" fmla="*/ 1135634 h 1249934"/>
                <a:gd name="connsiteX47" fmla="*/ 1589786 w 2499995"/>
                <a:gd name="connsiteY47" fmla="*/ 1099566 h 1249934"/>
                <a:gd name="connsiteX48" fmla="*/ 1622044 w 2499995"/>
                <a:gd name="connsiteY48" fmla="*/ 1055878 h 1249934"/>
                <a:gd name="connsiteX49" fmla="*/ 1643888 w 2499995"/>
                <a:gd name="connsiteY49" fmla="*/ 1022985 h 1249934"/>
                <a:gd name="connsiteX50" fmla="*/ 1666875 w 2499995"/>
                <a:gd name="connsiteY50" fmla="*/ 986282 h 1249934"/>
                <a:gd name="connsiteX51" fmla="*/ 1691132 w 2499995"/>
                <a:gd name="connsiteY51" fmla="*/ 946023 h 1249934"/>
                <a:gd name="connsiteX52" fmla="*/ 1716532 w 2499995"/>
                <a:gd name="connsiteY52" fmla="*/ 902081 h 1249934"/>
                <a:gd name="connsiteX53" fmla="*/ 1743202 w 2499995"/>
                <a:gd name="connsiteY53" fmla="*/ 854837 h 1249934"/>
                <a:gd name="connsiteX54" fmla="*/ 1770888 w 2499995"/>
                <a:gd name="connsiteY54" fmla="*/ 804672 h 1249934"/>
                <a:gd name="connsiteX55" fmla="*/ 1799463 w 2499995"/>
                <a:gd name="connsiteY55" fmla="*/ 752348 h 1249934"/>
                <a:gd name="connsiteX56" fmla="*/ 1828546 w 2499995"/>
                <a:gd name="connsiteY56" fmla="*/ 698627 h 1249934"/>
                <a:gd name="connsiteX57" fmla="*/ 1857756 w 2499995"/>
                <a:gd name="connsiteY57" fmla="*/ 644398 h 1249934"/>
                <a:gd name="connsiteX58" fmla="*/ 1886966 w 2499995"/>
                <a:gd name="connsiteY58" fmla="*/ 590550 h 1249934"/>
                <a:gd name="connsiteX59" fmla="*/ 1915541 w 2499995"/>
                <a:gd name="connsiteY59" fmla="*/ 537972 h 1249934"/>
                <a:gd name="connsiteX60" fmla="*/ 1943354 w 2499995"/>
                <a:gd name="connsiteY60" fmla="*/ 487553 h 1249934"/>
                <a:gd name="connsiteX61" fmla="*/ 1970151 w 2499995"/>
                <a:gd name="connsiteY61" fmla="*/ 439928 h 1249934"/>
                <a:gd name="connsiteX62" fmla="*/ 1995805 w 2499995"/>
                <a:gd name="connsiteY62" fmla="*/ 395478 h 1249934"/>
                <a:gd name="connsiteX63" fmla="*/ 2020189 w 2499995"/>
                <a:gd name="connsiteY63" fmla="*/ 354584 h 1249934"/>
                <a:gd name="connsiteX64" fmla="*/ 2043303 w 2499995"/>
                <a:gd name="connsiteY64" fmla="*/ 317373 h 1249934"/>
                <a:gd name="connsiteX65" fmla="*/ 2065401 w 2499995"/>
                <a:gd name="connsiteY65" fmla="*/ 283972 h 1249934"/>
                <a:gd name="connsiteX66" fmla="*/ 2068449 w 2499995"/>
                <a:gd name="connsiteY66" fmla="*/ 279527 h 1249934"/>
                <a:gd name="connsiteX67" fmla="*/ 2101088 w 2499995"/>
                <a:gd name="connsiteY67" fmla="*/ 235331 h 1249934"/>
                <a:gd name="connsiteX68" fmla="*/ 2132838 w 2499995"/>
                <a:gd name="connsiteY68" fmla="*/ 199263 h 1249934"/>
                <a:gd name="connsiteX69" fmla="*/ 2165223 w 2499995"/>
                <a:gd name="connsiteY69" fmla="*/ 170180 h 1249934"/>
                <a:gd name="connsiteX70" fmla="*/ 2199640 w 2499995"/>
                <a:gd name="connsiteY70" fmla="*/ 146431 h 1249934"/>
                <a:gd name="connsiteX71" fmla="*/ 2237105 w 2499995"/>
                <a:gd name="connsiteY71" fmla="*/ 127000 h 1249934"/>
                <a:gd name="connsiteX72" fmla="*/ 2276729 w 2499995"/>
                <a:gd name="connsiteY72" fmla="*/ 111506 h 1249934"/>
                <a:gd name="connsiteX73" fmla="*/ 2315337 w 2499995"/>
                <a:gd name="connsiteY73" fmla="*/ 99568 h 1249934"/>
                <a:gd name="connsiteX74" fmla="*/ 2347976 w 2499995"/>
                <a:gd name="connsiteY74" fmla="*/ 91567 h 1249934"/>
                <a:gd name="connsiteX75" fmla="*/ 2369820 w 2499995"/>
                <a:gd name="connsiteY75" fmla="*/ 87249 h 1249934"/>
                <a:gd name="connsiteX76" fmla="*/ 2379345 w 2499995"/>
                <a:gd name="connsiteY76" fmla="*/ 85725 h 1249934"/>
                <a:gd name="connsiteX77" fmla="*/ 2380869 w 2499995"/>
                <a:gd name="connsiteY77" fmla="*/ 85471 h 1249934"/>
                <a:gd name="connsiteX78" fmla="*/ 2499995 w 2499995"/>
                <a:gd name="connsiteY78" fmla="*/ 85471 h 1249934"/>
                <a:gd name="connsiteX79" fmla="*/ 2499995 w 2499995"/>
                <a:gd name="connsiteY79" fmla="*/ 0 h 1249934"/>
                <a:gd name="connsiteX80" fmla="*/ 2380869 w 2499995"/>
                <a:gd name="connsiteY80" fmla="*/ 0 h 1249934"/>
                <a:gd name="connsiteX81" fmla="*/ 2379345 w 2499995"/>
                <a:gd name="connsiteY81" fmla="*/ 254 h 1249934"/>
                <a:gd name="connsiteX82" fmla="*/ 2369566 w 2499995"/>
                <a:gd name="connsiteY82" fmla="*/ 1778 h 1249934"/>
                <a:gd name="connsiteX83" fmla="*/ 2347595 w 2499995"/>
                <a:gd name="connsiteY83" fmla="*/ 6223 h 1249934"/>
                <a:gd name="connsiteX84" fmla="*/ 2314829 w 2499995"/>
                <a:gd name="connsiteY84" fmla="*/ 14224 h 1249934"/>
                <a:gd name="connsiteX85" fmla="*/ 2276094 w 2499995"/>
                <a:gd name="connsiteY85" fmla="*/ 26162 h 1249934"/>
                <a:gd name="connsiteX86" fmla="*/ 2236597 w 2499995"/>
                <a:gd name="connsiteY86" fmla="*/ 41783 h 1249934"/>
                <a:gd name="connsiteX87" fmla="*/ 2199132 w 2499995"/>
                <a:gd name="connsiteY87" fmla="*/ 61341 h 1249934"/>
                <a:gd name="connsiteX88" fmla="*/ 2164715 w 2499995"/>
                <a:gd name="connsiteY88" fmla="*/ 85090 h 1249934"/>
                <a:gd name="connsiteX89" fmla="*/ 2132330 w 2499995"/>
                <a:gd name="connsiteY89" fmla="*/ 114300 h 1249934"/>
                <a:gd name="connsiteX90" fmla="*/ 2100580 w 2499995"/>
                <a:gd name="connsiteY90" fmla="*/ 150368 h 1249934"/>
                <a:gd name="connsiteX91" fmla="*/ 2068449 w 2499995"/>
                <a:gd name="connsiteY91" fmla="*/ 194056 h 1249934"/>
                <a:gd name="connsiteX92" fmla="*/ 2046478 w 2499995"/>
                <a:gd name="connsiteY92" fmla="*/ 226949 h 1249934"/>
                <a:gd name="connsiteX93" fmla="*/ 2023491 w 2499995"/>
                <a:gd name="connsiteY93" fmla="*/ 263652 h 1249934"/>
                <a:gd name="connsiteX94" fmla="*/ 1999361 w 2499995"/>
                <a:gd name="connsiteY94" fmla="*/ 303911 h 1249934"/>
                <a:gd name="connsiteX95" fmla="*/ 1973834 w 2499995"/>
                <a:gd name="connsiteY95" fmla="*/ 347980 h 1249934"/>
                <a:gd name="connsiteX96" fmla="*/ 1947291 w 2499995"/>
                <a:gd name="connsiteY96" fmla="*/ 395224 h 1249934"/>
                <a:gd name="connsiteX97" fmla="*/ 1919478 w 2499995"/>
                <a:gd name="connsiteY97" fmla="*/ 445262 h 1249934"/>
                <a:gd name="connsiteX98" fmla="*/ 1891030 w 2499995"/>
                <a:gd name="connsiteY98" fmla="*/ 497586 h 1249934"/>
                <a:gd name="connsiteX99" fmla="*/ 1861947 w 2499995"/>
                <a:gd name="connsiteY99" fmla="*/ 551307 h 1249934"/>
                <a:gd name="connsiteX100" fmla="*/ 1832610 w 2499995"/>
                <a:gd name="connsiteY100" fmla="*/ 605536 h 1249934"/>
                <a:gd name="connsiteX101" fmla="*/ 1803527 w 2499995"/>
                <a:gd name="connsiteY101" fmla="*/ 659384 h 1249934"/>
                <a:gd name="connsiteX102" fmla="*/ 1774825 w 2499995"/>
                <a:gd name="connsiteY102" fmla="*/ 711962 h 1249934"/>
                <a:gd name="connsiteX103" fmla="*/ 1747012 w 2499995"/>
                <a:gd name="connsiteY103" fmla="*/ 762381 h 1249934"/>
                <a:gd name="connsiteX104" fmla="*/ 1720215 w 2499995"/>
                <a:gd name="connsiteY104" fmla="*/ 810133 h 1249934"/>
                <a:gd name="connsiteX105" fmla="*/ 1694561 w 2499995"/>
                <a:gd name="connsiteY105" fmla="*/ 854583 h 1249934"/>
                <a:gd name="connsiteX106" fmla="*/ 1670304 w 2499995"/>
                <a:gd name="connsiteY106" fmla="*/ 895350 h 1249934"/>
                <a:gd name="connsiteX107" fmla="*/ 1647063 w 2499995"/>
                <a:gd name="connsiteY107" fmla="*/ 932561 h 1249934"/>
                <a:gd name="connsiteX108" fmla="*/ 1625092 w 2499995"/>
                <a:gd name="connsiteY108" fmla="*/ 965962 h 1249934"/>
                <a:gd name="connsiteX109" fmla="*/ 1622044 w 2499995"/>
                <a:gd name="connsiteY109" fmla="*/ 970407 h 1249934"/>
                <a:gd name="connsiteX110" fmla="*/ 1589278 w 2499995"/>
                <a:gd name="connsiteY110" fmla="*/ 1014603 h 1249934"/>
                <a:gd name="connsiteX111" fmla="*/ 1557655 w 2499995"/>
                <a:gd name="connsiteY111" fmla="*/ 1050671 h 1249934"/>
                <a:gd name="connsiteX112" fmla="*/ 1525270 w 2499995"/>
                <a:gd name="connsiteY112" fmla="*/ 1079754 h 1249934"/>
                <a:gd name="connsiteX113" fmla="*/ 1490726 w 2499995"/>
                <a:gd name="connsiteY113" fmla="*/ 1103503 h 1249934"/>
                <a:gd name="connsiteX114" fmla="*/ 1453261 w 2499995"/>
                <a:gd name="connsiteY114" fmla="*/ 1122934 h 1249934"/>
                <a:gd name="connsiteX115" fmla="*/ 1413764 w 2499995"/>
                <a:gd name="connsiteY115" fmla="*/ 1138555 h 1249934"/>
                <a:gd name="connsiteX116" fmla="*/ 1375029 w 2499995"/>
                <a:gd name="connsiteY116" fmla="*/ 1150366 h 1249934"/>
                <a:gd name="connsiteX117" fmla="*/ 1342390 w 2499995"/>
                <a:gd name="connsiteY117" fmla="*/ 1158367 h 1249934"/>
                <a:gd name="connsiteX118" fmla="*/ 1320673 w 2499995"/>
                <a:gd name="connsiteY118" fmla="*/ 1162685 h 1249934"/>
                <a:gd name="connsiteX119" fmla="*/ 1311021 w 2499995"/>
                <a:gd name="connsiteY119" fmla="*/ 1164336 h 1249934"/>
                <a:gd name="connsiteX120" fmla="*/ 1309497 w 2499995"/>
                <a:gd name="connsiteY120" fmla="*/ 1164463 h 1249934"/>
                <a:gd name="connsiteX121" fmla="*/ 1190498 w 2499995"/>
                <a:gd name="connsiteY121" fmla="*/ 1164463 h 1249934"/>
                <a:gd name="connsiteX122" fmla="*/ 1188466 w 2499995"/>
                <a:gd name="connsiteY122" fmla="*/ 1164463 h 1249934"/>
                <a:gd name="connsiteX123" fmla="*/ 1176274 w 2499995"/>
                <a:gd name="connsiteY123" fmla="*/ 1164463 h 1249934"/>
                <a:gd name="connsiteX124" fmla="*/ 1149731 w 2499995"/>
                <a:gd name="connsiteY124" fmla="*/ 1164463 h 1249934"/>
                <a:gd name="connsiteX125" fmla="*/ 1111631 w 2499995"/>
                <a:gd name="connsiteY125" fmla="*/ 1164463 h 1249934"/>
                <a:gd name="connsiteX126" fmla="*/ 1068705 w 2499995"/>
                <a:gd name="connsiteY126" fmla="*/ 1164463 h 1249934"/>
                <a:gd name="connsiteX127" fmla="*/ 1026668 w 2499995"/>
                <a:gd name="connsiteY127" fmla="*/ 1164463 h 1249934"/>
                <a:gd name="connsiteX128" fmla="*/ 987806 w 2499995"/>
                <a:gd name="connsiteY128" fmla="*/ 1164463 h 1249934"/>
                <a:gd name="connsiteX129" fmla="*/ 952119 w 2499995"/>
                <a:gd name="connsiteY129" fmla="*/ 1164463 h 1249934"/>
                <a:gd name="connsiteX130" fmla="*/ 917575 w 2499995"/>
                <a:gd name="connsiteY130" fmla="*/ 1164463 h 1249934"/>
                <a:gd name="connsiteX131" fmla="*/ 882523 w 2499995"/>
                <a:gd name="connsiteY131" fmla="*/ 1164463 h 1249934"/>
                <a:gd name="connsiteX132" fmla="*/ 877951 w 2499995"/>
                <a:gd name="connsiteY132" fmla="*/ 1164463 h 1249934"/>
                <a:gd name="connsiteX133" fmla="*/ 846582 w 2499995"/>
                <a:gd name="connsiteY133" fmla="*/ 1164463 h 1249934"/>
                <a:gd name="connsiteX134" fmla="*/ 812927 w 2499995"/>
                <a:gd name="connsiteY134" fmla="*/ 1164463 h 1249934"/>
                <a:gd name="connsiteX135" fmla="*/ 776859 w 2499995"/>
                <a:gd name="connsiteY135" fmla="*/ 1164463 h 1249934"/>
                <a:gd name="connsiteX136" fmla="*/ 738378 w 2499995"/>
                <a:gd name="connsiteY136" fmla="*/ 1164463 h 1249934"/>
                <a:gd name="connsiteX137" fmla="*/ 698119 w 2499995"/>
                <a:gd name="connsiteY137" fmla="*/ 1164463 h 1249934"/>
                <a:gd name="connsiteX138" fmla="*/ 656844 w 2499995"/>
                <a:gd name="connsiteY138" fmla="*/ 1164463 h 1249934"/>
                <a:gd name="connsiteX139" fmla="*/ 615442 w 2499995"/>
                <a:gd name="connsiteY139" fmla="*/ 1164463 h 1249934"/>
                <a:gd name="connsiteX140" fmla="*/ 575056 w 2499995"/>
                <a:gd name="connsiteY140" fmla="*/ 1164463 h 1249934"/>
                <a:gd name="connsiteX141" fmla="*/ 536448 w 2499995"/>
                <a:gd name="connsiteY141" fmla="*/ 1164463 h 1249934"/>
                <a:gd name="connsiteX142" fmla="*/ 500126 w 2499995"/>
                <a:gd name="connsiteY142" fmla="*/ 1164463 h 1249934"/>
                <a:gd name="connsiteX143" fmla="*/ 466217 w 2499995"/>
                <a:gd name="connsiteY143" fmla="*/ 1164463 h 1249934"/>
                <a:gd name="connsiteX144" fmla="*/ 434594 w 2499995"/>
                <a:gd name="connsiteY144" fmla="*/ 1164463 h 1249934"/>
                <a:gd name="connsiteX145" fmla="*/ 431546 w 2499995"/>
                <a:gd name="connsiteY145" fmla="*/ 1164463 h 1249934"/>
                <a:gd name="connsiteX146" fmla="*/ 396113 w 2499995"/>
                <a:gd name="connsiteY146" fmla="*/ 1164463 h 1249934"/>
                <a:gd name="connsiteX147" fmla="*/ 361696 w 2499995"/>
                <a:gd name="connsiteY147" fmla="*/ 1164463 h 1249934"/>
                <a:gd name="connsiteX148" fmla="*/ 326263 w 2499995"/>
                <a:gd name="connsiteY148" fmla="*/ 1164463 h 1249934"/>
                <a:gd name="connsiteX149" fmla="*/ 287909 w 2499995"/>
                <a:gd name="connsiteY149" fmla="*/ 1164463 h 1249934"/>
                <a:gd name="connsiteX150" fmla="*/ 246126 w 2499995"/>
                <a:gd name="connsiteY150" fmla="*/ 1164463 h 1249934"/>
                <a:gd name="connsiteX151" fmla="*/ 203073 w 2499995"/>
                <a:gd name="connsiteY151" fmla="*/ 1164463 h 1249934"/>
                <a:gd name="connsiteX152" fmla="*/ 164084 w 2499995"/>
                <a:gd name="connsiteY152" fmla="*/ 1164463 h 1249934"/>
                <a:gd name="connsiteX153" fmla="*/ 135763 w 2499995"/>
                <a:gd name="connsiteY153" fmla="*/ 1164463 h 1249934"/>
                <a:gd name="connsiteX154" fmla="*/ 121793 w 2499995"/>
                <a:gd name="connsiteY154" fmla="*/ 1164463 h 1249934"/>
                <a:gd name="connsiteX155" fmla="*/ 118999 w 2499995"/>
                <a:gd name="connsiteY155" fmla="*/ 1164463 h 1249934"/>
                <a:gd name="connsiteX156" fmla="*/ 118999 w 2499995"/>
                <a:gd name="connsiteY156" fmla="*/ 1164463 h 1249934"/>
                <a:gd name="connsiteX157" fmla="*/ 0 w 2499995"/>
                <a:gd name="connsiteY157" fmla="*/ 1164463 h 124993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</a:cxnLst>
              <a:rect l="l" t="t" r="r" b="b"/>
              <a:pathLst>
                <a:path w="2499995" h="1249934">
                  <a:moveTo>
                    <a:pt x="0" y="1249934"/>
                  </a:moveTo>
                  <a:lnTo>
                    <a:pt x="118999" y="1249934"/>
                  </a:lnTo>
                  <a:lnTo>
                    <a:pt x="121031" y="1249934"/>
                  </a:lnTo>
                  <a:lnTo>
                    <a:pt x="133223" y="1249934"/>
                  </a:lnTo>
                  <a:lnTo>
                    <a:pt x="159766" y="1249934"/>
                  </a:lnTo>
                  <a:lnTo>
                    <a:pt x="197866" y="1249934"/>
                  </a:lnTo>
                  <a:lnTo>
                    <a:pt x="240792" y="1249934"/>
                  </a:lnTo>
                  <a:lnTo>
                    <a:pt x="282829" y="1249934"/>
                  </a:lnTo>
                  <a:lnTo>
                    <a:pt x="321564" y="1249934"/>
                  </a:lnTo>
                  <a:lnTo>
                    <a:pt x="357378" y="1249934"/>
                  </a:lnTo>
                  <a:lnTo>
                    <a:pt x="391795" y="1249934"/>
                  </a:lnTo>
                  <a:lnTo>
                    <a:pt x="426974" y="1249934"/>
                  </a:lnTo>
                  <a:lnTo>
                    <a:pt x="431546" y="1249934"/>
                  </a:lnTo>
                  <a:lnTo>
                    <a:pt x="462915" y="1249934"/>
                  </a:lnTo>
                  <a:lnTo>
                    <a:pt x="496443" y="1249934"/>
                  </a:lnTo>
                  <a:lnTo>
                    <a:pt x="532638" y="1249934"/>
                  </a:lnTo>
                  <a:lnTo>
                    <a:pt x="570992" y="1249934"/>
                  </a:lnTo>
                  <a:lnTo>
                    <a:pt x="611251" y="1249934"/>
                  </a:lnTo>
                  <a:lnTo>
                    <a:pt x="652653" y="1249934"/>
                  </a:lnTo>
                  <a:lnTo>
                    <a:pt x="693928" y="1249934"/>
                  </a:lnTo>
                  <a:lnTo>
                    <a:pt x="734314" y="1249934"/>
                  </a:lnTo>
                  <a:lnTo>
                    <a:pt x="773049" y="1249934"/>
                  </a:lnTo>
                  <a:lnTo>
                    <a:pt x="809371" y="1249934"/>
                  </a:lnTo>
                  <a:lnTo>
                    <a:pt x="843280" y="1249934"/>
                  </a:lnTo>
                  <a:lnTo>
                    <a:pt x="874776" y="1249934"/>
                  </a:lnTo>
                  <a:lnTo>
                    <a:pt x="877951" y="1249934"/>
                  </a:lnTo>
                  <a:lnTo>
                    <a:pt x="913257" y="1249934"/>
                  </a:lnTo>
                  <a:lnTo>
                    <a:pt x="947674" y="1249934"/>
                  </a:lnTo>
                  <a:lnTo>
                    <a:pt x="983234" y="1249934"/>
                  </a:lnTo>
                  <a:lnTo>
                    <a:pt x="1021588" y="1249934"/>
                  </a:lnTo>
                  <a:lnTo>
                    <a:pt x="1063371" y="1249934"/>
                  </a:lnTo>
                  <a:lnTo>
                    <a:pt x="1106297" y="1249934"/>
                  </a:lnTo>
                  <a:lnTo>
                    <a:pt x="1145413" y="1249934"/>
                  </a:lnTo>
                  <a:lnTo>
                    <a:pt x="1173734" y="1249934"/>
                  </a:lnTo>
                  <a:lnTo>
                    <a:pt x="1187577" y="1249934"/>
                  </a:lnTo>
                  <a:lnTo>
                    <a:pt x="1190498" y="1249934"/>
                  </a:lnTo>
                  <a:lnTo>
                    <a:pt x="1190498" y="1249934"/>
                  </a:lnTo>
                  <a:lnTo>
                    <a:pt x="1309497" y="1249934"/>
                  </a:lnTo>
                  <a:lnTo>
                    <a:pt x="1311021" y="1249807"/>
                  </a:lnTo>
                  <a:lnTo>
                    <a:pt x="1320800" y="1248156"/>
                  </a:lnTo>
                  <a:lnTo>
                    <a:pt x="1342771" y="1243711"/>
                  </a:lnTo>
                  <a:lnTo>
                    <a:pt x="1375537" y="1235710"/>
                  </a:lnTo>
                  <a:lnTo>
                    <a:pt x="1414272" y="1223772"/>
                  </a:lnTo>
                  <a:lnTo>
                    <a:pt x="1453896" y="1208151"/>
                  </a:lnTo>
                  <a:lnTo>
                    <a:pt x="1491234" y="1188720"/>
                  </a:lnTo>
                  <a:lnTo>
                    <a:pt x="1525778" y="1164844"/>
                  </a:lnTo>
                  <a:lnTo>
                    <a:pt x="1558036" y="1135634"/>
                  </a:lnTo>
                  <a:lnTo>
                    <a:pt x="1589786" y="1099566"/>
                  </a:lnTo>
                  <a:lnTo>
                    <a:pt x="1622044" y="1055878"/>
                  </a:lnTo>
                  <a:lnTo>
                    <a:pt x="1643888" y="1022985"/>
                  </a:lnTo>
                  <a:lnTo>
                    <a:pt x="1666875" y="986282"/>
                  </a:lnTo>
                  <a:lnTo>
                    <a:pt x="1691132" y="946023"/>
                  </a:lnTo>
                  <a:lnTo>
                    <a:pt x="1716532" y="902081"/>
                  </a:lnTo>
                  <a:lnTo>
                    <a:pt x="1743202" y="854837"/>
                  </a:lnTo>
                  <a:lnTo>
                    <a:pt x="1770888" y="804672"/>
                  </a:lnTo>
                  <a:lnTo>
                    <a:pt x="1799463" y="752348"/>
                  </a:lnTo>
                  <a:lnTo>
                    <a:pt x="1828546" y="698627"/>
                  </a:lnTo>
                  <a:lnTo>
                    <a:pt x="1857756" y="644398"/>
                  </a:lnTo>
                  <a:lnTo>
                    <a:pt x="1886966" y="590550"/>
                  </a:lnTo>
                  <a:lnTo>
                    <a:pt x="1915541" y="537972"/>
                  </a:lnTo>
                  <a:lnTo>
                    <a:pt x="1943354" y="487553"/>
                  </a:lnTo>
                  <a:lnTo>
                    <a:pt x="1970151" y="439928"/>
                  </a:lnTo>
                  <a:lnTo>
                    <a:pt x="1995805" y="395478"/>
                  </a:lnTo>
                  <a:lnTo>
                    <a:pt x="2020189" y="354584"/>
                  </a:lnTo>
                  <a:lnTo>
                    <a:pt x="2043303" y="317373"/>
                  </a:lnTo>
                  <a:lnTo>
                    <a:pt x="2065401" y="283972"/>
                  </a:lnTo>
                  <a:lnTo>
                    <a:pt x="2068449" y="279527"/>
                  </a:lnTo>
                  <a:lnTo>
                    <a:pt x="2101088" y="235331"/>
                  </a:lnTo>
                  <a:lnTo>
                    <a:pt x="2132838" y="199263"/>
                  </a:lnTo>
                  <a:lnTo>
                    <a:pt x="2165223" y="170180"/>
                  </a:lnTo>
                  <a:lnTo>
                    <a:pt x="2199640" y="146431"/>
                  </a:lnTo>
                  <a:lnTo>
                    <a:pt x="2237105" y="127000"/>
                  </a:lnTo>
                  <a:lnTo>
                    <a:pt x="2276729" y="111506"/>
                  </a:lnTo>
                  <a:lnTo>
                    <a:pt x="2315337" y="99568"/>
                  </a:lnTo>
                  <a:lnTo>
                    <a:pt x="2347976" y="91567"/>
                  </a:lnTo>
                  <a:lnTo>
                    <a:pt x="2369820" y="87249"/>
                  </a:lnTo>
                  <a:lnTo>
                    <a:pt x="2379345" y="85725"/>
                  </a:lnTo>
                  <a:lnTo>
                    <a:pt x="2380869" y="85471"/>
                  </a:lnTo>
                  <a:lnTo>
                    <a:pt x="2499995" y="85471"/>
                  </a:lnTo>
                  <a:lnTo>
                    <a:pt x="2499995" y="0"/>
                  </a:lnTo>
                  <a:lnTo>
                    <a:pt x="2380869" y="0"/>
                  </a:lnTo>
                  <a:lnTo>
                    <a:pt x="2379345" y="254"/>
                  </a:lnTo>
                  <a:lnTo>
                    <a:pt x="2369566" y="1778"/>
                  </a:lnTo>
                  <a:lnTo>
                    <a:pt x="2347595" y="6223"/>
                  </a:lnTo>
                  <a:lnTo>
                    <a:pt x="2314829" y="14224"/>
                  </a:lnTo>
                  <a:lnTo>
                    <a:pt x="2276094" y="26162"/>
                  </a:lnTo>
                  <a:lnTo>
                    <a:pt x="2236597" y="41783"/>
                  </a:lnTo>
                  <a:lnTo>
                    <a:pt x="2199132" y="61341"/>
                  </a:lnTo>
                  <a:lnTo>
                    <a:pt x="2164715" y="85090"/>
                  </a:lnTo>
                  <a:lnTo>
                    <a:pt x="2132330" y="114300"/>
                  </a:lnTo>
                  <a:lnTo>
                    <a:pt x="2100580" y="150368"/>
                  </a:lnTo>
                  <a:lnTo>
                    <a:pt x="2068449" y="194056"/>
                  </a:lnTo>
                  <a:lnTo>
                    <a:pt x="2046478" y="226949"/>
                  </a:lnTo>
                  <a:lnTo>
                    <a:pt x="2023491" y="263652"/>
                  </a:lnTo>
                  <a:lnTo>
                    <a:pt x="1999361" y="303911"/>
                  </a:lnTo>
                  <a:lnTo>
                    <a:pt x="1973834" y="347980"/>
                  </a:lnTo>
                  <a:lnTo>
                    <a:pt x="1947291" y="395224"/>
                  </a:lnTo>
                  <a:lnTo>
                    <a:pt x="1919478" y="445262"/>
                  </a:lnTo>
                  <a:lnTo>
                    <a:pt x="1891030" y="497586"/>
                  </a:lnTo>
                  <a:lnTo>
                    <a:pt x="1861947" y="551307"/>
                  </a:lnTo>
                  <a:lnTo>
                    <a:pt x="1832610" y="605536"/>
                  </a:lnTo>
                  <a:lnTo>
                    <a:pt x="1803527" y="659384"/>
                  </a:lnTo>
                  <a:lnTo>
                    <a:pt x="1774825" y="711962"/>
                  </a:lnTo>
                  <a:lnTo>
                    <a:pt x="1747012" y="762381"/>
                  </a:lnTo>
                  <a:lnTo>
                    <a:pt x="1720215" y="810133"/>
                  </a:lnTo>
                  <a:lnTo>
                    <a:pt x="1694561" y="854583"/>
                  </a:lnTo>
                  <a:lnTo>
                    <a:pt x="1670304" y="895350"/>
                  </a:lnTo>
                  <a:lnTo>
                    <a:pt x="1647063" y="932561"/>
                  </a:lnTo>
                  <a:lnTo>
                    <a:pt x="1625092" y="965962"/>
                  </a:lnTo>
                  <a:lnTo>
                    <a:pt x="1622044" y="970407"/>
                  </a:lnTo>
                  <a:lnTo>
                    <a:pt x="1589278" y="1014603"/>
                  </a:lnTo>
                  <a:lnTo>
                    <a:pt x="1557655" y="1050671"/>
                  </a:lnTo>
                  <a:lnTo>
                    <a:pt x="1525270" y="1079754"/>
                  </a:lnTo>
                  <a:lnTo>
                    <a:pt x="1490726" y="1103503"/>
                  </a:lnTo>
                  <a:lnTo>
                    <a:pt x="1453261" y="1122934"/>
                  </a:lnTo>
                  <a:lnTo>
                    <a:pt x="1413764" y="1138555"/>
                  </a:lnTo>
                  <a:lnTo>
                    <a:pt x="1375029" y="1150366"/>
                  </a:lnTo>
                  <a:lnTo>
                    <a:pt x="1342390" y="1158367"/>
                  </a:lnTo>
                  <a:lnTo>
                    <a:pt x="1320673" y="1162685"/>
                  </a:lnTo>
                  <a:lnTo>
                    <a:pt x="1311021" y="1164336"/>
                  </a:lnTo>
                  <a:lnTo>
                    <a:pt x="1309497" y="1164463"/>
                  </a:lnTo>
                  <a:lnTo>
                    <a:pt x="1190498" y="1164463"/>
                  </a:lnTo>
                  <a:lnTo>
                    <a:pt x="1188466" y="1164463"/>
                  </a:lnTo>
                  <a:lnTo>
                    <a:pt x="1176274" y="1164463"/>
                  </a:lnTo>
                  <a:lnTo>
                    <a:pt x="1149731" y="1164463"/>
                  </a:lnTo>
                  <a:lnTo>
                    <a:pt x="1111631" y="1164463"/>
                  </a:lnTo>
                  <a:lnTo>
                    <a:pt x="1068705" y="1164463"/>
                  </a:lnTo>
                  <a:lnTo>
                    <a:pt x="1026668" y="1164463"/>
                  </a:lnTo>
                  <a:lnTo>
                    <a:pt x="987806" y="1164463"/>
                  </a:lnTo>
                  <a:lnTo>
                    <a:pt x="952119" y="1164463"/>
                  </a:lnTo>
                  <a:lnTo>
                    <a:pt x="917575" y="1164463"/>
                  </a:lnTo>
                  <a:lnTo>
                    <a:pt x="882523" y="1164463"/>
                  </a:lnTo>
                  <a:lnTo>
                    <a:pt x="877951" y="1164463"/>
                  </a:lnTo>
                  <a:lnTo>
                    <a:pt x="846582" y="1164463"/>
                  </a:lnTo>
                  <a:lnTo>
                    <a:pt x="812927" y="1164463"/>
                  </a:lnTo>
                  <a:lnTo>
                    <a:pt x="776859" y="1164463"/>
                  </a:lnTo>
                  <a:lnTo>
                    <a:pt x="738378" y="1164463"/>
                  </a:lnTo>
                  <a:lnTo>
                    <a:pt x="698119" y="1164463"/>
                  </a:lnTo>
                  <a:lnTo>
                    <a:pt x="656844" y="1164463"/>
                  </a:lnTo>
                  <a:lnTo>
                    <a:pt x="615442" y="1164463"/>
                  </a:lnTo>
                  <a:lnTo>
                    <a:pt x="575056" y="1164463"/>
                  </a:lnTo>
                  <a:lnTo>
                    <a:pt x="536448" y="1164463"/>
                  </a:lnTo>
                  <a:lnTo>
                    <a:pt x="500126" y="1164463"/>
                  </a:lnTo>
                  <a:lnTo>
                    <a:pt x="466217" y="1164463"/>
                  </a:lnTo>
                  <a:lnTo>
                    <a:pt x="434594" y="1164463"/>
                  </a:lnTo>
                  <a:lnTo>
                    <a:pt x="431546" y="1164463"/>
                  </a:lnTo>
                  <a:lnTo>
                    <a:pt x="396113" y="1164463"/>
                  </a:lnTo>
                  <a:lnTo>
                    <a:pt x="361696" y="1164463"/>
                  </a:lnTo>
                  <a:lnTo>
                    <a:pt x="326263" y="1164463"/>
                  </a:lnTo>
                  <a:lnTo>
                    <a:pt x="287909" y="1164463"/>
                  </a:lnTo>
                  <a:lnTo>
                    <a:pt x="246126" y="1164463"/>
                  </a:lnTo>
                  <a:lnTo>
                    <a:pt x="203073" y="1164463"/>
                  </a:lnTo>
                  <a:lnTo>
                    <a:pt x="164084" y="1164463"/>
                  </a:lnTo>
                  <a:lnTo>
                    <a:pt x="135763" y="1164463"/>
                  </a:lnTo>
                  <a:lnTo>
                    <a:pt x="121793" y="1164463"/>
                  </a:lnTo>
                  <a:lnTo>
                    <a:pt x="118999" y="1164463"/>
                  </a:lnTo>
                  <a:lnTo>
                    <a:pt x="118999" y="1164463"/>
                  </a:lnTo>
                  <a:lnTo>
                    <a:pt x="0" y="1164463"/>
                  </a:lnTo>
                  <a:close/>
                </a:path>
              </a:pathLst>
            </a:custGeom>
            <a:solidFill>
              <a:srgbClr val="FFFFBF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2" name="Forme libre 41">
              <a:extLst>
                <a:ext uri="{FF2B5EF4-FFF2-40B4-BE49-F238E27FC236}">
                  <a16:creationId xmlns:a16="http://schemas.microsoft.com/office/drawing/2014/main" id="{FE90A35E-FE2C-9E32-4CE5-B203F39D7395}"/>
                </a:ext>
              </a:extLst>
            </p:cNvPr>
            <p:cNvSpPr/>
            <p:nvPr/>
          </p:nvSpPr>
          <p:spPr>
            <a:xfrm>
              <a:off x="3934840" y="6332252"/>
              <a:ext cx="2499995" cy="138938"/>
            </a:xfrm>
            <a:custGeom>
              <a:avLst/>
              <a:gdLst>
                <a:gd name="connsiteX0" fmla="*/ 0 w 2499995"/>
                <a:gd name="connsiteY0" fmla="*/ 138938 h 138938"/>
                <a:gd name="connsiteX1" fmla="*/ 118999 w 2499995"/>
                <a:gd name="connsiteY1" fmla="*/ 138938 h 138938"/>
                <a:gd name="connsiteX2" fmla="*/ 121031 w 2499995"/>
                <a:gd name="connsiteY2" fmla="*/ 138938 h 138938"/>
                <a:gd name="connsiteX3" fmla="*/ 133223 w 2499995"/>
                <a:gd name="connsiteY3" fmla="*/ 138938 h 138938"/>
                <a:gd name="connsiteX4" fmla="*/ 159766 w 2499995"/>
                <a:gd name="connsiteY4" fmla="*/ 138938 h 138938"/>
                <a:gd name="connsiteX5" fmla="*/ 197866 w 2499995"/>
                <a:gd name="connsiteY5" fmla="*/ 138938 h 138938"/>
                <a:gd name="connsiteX6" fmla="*/ 240792 w 2499995"/>
                <a:gd name="connsiteY6" fmla="*/ 138938 h 138938"/>
                <a:gd name="connsiteX7" fmla="*/ 282829 w 2499995"/>
                <a:gd name="connsiteY7" fmla="*/ 138938 h 138938"/>
                <a:gd name="connsiteX8" fmla="*/ 321564 w 2499995"/>
                <a:gd name="connsiteY8" fmla="*/ 138938 h 138938"/>
                <a:gd name="connsiteX9" fmla="*/ 357378 w 2499995"/>
                <a:gd name="connsiteY9" fmla="*/ 138938 h 138938"/>
                <a:gd name="connsiteX10" fmla="*/ 391795 w 2499995"/>
                <a:gd name="connsiteY10" fmla="*/ 138938 h 138938"/>
                <a:gd name="connsiteX11" fmla="*/ 426974 w 2499995"/>
                <a:gd name="connsiteY11" fmla="*/ 138938 h 138938"/>
                <a:gd name="connsiteX12" fmla="*/ 431546 w 2499995"/>
                <a:gd name="connsiteY12" fmla="*/ 138938 h 138938"/>
                <a:gd name="connsiteX13" fmla="*/ 462915 w 2499995"/>
                <a:gd name="connsiteY13" fmla="*/ 138938 h 138938"/>
                <a:gd name="connsiteX14" fmla="*/ 496443 w 2499995"/>
                <a:gd name="connsiteY14" fmla="*/ 138938 h 138938"/>
                <a:gd name="connsiteX15" fmla="*/ 532638 w 2499995"/>
                <a:gd name="connsiteY15" fmla="*/ 138938 h 138938"/>
                <a:gd name="connsiteX16" fmla="*/ 570992 w 2499995"/>
                <a:gd name="connsiteY16" fmla="*/ 138938 h 138938"/>
                <a:gd name="connsiteX17" fmla="*/ 611251 w 2499995"/>
                <a:gd name="connsiteY17" fmla="*/ 138938 h 138938"/>
                <a:gd name="connsiteX18" fmla="*/ 652653 w 2499995"/>
                <a:gd name="connsiteY18" fmla="*/ 138938 h 138938"/>
                <a:gd name="connsiteX19" fmla="*/ 693928 w 2499995"/>
                <a:gd name="connsiteY19" fmla="*/ 138938 h 138938"/>
                <a:gd name="connsiteX20" fmla="*/ 734314 w 2499995"/>
                <a:gd name="connsiteY20" fmla="*/ 138938 h 138938"/>
                <a:gd name="connsiteX21" fmla="*/ 773049 w 2499995"/>
                <a:gd name="connsiteY21" fmla="*/ 138938 h 138938"/>
                <a:gd name="connsiteX22" fmla="*/ 809371 w 2499995"/>
                <a:gd name="connsiteY22" fmla="*/ 138938 h 138938"/>
                <a:gd name="connsiteX23" fmla="*/ 843280 w 2499995"/>
                <a:gd name="connsiteY23" fmla="*/ 138938 h 138938"/>
                <a:gd name="connsiteX24" fmla="*/ 874776 w 2499995"/>
                <a:gd name="connsiteY24" fmla="*/ 138938 h 138938"/>
                <a:gd name="connsiteX25" fmla="*/ 877951 w 2499995"/>
                <a:gd name="connsiteY25" fmla="*/ 138938 h 138938"/>
                <a:gd name="connsiteX26" fmla="*/ 913257 w 2499995"/>
                <a:gd name="connsiteY26" fmla="*/ 138938 h 138938"/>
                <a:gd name="connsiteX27" fmla="*/ 947674 w 2499995"/>
                <a:gd name="connsiteY27" fmla="*/ 138938 h 138938"/>
                <a:gd name="connsiteX28" fmla="*/ 983234 w 2499995"/>
                <a:gd name="connsiteY28" fmla="*/ 138938 h 138938"/>
                <a:gd name="connsiteX29" fmla="*/ 1021588 w 2499995"/>
                <a:gd name="connsiteY29" fmla="*/ 138938 h 138938"/>
                <a:gd name="connsiteX30" fmla="*/ 1063371 w 2499995"/>
                <a:gd name="connsiteY30" fmla="*/ 138938 h 138938"/>
                <a:gd name="connsiteX31" fmla="*/ 1106297 w 2499995"/>
                <a:gd name="connsiteY31" fmla="*/ 138938 h 138938"/>
                <a:gd name="connsiteX32" fmla="*/ 1145413 w 2499995"/>
                <a:gd name="connsiteY32" fmla="*/ 138938 h 138938"/>
                <a:gd name="connsiteX33" fmla="*/ 1173734 w 2499995"/>
                <a:gd name="connsiteY33" fmla="*/ 138938 h 138938"/>
                <a:gd name="connsiteX34" fmla="*/ 1187577 w 2499995"/>
                <a:gd name="connsiteY34" fmla="*/ 138938 h 138938"/>
                <a:gd name="connsiteX35" fmla="*/ 1190498 w 2499995"/>
                <a:gd name="connsiteY35" fmla="*/ 138938 h 138938"/>
                <a:gd name="connsiteX36" fmla="*/ 1190498 w 2499995"/>
                <a:gd name="connsiteY36" fmla="*/ 138938 h 138938"/>
                <a:gd name="connsiteX37" fmla="*/ 1309497 w 2499995"/>
                <a:gd name="connsiteY37" fmla="*/ 138938 h 138938"/>
                <a:gd name="connsiteX38" fmla="*/ 1311529 w 2499995"/>
                <a:gd name="connsiteY38" fmla="*/ 138938 h 138938"/>
                <a:gd name="connsiteX39" fmla="*/ 1323721 w 2499995"/>
                <a:gd name="connsiteY39" fmla="*/ 138938 h 138938"/>
                <a:gd name="connsiteX40" fmla="*/ 1350264 w 2499995"/>
                <a:gd name="connsiteY40" fmla="*/ 138938 h 138938"/>
                <a:gd name="connsiteX41" fmla="*/ 1388364 w 2499995"/>
                <a:gd name="connsiteY41" fmla="*/ 138938 h 138938"/>
                <a:gd name="connsiteX42" fmla="*/ 1431163 w 2499995"/>
                <a:gd name="connsiteY42" fmla="*/ 138938 h 138938"/>
                <a:gd name="connsiteX43" fmla="*/ 1473327 w 2499995"/>
                <a:gd name="connsiteY43" fmla="*/ 138938 h 138938"/>
                <a:gd name="connsiteX44" fmla="*/ 1512062 w 2499995"/>
                <a:gd name="connsiteY44" fmla="*/ 138938 h 138938"/>
                <a:gd name="connsiteX45" fmla="*/ 1547876 w 2499995"/>
                <a:gd name="connsiteY45" fmla="*/ 138938 h 138938"/>
                <a:gd name="connsiteX46" fmla="*/ 1582293 w 2499995"/>
                <a:gd name="connsiteY46" fmla="*/ 138938 h 138938"/>
                <a:gd name="connsiteX47" fmla="*/ 1617472 w 2499995"/>
                <a:gd name="connsiteY47" fmla="*/ 138938 h 138938"/>
                <a:gd name="connsiteX48" fmla="*/ 1622044 w 2499995"/>
                <a:gd name="connsiteY48" fmla="*/ 138938 h 138938"/>
                <a:gd name="connsiteX49" fmla="*/ 1653413 w 2499995"/>
                <a:gd name="connsiteY49" fmla="*/ 138938 h 138938"/>
                <a:gd name="connsiteX50" fmla="*/ 1686941 w 2499995"/>
                <a:gd name="connsiteY50" fmla="*/ 138938 h 138938"/>
                <a:gd name="connsiteX51" fmla="*/ 1723009 w 2499995"/>
                <a:gd name="connsiteY51" fmla="*/ 138938 h 138938"/>
                <a:gd name="connsiteX52" fmla="*/ 1761490 w 2499995"/>
                <a:gd name="connsiteY52" fmla="*/ 138938 h 138938"/>
                <a:gd name="connsiteX53" fmla="*/ 1801749 w 2499995"/>
                <a:gd name="connsiteY53" fmla="*/ 138938 h 138938"/>
                <a:gd name="connsiteX54" fmla="*/ 1843024 w 2499995"/>
                <a:gd name="connsiteY54" fmla="*/ 138938 h 138938"/>
                <a:gd name="connsiteX55" fmla="*/ 1884426 w 2499995"/>
                <a:gd name="connsiteY55" fmla="*/ 138938 h 138938"/>
                <a:gd name="connsiteX56" fmla="*/ 1924812 w 2499995"/>
                <a:gd name="connsiteY56" fmla="*/ 138938 h 138938"/>
                <a:gd name="connsiteX57" fmla="*/ 1963547 w 2499995"/>
                <a:gd name="connsiteY57" fmla="*/ 138938 h 138938"/>
                <a:gd name="connsiteX58" fmla="*/ 1999869 w 2499995"/>
                <a:gd name="connsiteY58" fmla="*/ 138938 h 138938"/>
                <a:gd name="connsiteX59" fmla="*/ 2033778 w 2499995"/>
                <a:gd name="connsiteY59" fmla="*/ 138938 h 138938"/>
                <a:gd name="connsiteX60" fmla="*/ 2065274 w 2499995"/>
                <a:gd name="connsiteY60" fmla="*/ 138938 h 138938"/>
                <a:gd name="connsiteX61" fmla="*/ 2068449 w 2499995"/>
                <a:gd name="connsiteY61" fmla="*/ 138938 h 138938"/>
                <a:gd name="connsiteX62" fmla="*/ 2103755 w 2499995"/>
                <a:gd name="connsiteY62" fmla="*/ 138938 h 138938"/>
                <a:gd name="connsiteX63" fmla="*/ 2138172 w 2499995"/>
                <a:gd name="connsiteY63" fmla="*/ 138938 h 138938"/>
                <a:gd name="connsiteX64" fmla="*/ 2173732 w 2499995"/>
                <a:gd name="connsiteY64" fmla="*/ 138938 h 138938"/>
                <a:gd name="connsiteX65" fmla="*/ 2212086 w 2499995"/>
                <a:gd name="connsiteY65" fmla="*/ 138938 h 138938"/>
                <a:gd name="connsiteX66" fmla="*/ 2253742 w 2499995"/>
                <a:gd name="connsiteY66" fmla="*/ 138938 h 138938"/>
                <a:gd name="connsiteX67" fmla="*/ 2296795 w 2499995"/>
                <a:gd name="connsiteY67" fmla="*/ 138938 h 138938"/>
                <a:gd name="connsiteX68" fmla="*/ 2335911 w 2499995"/>
                <a:gd name="connsiteY68" fmla="*/ 138938 h 138938"/>
                <a:gd name="connsiteX69" fmla="*/ 2364232 w 2499995"/>
                <a:gd name="connsiteY69" fmla="*/ 138938 h 138938"/>
                <a:gd name="connsiteX70" fmla="*/ 2378075 w 2499995"/>
                <a:gd name="connsiteY70" fmla="*/ 138938 h 138938"/>
                <a:gd name="connsiteX71" fmla="*/ 2380869 w 2499995"/>
                <a:gd name="connsiteY71" fmla="*/ 138938 h 138938"/>
                <a:gd name="connsiteX72" fmla="*/ 2380869 w 2499995"/>
                <a:gd name="connsiteY72" fmla="*/ 138938 h 138938"/>
                <a:gd name="connsiteX73" fmla="*/ 2499995 w 2499995"/>
                <a:gd name="connsiteY73" fmla="*/ 138938 h 138938"/>
                <a:gd name="connsiteX74" fmla="*/ 2499995 w 2499995"/>
                <a:gd name="connsiteY74" fmla="*/ 0 h 138938"/>
                <a:gd name="connsiteX75" fmla="*/ 2380869 w 2499995"/>
                <a:gd name="connsiteY75" fmla="*/ 0 h 138938"/>
                <a:gd name="connsiteX76" fmla="*/ 2378964 w 2499995"/>
                <a:gd name="connsiteY76" fmla="*/ 0 h 138938"/>
                <a:gd name="connsiteX77" fmla="*/ 2366772 w 2499995"/>
                <a:gd name="connsiteY77" fmla="*/ 0 h 138938"/>
                <a:gd name="connsiteX78" fmla="*/ 2340102 w 2499995"/>
                <a:gd name="connsiteY78" fmla="*/ 0 h 138938"/>
                <a:gd name="connsiteX79" fmla="*/ 2302129 w 2499995"/>
                <a:gd name="connsiteY79" fmla="*/ 0 h 138938"/>
                <a:gd name="connsiteX80" fmla="*/ 2259203 w 2499995"/>
                <a:gd name="connsiteY80" fmla="*/ 0 h 138938"/>
                <a:gd name="connsiteX81" fmla="*/ 2217166 w 2499995"/>
                <a:gd name="connsiteY81" fmla="*/ 0 h 138938"/>
                <a:gd name="connsiteX82" fmla="*/ 2178304 w 2499995"/>
                <a:gd name="connsiteY82" fmla="*/ 0 h 138938"/>
                <a:gd name="connsiteX83" fmla="*/ 2142617 w 2499995"/>
                <a:gd name="connsiteY83" fmla="*/ 0 h 138938"/>
                <a:gd name="connsiteX84" fmla="*/ 2108073 w 2499995"/>
                <a:gd name="connsiteY84" fmla="*/ 0 h 138938"/>
                <a:gd name="connsiteX85" fmla="*/ 2073021 w 2499995"/>
                <a:gd name="connsiteY85" fmla="*/ 0 h 138938"/>
                <a:gd name="connsiteX86" fmla="*/ 2068449 w 2499995"/>
                <a:gd name="connsiteY86" fmla="*/ 0 h 138938"/>
                <a:gd name="connsiteX87" fmla="*/ 2037080 w 2499995"/>
                <a:gd name="connsiteY87" fmla="*/ 0 h 138938"/>
                <a:gd name="connsiteX88" fmla="*/ 2003425 w 2499995"/>
                <a:gd name="connsiteY88" fmla="*/ 0 h 138938"/>
                <a:gd name="connsiteX89" fmla="*/ 1967357 w 2499995"/>
                <a:gd name="connsiteY89" fmla="*/ 0 h 138938"/>
                <a:gd name="connsiteX90" fmla="*/ 1928876 w 2499995"/>
                <a:gd name="connsiteY90" fmla="*/ 0 h 138938"/>
                <a:gd name="connsiteX91" fmla="*/ 1888617 w 2499995"/>
                <a:gd name="connsiteY91" fmla="*/ 0 h 138938"/>
                <a:gd name="connsiteX92" fmla="*/ 1847342 w 2499995"/>
                <a:gd name="connsiteY92" fmla="*/ 0 h 138938"/>
                <a:gd name="connsiteX93" fmla="*/ 1805940 w 2499995"/>
                <a:gd name="connsiteY93" fmla="*/ 0 h 138938"/>
                <a:gd name="connsiteX94" fmla="*/ 1765554 w 2499995"/>
                <a:gd name="connsiteY94" fmla="*/ 0 h 138938"/>
                <a:gd name="connsiteX95" fmla="*/ 1726946 w 2499995"/>
                <a:gd name="connsiteY95" fmla="*/ 0 h 138938"/>
                <a:gd name="connsiteX96" fmla="*/ 1690497 w 2499995"/>
                <a:gd name="connsiteY96" fmla="*/ 0 h 138938"/>
                <a:gd name="connsiteX97" fmla="*/ 1656715 w 2499995"/>
                <a:gd name="connsiteY97" fmla="*/ 0 h 138938"/>
                <a:gd name="connsiteX98" fmla="*/ 1625092 w 2499995"/>
                <a:gd name="connsiteY98" fmla="*/ 0 h 138938"/>
                <a:gd name="connsiteX99" fmla="*/ 1622044 w 2499995"/>
                <a:gd name="connsiteY99" fmla="*/ 0 h 138938"/>
                <a:gd name="connsiteX100" fmla="*/ 1586611 w 2499995"/>
                <a:gd name="connsiteY100" fmla="*/ 0 h 138938"/>
                <a:gd name="connsiteX101" fmla="*/ 1552194 w 2499995"/>
                <a:gd name="connsiteY101" fmla="*/ 0 h 138938"/>
                <a:gd name="connsiteX102" fmla="*/ 1516761 w 2499995"/>
                <a:gd name="connsiteY102" fmla="*/ 0 h 138938"/>
                <a:gd name="connsiteX103" fmla="*/ 1478280 w 2499995"/>
                <a:gd name="connsiteY103" fmla="*/ 0 h 138938"/>
                <a:gd name="connsiteX104" fmla="*/ 1436624 w 2499995"/>
                <a:gd name="connsiteY104" fmla="*/ 0 h 138938"/>
                <a:gd name="connsiteX105" fmla="*/ 1393571 w 2499995"/>
                <a:gd name="connsiteY105" fmla="*/ 0 h 138938"/>
                <a:gd name="connsiteX106" fmla="*/ 1354582 w 2499995"/>
                <a:gd name="connsiteY106" fmla="*/ 0 h 138938"/>
                <a:gd name="connsiteX107" fmla="*/ 1326261 w 2499995"/>
                <a:gd name="connsiteY107" fmla="*/ 0 h 138938"/>
                <a:gd name="connsiteX108" fmla="*/ 1312291 w 2499995"/>
                <a:gd name="connsiteY108" fmla="*/ 0 h 138938"/>
                <a:gd name="connsiteX109" fmla="*/ 1309497 w 2499995"/>
                <a:gd name="connsiteY109" fmla="*/ 0 h 138938"/>
                <a:gd name="connsiteX110" fmla="*/ 1309497 w 2499995"/>
                <a:gd name="connsiteY110" fmla="*/ 0 h 138938"/>
                <a:gd name="connsiteX111" fmla="*/ 1190498 w 2499995"/>
                <a:gd name="connsiteY111" fmla="*/ 0 h 138938"/>
                <a:gd name="connsiteX112" fmla="*/ 1188466 w 2499995"/>
                <a:gd name="connsiteY112" fmla="*/ 0 h 138938"/>
                <a:gd name="connsiteX113" fmla="*/ 1176274 w 2499995"/>
                <a:gd name="connsiteY113" fmla="*/ 0 h 138938"/>
                <a:gd name="connsiteX114" fmla="*/ 1149731 w 2499995"/>
                <a:gd name="connsiteY114" fmla="*/ 0 h 138938"/>
                <a:gd name="connsiteX115" fmla="*/ 1111631 w 2499995"/>
                <a:gd name="connsiteY115" fmla="*/ 0 h 138938"/>
                <a:gd name="connsiteX116" fmla="*/ 1068705 w 2499995"/>
                <a:gd name="connsiteY116" fmla="*/ 0 h 138938"/>
                <a:gd name="connsiteX117" fmla="*/ 1026668 w 2499995"/>
                <a:gd name="connsiteY117" fmla="*/ 0 h 138938"/>
                <a:gd name="connsiteX118" fmla="*/ 987806 w 2499995"/>
                <a:gd name="connsiteY118" fmla="*/ 0 h 138938"/>
                <a:gd name="connsiteX119" fmla="*/ 952119 w 2499995"/>
                <a:gd name="connsiteY119" fmla="*/ 0 h 138938"/>
                <a:gd name="connsiteX120" fmla="*/ 917575 w 2499995"/>
                <a:gd name="connsiteY120" fmla="*/ 0 h 138938"/>
                <a:gd name="connsiteX121" fmla="*/ 882523 w 2499995"/>
                <a:gd name="connsiteY121" fmla="*/ 0 h 138938"/>
                <a:gd name="connsiteX122" fmla="*/ 877951 w 2499995"/>
                <a:gd name="connsiteY122" fmla="*/ 0 h 138938"/>
                <a:gd name="connsiteX123" fmla="*/ 846582 w 2499995"/>
                <a:gd name="connsiteY123" fmla="*/ 0 h 138938"/>
                <a:gd name="connsiteX124" fmla="*/ 812927 w 2499995"/>
                <a:gd name="connsiteY124" fmla="*/ 0 h 138938"/>
                <a:gd name="connsiteX125" fmla="*/ 776859 w 2499995"/>
                <a:gd name="connsiteY125" fmla="*/ 0 h 138938"/>
                <a:gd name="connsiteX126" fmla="*/ 738378 w 2499995"/>
                <a:gd name="connsiteY126" fmla="*/ 0 h 138938"/>
                <a:gd name="connsiteX127" fmla="*/ 698119 w 2499995"/>
                <a:gd name="connsiteY127" fmla="*/ 0 h 138938"/>
                <a:gd name="connsiteX128" fmla="*/ 656844 w 2499995"/>
                <a:gd name="connsiteY128" fmla="*/ 0 h 138938"/>
                <a:gd name="connsiteX129" fmla="*/ 615442 w 2499995"/>
                <a:gd name="connsiteY129" fmla="*/ 0 h 138938"/>
                <a:gd name="connsiteX130" fmla="*/ 575056 w 2499995"/>
                <a:gd name="connsiteY130" fmla="*/ 0 h 138938"/>
                <a:gd name="connsiteX131" fmla="*/ 536448 w 2499995"/>
                <a:gd name="connsiteY131" fmla="*/ 0 h 138938"/>
                <a:gd name="connsiteX132" fmla="*/ 500126 w 2499995"/>
                <a:gd name="connsiteY132" fmla="*/ 0 h 138938"/>
                <a:gd name="connsiteX133" fmla="*/ 466217 w 2499995"/>
                <a:gd name="connsiteY133" fmla="*/ 0 h 138938"/>
                <a:gd name="connsiteX134" fmla="*/ 434594 w 2499995"/>
                <a:gd name="connsiteY134" fmla="*/ 0 h 138938"/>
                <a:gd name="connsiteX135" fmla="*/ 431546 w 2499995"/>
                <a:gd name="connsiteY135" fmla="*/ 0 h 138938"/>
                <a:gd name="connsiteX136" fmla="*/ 396113 w 2499995"/>
                <a:gd name="connsiteY136" fmla="*/ 0 h 138938"/>
                <a:gd name="connsiteX137" fmla="*/ 361696 w 2499995"/>
                <a:gd name="connsiteY137" fmla="*/ 0 h 138938"/>
                <a:gd name="connsiteX138" fmla="*/ 326263 w 2499995"/>
                <a:gd name="connsiteY138" fmla="*/ 0 h 138938"/>
                <a:gd name="connsiteX139" fmla="*/ 287909 w 2499995"/>
                <a:gd name="connsiteY139" fmla="*/ 0 h 138938"/>
                <a:gd name="connsiteX140" fmla="*/ 246126 w 2499995"/>
                <a:gd name="connsiteY140" fmla="*/ 0 h 138938"/>
                <a:gd name="connsiteX141" fmla="*/ 203073 w 2499995"/>
                <a:gd name="connsiteY141" fmla="*/ 0 h 138938"/>
                <a:gd name="connsiteX142" fmla="*/ 164084 w 2499995"/>
                <a:gd name="connsiteY142" fmla="*/ 0 h 138938"/>
                <a:gd name="connsiteX143" fmla="*/ 135763 w 2499995"/>
                <a:gd name="connsiteY143" fmla="*/ 0 h 138938"/>
                <a:gd name="connsiteX144" fmla="*/ 121793 w 2499995"/>
                <a:gd name="connsiteY144" fmla="*/ 0 h 138938"/>
                <a:gd name="connsiteX145" fmla="*/ 118999 w 2499995"/>
                <a:gd name="connsiteY145" fmla="*/ 0 h 138938"/>
                <a:gd name="connsiteX146" fmla="*/ 118999 w 2499995"/>
                <a:gd name="connsiteY146" fmla="*/ 0 h 138938"/>
                <a:gd name="connsiteX147" fmla="*/ 0 w 2499995"/>
                <a:gd name="connsiteY147" fmla="*/ 0 h 1389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138938">
                  <a:moveTo>
                    <a:pt x="0" y="138938"/>
                  </a:moveTo>
                  <a:lnTo>
                    <a:pt x="118999" y="138938"/>
                  </a:lnTo>
                  <a:lnTo>
                    <a:pt x="121031" y="138938"/>
                  </a:lnTo>
                  <a:lnTo>
                    <a:pt x="133223" y="138938"/>
                  </a:lnTo>
                  <a:lnTo>
                    <a:pt x="159766" y="138938"/>
                  </a:lnTo>
                  <a:lnTo>
                    <a:pt x="197866" y="138938"/>
                  </a:lnTo>
                  <a:lnTo>
                    <a:pt x="240792" y="138938"/>
                  </a:lnTo>
                  <a:lnTo>
                    <a:pt x="282829" y="138938"/>
                  </a:lnTo>
                  <a:lnTo>
                    <a:pt x="321564" y="138938"/>
                  </a:lnTo>
                  <a:lnTo>
                    <a:pt x="357378" y="138938"/>
                  </a:lnTo>
                  <a:lnTo>
                    <a:pt x="391795" y="138938"/>
                  </a:lnTo>
                  <a:lnTo>
                    <a:pt x="426974" y="138938"/>
                  </a:lnTo>
                  <a:lnTo>
                    <a:pt x="431546" y="138938"/>
                  </a:lnTo>
                  <a:lnTo>
                    <a:pt x="462915" y="138938"/>
                  </a:lnTo>
                  <a:lnTo>
                    <a:pt x="496443" y="138938"/>
                  </a:lnTo>
                  <a:lnTo>
                    <a:pt x="532638" y="138938"/>
                  </a:lnTo>
                  <a:lnTo>
                    <a:pt x="570992" y="138938"/>
                  </a:lnTo>
                  <a:lnTo>
                    <a:pt x="611251" y="138938"/>
                  </a:lnTo>
                  <a:lnTo>
                    <a:pt x="652653" y="138938"/>
                  </a:lnTo>
                  <a:lnTo>
                    <a:pt x="693928" y="138938"/>
                  </a:lnTo>
                  <a:lnTo>
                    <a:pt x="734314" y="138938"/>
                  </a:lnTo>
                  <a:lnTo>
                    <a:pt x="773049" y="138938"/>
                  </a:lnTo>
                  <a:lnTo>
                    <a:pt x="809371" y="138938"/>
                  </a:lnTo>
                  <a:lnTo>
                    <a:pt x="843280" y="138938"/>
                  </a:lnTo>
                  <a:lnTo>
                    <a:pt x="874776" y="138938"/>
                  </a:lnTo>
                  <a:lnTo>
                    <a:pt x="877951" y="138938"/>
                  </a:lnTo>
                  <a:lnTo>
                    <a:pt x="913257" y="138938"/>
                  </a:lnTo>
                  <a:lnTo>
                    <a:pt x="947674" y="138938"/>
                  </a:lnTo>
                  <a:lnTo>
                    <a:pt x="983234" y="138938"/>
                  </a:lnTo>
                  <a:lnTo>
                    <a:pt x="1021588" y="138938"/>
                  </a:lnTo>
                  <a:lnTo>
                    <a:pt x="1063371" y="138938"/>
                  </a:lnTo>
                  <a:lnTo>
                    <a:pt x="1106297" y="138938"/>
                  </a:lnTo>
                  <a:lnTo>
                    <a:pt x="1145413" y="138938"/>
                  </a:lnTo>
                  <a:lnTo>
                    <a:pt x="1173734" y="138938"/>
                  </a:lnTo>
                  <a:lnTo>
                    <a:pt x="1187577" y="138938"/>
                  </a:lnTo>
                  <a:lnTo>
                    <a:pt x="1190498" y="138938"/>
                  </a:lnTo>
                  <a:lnTo>
                    <a:pt x="1190498" y="138938"/>
                  </a:lnTo>
                  <a:lnTo>
                    <a:pt x="1309497" y="138938"/>
                  </a:lnTo>
                  <a:lnTo>
                    <a:pt x="1311529" y="138938"/>
                  </a:lnTo>
                  <a:lnTo>
                    <a:pt x="1323721" y="138938"/>
                  </a:lnTo>
                  <a:lnTo>
                    <a:pt x="1350264" y="138938"/>
                  </a:lnTo>
                  <a:lnTo>
                    <a:pt x="1388364" y="138938"/>
                  </a:lnTo>
                  <a:lnTo>
                    <a:pt x="1431163" y="138938"/>
                  </a:lnTo>
                  <a:lnTo>
                    <a:pt x="1473327" y="138938"/>
                  </a:lnTo>
                  <a:lnTo>
                    <a:pt x="1512062" y="138938"/>
                  </a:lnTo>
                  <a:lnTo>
                    <a:pt x="1547876" y="138938"/>
                  </a:lnTo>
                  <a:lnTo>
                    <a:pt x="1582293" y="138938"/>
                  </a:lnTo>
                  <a:lnTo>
                    <a:pt x="1617472" y="138938"/>
                  </a:lnTo>
                  <a:lnTo>
                    <a:pt x="1622044" y="138938"/>
                  </a:lnTo>
                  <a:lnTo>
                    <a:pt x="1653413" y="138938"/>
                  </a:lnTo>
                  <a:lnTo>
                    <a:pt x="1686941" y="138938"/>
                  </a:lnTo>
                  <a:lnTo>
                    <a:pt x="1723009" y="138938"/>
                  </a:lnTo>
                  <a:lnTo>
                    <a:pt x="1761490" y="138938"/>
                  </a:lnTo>
                  <a:lnTo>
                    <a:pt x="1801749" y="138938"/>
                  </a:lnTo>
                  <a:lnTo>
                    <a:pt x="1843024" y="138938"/>
                  </a:lnTo>
                  <a:lnTo>
                    <a:pt x="1884426" y="138938"/>
                  </a:lnTo>
                  <a:lnTo>
                    <a:pt x="1924812" y="138938"/>
                  </a:lnTo>
                  <a:lnTo>
                    <a:pt x="1963547" y="138938"/>
                  </a:lnTo>
                  <a:lnTo>
                    <a:pt x="1999869" y="138938"/>
                  </a:lnTo>
                  <a:lnTo>
                    <a:pt x="2033778" y="138938"/>
                  </a:lnTo>
                  <a:lnTo>
                    <a:pt x="2065274" y="138938"/>
                  </a:lnTo>
                  <a:lnTo>
                    <a:pt x="2068449" y="138938"/>
                  </a:lnTo>
                  <a:lnTo>
                    <a:pt x="2103755" y="138938"/>
                  </a:lnTo>
                  <a:lnTo>
                    <a:pt x="2138172" y="138938"/>
                  </a:lnTo>
                  <a:lnTo>
                    <a:pt x="2173732" y="138938"/>
                  </a:lnTo>
                  <a:lnTo>
                    <a:pt x="2212086" y="138938"/>
                  </a:lnTo>
                  <a:lnTo>
                    <a:pt x="2253742" y="138938"/>
                  </a:lnTo>
                  <a:lnTo>
                    <a:pt x="2296795" y="138938"/>
                  </a:lnTo>
                  <a:lnTo>
                    <a:pt x="2335911" y="138938"/>
                  </a:lnTo>
                  <a:lnTo>
                    <a:pt x="2364232" y="138938"/>
                  </a:lnTo>
                  <a:lnTo>
                    <a:pt x="2378075" y="138938"/>
                  </a:lnTo>
                  <a:lnTo>
                    <a:pt x="2380869" y="138938"/>
                  </a:lnTo>
                  <a:lnTo>
                    <a:pt x="2380869" y="138938"/>
                  </a:lnTo>
                  <a:lnTo>
                    <a:pt x="2499995" y="138938"/>
                  </a:lnTo>
                  <a:lnTo>
                    <a:pt x="2499995" y="0"/>
                  </a:lnTo>
                  <a:lnTo>
                    <a:pt x="2380869" y="0"/>
                  </a:lnTo>
                  <a:lnTo>
                    <a:pt x="2378964" y="0"/>
                  </a:lnTo>
                  <a:lnTo>
                    <a:pt x="2366772" y="0"/>
                  </a:lnTo>
                  <a:lnTo>
                    <a:pt x="2340102" y="0"/>
                  </a:lnTo>
                  <a:lnTo>
                    <a:pt x="2302129" y="0"/>
                  </a:lnTo>
                  <a:lnTo>
                    <a:pt x="2259203" y="0"/>
                  </a:lnTo>
                  <a:lnTo>
                    <a:pt x="2217166" y="0"/>
                  </a:lnTo>
                  <a:lnTo>
                    <a:pt x="2178304" y="0"/>
                  </a:lnTo>
                  <a:lnTo>
                    <a:pt x="2142617" y="0"/>
                  </a:lnTo>
                  <a:lnTo>
                    <a:pt x="2108073" y="0"/>
                  </a:lnTo>
                  <a:lnTo>
                    <a:pt x="2073021" y="0"/>
                  </a:lnTo>
                  <a:lnTo>
                    <a:pt x="2068449" y="0"/>
                  </a:lnTo>
                  <a:lnTo>
                    <a:pt x="2037080" y="0"/>
                  </a:lnTo>
                  <a:lnTo>
                    <a:pt x="2003425" y="0"/>
                  </a:lnTo>
                  <a:lnTo>
                    <a:pt x="1967357" y="0"/>
                  </a:lnTo>
                  <a:lnTo>
                    <a:pt x="1928876" y="0"/>
                  </a:lnTo>
                  <a:lnTo>
                    <a:pt x="1888617" y="0"/>
                  </a:lnTo>
                  <a:lnTo>
                    <a:pt x="1847342" y="0"/>
                  </a:lnTo>
                  <a:lnTo>
                    <a:pt x="1805940" y="0"/>
                  </a:lnTo>
                  <a:lnTo>
                    <a:pt x="1765554" y="0"/>
                  </a:lnTo>
                  <a:lnTo>
                    <a:pt x="1726946" y="0"/>
                  </a:lnTo>
                  <a:lnTo>
                    <a:pt x="1690497" y="0"/>
                  </a:lnTo>
                  <a:lnTo>
                    <a:pt x="1656715" y="0"/>
                  </a:lnTo>
                  <a:lnTo>
                    <a:pt x="1625092" y="0"/>
                  </a:lnTo>
                  <a:lnTo>
                    <a:pt x="1622044" y="0"/>
                  </a:lnTo>
                  <a:lnTo>
                    <a:pt x="1586611" y="0"/>
                  </a:lnTo>
                  <a:lnTo>
                    <a:pt x="1552194" y="0"/>
                  </a:lnTo>
                  <a:lnTo>
                    <a:pt x="1516761" y="0"/>
                  </a:lnTo>
                  <a:lnTo>
                    <a:pt x="1478280" y="0"/>
                  </a:lnTo>
                  <a:lnTo>
                    <a:pt x="1436624" y="0"/>
                  </a:lnTo>
                  <a:lnTo>
                    <a:pt x="1393571" y="0"/>
                  </a:lnTo>
                  <a:lnTo>
                    <a:pt x="1354582" y="0"/>
                  </a:lnTo>
                  <a:lnTo>
                    <a:pt x="1326261" y="0"/>
                  </a:lnTo>
                  <a:lnTo>
                    <a:pt x="1312291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705" y="0"/>
                  </a:lnTo>
                  <a:lnTo>
                    <a:pt x="1026668" y="0"/>
                  </a:lnTo>
                  <a:lnTo>
                    <a:pt x="987806" y="0"/>
                  </a:lnTo>
                  <a:lnTo>
                    <a:pt x="952119" y="0"/>
                  </a:lnTo>
                  <a:lnTo>
                    <a:pt x="917575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2927" y="0"/>
                  </a:lnTo>
                  <a:lnTo>
                    <a:pt x="776859" y="0"/>
                  </a:lnTo>
                  <a:lnTo>
                    <a:pt x="738378" y="0"/>
                  </a:lnTo>
                  <a:lnTo>
                    <a:pt x="698119" y="0"/>
                  </a:lnTo>
                  <a:lnTo>
                    <a:pt x="656844" y="0"/>
                  </a:lnTo>
                  <a:lnTo>
                    <a:pt x="615442" y="0"/>
                  </a:lnTo>
                  <a:lnTo>
                    <a:pt x="575056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594" y="0"/>
                  </a:lnTo>
                  <a:lnTo>
                    <a:pt x="431546" y="0"/>
                  </a:lnTo>
                  <a:lnTo>
                    <a:pt x="396113" y="0"/>
                  </a:lnTo>
                  <a:lnTo>
                    <a:pt x="361696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126" y="0"/>
                  </a:lnTo>
                  <a:lnTo>
                    <a:pt x="203073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793" y="0"/>
                  </a:lnTo>
                  <a:lnTo>
                    <a:pt x="118999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DAE61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3" name="Forme libre 42">
              <a:extLst>
                <a:ext uri="{FF2B5EF4-FFF2-40B4-BE49-F238E27FC236}">
                  <a16:creationId xmlns:a16="http://schemas.microsoft.com/office/drawing/2014/main" id="{833917AF-3708-1595-7D15-1E2D64F93CF9}"/>
                </a:ext>
              </a:extLst>
            </p:cNvPr>
            <p:cNvSpPr/>
            <p:nvPr/>
          </p:nvSpPr>
          <p:spPr>
            <a:xfrm>
              <a:off x="3934840" y="6471190"/>
              <a:ext cx="2499995" cy="21335"/>
            </a:xfrm>
            <a:custGeom>
              <a:avLst/>
              <a:gdLst>
                <a:gd name="connsiteX0" fmla="*/ 0 w 2499995"/>
                <a:gd name="connsiteY0" fmla="*/ 21336 h 21335"/>
                <a:gd name="connsiteX1" fmla="*/ 118999 w 2499995"/>
                <a:gd name="connsiteY1" fmla="*/ 21336 h 21335"/>
                <a:gd name="connsiteX2" fmla="*/ 121031 w 2499995"/>
                <a:gd name="connsiteY2" fmla="*/ 21336 h 21335"/>
                <a:gd name="connsiteX3" fmla="*/ 133223 w 2499995"/>
                <a:gd name="connsiteY3" fmla="*/ 21336 h 21335"/>
                <a:gd name="connsiteX4" fmla="*/ 159766 w 2499995"/>
                <a:gd name="connsiteY4" fmla="*/ 21336 h 21335"/>
                <a:gd name="connsiteX5" fmla="*/ 197866 w 2499995"/>
                <a:gd name="connsiteY5" fmla="*/ 21336 h 21335"/>
                <a:gd name="connsiteX6" fmla="*/ 240792 w 2499995"/>
                <a:gd name="connsiteY6" fmla="*/ 21336 h 21335"/>
                <a:gd name="connsiteX7" fmla="*/ 282829 w 2499995"/>
                <a:gd name="connsiteY7" fmla="*/ 21336 h 21335"/>
                <a:gd name="connsiteX8" fmla="*/ 321564 w 2499995"/>
                <a:gd name="connsiteY8" fmla="*/ 21336 h 21335"/>
                <a:gd name="connsiteX9" fmla="*/ 357378 w 2499995"/>
                <a:gd name="connsiteY9" fmla="*/ 21336 h 21335"/>
                <a:gd name="connsiteX10" fmla="*/ 391795 w 2499995"/>
                <a:gd name="connsiteY10" fmla="*/ 21336 h 21335"/>
                <a:gd name="connsiteX11" fmla="*/ 426974 w 2499995"/>
                <a:gd name="connsiteY11" fmla="*/ 21336 h 21335"/>
                <a:gd name="connsiteX12" fmla="*/ 431546 w 2499995"/>
                <a:gd name="connsiteY12" fmla="*/ 21336 h 21335"/>
                <a:gd name="connsiteX13" fmla="*/ 462915 w 2499995"/>
                <a:gd name="connsiteY13" fmla="*/ 21336 h 21335"/>
                <a:gd name="connsiteX14" fmla="*/ 496443 w 2499995"/>
                <a:gd name="connsiteY14" fmla="*/ 21336 h 21335"/>
                <a:gd name="connsiteX15" fmla="*/ 532638 w 2499995"/>
                <a:gd name="connsiteY15" fmla="*/ 21336 h 21335"/>
                <a:gd name="connsiteX16" fmla="*/ 570992 w 2499995"/>
                <a:gd name="connsiteY16" fmla="*/ 21336 h 21335"/>
                <a:gd name="connsiteX17" fmla="*/ 611251 w 2499995"/>
                <a:gd name="connsiteY17" fmla="*/ 21336 h 21335"/>
                <a:gd name="connsiteX18" fmla="*/ 652653 w 2499995"/>
                <a:gd name="connsiteY18" fmla="*/ 21336 h 21335"/>
                <a:gd name="connsiteX19" fmla="*/ 693928 w 2499995"/>
                <a:gd name="connsiteY19" fmla="*/ 21336 h 21335"/>
                <a:gd name="connsiteX20" fmla="*/ 734314 w 2499995"/>
                <a:gd name="connsiteY20" fmla="*/ 21336 h 21335"/>
                <a:gd name="connsiteX21" fmla="*/ 773049 w 2499995"/>
                <a:gd name="connsiteY21" fmla="*/ 21336 h 21335"/>
                <a:gd name="connsiteX22" fmla="*/ 809371 w 2499995"/>
                <a:gd name="connsiteY22" fmla="*/ 21336 h 21335"/>
                <a:gd name="connsiteX23" fmla="*/ 843280 w 2499995"/>
                <a:gd name="connsiteY23" fmla="*/ 21336 h 21335"/>
                <a:gd name="connsiteX24" fmla="*/ 874776 w 2499995"/>
                <a:gd name="connsiteY24" fmla="*/ 21336 h 21335"/>
                <a:gd name="connsiteX25" fmla="*/ 877951 w 2499995"/>
                <a:gd name="connsiteY25" fmla="*/ 21336 h 21335"/>
                <a:gd name="connsiteX26" fmla="*/ 913257 w 2499995"/>
                <a:gd name="connsiteY26" fmla="*/ 21336 h 21335"/>
                <a:gd name="connsiteX27" fmla="*/ 947674 w 2499995"/>
                <a:gd name="connsiteY27" fmla="*/ 21336 h 21335"/>
                <a:gd name="connsiteX28" fmla="*/ 983234 w 2499995"/>
                <a:gd name="connsiteY28" fmla="*/ 21336 h 21335"/>
                <a:gd name="connsiteX29" fmla="*/ 1021588 w 2499995"/>
                <a:gd name="connsiteY29" fmla="*/ 21336 h 21335"/>
                <a:gd name="connsiteX30" fmla="*/ 1063371 w 2499995"/>
                <a:gd name="connsiteY30" fmla="*/ 21336 h 21335"/>
                <a:gd name="connsiteX31" fmla="*/ 1106297 w 2499995"/>
                <a:gd name="connsiteY31" fmla="*/ 21336 h 21335"/>
                <a:gd name="connsiteX32" fmla="*/ 1145413 w 2499995"/>
                <a:gd name="connsiteY32" fmla="*/ 21336 h 21335"/>
                <a:gd name="connsiteX33" fmla="*/ 1173734 w 2499995"/>
                <a:gd name="connsiteY33" fmla="*/ 21336 h 21335"/>
                <a:gd name="connsiteX34" fmla="*/ 1187577 w 2499995"/>
                <a:gd name="connsiteY34" fmla="*/ 21336 h 21335"/>
                <a:gd name="connsiteX35" fmla="*/ 1190498 w 2499995"/>
                <a:gd name="connsiteY35" fmla="*/ 21336 h 21335"/>
                <a:gd name="connsiteX36" fmla="*/ 1190498 w 2499995"/>
                <a:gd name="connsiteY36" fmla="*/ 21336 h 21335"/>
                <a:gd name="connsiteX37" fmla="*/ 1309497 w 2499995"/>
                <a:gd name="connsiteY37" fmla="*/ 21336 h 21335"/>
                <a:gd name="connsiteX38" fmla="*/ 1311529 w 2499995"/>
                <a:gd name="connsiteY38" fmla="*/ 21336 h 21335"/>
                <a:gd name="connsiteX39" fmla="*/ 1323721 w 2499995"/>
                <a:gd name="connsiteY39" fmla="*/ 21336 h 21335"/>
                <a:gd name="connsiteX40" fmla="*/ 1350264 w 2499995"/>
                <a:gd name="connsiteY40" fmla="*/ 21336 h 21335"/>
                <a:gd name="connsiteX41" fmla="*/ 1388364 w 2499995"/>
                <a:gd name="connsiteY41" fmla="*/ 21336 h 21335"/>
                <a:gd name="connsiteX42" fmla="*/ 1431163 w 2499995"/>
                <a:gd name="connsiteY42" fmla="*/ 21336 h 21335"/>
                <a:gd name="connsiteX43" fmla="*/ 1473327 w 2499995"/>
                <a:gd name="connsiteY43" fmla="*/ 21336 h 21335"/>
                <a:gd name="connsiteX44" fmla="*/ 1512062 w 2499995"/>
                <a:gd name="connsiteY44" fmla="*/ 21336 h 21335"/>
                <a:gd name="connsiteX45" fmla="*/ 1547876 w 2499995"/>
                <a:gd name="connsiteY45" fmla="*/ 21336 h 21335"/>
                <a:gd name="connsiteX46" fmla="*/ 1582293 w 2499995"/>
                <a:gd name="connsiteY46" fmla="*/ 21336 h 21335"/>
                <a:gd name="connsiteX47" fmla="*/ 1617472 w 2499995"/>
                <a:gd name="connsiteY47" fmla="*/ 21336 h 21335"/>
                <a:gd name="connsiteX48" fmla="*/ 1622044 w 2499995"/>
                <a:gd name="connsiteY48" fmla="*/ 21336 h 21335"/>
                <a:gd name="connsiteX49" fmla="*/ 1653413 w 2499995"/>
                <a:gd name="connsiteY49" fmla="*/ 21336 h 21335"/>
                <a:gd name="connsiteX50" fmla="*/ 1686941 w 2499995"/>
                <a:gd name="connsiteY50" fmla="*/ 21336 h 21335"/>
                <a:gd name="connsiteX51" fmla="*/ 1723009 w 2499995"/>
                <a:gd name="connsiteY51" fmla="*/ 21336 h 21335"/>
                <a:gd name="connsiteX52" fmla="*/ 1761490 w 2499995"/>
                <a:gd name="connsiteY52" fmla="*/ 21336 h 21335"/>
                <a:gd name="connsiteX53" fmla="*/ 1801749 w 2499995"/>
                <a:gd name="connsiteY53" fmla="*/ 21336 h 21335"/>
                <a:gd name="connsiteX54" fmla="*/ 1843024 w 2499995"/>
                <a:gd name="connsiteY54" fmla="*/ 21336 h 21335"/>
                <a:gd name="connsiteX55" fmla="*/ 1884426 w 2499995"/>
                <a:gd name="connsiteY55" fmla="*/ 21336 h 21335"/>
                <a:gd name="connsiteX56" fmla="*/ 1924812 w 2499995"/>
                <a:gd name="connsiteY56" fmla="*/ 21336 h 21335"/>
                <a:gd name="connsiteX57" fmla="*/ 1963547 w 2499995"/>
                <a:gd name="connsiteY57" fmla="*/ 21336 h 21335"/>
                <a:gd name="connsiteX58" fmla="*/ 1999869 w 2499995"/>
                <a:gd name="connsiteY58" fmla="*/ 21336 h 21335"/>
                <a:gd name="connsiteX59" fmla="*/ 2033778 w 2499995"/>
                <a:gd name="connsiteY59" fmla="*/ 21336 h 21335"/>
                <a:gd name="connsiteX60" fmla="*/ 2065274 w 2499995"/>
                <a:gd name="connsiteY60" fmla="*/ 21336 h 21335"/>
                <a:gd name="connsiteX61" fmla="*/ 2068449 w 2499995"/>
                <a:gd name="connsiteY61" fmla="*/ 21336 h 21335"/>
                <a:gd name="connsiteX62" fmla="*/ 2103755 w 2499995"/>
                <a:gd name="connsiteY62" fmla="*/ 21336 h 21335"/>
                <a:gd name="connsiteX63" fmla="*/ 2138172 w 2499995"/>
                <a:gd name="connsiteY63" fmla="*/ 21336 h 21335"/>
                <a:gd name="connsiteX64" fmla="*/ 2173732 w 2499995"/>
                <a:gd name="connsiteY64" fmla="*/ 21336 h 21335"/>
                <a:gd name="connsiteX65" fmla="*/ 2212086 w 2499995"/>
                <a:gd name="connsiteY65" fmla="*/ 21336 h 21335"/>
                <a:gd name="connsiteX66" fmla="*/ 2253742 w 2499995"/>
                <a:gd name="connsiteY66" fmla="*/ 21336 h 21335"/>
                <a:gd name="connsiteX67" fmla="*/ 2296795 w 2499995"/>
                <a:gd name="connsiteY67" fmla="*/ 21336 h 21335"/>
                <a:gd name="connsiteX68" fmla="*/ 2335911 w 2499995"/>
                <a:gd name="connsiteY68" fmla="*/ 21336 h 21335"/>
                <a:gd name="connsiteX69" fmla="*/ 2364232 w 2499995"/>
                <a:gd name="connsiteY69" fmla="*/ 21336 h 21335"/>
                <a:gd name="connsiteX70" fmla="*/ 2378075 w 2499995"/>
                <a:gd name="connsiteY70" fmla="*/ 21336 h 21335"/>
                <a:gd name="connsiteX71" fmla="*/ 2380869 w 2499995"/>
                <a:gd name="connsiteY71" fmla="*/ 21336 h 21335"/>
                <a:gd name="connsiteX72" fmla="*/ 2380869 w 2499995"/>
                <a:gd name="connsiteY72" fmla="*/ 21336 h 21335"/>
                <a:gd name="connsiteX73" fmla="*/ 2499995 w 2499995"/>
                <a:gd name="connsiteY73" fmla="*/ 21336 h 21335"/>
                <a:gd name="connsiteX74" fmla="*/ 2499995 w 2499995"/>
                <a:gd name="connsiteY74" fmla="*/ 0 h 21335"/>
                <a:gd name="connsiteX75" fmla="*/ 2380869 w 2499995"/>
                <a:gd name="connsiteY75" fmla="*/ 0 h 21335"/>
                <a:gd name="connsiteX76" fmla="*/ 2378964 w 2499995"/>
                <a:gd name="connsiteY76" fmla="*/ 0 h 21335"/>
                <a:gd name="connsiteX77" fmla="*/ 2366772 w 2499995"/>
                <a:gd name="connsiteY77" fmla="*/ 0 h 21335"/>
                <a:gd name="connsiteX78" fmla="*/ 2340102 w 2499995"/>
                <a:gd name="connsiteY78" fmla="*/ 0 h 21335"/>
                <a:gd name="connsiteX79" fmla="*/ 2302129 w 2499995"/>
                <a:gd name="connsiteY79" fmla="*/ 0 h 21335"/>
                <a:gd name="connsiteX80" fmla="*/ 2259203 w 2499995"/>
                <a:gd name="connsiteY80" fmla="*/ 0 h 21335"/>
                <a:gd name="connsiteX81" fmla="*/ 2217166 w 2499995"/>
                <a:gd name="connsiteY81" fmla="*/ 0 h 21335"/>
                <a:gd name="connsiteX82" fmla="*/ 2178304 w 2499995"/>
                <a:gd name="connsiteY82" fmla="*/ 0 h 21335"/>
                <a:gd name="connsiteX83" fmla="*/ 2142617 w 2499995"/>
                <a:gd name="connsiteY83" fmla="*/ 0 h 21335"/>
                <a:gd name="connsiteX84" fmla="*/ 2108073 w 2499995"/>
                <a:gd name="connsiteY84" fmla="*/ 0 h 21335"/>
                <a:gd name="connsiteX85" fmla="*/ 2073021 w 2499995"/>
                <a:gd name="connsiteY85" fmla="*/ 0 h 21335"/>
                <a:gd name="connsiteX86" fmla="*/ 2068449 w 2499995"/>
                <a:gd name="connsiteY86" fmla="*/ 0 h 21335"/>
                <a:gd name="connsiteX87" fmla="*/ 2037080 w 2499995"/>
                <a:gd name="connsiteY87" fmla="*/ 0 h 21335"/>
                <a:gd name="connsiteX88" fmla="*/ 2003425 w 2499995"/>
                <a:gd name="connsiteY88" fmla="*/ 0 h 21335"/>
                <a:gd name="connsiteX89" fmla="*/ 1967357 w 2499995"/>
                <a:gd name="connsiteY89" fmla="*/ 0 h 21335"/>
                <a:gd name="connsiteX90" fmla="*/ 1928876 w 2499995"/>
                <a:gd name="connsiteY90" fmla="*/ 0 h 21335"/>
                <a:gd name="connsiteX91" fmla="*/ 1888617 w 2499995"/>
                <a:gd name="connsiteY91" fmla="*/ 0 h 21335"/>
                <a:gd name="connsiteX92" fmla="*/ 1847342 w 2499995"/>
                <a:gd name="connsiteY92" fmla="*/ 0 h 21335"/>
                <a:gd name="connsiteX93" fmla="*/ 1805940 w 2499995"/>
                <a:gd name="connsiteY93" fmla="*/ 0 h 21335"/>
                <a:gd name="connsiteX94" fmla="*/ 1765554 w 2499995"/>
                <a:gd name="connsiteY94" fmla="*/ 0 h 21335"/>
                <a:gd name="connsiteX95" fmla="*/ 1726946 w 2499995"/>
                <a:gd name="connsiteY95" fmla="*/ 0 h 21335"/>
                <a:gd name="connsiteX96" fmla="*/ 1690497 w 2499995"/>
                <a:gd name="connsiteY96" fmla="*/ 0 h 21335"/>
                <a:gd name="connsiteX97" fmla="*/ 1656715 w 2499995"/>
                <a:gd name="connsiteY97" fmla="*/ 0 h 21335"/>
                <a:gd name="connsiteX98" fmla="*/ 1625092 w 2499995"/>
                <a:gd name="connsiteY98" fmla="*/ 0 h 21335"/>
                <a:gd name="connsiteX99" fmla="*/ 1622044 w 2499995"/>
                <a:gd name="connsiteY99" fmla="*/ 0 h 21335"/>
                <a:gd name="connsiteX100" fmla="*/ 1586611 w 2499995"/>
                <a:gd name="connsiteY100" fmla="*/ 0 h 21335"/>
                <a:gd name="connsiteX101" fmla="*/ 1552194 w 2499995"/>
                <a:gd name="connsiteY101" fmla="*/ 0 h 21335"/>
                <a:gd name="connsiteX102" fmla="*/ 1516761 w 2499995"/>
                <a:gd name="connsiteY102" fmla="*/ 0 h 21335"/>
                <a:gd name="connsiteX103" fmla="*/ 1478280 w 2499995"/>
                <a:gd name="connsiteY103" fmla="*/ 0 h 21335"/>
                <a:gd name="connsiteX104" fmla="*/ 1436624 w 2499995"/>
                <a:gd name="connsiteY104" fmla="*/ 0 h 21335"/>
                <a:gd name="connsiteX105" fmla="*/ 1393571 w 2499995"/>
                <a:gd name="connsiteY105" fmla="*/ 0 h 21335"/>
                <a:gd name="connsiteX106" fmla="*/ 1354582 w 2499995"/>
                <a:gd name="connsiteY106" fmla="*/ 0 h 21335"/>
                <a:gd name="connsiteX107" fmla="*/ 1326261 w 2499995"/>
                <a:gd name="connsiteY107" fmla="*/ 0 h 21335"/>
                <a:gd name="connsiteX108" fmla="*/ 1312291 w 2499995"/>
                <a:gd name="connsiteY108" fmla="*/ 0 h 21335"/>
                <a:gd name="connsiteX109" fmla="*/ 1309497 w 2499995"/>
                <a:gd name="connsiteY109" fmla="*/ 0 h 21335"/>
                <a:gd name="connsiteX110" fmla="*/ 1309497 w 2499995"/>
                <a:gd name="connsiteY110" fmla="*/ 0 h 21335"/>
                <a:gd name="connsiteX111" fmla="*/ 1190498 w 2499995"/>
                <a:gd name="connsiteY111" fmla="*/ 0 h 21335"/>
                <a:gd name="connsiteX112" fmla="*/ 1188466 w 2499995"/>
                <a:gd name="connsiteY112" fmla="*/ 0 h 21335"/>
                <a:gd name="connsiteX113" fmla="*/ 1176274 w 2499995"/>
                <a:gd name="connsiteY113" fmla="*/ 0 h 21335"/>
                <a:gd name="connsiteX114" fmla="*/ 1149731 w 2499995"/>
                <a:gd name="connsiteY114" fmla="*/ 0 h 21335"/>
                <a:gd name="connsiteX115" fmla="*/ 1111631 w 2499995"/>
                <a:gd name="connsiteY115" fmla="*/ 0 h 21335"/>
                <a:gd name="connsiteX116" fmla="*/ 1068705 w 2499995"/>
                <a:gd name="connsiteY116" fmla="*/ 0 h 21335"/>
                <a:gd name="connsiteX117" fmla="*/ 1026668 w 2499995"/>
                <a:gd name="connsiteY117" fmla="*/ 0 h 21335"/>
                <a:gd name="connsiteX118" fmla="*/ 987806 w 2499995"/>
                <a:gd name="connsiteY118" fmla="*/ 0 h 21335"/>
                <a:gd name="connsiteX119" fmla="*/ 952119 w 2499995"/>
                <a:gd name="connsiteY119" fmla="*/ 0 h 21335"/>
                <a:gd name="connsiteX120" fmla="*/ 917575 w 2499995"/>
                <a:gd name="connsiteY120" fmla="*/ 0 h 21335"/>
                <a:gd name="connsiteX121" fmla="*/ 882523 w 2499995"/>
                <a:gd name="connsiteY121" fmla="*/ 0 h 21335"/>
                <a:gd name="connsiteX122" fmla="*/ 877951 w 2499995"/>
                <a:gd name="connsiteY122" fmla="*/ 0 h 21335"/>
                <a:gd name="connsiteX123" fmla="*/ 846582 w 2499995"/>
                <a:gd name="connsiteY123" fmla="*/ 0 h 21335"/>
                <a:gd name="connsiteX124" fmla="*/ 812927 w 2499995"/>
                <a:gd name="connsiteY124" fmla="*/ 0 h 21335"/>
                <a:gd name="connsiteX125" fmla="*/ 776859 w 2499995"/>
                <a:gd name="connsiteY125" fmla="*/ 0 h 21335"/>
                <a:gd name="connsiteX126" fmla="*/ 738378 w 2499995"/>
                <a:gd name="connsiteY126" fmla="*/ 0 h 21335"/>
                <a:gd name="connsiteX127" fmla="*/ 698119 w 2499995"/>
                <a:gd name="connsiteY127" fmla="*/ 0 h 21335"/>
                <a:gd name="connsiteX128" fmla="*/ 656844 w 2499995"/>
                <a:gd name="connsiteY128" fmla="*/ 0 h 21335"/>
                <a:gd name="connsiteX129" fmla="*/ 615442 w 2499995"/>
                <a:gd name="connsiteY129" fmla="*/ 0 h 21335"/>
                <a:gd name="connsiteX130" fmla="*/ 575056 w 2499995"/>
                <a:gd name="connsiteY130" fmla="*/ 0 h 21335"/>
                <a:gd name="connsiteX131" fmla="*/ 536448 w 2499995"/>
                <a:gd name="connsiteY131" fmla="*/ 0 h 21335"/>
                <a:gd name="connsiteX132" fmla="*/ 500126 w 2499995"/>
                <a:gd name="connsiteY132" fmla="*/ 0 h 21335"/>
                <a:gd name="connsiteX133" fmla="*/ 466217 w 2499995"/>
                <a:gd name="connsiteY133" fmla="*/ 0 h 21335"/>
                <a:gd name="connsiteX134" fmla="*/ 434594 w 2499995"/>
                <a:gd name="connsiteY134" fmla="*/ 0 h 21335"/>
                <a:gd name="connsiteX135" fmla="*/ 431546 w 2499995"/>
                <a:gd name="connsiteY135" fmla="*/ 0 h 21335"/>
                <a:gd name="connsiteX136" fmla="*/ 396113 w 2499995"/>
                <a:gd name="connsiteY136" fmla="*/ 0 h 21335"/>
                <a:gd name="connsiteX137" fmla="*/ 361696 w 2499995"/>
                <a:gd name="connsiteY137" fmla="*/ 0 h 21335"/>
                <a:gd name="connsiteX138" fmla="*/ 326263 w 2499995"/>
                <a:gd name="connsiteY138" fmla="*/ 0 h 21335"/>
                <a:gd name="connsiteX139" fmla="*/ 287909 w 2499995"/>
                <a:gd name="connsiteY139" fmla="*/ 0 h 21335"/>
                <a:gd name="connsiteX140" fmla="*/ 246126 w 2499995"/>
                <a:gd name="connsiteY140" fmla="*/ 0 h 21335"/>
                <a:gd name="connsiteX141" fmla="*/ 203073 w 2499995"/>
                <a:gd name="connsiteY141" fmla="*/ 0 h 21335"/>
                <a:gd name="connsiteX142" fmla="*/ 164084 w 2499995"/>
                <a:gd name="connsiteY142" fmla="*/ 0 h 21335"/>
                <a:gd name="connsiteX143" fmla="*/ 135763 w 2499995"/>
                <a:gd name="connsiteY143" fmla="*/ 0 h 21335"/>
                <a:gd name="connsiteX144" fmla="*/ 121793 w 2499995"/>
                <a:gd name="connsiteY144" fmla="*/ 0 h 21335"/>
                <a:gd name="connsiteX145" fmla="*/ 118999 w 2499995"/>
                <a:gd name="connsiteY145" fmla="*/ 0 h 21335"/>
                <a:gd name="connsiteX146" fmla="*/ 118999 w 2499995"/>
                <a:gd name="connsiteY146" fmla="*/ 0 h 21335"/>
                <a:gd name="connsiteX147" fmla="*/ 0 w 2499995"/>
                <a:gd name="connsiteY147" fmla="*/ 0 h 213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</a:cxnLst>
              <a:rect l="l" t="t" r="r" b="b"/>
              <a:pathLst>
                <a:path w="2499995" h="21335">
                  <a:moveTo>
                    <a:pt x="0" y="21336"/>
                  </a:moveTo>
                  <a:lnTo>
                    <a:pt x="118999" y="21336"/>
                  </a:lnTo>
                  <a:lnTo>
                    <a:pt x="121031" y="21336"/>
                  </a:lnTo>
                  <a:lnTo>
                    <a:pt x="133223" y="21336"/>
                  </a:lnTo>
                  <a:lnTo>
                    <a:pt x="159766" y="21336"/>
                  </a:lnTo>
                  <a:lnTo>
                    <a:pt x="197866" y="21336"/>
                  </a:lnTo>
                  <a:lnTo>
                    <a:pt x="240792" y="21336"/>
                  </a:lnTo>
                  <a:lnTo>
                    <a:pt x="282829" y="21336"/>
                  </a:lnTo>
                  <a:lnTo>
                    <a:pt x="321564" y="21336"/>
                  </a:lnTo>
                  <a:lnTo>
                    <a:pt x="357378" y="21336"/>
                  </a:lnTo>
                  <a:lnTo>
                    <a:pt x="391795" y="21336"/>
                  </a:lnTo>
                  <a:lnTo>
                    <a:pt x="426974" y="21336"/>
                  </a:lnTo>
                  <a:lnTo>
                    <a:pt x="431546" y="21336"/>
                  </a:lnTo>
                  <a:lnTo>
                    <a:pt x="462915" y="21336"/>
                  </a:lnTo>
                  <a:lnTo>
                    <a:pt x="496443" y="21336"/>
                  </a:lnTo>
                  <a:lnTo>
                    <a:pt x="532638" y="21336"/>
                  </a:lnTo>
                  <a:lnTo>
                    <a:pt x="570992" y="21336"/>
                  </a:lnTo>
                  <a:lnTo>
                    <a:pt x="611251" y="21336"/>
                  </a:lnTo>
                  <a:lnTo>
                    <a:pt x="652653" y="21336"/>
                  </a:lnTo>
                  <a:lnTo>
                    <a:pt x="693928" y="21336"/>
                  </a:lnTo>
                  <a:lnTo>
                    <a:pt x="734314" y="21336"/>
                  </a:lnTo>
                  <a:lnTo>
                    <a:pt x="773049" y="21336"/>
                  </a:lnTo>
                  <a:lnTo>
                    <a:pt x="809371" y="21336"/>
                  </a:lnTo>
                  <a:lnTo>
                    <a:pt x="843280" y="21336"/>
                  </a:lnTo>
                  <a:lnTo>
                    <a:pt x="874776" y="21336"/>
                  </a:lnTo>
                  <a:lnTo>
                    <a:pt x="877951" y="21336"/>
                  </a:lnTo>
                  <a:lnTo>
                    <a:pt x="913257" y="21336"/>
                  </a:lnTo>
                  <a:lnTo>
                    <a:pt x="947674" y="21336"/>
                  </a:lnTo>
                  <a:lnTo>
                    <a:pt x="983234" y="21336"/>
                  </a:lnTo>
                  <a:lnTo>
                    <a:pt x="1021588" y="21336"/>
                  </a:lnTo>
                  <a:lnTo>
                    <a:pt x="1063371" y="21336"/>
                  </a:lnTo>
                  <a:lnTo>
                    <a:pt x="1106297" y="21336"/>
                  </a:lnTo>
                  <a:lnTo>
                    <a:pt x="1145413" y="21336"/>
                  </a:lnTo>
                  <a:lnTo>
                    <a:pt x="1173734" y="21336"/>
                  </a:lnTo>
                  <a:lnTo>
                    <a:pt x="1187577" y="21336"/>
                  </a:lnTo>
                  <a:lnTo>
                    <a:pt x="1190498" y="21336"/>
                  </a:lnTo>
                  <a:lnTo>
                    <a:pt x="1190498" y="21336"/>
                  </a:lnTo>
                  <a:lnTo>
                    <a:pt x="1309497" y="21336"/>
                  </a:lnTo>
                  <a:lnTo>
                    <a:pt x="1311529" y="21336"/>
                  </a:lnTo>
                  <a:lnTo>
                    <a:pt x="1323721" y="21336"/>
                  </a:lnTo>
                  <a:lnTo>
                    <a:pt x="1350264" y="21336"/>
                  </a:lnTo>
                  <a:lnTo>
                    <a:pt x="1388364" y="21336"/>
                  </a:lnTo>
                  <a:lnTo>
                    <a:pt x="1431163" y="21336"/>
                  </a:lnTo>
                  <a:lnTo>
                    <a:pt x="1473327" y="21336"/>
                  </a:lnTo>
                  <a:lnTo>
                    <a:pt x="1512062" y="21336"/>
                  </a:lnTo>
                  <a:lnTo>
                    <a:pt x="1547876" y="21336"/>
                  </a:lnTo>
                  <a:lnTo>
                    <a:pt x="1582293" y="21336"/>
                  </a:lnTo>
                  <a:lnTo>
                    <a:pt x="1617472" y="21336"/>
                  </a:lnTo>
                  <a:lnTo>
                    <a:pt x="1622044" y="21336"/>
                  </a:lnTo>
                  <a:lnTo>
                    <a:pt x="1653413" y="21336"/>
                  </a:lnTo>
                  <a:lnTo>
                    <a:pt x="1686941" y="21336"/>
                  </a:lnTo>
                  <a:lnTo>
                    <a:pt x="1723009" y="21336"/>
                  </a:lnTo>
                  <a:lnTo>
                    <a:pt x="1761490" y="21336"/>
                  </a:lnTo>
                  <a:lnTo>
                    <a:pt x="1801749" y="21336"/>
                  </a:lnTo>
                  <a:lnTo>
                    <a:pt x="1843024" y="21336"/>
                  </a:lnTo>
                  <a:lnTo>
                    <a:pt x="1884426" y="21336"/>
                  </a:lnTo>
                  <a:lnTo>
                    <a:pt x="1924812" y="21336"/>
                  </a:lnTo>
                  <a:lnTo>
                    <a:pt x="1963547" y="21336"/>
                  </a:lnTo>
                  <a:lnTo>
                    <a:pt x="1999869" y="21336"/>
                  </a:lnTo>
                  <a:lnTo>
                    <a:pt x="2033778" y="21336"/>
                  </a:lnTo>
                  <a:lnTo>
                    <a:pt x="2065274" y="21336"/>
                  </a:lnTo>
                  <a:lnTo>
                    <a:pt x="2068449" y="21336"/>
                  </a:lnTo>
                  <a:lnTo>
                    <a:pt x="2103755" y="21336"/>
                  </a:lnTo>
                  <a:lnTo>
                    <a:pt x="2138172" y="21336"/>
                  </a:lnTo>
                  <a:lnTo>
                    <a:pt x="2173732" y="21336"/>
                  </a:lnTo>
                  <a:lnTo>
                    <a:pt x="2212086" y="21336"/>
                  </a:lnTo>
                  <a:lnTo>
                    <a:pt x="2253742" y="21336"/>
                  </a:lnTo>
                  <a:lnTo>
                    <a:pt x="2296795" y="21336"/>
                  </a:lnTo>
                  <a:lnTo>
                    <a:pt x="2335911" y="21336"/>
                  </a:lnTo>
                  <a:lnTo>
                    <a:pt x="2364232" y="21336"/>
                  </a:lnTo>
                  <a:lnTo>
                    <a:pt x="2378075" y="21336"/>
                  </a:lnTo>
                  <a:lnTo>
                    <a:pt x="2380869" y="21336"/>
                  </a:lnTo>
                  <a:lnTo>
                    <a:pt x="2380869" y="21336"/>
                  </a:lnTo>
                  <a:lnTo>
                    <a:pt x="2499995" y="21336"/>
                  </a:lnTo>
                  <a:lnTo>
                    <a:pt x="2499995" y="0"/>
                  </a:lnTo>
                  <a:lnTo>
                    <a:pt x="2380869" y="0"/>
                  </a:lnTo>
                  <a:lnTo>
                    <a:pt x="2378964" y="0"/>
                  </a:lnTo>
                  <a:lnTo>
                    <a:pt x="2366772" y="0"/>
                  </a:lnTo>
                  <a:lnTo>
                    <a:pt x="2340102" y="0"/>
                  </a:lnTo>
                  <a:lnTo>
                    <a:pt x="2302129" y="0"/>
                  </a:lnTo>
                  <a:lnTo>
                    <a:pt x="2259203" y="0"/>
                  </a:lnTo>
                  <a:lnTo>
                    <a:pt x="2217166" y="0"/>
                  </a:lnTo>
                  <a:lnTo>
                    <a:pt x="2178304" y="0"/>
                  </a:lnTo>
                  <a:lnTo>
                    <a:pt x="2142617" y="0"/>
                  </a:lnTo>
                  <a:lnTo>
                    <a:pt x="2108073" y="0"/>
                  </a:lnTo>
                  <a:lnTo>
                    <a:pt x="2073021" y="0"/>
                  </a:lnTo>
                  <a:lnTo>
                    <a:pt x="2068449" y="0"/>
                  </a:lnTo>
                  <a:lnTo>
                    <a:pt x="2037080" y="0"/>
                  </a:lnTo>
                  <a:lnTo>
                    <a:pt x="2003425" y="0"/>
                  </a:lnTo>
                  <a:lnTo>
                    <a:pt x="1967357" y="0"/>
                  </a:lnTo>
                  <a:lnTo>
                    <a:pt x="1928876" y="0"/>
                  </a:lnTo>
                  <a:lnTo>
                    <a:pt x="1888617" y="0"/>
                  </a:lnTo>
                  <a:lnTo>
                    <a:pt x="1847342" y="0"/>
                  </a:lnTo>
                  <a:lnTo>
                    <a:pt x="1805940" y="0"/>
                  </a:lnTo>
                  <a:lnTo>
                    <a:pt x="1765554" y="0"/>
                  </a:lnTo>
                  <a:lnTo>
                    <a:pt x="1726946" y="0"/>
                  </a:lnTo>
                  <a:lnTo>
                    <a:pt x="1690497" y="0"/>
                  </a:lnTo>
                  <a:lnTo>
                    <a:pt x="1656715" y="0"/>
                  </a:lnTo>
                  <a:lnTo>
                    <a:pt x="1625092" y="0"/>
                  </a:lnTo>
                  <a:lnTo>
                    <a:pt x="1622044" y="0"/>
                  </a:lnTo>
                  <a:lnTo>
                    <a:pt x="1586611" y="0"/>
                  </a:lnTo>
                  <a:lnTo>
                    <a:pt x="1552194" y="0"/>
                  </a:lnTo>
                  <a:lnTo>
                    <a:pt x="1516761" y="0"/>
                  </a:lnTo>
                  <a:lnTo>
                    <a:pt x="1478280" y="0"/>
                  </a:lnTo>
                  <a:lnTo>
                    <a:pt x="1436624" y="0"/>
                  </a:lnTo>
                  <a:lnTo>
                    <a:pt x="1393571" y="0"/>
                  </a:lnTo>
                  <a:lnTo>
                    <a:pt x="1354582" y="0"/>
                  </a:lnTo>
                  <a:lnTo>
                    <a:pt x="1326261" y="0"/>
                  </a:lnTo>
                  <a:lnTo>
                    <a:pt x="1312291" y="0"/>
                  </a:lnTo>
                  <a:lnTo>
                    <a:pt x="1309497" y="0"/>
                  </a:lnTo>
                  <a:lnTo>
                    <a:pt x="1309497" y="0"/>
                  </a:lnTo>
                  <a:lnTo>
                    <a:pt x="1190498" y="0"/>
                  </a:lnTo>
                  <a:lnTo>
                    <a:pt x="1188466" y="0"/>
                  </a:lnTo>
                  <a:lnTo>
                    <a:pt x="1176274" y="0"/>
                  </a:lnTo>
                  <a:lnTo>
                    <a:pt x="1149731" y="0"/>
                  </a:lnTo>
                  <a:lnTo>
                    <a:pt x="1111631" y="0"/>
                  </a:lnTo>
                  <a:lnTo>
                    <a:pt x="1068705" y="0"/>
                  </a:lnTo>
                  <a:lnTo>
                    <a:pt x="1026668" y="0"/>
                  </a:lnTo>
                  <a:lnTo>
                    <a:pt x="987806" y="0"/>
                  </a:lnTo>
                  <a:lnTo>
                    <a:pt x="952119" y="0"/>
                  </a:lnTo>
                  <a:lnTo>
                    <a:pt x="917575" y="0"/>
                  </a:lnTo>
                  <a:lnTo>
                    <a:pt x="882523" y="0"/>
                  </a:lnTo>
                  <a:lnTo>
                    <a:pt x="877951" y="0"/>
                  </a:lnTo>
                  <a:lnTo>
                    <a:pt x="846582" y="0"/>
                  </a:lnTo>
                  <a:lnTo>
                    <a:pt x="812927" y="0"/>
                  </a:lnTo>
                  <a:lnTo>
                    <a:pt x="776859" y="0"/>
                  </a:lnTo>
                  <a:lnTo>
                    <a:pt x="738378" y="0"/>
                  </a:lnTo>
                  <a:lnTo>
                    <a:pt x="698119" y="0"/>
                  </a:lnTo>
                  <a:lnTo>
                    <a:pt x="656844" y="0"/>
                  </a:lnTo>
                  <a:lnTo>
                    <a:pt x="615442" y="0"/>
                  </a:lnTo>
                  <a:lnTo>
                    <a:pt x="575056" y="0"/>
                  </a:lnTo>
                  <a:lnTo>
                    <a:pt x="536448" y="0"/>
                  </a:lnTo>
                  <a:lnTo>
                    <a:pt x="500126" y="0"/>
                  </a:lnTo>
                  <a:lnTo>
                    <a:pt x="466217" y="0"/>
                  </a:lnTo>
                  <a:lnTo>
                    <a:pt x="434594" y="0"/>
                  </a:lnTo>
                  <a:lnTo>
                    <a:pt x="431546" y="0"/>
                  </a:lnTo>
                  <a:lnTo>
                    <a:pt x="396113" y="0"/>
                  </a:lnTo>
                  <a:lnTo>
                    <a:pt x="361696" y="0"/>
                  </a:lnTo>
                  <a:lnTo>
                    <a:pt x="326263" y="0"/>
                  </a:lnTo>
                  <a:lnTo>
                    <a:pt x="287909" y="0"/>
                  </a:lnTo>
                  <a:lnTo>
                    <a:pt x="246126" y="0"/>
                  </a:lnTo>
                  <a:lnTo>
                    <a:pt x="203073" y="0"/>
                  </a:lnTo>
                  <a:lnTo>
                    <a:pt x="164084" y="0"/>
                  </a:lnTo>
                  <a:lnTo>
                    <a:pt x="135763" y="0"/>
                  </a:lnTo>
                  <a:lnTo>
                    <a:pt x="121793" y="0"/>
                  </a:lnTo>
                  <a:lnTo>
                    <a:pt x="118999" y="0"/>
                  </a:lnTo>
                  <a:lnTo>
                    <a:pt x="11899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7191C">
                <a:alpha val="50000"/>
              </a:srgbClr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4" name="Forme libre 43">
              <a:extLst>
                <a:ext uri="{FF2B5EF4-FFF2-40B4-BE49-F238E27FC236}">
                  <a16:creationId xmlns:a16="http://schemas.microsoft.com/office/drawing/2014/main" id="{97E77C31-B6E8-A974-D2DE-BA86AFE4F013}"/>
                </a:ext>
              </a:extLst>
            </p:cNvPr>
            <p:cNvSpPr/>
            <p:nvPr/>
          </p:nvSpPr>
          <p:spPr>
            <a:xfrm>
              <a:off x="3934840" y="6471190"/>
              <a:ext cx="118999" cy="21335"/>
            </a:xfrm>
            <a:custGeom>
              <a:avLst/>
              <a:gdLst>
                <a:gd name="connsiteX0" fmla="*/ 0 w 118999"/>
                <a:gd name="connsiteY0" fmla="*/ 0 h 21335"/>
                <a:gd name="connsiteX1" fmla="*/ 118999 w 118999"/>
                <a:gd name="connsiteY1" fmla="*/ 0 h 21335"/>
                <a:gd name="connsiteX2" fmla="*/ 118999 w 118999"/>
                <a:gd name="connsiteY2" fmla="*/ 21336 h 21335"/>
                <a:gd name="connsiteX3" fmla="*/ 0 w 118999"/>
                <a:gd name="connsiteY3" fmla="*/ 21336 h 21335"/>
                <a:gd name="connsiteX4" fmla="*/ 0 w 118999"/>
                <a:gd name="connsiteY4" fmla="*/ 0 h 213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9" h="21335">
                  <a:moveTo>
                    <a:pt x="0" y="0"/>
                  </a:moveTo>
                  <a:lnTo>
                    <a:pt x="118999" y="0"/>
                  </a:lnTo>
                  <a:lnTo>
                    <a:pt x="118999" y="21336"/>
                  </a:lnTo>
                  <a:lnTo>
                    <a:pt x="0" y="2133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5" name="Forme libre 44">
              <a:extLst>
                <a:ext uri="{FF2B5EF4-FFF2-40B4-BE49-F238E27FC236}">
                  <a16:creationId xmlns:a16="http://schemas.microsoft.com/office/drawing/2014/main" id="{84B61173-776F-C26B-AE36-C4C5AEDC8D3B}"/>
                </a:ext>
              </a:extLst>
            </p:cNvPr>
            <p:cNvSpPr/>
            <p:nvPr/>
          </p:nvSpPr>
          <p:spPr>
            <a:xfrm>
              <a:off x="3934840" y="3992530"/>
              <a:ext cx="118999" cy="2478659"/>
            </a:xfrm>
            <a:custGeom>
              <a:avLst/>
              <a:gdLst>
                <a:gd name="connsiteX0" fmla="*/ 0 w 118999"/>
                <a:gd name="connsiteY0" fmla="*/ 0 h 2478659"/>
                <a:gd name="connsiteX1" fmla="*/ 118999 w 118999"/>
                <a:gd name="connsiteY1" fmla="*/ 0 h 2478659"/>
                <a:gd name="connsiteX2" fmla="*/ 118999 w 118999"/>
                <a:gd name="connsiteY2" fmla="*/ 2478659 h 2478659"/>
                <a:gd name="connsiteX3" fmla="*/ 0 w 118999"/>
                <a:gd name="connsiteY3" fmla="*/ 2478659 h 2478659"/>
                <a:gd name="connsiteX4" fmla="*/ 0 w 118999"/>
                <a:gd name="connsiteY4" fmla="*/ 0 h 24786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9" h="2478659">
                  <a:moveTo>
                    <a:pt x="0" y="0"/>
                  </a:moveTo>
                  <a:lnTo>
                    <a:pt x="118999" y="0"/>
                  </a:lnTo>
                  <a:lnTo>
                    <a:pt x="118999" y="2478659"/>
                  </a:lnTo>
                  <a:lnTo>
                    <a:pt x="0" y="24786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6" name="Forme libre 45">
              <a:extLst>
                <a:ext uri="{FF2B5EF4-FFF2-40B4-BE49-F238E27FC236}">
                  <a16:creationId xmlns:a16="http://schemas.microsoft.com/office/drawing/2014/main" id="{DC03175C-3C7A-FF44-8E15-E94BB066F13C}"/>
                </a:ext>
              </a:extLst>
            </p:cNvPr>
            <p:cNvSpPr/>
            <p:nvPr/>
          </p:nvSpPr>
          <p:spPr>
            <a:xfrm>
              <a:off x="5125339" y="6246780"/>
              <a:ext cx="118998" cy="245745"/>
            </a:xfrm>
            <a:custGeom>
              <a:avLst/>
              <a:gdLst>
                <a:gd name="connsiteX0" fmla="*/ 0 w 118998"/>
                <a:gd name="connsiteY0" fmla="*/ 0 h 245745"/>
                <a:gd name="connsiteX1" fmla="*/ 118999 w 118998"/>
                <a:gd name="connsiteY1" fmla="*/ 0 h 245745"/>
                <a:gd name="connsiteX2" fmla="*/ 118999 w 118998"/>
                <a:gd name="connsiteY2" fmla="*/ 245745 h 245745"/>
                <a:gd name="connsiteX3" fmla="*/ 0 w 118998"/>
                <a:gd name="connsiteY3" fmla="*/ 245745 h 245745"/>
                <a:gd name="connsiteX4" fmla="*/ 0 w 118998"/>
                <a:gd name="connsiteY4" fmla="*/ 0 h 2457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245745">
                  <a:moveTo>
                    <a:pt x="0" y="0"/>
                  </a:moveTo>
                  <a:lnTo>
                    <a:pt x="118999" y="0"/>
                  </a:lnTo>
                  <a:lnTo>
                    <a:pt x="118999" y="245745"/>
                  </a:lnTo>
                  <a:lnTo>
                    <a:pt x="0" y="24574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7" name="Forme libre 46">
              <a:extLst>
                <a:ext uri="{FF2B5EF4-FFF2-40B4-BE49-F238E27FC236}">
                  <a16:creationId xmlns:a16="http://schemas.microsoft.com/office/drawing/2014/main" id="{88B7FF40-B6A9-42B8-D4F2-0AB76B431FAF}"/>
                </a:ext>
              </a:extLst>
            </p:cNvPr>
            <p:cNvSpPr/>
            <p:nvPr/>
          </p:nvSpPr>
          <p:spPr>
            <a:xfrm>
              <a:off x="5125339" y="3992530"/>
              <a:ext cx="118998" cy="2254250"/>
            </a:xfrm>
            <a:custGeom>
              <a:avLst/>
              <a:gdLst>
                <a:gd name="connsiteX0" fmla="*/ 0 w 118998"/>
                <a:gd name="connsiteY0" fmla="*/ 0 h 2254250"/>
                <a:gd name="connsiteX1" fmla="*/ 118999 w 118998"/>
                <a:gd name="connsiteY1" fmla="*/ 0 h 2254250"/>
                <a:gd name="connsiteX2" fmla="*/ 118999 w 118998"/>
                <a:gd name="connsiteY2" fmla="*/ 2254250 h 2254250"/>
                <a:gd name="connsiteX3" fmla="*/ 0 w 118998"/>
                <a:gd name="connsiteY3" fmla="*/ 2254250 h 2254250"/>
                <a:gd name="connsiteX4" fmla="*/ 0 w 118998"/>
                <a:gd name="connsiteY4" fmla="*/ 0 h 22542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8998" h="2254250">
                  <a:moveTo>
                    <a:pt x="0" y="0"/>
                  </a:moveTo>
                  <a:lnTo>
                    <a:pt x="118999" y="0"/>
                  </a:lnTo>
                  <a:lnTo>
                    <a:pt x="118999" y="2254250"/>
                  </a:lnTo>
                  <a:lnTo>
                    <a:pt x="0" y="225425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8" name="Forme libre 47">
              <a:extLst>
                <a:ext uri="{FF2B5EF4-FFF2-40B4-BE49-F238E27FC236}">
                  <a16:creationId xmlns:a16="http://schemas.microsoft.com/office/drawing/2014/main" id="{EDD3B826-D71D-996C-9D79-538BFA9DC0BD}"/>
                </a:ext>
              </a:extLst>
            </p:cNvPr>
            <p:cNvSpPr/>
            <p:nvPr/>
          </p:nvSpPr>
          <p:spPr>
            <a:xfrm>
              <a:off x="6315709" y="5167789"/>
              <a:ext cx="119126" cy="1324736"/>
            </a:xfrm>
            <a:custGeom>
              <a:avLst/>
              <a:gdLst>
                <a:gd name="connsiteX0" fmla="*/ 0 w 119126"/>
                <a:gd name="connsiteY0" fmla="*/ 0 h 1324736"/>
                <a:gd name="connsiteX1" fmla="*/ 119126 w 119126"/>
                <a:gd name="connsiteY1" fmla="*/ 0 h 1324736"/>
                <a:gd name="connsiteX2" fmla="*/ 119126 w 119126"/>
                <a:gd name="connsiteY2" fmla="*/ 1324737 h 1324736"/>
                <a:gd name="connsiteX3" fmla="*/ 0 w 119126"/>
                <a:gd name="connsiteY3" fmla="*/ 1324737 h 1324736"/>
                <a:gd name="connsiteX4" fmla="*/ 0 w 119126"/>
                <a:gd name="connsiteY4" fmla="*/ 0 h 13247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9126" h="1324736">
                  <a:moveTo>
                    <a:pt x="0" y="0"/>
                  </a:moveTo>
                  <a:lnTo>
                    <a:pt x="119126" y="0"/>
                  </a:lnTo>
                  <a:lnTo>
                    <a:pt x="119126" y="1324737"/>
                  </a:lnTo>
                  <a:lnTo>
                    <a:pt x="0" y="13247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49" name="Forme libre 48">
              <a:extLst>
                <a:ext uri="{FF2B5EF4-FFF2-40B4-BE49-F238E27FC236}">
                  <a16:creationId xmlns:a16="http://schemas.microsoft.com/office/drawing/2014/main" id="{73A1EC8C-AF58-2700-8E1E-E5B8E50D2419}"/>
                </a:ext>
              </a:extLst>
            </p:cNvPr>
            <p:cNvSpPr/>
            <p:nvPr/>
          </p:nvSpPr>
          <p:spPr>
            <a:xfrm>
              <a:off x="6315709" y="3992530"/>
              <a:ext cx="119126" cy="1175258"/>
            </a:xfrm>
            <a:custGeom>
              <a:avLst/>
              <a:gdLst>
                <a:gd name="connsiteX0" fmla="*/ 0 w 119126"/>
                <a:gd name="connsiteY0" fmla="*/ 0 h 1175258"/>
                <a:gd name="connsiteX1" fmla="*/ 119126 w 119126"/>
                <a:gd name="connsiteY1" fmla="*/ 0 h 1175258"/>
                <a:gd name="connsiteX2" fmla="*/ 119126 w 119126"/>
                <a:gd name="connsiteY2" fmla="*/ 1175258 h 1175258"/>
                <a:gd name="connsiteX3" fmla="*/ 0 w 119126"/>
                <a:gd name="connsiteY3" fmla="*/ 1175258 h 1175258"/>
                <a:gd name="connsiteX4" fmla="*/ 0 w 119126"/>
                <a:gd name="connsiteY4" fmla="*/ 0 h 11752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9126" h="1175258">
                  <a:moveTo>
                    <a:pt x="0" y="0"/>
                  </a:moveTo>
                  <a:lnTo>
                    <a:pt x="119126" y="0"/>
                  </a:lnTo>
                  <a:lnTo>
                    <a:pt x="119126" y="1175258"/>
                  </a:lnTo>
                  <a:lnTo>
                    <a:pt x="0" y="117525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  <p:sp>
        <p:nvSpPr>
          <p:cNvPr id="50" name="ZoneTexte 49">
            <a:extLst>
              <a:ext uri="{FF2B5EF4-FFF2-40B4-BE49-F238E27FC236}">
                <a16:creationId xmlns:a16="http://schemas.microsoft.com/office/drawing/2014/main" id="{DD0F6300-E312-342C-9D45-4DA7DA0A8F26}"/>
              </a:ext>
            </a:extLst>
          </p:cNvPr>
          <p:cNvSpPr txBox="1"/>
          <p:nvPr/>
        </p:nvSpPr>
        <p:spPr>
          <a:xfrm>
            <a:off x="1458213" y="3637819"/>
            <a:ext cx="100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1200" b="1" spc="0" baseline="0" dirty="0">
                <a:ln/>
                <a:solidFill>
                  <a:srgbClr val="1A1A1A"/>
                </a:solidFill>
                <a:latin typeface="Arial"/>
                <a:cs typeface="Arial"/>
                <a:sym typeface="Arial"/>
                <a:rtl val="0"/>
              </a:rPr>
              <a:t>5-year-olds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DE92518B-2A01-1D89-CF15-B75B7F608AD7}"/>
              </a:ext>
            </a:extLst>
          </p:cNvPr>
          <p:cNvSpPr txBox="1"/>
          <p:nvPr/>
        </p:nvSpPr>
        <p:spPr>
          <a:xfrm>
            <a:off x="4756785" y="3637819"/>
            <a:ext cx="100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1200" b="1" spc="0" baseline="0" dirty="0">
                <a:ln/>
                <a:solidFill>
                  <a:srgbClr val="1A1A1A"/>
                </a:solidFill>
                <a:latin typeface="Arial"/>
                <a:cs typeface="Arial"/>
                <a:sym typeface="Arial"/>
                <a:rtl val="0"/>
              </a:rPr>
              <a:t>6-year-olds</a:t>
            </a:r>
          </a:p>
        </p:txBody>
      </p:sp>
      <p:grpSp>
        <p:nvGrpSpPr>
          <p:cNvPr id="52" name="Graphique 19">
            <a:extLst>
              <a:ext uri="{FF2B5EF4-FFF2-40B4-BE49-F238E27FC236}">
                <a16:creationId xmlns:a16="http://schemas.microsoft.com/office/drawing/2014/main" id="{80FEE328-CC61-826F-A9E8-2656D6FB6112}"/>
              </a:ext>
            </a:extLst>
          </p:cNvPr>
          <p:cNvGrpSpPr/>
          <p:nvPr/>
        </p:nvGrpSpPr>
        <p:grpSpPr>
          <a:xfrm>
            <a:off x="218625" y="3178207"/>
            <a:ext cx="6642504" cy="4008292"/>
            <a:chOff x="218625" y="3178207"/>
            <a:chExt cx="6642504" cy="4008292"/>
          </a:xfrm>
        </p:grpSpPr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B49F3EC5-3767-436F-C715-03200EAC3E8D}"/>
                </a:ext>
              </a:extLst>
            </p:cNvPr>
            <p:cNvSpPr txBox="1"/>
            <p:nvPr/>
          </p:nvSpPr>
          <p:spPr>
            <a:xfrm>
              <a:off x="337565" y="6614953"/>
              <a:ext cx="7745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spc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Oscillating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FC9DA885-F552-6AF7-2F8D-CE6288595DA7}"/>
                </a:ext>
              </a:extLst>
            </p:cNvPr>
            <p:cNvSpPr txBox="1"/>
            <p:nvPr/>
          </p:nvSpPr>
          <p:spPr>
            <a:xfrm>
              <a:off x="1667763" y="6614953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spc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otif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A51BEE8D-E321-59AC-F6A5-E6B1703AF61E}"/>
                </a:ext>
              </a:extLst>
            </p:cNvPr>
            <p:cNvSpPr txBox="1"/>
            <p:nvPr/>
          </p:nvSpPr>
          <p:spPr>
            <a:xfrm>
              <a:off x="2667761" y="6614953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spc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omposition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E562F79D-ED72-6097-64B6-5D94900D0A50}"/>
                </a:ext>
              </a:extLst>
            </p:cNvPr>
            <p:cNvSpPr txBox="1"/>
            <p:nvPr/>
          </p:nvSpPr>
          <p:spPr>
            <a:xfrm>
              <a:off x="3636137" y="6614953"/>
              <a:ext cx="7745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spc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Oscillating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A4116FAF-ADDF-05B0-E96B-90F6C18BF9B6}"/>
                </a:ext>
              </a:extLst>
            </p:cNvPr>
            <p:cNvSpPr txBox="1"/>
            <p:nvPr/>
          </p:nvSpPr>
          <p:spPr>
            <a:xfrm>
              <a:off x="4966335" y="6614953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spc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Motif</a:t>
              </a:r>
            </a:p>
          </p:txBody>
        </p:sp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AB7D70C3-F736-3569-EC6A-71EE6806E38E}"/>
                </a:ext>
              </a:extLst>
            </p:cNvPr>
            <p:cNvSpPr txBox="1"/>
            <p:nvPr/>
          </p:nvSpPr>
          <p:spPr>
            <a:xfrm>
              <a:off x="5966332" y="6614953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00" spc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omposition</a:t>
              </a:r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314CB70A-7D1C-1846-D14F-2214E3F3B53D}"/>
                </a:ext>
              </a:extLst>
            </p:cNvPr>
            <p:cNvSpPr txBox="1"/>
            <p:nvPr/>
          </p:nvSpPr>
          <p:spPr>
            <a:xfrm>
              <a:off x="3125396" y="6909500"/>
              <a:ext cx="9444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200" b="1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roperties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DB8FFC2E-0611-F7FE-BEE0-DA61D9477AEF}"/>
                </a:ext>
              </a:extLst>
            </p:cNvPr>
            <p:cNvSpPr txBox="1"/>
            <p:nvPr/>
          </p:nvSpPr>
          <p:spPr>
            <a:xfrm rot="16200000">
              <a:off x="-137562" y="5110443"/>
              <a:ext cx="9893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200" b="1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% </a:t>
              </a:r>
              <a:r>
                <a:rPr lang="fr-FR" sz="1200" b="1" spc="0" baseline="0" dirty="0" err="1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hildren</a:t>
              </a:r>
              <a:endParaRPr lang="fr-FR" sz="1200" b="1" spc="0" baseline="0" dirty="0">
                <a:ln/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endParaRPr>
            </a:p>
          </p:txBody>
        </p:sp>
        <p:sp>
          <p:nvSpPr>
            <p:cNvPr id="61" name="Forme libre 60">
              <a:extLst>
                <a:ext uri="{FF2B5EF4-FFF2-40B4-BE49-F238E27FC236}">
                  <a16:creationId xmlns:a16="http://schemas.microsoft.com/office/drawing/2014/main" id="{6EF8716F-35ED-F76E-CE26-A2E1F69045AF}"/>
                </a:ext>
              </a:extLst>
            </p:cNvPr>
            <p:cNvSpPr/>
            <p:nvPr/>
          </p:nvSpPr>
          <p:spPr>
            <a:xfrm>
              <a:off x="2783459" y="3178207"/>
              <a:ext cx="1504061" cy="319150"/>
            </a:xfrm>
            <a:custGeom>
              <a:avLst/>
              <a:gdLst>
                <a:gd name="connsiteX0" fmla="*/ 0 w 1504061"/>
                <a:gd name="connsiteY0" fmla="*/ 0 h 319150"/>
                <a:gd name="connsiteX1" fmla="*/ 1504061 w 1504061"/>
                <a:gd name="connsiteY1" fmla="*/ 0 h 319150"/>
                <a:gd name="connsiteX2" fmla="*/ 1504061 w 1504061"/>
                <a:gd name="connsiteY2" fmla="*/ 319151 h 319150"/>
                <a:gd name="connsiteX3" fmla="*/ 0 w 1504061"/>
                <a:gd name="connsiteY3" fmla="*/ 319151 h 3191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04061" h="319150">
                  <a:moveTo>
                    <a:pt x="0" y="0"/>
                  </a:moveTo>
                  <a:lnTo>
                    <a:pt x="1504061" y="0"/>
                  </a:lnTo>
                  <a:lnTo>
                    <a:pt x="1504061" y="319151"/>
                  </a:lnTo>
                  <a:lnTo>
                    <a:pt x="0" y="319151"/>
                  </a:lnTo>
                  <a:close/>
                </a:path>
              </a:pathLst>
            </a:custGeom>
            <a:solidFill>
              <a:srgbClr val="FFFFFF"/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dirty="0"/>
            </a:p>
          </p:txBody>
        </p:sp>
        <p:sp>
          <p:nvSpPr>
            <p:cNvPr id="62" name="Forme libre 61">
              <a:extLst>
                <a:ext uri="{FF2B5EF4-FFF2-40B4-BE49-F238E27FC236}">
                  <a16:creationId xmlns:a16="http://schemas.microsoft.com/office/drawing/2014/main" id="{830973E2-6DB7-19CE-658D-8C1FB40B4513}"/>
                </a:ext>
              </a:extLst>
            </p:cNvPr>
            <p:cNvSpPr/>
            <p:nvPr/>
          </p:nvSpPr>
          <p:spPr>
            <a:xfrm>
              <a:off x="2853055" y="3247803"/>
              <a:ext cx="179958" cy="179959"/>
            </a:xfrm>
            <a:custGeom>
              <a:avLst/>
              <a:gdLst>
                <a:gd name="connsiteX0" fmla="*/ 0 w 179958"/>
                <a:gd name="connsiteY0" fmla="*/ 0 h 179959"/>
                <a:gd name="connsiteX1" fmla="*/ 179959 w 179958"/>
                <a:gd name="connsiteY1" fmla="*/ 0 h 179959"/>
                <a:gd name="connsiteX2" fmla="*/ 179959 w 179958"/>
                <a:gd name="connsiteY2" fmla="*/ 179959 h 179959"/>
                <a:gd name="connsiteX3" fmla="*/ 0 w 179958"/>
                <a:gd name="connsiteY3" fmla="*/ 179959 h 179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9958" h="179959">
                  <a:moveTo>
                    <a:pt x="0" y="0"/>
                  </a:moveTo>
                  <a:lnTo>
                    <a:pt x="179959" y="0"/>
                  </a:lnTo>
                  <a:lnTo>
                    <a:pt x="179959" y="179959"/>
                  </a:lnTo>
                  <a:lnTo>
                    <a:pt x="0" y="179959"/>
                  </a:lnTo>
                  <a:close/>
                </a:path>
              </a:pathLst>
            </a:custGeom>
            <a:solidFill>
              <a:srgbClr val="FFFFFF"/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63" name="Forme libre 62">
              <a:extLst>
                <a:ext uri="{FF2B5EF4-FFF2-40B4-BE49-F238E27FC236}">
                  <a16:creationId xmlns:a16="http://schemas.microsoft.com/office/drawing/2014/main" id="{1B3B8C8A-8CF6-3B31-44E6-DFB3902D6859}"/>
                </a:ext>
              </a:extLst>
            </p:cNvPr>
            <p:cNvSpPr/>
            <p:nvPr/>
          </p:nvSpPr>
          <p:spPr>
            <a:xfrm>
              <a:off x="2725341" y="3256820"/>
              <a:ext cx="162051" cy="162051"/>
            </a:xfrm>
            <a:custGeom>
              <a:avLst/>
              <a:gdLst>
                <a:gd name="connsiteX0" fmla="*/ 0 w 162051"/>
                <a:gd name="connsiteY0" fmla="*/ 0 h 162051"/>
                <a:gd name="connsiteX1" fmla="*/ 162052 w 162051"/>
                <a:gd name="connsiteY1" fmla="*/ 0 h 162051"/>
                <a:gd name="connsiteX2" fmla="*/ 162052 w 162051"/>
                <a:gd name="connsiteY2" fmla="*/ 162052 h 162051"/>
                <a:gd name="connsiteX3" fmla="*/ 0 w 162051"/>
                <a:gd name="connsiteY3" fmla="*/ 162052 h 162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2051" h="162051">
                  <a:moveTo>
                    <a:pt x="0" y="0"/>
                  </a:moveTo>
                  <a:lnTo>
                    <a:pt x="162052" y="0"/>
                  </a:lnTo>
                  <a:lnTo>
                    <a:pt x="162052" y="162052"/>
                  </a:lnTo>
                  <a:lnTo>
                    <a:pt x="0" y="162052"/>
                  </a:lnTo>
                  <a:close/>
                </a:path>
              </a:pathLst>
            </a:custGeom>
            <a:solidFill>
              <a:srgbClr val="A7CBAC"/>
            </a:solidFill>
            <a:ln w="13589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64" name="Forme libre 63">
              <a:extLst>
                <a:ext uri="{FF2B5EF4-FFF2-40B4-BE49-F238E27FC236}">
                  <a16:creationId xmlns:a16="http://schemas.microsoft.com/office/drawing/2014/main" id="{ECDAA904-F6ED-2DDB-66A7-E376F52DA91C}"/>
                </a:ext>
              </a:extLst>
            </p:cNvPr>
            <p:cNvSpPr/>
            <p:nvPr/>
          </p:nvSpPr>
          <p:spPr>
            <a:xfrm>
              <a:off x="3533521" y="3247803"/>
              <a:ext cx="179959" cy="179959"/>
            </a:xfrm>
            <a:custGeom>
              <a:avLst/>
              <a:gdLst>
                <a:gd name="connsiteX0" fmla="*/ 0 w 179959"/>
                <a:gd name="connsiteY0" fmla="*/ 0 h 179959"/>
                <a:gd name="connsiteX1" fmla="*/ 179959 w 179959"/>
                <a:gd name="connsiteY1" fmla="*/ 0 h 179959"/>
                <a:gd name="connsiteX2" fmla="*/ 179959 w 179959"/>
                <a:gd name="connsiteY2" fmla="*/ 179959 h 179959"/>
                <a:gd name="connsiteX3" fmla="*/ 0 w 179959"/>
                <a:gd name="connsiteY3" fmla="*/ 179959 h 1799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9959" h="179959">
                  <a:moveTo>
                    <a:pt x="0" y="0"/>
                  </a:moveTo>
                  <a:lnTo>
                    <a:pt x="179959" y="0"/>
                  </a:lnTo>
                  <a:lnTo>
                    <a:pt x="179959" y="179959"/>
                  </a:lnTo>
                  <a:lnTo>
                    <a:pt x="0" y="179959"/>
                  </a:lnTo>
                  <a:close/>
                </a:path>
              </a:pathLst>
            </a:custGeom>
            <a:solidFill>
              <a:srgbClr val="FFFFFF"/>
            </a:solidFill>
            <a:ln w="13589" cap="rnd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65" name="Forme libre 64">
              <a:extLst>
                <a:ext uri="{FF2B5EF4-FFF2-40B4-BE49-F238E27FC236}">
                  <a16:creationId xmlns:a16="http://schemas.microsoft.com/office/drawing/2014/main" id="{01E5B731-BBEC-2E70-D1BD-72CCFBCE149B}"/>
                </a:ext>
              </a:extLst>
            </p:cNvPr>
            <p:cNvSpPr/>
            <p:nvPr/>
          </p:nvSpPr>
          <p:spPr>
            <a:xfrm>
              <a:off x="3542538" y="3256820"/>
              <a:ext cx="162051" cy="162051"/>
            </a:xfrm>
            <a:custGeom>
              <a:avLst/>
              <a:gdLst>
                <a:gd name="connsiteX0" fmla="*/ 0 w 162051"/>
                <a:gd name="connsiteY0" fmla="*/ 0 h 162051"/>
                <a:gd name="connsiteX1" fmla="*/ 162052 w 162051"/>
                <a:gd name="connsiteY1" fmla="*/ 0 h 162051"/>
                <a:gd name="connsiteX2" fmla="*/ 162052 w 162051"/>
                <a:gd name="connsiteY2" fmla="*/ 162052 h 162051"/>
                <a:gd name="connsiteX3" fmla="*/ 0 w 162051"/>
                <a:gd name="connsiteY3" fmla="*/ 162052 h 162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2051" h="162051">
                  <a:moveTo>
                    <a:pt x="0" y="0"/>
                  </a:moveTo>
                  <a:lnTo>
                    <a:pt x="162052" y="0"/>
                  </a:lnTo>
                  <a:lnTo>
                    <a:pt x="162052" y="162052"/>
                  </a:lnTo>
                  <a:lnTo>
                    <a:pt x="0" y="162052"/>
                  </a:lnTo>
                  <a:close/>
                </a:path>
              </a:pathLst>
            </a:custGeom>
            <a:solidFill>
              <a:srgbClr val="E0999E"/>
            </a:solidFill>
            <a:ln w="13589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80C372EB-6F80-C10D-988D-313398C132B4}"/>
                </a:ext>
              </a:extLst>
            </p:cNvPr>
            <p:cNvSpPr txBox="1"/>
            <p:nvPr/>
          </p:nvSpPr>
          <p:spPr>
            <a:xfrm>
              <a:off x="2880398" y="3221228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00" b="1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Correct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5616C947-FBB2-8CDD-DA2B-E4683B2FC24A}"/>
                </a:ext>
              </a:extLst>
            </p:cNvPr>
            <p:cNvSpPr txBox="1"/>
            <p:nvPr/>
          </p:nvSpPr>
          <p:spPr>
            <a:xfrm>
              <a:off x="3713480" y="3213088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00" b="1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Incorrect</a:t>
              </a: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3A939233-088B-67F1-29C5-A56A5EB80CC3}"/>
              </a:ext>
            </a:extLst>
          </p:cNvPr>
          <p:cNvSpPr txBox="1"/>
          <p:nvPr/>
        </p:nvSpPr>
        <p:spPr>
          <a:xfrm>
            <a:off x="1577373" y="7430508"/>
            <a:ext cx="3970369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Percentage of children respecting three of the properties of sinusoids and zigzags varying in amplitude.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ach stream represents a separate group of children. Green rectangles refer to correct responses, whereas read ones refer to wrong responses. 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57738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668F16E3-FD47-9EE9-E183-0BB9A1EFBDCA}"/>
              </a:ext>
            </a:extLst>
          </p:cNvPr>
          <p:cNvSpPr txBox="1"/>
          <p:nvPr/>
        </p:nvSpPr>
        <p:spPr>
          <a:xfrm>
            <a:off x="2504073" y="839114"/>
            <a:ext cx="99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5-year-olds</a:t>
            </a:r>
          </a:p>
        </p:txBody>
      </p:sp>
      <p:sp>
        <p:nvSpPr>
          <p:cNvPr id="5" name="CasellaDiTesto 3">
            <a:extLst>
              <a:ext uri="{FF2B5EF4-FFF2-40B4-BE49-F238E27FC236}">
                <a16:creationId xmlns:a16="http://schemas.microsoft.com/office/drawing/2014/main" id="{1F62AA37-6C82-FABB-9E71-872DDDC25C2D}"/>
              </a:ext>
            </a:extLst>
          </p:cNvPr>
          <p:cNvSpPr txBox="1"/>
          <p:nvPr/>
        </p:nvSpPr>
        <p:spPr>
          <a:xfrm>
            <a:off x="39161" y="2452466"/>
            <a:ext cx="16877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Stairs</a:t>
            </a:r>
            <a:r>
              <a:rPr lang="fr-FR" sz="1200" b="1" dirty="0"/>
              <a:t> </a:t>
            </a:r>
            <a:r>
              <a:rPr lang="fr-FR" sz="1200" b="1" dirty="0" err="1"/>
              <a:t>with</a:t>
            </a:r>
            <a:r>
              <a:rPr lang="fr-FR" sz="1200" b="1" dirty="0"/>
              <a:t> </a:t>
            </a:r>
            <a:r>
              <a:rPr lang="fr-FR" sz="1200" b="1" dirty="0" err="1"/>
              <a:t>increasing</a:t>
            </a:r>
            <a:r>
              <a:rPr lang="fr-FR" sz="1200" b="1" dirty="0"/>
              <a:t> amplitude and </a:t>
            </a:r>
            <a:r>
              <a:rPr lang="fr-FR" sz="1200" b="1" dirty="0" err="1"/>
              <a:t>decreasing</a:t>
            </a:r>
            <a:r>
              <a:rPr lang="fr-FR" sz="1200" b="1" dirty="0"/>
              <a:t> </a:t>
            </a:r>
            <a:r>
              <a:rPr lang="fr-FR" sz="1200" b="1" dirty="0" err="1"/>
              <a:t>frequency</a:t>
            </a:r>
            <a:endParaRPr lang="fr-FR" sz="1200" b="1" dirty="0"/>
          </a:p>
        </p:txBody>
      </p:sp>
      <p:sp>
        <p:nvSpPr>
          <p:cNvPr id="6" name="CasellaDiTesto 6">
            <a:extLst>
              <a:ext uri="{FF2B5EF4-FFF2-40B4-BE49-F238E27FC236}">
                <a16:creationId xmlns:a16="http://schemas.microsoft.com/office/drawing/2014/main" id="{47AD8BB6-A896-FEAF-C81B-5CAA04DED346}"/>
              </a:ext>
            </a:extLst>
          </p:cNvPr>
          <p:cNvSpPr txBox="1"/>
          <p:nvPr/>
        </p:nvSpPr>
        <p:spPr>
          <a:xfrm>
            <a:off x="37041" y="3430911"/>
            <a:ext cx="16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Stairs</a:t>
            </a:r>
            <a:r>
              <a:rPr lang="fr-FR" sz="1200" b="1" dirty="0"/>
              <a:t> </a:t>
            </a:r>
            <a:r>
              <a:rPr lang="fr-FR" sz="1200" b="1" dirty="0" err="1"/>
              <a:t>with</a:t>
            </a:r>
            <a:r>
              <a:rPr lang="fr-FR" sz="1200" b="1" dirty="0"/>
              <a:t> </a:t>
            </a:r>
            <a:r>
              <a:rPr lang="fr-FR" sz="1200" b="1" dirty="0" err="1"/>
              <a:t>increasing</a:t>
            </a:r>
            <a:r>
              <a:rPr lang="fr-FR" sz="1200" b="1" dirty="0"/>
              <a:t> amplitude and </a:t>
            </a:r>
            <a:r>
              <a:rPr lang="fr-FR" sz="1200" b="1" dirty="0" err="1"/>
              <a:t>decreasing</a:t>
            </a:r>
            <a:r>
              <a:rPr lang="fr-FR" sz="1200" b="1" dirty="0"/>
              <a:t> </a:t>
            </a:r>
            <a:r>
              <a:rPr lang="fr-FR" sz="1200" b="1" dirty="0" err="1"/>
              <a:t>frequency</a:t>
            </a:r>
            <a:endParaRPr lang="fr-FR" sz="1200" b="1" dirty="0"/>
          </a:p>
        </p:txBody>
      </p:sp>
      <p:sp>
        <p:nvSpPr>
          <p:cNvPr id="7" name="ZoneTexte 1">
            <a:extLst>
              <a:ext uri="{FF2B5EF4-FFF2-40B4-BE49-F238E27FC236}">
                <a16:creationId xmlns:a16="http://schemas.microsoft.com/office/drawing/2014/main" id="{2B38F98C-C577-FAD8-6526-D492FC97B8A8}"/>
              </a:ext>
            </a:extLst>
          </p:cNvPr>
          <p:cNvSpPr txBox="1"/>
          <p:nvPr/>
        </p:nvSpPr>
        <p:spPr>
          <a:xfrm>
            <a:off x="4779580" y="839115"/>
            <a:ext cx="99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6-year-olds</a:t>
            </a:r>
          </a:p>
        </p:txBody>
      </p:sp>
      <p:sp>
        <p:nvSpPr>
          <p:cNvPr id="8" name="CasellaDiTesto 3">
            <a:extLst>
              <a:ext uri="{FF2B5EF4-FFF2-40B4-BE49-F238E27FC236}">
                <a16:creationId xmlns:a16="http://schemas.microsoft.com/office/drawing/2014/main" id="{BF61390B-4268-947D-5B6D-A334FE924C61}"/>
              </a:ext>
            </a:extLst>
          </p:cNvPr>
          <p:cNvSpPr txBox="1"/>
          <p:nvPr/>
        </p:nvSpPr>
        <p:spPr>
          <a:xfrm>
            <a:off x="615244" y="1663992"/>
            <a:ext cx="535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err="1"/>
              <a:t>Stairs</a:t>
            </a:r>
            <a:endParaRPr lang="fr-FR" sz="1200" b="1" dirty="0"/>
          </a:p>
        </p:txBody>
      </p:sp>
      <p:pic>
        <p:nvPicPr>
          <p:cNvPr id="9" name="Image 8" descr="Une image contenant capture d’écran, obscurité, art&#10;&#10;Description générée automatiquement">
            <a:extLst>
              <a:ext uri="{FF2B5EF4-FFF2-40B4-BE49-F238E27FC236}">
                <a16:creationId xmlns:a16="http://schemas.microsoft.com/office/drawing/2014/main" id="{0ABB6175-1C68-4162-5A48-20E50F46D0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5600" y="2325632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0" name="Image 9" descr="Une image contenant capture d’écran, obscurité, art, léger&#10;&#10;Description générée automatiquement">
            <a:extLst>
              <a:ext uri="{FF2B5EF4-FFF2-40B4-BE49-F238E27FC236}">
                <a16:creationId xmlns:a16="http://schemas.microsoft.com/office/drawing/2014/main" id="{BA1B0397-A262-0C4A-EDB3-940311EB5B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5600" y="2325632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1" name="Image 10" descr="Une image contenant capture d’écran, Graphique, graphisme, art&#10;&#10;Description générée automatiquement">
            <a:extLst>
              <a:ext uri="{FF2B5EF4-FFF2-40B4-BE49-F238E27FC236}">
                <a16:creationId xmlns:a16="http://schemas.microsoft.com/office/drawing/2014/main" id="{C48DC3FA-7CFF-DBD6-0104-A00CE7F62E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5600" y="3304077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F4090919-A79E-DC12-A1CE-EE174029F8D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55600" y="1347187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15CA2AC1-7596-66FC-3EB1-03AC05F528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45600" y="1352492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4" name="Image 13" descr="Une image contenant capture d’écran, Caractère coloré, art&#10;&#10;Description générée automatiquement">
            <a:extLst>
              <a:ext uri="{FF2B5EF4-FFF2-40B4-BE49-F238E27FC236}">
                <a16:creationId xmlns:a16="http://schemas.microsoft.com/office/drawing/2014/main" id="{08233E6D-8D99-D1F9-0EB6-60A04CA976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45600" y="3304077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92EB1D10-5868-7DE3-D8EA-FB698B660CC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52192" y="2325632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6" name="Image 15" descr="Une image contenant capture d’écran, obscurité, art&#10;&#10;Description générée automatiquement">
            <a:extLst>
              <a:ext uri="{FF2B5EF4-FFF2-40B4-BE49-F238E27FC236}">
                <a16:creationId xmlns:a16="http://schemas.microsoft.com/office/drawing/2014/main" id="{C769EB1F-B0E6-B78A-A12F-F51B915E0FF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32480" y="2325632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3EE01C79-9393-8EF6-2F32-310819F54AB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32480" y="3304077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8" name="Image 17" descr="Une image contenant capture d’écran, art&#10;&#10;Description générée automatiquement">
            <a:extLst>
              <a:ext uri="{FF2B5EF4-FFF2-40B4-BE49-F238E27FC236}">
                <a16:creationId xmlns:a16="http://schemas.microsoft.com/office/drawing/2014/main" id="{B4EBABFF-45C6-3D2E-ECBC-E54EF9A9322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32480" y="134427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9" name="Image 18" descr="Une image contenant capture d’écran, Graphique, obscurité, art&#10;&#10;Description générée automatiquement">
            <a:extLst>
              <a:ext uri="{FF2B5EF4-FFF2-40B4-BE49-F238E27FC236}">
                <a16:creationId xmlns:a16="http://schemas.microsoft.com/office/drawing/2014/main" id="{5126AEA0-C94B-F89C-18A6-06DD4C014ED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22480" y="134427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0" name="Image 19" descr="Une image contenant capture d’écran, obscurité, Caractère coloré, léger&#10;&#10;Description générée automatiquement">
            <a:extLst>
              <a:ext uri="{FF2B5EF4-FFF2-40B4-BE49-F238E27FC236}">
                <a16:creationId xmlns:a16="http://schemas.microsoft.com/office/drawing/2014/main" id="{3C91EEFD-3FC0-37FF-3418-6EE7EF7296F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352192" y="3304077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94EE5BF9-9F97-EB76-EC0C-09F2EFCAE451}"/>
              </a:ext>
            </a:extLst>
          </p:cNvPr>
          <p:cNvSpPr txBox="1"/>
          <p:nvPr/>
        </p:nvSpPr>
        <p:spPr>
          <a:xfrm>
            <a:off x="1831823" y="4828202"/>
            <a:ext cx="3970369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Prolongations of staircase patterns.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Each image presents all individual children’s drawings superposed one on each other, separately for the two age groups.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62877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46BF7883-5E4B-BB8F-FB4F-9DCA41165C0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522" t="23722" b="42740"/>
          <a:stretch/>
        </p:blipFill>
        <p:spPr>
          <a:xfrm>
            <a:off x="1509391" y="1566390"/>
            <a:ext cx="4563434" cy="2115149"/>
          </a:xfrm>
          <a:prstGeom prst="rect">
            <a:avLst/>
          </a:prstGeom>
        </p:spPr>
      </p:pic>
      <p:grpSp>
        <p:nvGrpSpPr>
          <p:cNvPr id="3" name="Groupe 2">
            <a:extLst>
              <a:ext uri="{FF2B5EF4-FFF2-40B4-BE49-F238E27FC236}">
                <a16:creationId xmlns:a16="http://schemas.microsoft.com/office/drawing/2014/main" id="{76E66A2E-030D-2315-8CC6-963CF06D912A}"/>
              </a:ext>
            </a:extLst>
          </p:cNvPr>
          <p:cNvGrpSpPr/>
          <p:nvPr/>
        </p:nvGrpSpPr>
        <p:grpSpPr>
          <a:xfrm>
            <a:off x="5732660" y="3107761"/>
            <a:ext cx="998238" cy="246221"/>
            <a:chOff x="1903018" y="1061362"/>
            <a:chExt cx="998238" cy="246221"/>
          </a:xfrm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DA94DA08-3E87-2305-EF7C-5D9B533B1AA2}"/>
                </a:ext>
              </a:extLst>
            </p:cNvPr>
            <p:cNvSpPr/>
            <p:nvPr/>
          </p:nvSpPr>
          <p:spPr>
            <a:xfrm>
              <a:off x="1903018" y="1131875"/>
              <a:ext cx="105196" cy="105196"/>
            </a:xfrm>
            <a:prstGeom prst="rect">
              <a:avLst/>
            </a:prstGeom>
            <a:solidFill>
              <a:srgbClr val="3EA0D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B3B26220-B8AC-F630-D54A-EDB834B0F344}"/>
                </a:ext>
              </a:extLst>
            </p:cNvPr>
            <p:cNvSpPr txBox="1"/>
            <p:nvPr/>
          </p:nvSpPr>
          <p:spPr>
            <a:xfrm>
              <a:off x="1996841" y="1061362"/>
              <a:ext cx="9044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Upward</a:t>
              </a:r>
              <a:r>
                <a:rPr lang="fr-FR" sz="1000" dirty="0"/>
                <a:t> </a:t>
              </a:r>
              <a:r>
                <a:rPr lang="fr-FR" sz="1000" dirty="0" err="1"/>
                <a:t>stairs</a:t>
              </a:r>
              <a:endParaRPr lang="fr-FR" sz="1000" dirty="0"/>
            </a:p>
          </p:txBody>
        </p:sp>
      </p:grpSp>
      <p:grpSp>
        <p:nvGrpSpPr>
          <p:cNvPr id="7" name="Groupe 6">
            <a:extLst>
              <a:ext uri="{FF2B5EF4-FFF2-40B4-BE49-F238E27FC236}">
                <a16:creationId xmlns:a16="http://schemas.microsoft.com/office/drawing/2014/main" id="{14966CDD-A82A-4B2A-B088-192A4C3BE00F}"/>
              </a:ext>
            </a:extLst>
          </p:cNvPr>
          <p:cNvGrpSpPr/>
          <p:nvPr/>
        </p:nvGrpSpPr>
        <p:grpSpPr>
          <a:xfrm>
            <a:off x="5732660" y="3312733"/>
            <a:ext cx="1153729" cy="246221"/>
            <a:chOff x="3349910" y="1086014"/>
            <a:chExt cx="1153729" cy="246221"/>
          </a:xfrm>
        </p:grpSpPr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6C8F638F-0250-FA4E-63C8-A2AA8A594692}"/>
                </a:ext>
              </a:extLst>
            </p:cNvPr>
            <p:cNvSpPr/>
            <p:nvPr/>
          </p:nvSpPr>
          <p:spPr>
            <a:xfrm>
              <a:off x="3349910" y="1156526"/>
              <a:ext cx="105196" cy="105196"/>
            </a:xfrm>
            <a:prstGeom prst="rect">
              <a:avLst/>
            </a:prstGeom>
            <a:solidFill>
              <a:srgbClr val="3BBE57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B3D6D20D-9AB6-BA79-951D-D2AB193AFFCD}"/>
                </a:ext>
              </a:extLst>
            </p:cNvPr>
            <p:cNvSpPr txBox="1"/>
            <p:nvPr/>
          </p:nvSpPr>
          <p:spPr>
            <a:xfrm>
              <a:off x="3443733" y="1086014"/>
              <a:ext cx="1059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Downward</a:t>
              </a:r>
              <a:r>
                <a:rPr lang="fr-FR" sz="1000" dirty="0"/>
                <a:t> </a:t>
              </a:r>
              <a:r>
                <a:rPr lang="fr-FR" sz="1000" dirty="0" err="1"/>
                <a:t>stairs</a:t>
              </a:r>
              <a:endParaRPr lang="fr-FR" sz="1000" dirty="0"/>
            </a:p>
          </p:txBody>
        </p:sp>
      </p:grp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FA87A034-9594-9890-128C-0D2F4545462F}"/>
              </a:ext>
            </a:extLst>
          </p:cNvPr>
          <p:cNvGrpSpPr/>
          <p:nvPr/>
        </p:nvGrpSpPr>
        <p:grpSpPr>
          <a:xfrm>
            <a:off x="4082681" y="3682589"/>
            <a:ext cx="2015037" cy="283614"/>
            <a:chOff x="892319" y="3682589"/>
            <a:chExt cx="2015037" cy="283614"/>
          </a:xfrm>
        </p:grpSpPr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60FEDAB2-649F-1CC4-D461-ED74B72F2FB3}"/>
                </a:ext>
              </a:extLst>
            </p:cNvPr>
            <p:cNvSpPr txBox="1"/>
            <p:nvPr/>
          </p:nvSpPr>
          <p:spPr>
            <a:xfrm>
              <a:off x="892319" y="3719982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err="1"/>
                <a:t>Decreasing</a:t>
              </a:r>
              <a:endParaRPr lang="fr-FR" sz="1000" dirty="0"/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8758A1A9-6CA9-E9C0-A044-26C9A4A425D7}"/>
                </a:ext>
              </a:extLst>
            </p:cNvPr>
            <p:cNvSpPr txBox="1"/>
            <p:nvPr/>
          </p:nvSpPr>
          <p:spPr>
            <a:xfrm>
              <a:off x="1573886" y="3719982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/>
                <a:t>Constant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D678BDAA-A173-263B-664F-5FCFEB24962C}"/>
                </a:ext>
              </a:extLst>
            </p:cNvPr>
            <p:cNvSpPr txBox="1"/>
            <p:nvPr/>
          </p:nvSpPr>
          <p:spPr>
            <a:xfrm>
              <a:off x="2182478" y="3719982"/>
              <a:ext cx="7248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err="1"/>
                <a:t>Increasing</a:t>
              </a:r>
              <a:endParaRPr lang="fr-FR" sz="1000" dirty="0"/>
            </a:p>
          </p:txBody>
        </p:sp>
        <p:cxnSp>
          <p:nvCxnSpPr>
            <p:cNvPr id="44" name="Connecteur droit 43">
              <a:extLst>
                <a:ext uri="{FF2B5EF4-FFF2-40B4-BE49-F238E27FC236}">
                  <a16:creationId xmlns:a16="http://schemas.microsoft.com/office/drawing/2014/main" id="{4B11EAC8-F113-77D4-C87A-D03E7FBA18C3}"/>
                </a:ext>
              </a:extLst>
            </p:cNvPr>
            <p:cNvCxnSpPr/>
            <p:nvPr/>
          </p:nvCxnSpPr>
          <p:spPr>
            <a:xfrm>
              <a:off x="1270531" y="3686955"/>
              <a:ext cx="0" cy="72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Connecteur droit 44">
              <a:extLst>
                <a:ext uri="{FF2B5EF4-FFF2-40B4-BE49-F238E27FC236}">
                  <a16:creationId xmlns:a16="http://schemas.microsoft.com/office/drawing/2014/main" id="{4F45A96F-EE4D-05CD-EE1C-FFABB49539DB}"/>
                </a:ext>
              </a:extLst>
            </p:cNvPr>
            <p:cNvCxnSpPr/>
            <p:nvPr/>
          </p:nvCxnSpPr>
          <p:spPr>
            <a:xfrm>
              <a:off x="1901911" y="3686955"/>
              <a:ext cx="0" cy="72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Connecteur droit 45">
              <a:extLst>
                <a:ext uri="{FF2B5EF4-FFF2-40B4-BE49-F238E27FC236}">
                  <a16:creationId xmlns:a16="http://schemas.microsoft.com/office/drawing/2014/main" id="{1DCB6D32-384E-1C5C-A170-839FD555891D}"/>
                </a:ext>
              </a:extLst>
            </p:cNvPr>
            <p:cNvCxnSpPr/>
            <p:nvPr/>
          </p:nvCxnSpPr>
          <p:spPr>
            <a:xfrm>
              <a:off x="2542298" y="3682589"/>
              <a:ext cx="0" cy="72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" name="Groupe 46">
            <a:extLst>
              <a:ext uri="{FF2B5EF4-FFF2-40B4-BE49-F238E27FC236}">
                <a16:creationId xmlns:a16="http://schemas.microsoft.com/office/drawing/2014/main" id="{48EBFAA6-C2EC-2146-0F59-37791884B813}"/>
              </a:ext>
            </a:extLst>
          </p:cNvPr>
          <p:cNvGrpSpPr/>
          <p:nvPr/>
        </p:nvGrpSpPr>
        <p:grpSpPr>
          <a:xfrm>
            <a:off x="1802231" y="3682589"/>
            <a:ext cx="2015037" cy="283614"/>
            <a:chOff x="892319" y="3682589"/>
            <a:chExt cx="2015037" cy="283614"/>
          </a:xfrm>
        </p:grpSpPr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A932E5F6-D1BF-AE9B-9E49-BE9D1F0210AA}"/>
                </a:ext>
              </a:extLst>
            </p:cNvPr>
            <p:cNvSpPr txBox="1"/>
            <p:nvPr/>
          </p:nvSpPr>
          <p:spPr>
            <a:xfrm>
              <a:off x="892319" y="3719982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err="1"/>
                <a:t>Decreasing</a:t>
              </a:r>
              <a:endParaRPr lang="fr-FR" sz="1000" dirty="0"/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EC71FB42-0A0D-2CDB-2B1F-899C248C97E5}"/>
                </a:ext>
              </a:extLst>
            </p:cNvPr>
            <p:cNvSpPr txBox="1"/>
            <p:nvPr/>
          </p:nvSpPr>
          <p:spPr>
            <a:xfrm>
              <a:off x="1573886" y="3719982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/>
                <a:t>Constant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A8B22364-75FA-3A9C-404F-D0D45ED7DC71}"/>
                </a:ext>
              </a:extLst>
            </p:cNvPr>
            <p:cNvSpPr txBox="1"/>
            <p:nvPr/>
          </p:nvSpPr>
          <p:spPr>
            <a:xfrm>
              <a:off x="2182478" y="3719982"/>
              <a:ext cx="7248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err="1"/>
                <a:t>Increasing</a:t>
              </a:r>
              <a:endParaRPr lang="fr-FR" sz="1000" dirty="0"/>
            </a:p>
          </p:txBody>
        </p:sp>
        <p:cxnSp>
          <p:nvCxnSpPr>
            <p:cNvPr id="51" name="Connecteur droit 50">
              <a:extLst>
                <a:ext uri="{FF2B5EF4-FFF2-40B4-BE49-F238E27FC236}">
                  <a16:creationId xmlns:a16="http://schemas.microsoft.com/office/drawing/2014/main" id="{F2C1DD62-1FC0-0284-1E8F-BAA9268F9DB0}"/>
                </a:ext>
              </a:extLst>
            </p:cNvPr>
            <p:cNvCxnSpPr/>
            <p:nvPr/>
          </p:nvCxnSpPr>
          <p:spPr>
            <a:xfrm>
              <a:off x="1270531" y="3686955"/>
              <a:ext cx="0" cy="72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Connecteur droit 51">
              <a:extLst>
                <a:ext uri="{FF2B5EF4-FFF2-40B4-BE49-F238E27FC236}">
                  <a16:creationId xmlns:a16="http://schemas.microsoft.com/office/drawing/2014/main" id="{37F302A8-5CFA-DA88-9FAD-076E06AF76C7}"/>
                </a:ext>
              </a:extLst>
            </p:cNvPr>
            <p:cNvCxnSpPr/>
            <p:nvPr/>
          </p:nvCxnSpPr>
          <p:spPr>
            <a:xfrm>
              <a:off x="1901911" y="3686955"/>
              <a:ext cx="0" cy="72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Connecteur droit 52">
              <a:extLst>
                <a:ext uri="{FF2B5EF4-FFF2-40B4-BE49-F238E27FC236}">
                  <a16:creationId xmlns:a16="http://schemas.microsoft.com/office/drawing/2014/main" id="{C8950DFE-5A27-228D-6D30-7372062DC3B5}"/>
                </a:ext>
              </a:extLst>
            </p:cNvPr>
            <p:cNvCxnSpPr/>
            <p:nvPr/>
          </p:nvCxnSpPr>
          <p:spPr>
            <a:xfrm>
              <a:off x="2542298" y="3682589"/>
              <a:ext cx="0" cy="720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Groupe 60">
            <a:extLst>
              <a:ext uri="{FF2B5EF4-FFF2-40B4-BE49-F238E27FC236}">
                <a16:creationId xmlns:a16="http://schemas.microsoft.com/office/drawing/2014/main" id="{8266E00A-5C19-6DB7-CEE4-7E707D056D2A}"/>
              </a:ext>
            </a:extLst>
          </p:cNvPr>
          <p:cNvGrpSpPr/>
          <p:nvPr/>
        </p:nvGrpSpPr>
        <p:grpSpPr>
          <a:xfrm>
            <a:off x="512753" y="1351789"/>
            <a:ext cx="1289478" cy="2076145"/>
            <a:chOff x="5142831" y="1332437"/>
            <a:chExt cx="1289478" cy="2076145"/>
          </a:xfrm>
        </p:grpSpPr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EBF24969-A615-0404-38D6-B83269755E7D}"/>
                </a:ext>
              </a:extLst>
            </p:cNvPr>
            <p:cNvGrpSpPr/>
            <p:nvPr/>
          </p:nvGrpSpPr>
          <p:grpSpPr>
            <a:xfrm>
              <a:off x="5142831" y="1873688"/>
              <a:ext cx="1289478" cy="923514"/>
              <a:chOff x="8720296" y="2466047"/>
              <a:chExt cx="2292405" cy="1641802"/>
            </a:xfrm>
          </p:grpSpPr>
          <p:sp>
            <p:nvSpPr>
              <p:cNvPr id="5" name="CasellaDiTesto 29">
                <a:extLst>
                  <a:ext uri="{FF2B5EF4-FFF2-40B4-BE49-F238E27FC236}">
                    <a16:creationId xmlns:a16="http://schemas.microsoft.com/office/drawing/2014/main" id="{B863981C-3B75-35A1-0FDC-94BFD580106A}"/>
                  </a:ext>
                </a:extLst>
              </p:cNvPr>
              <p:cNvSpPr txBox="1"/>
              <p:nvPr/>
            </p:nvSpPr>
            <p:spPr>
              <a:xfrm>
                <a:off x="8890557" y="3670123"/>
                <a:ext cx="1951884" cy="437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Decreasing</a:t>
                </a:r>
                <a:endParaRPr lang="fr-FR" sz="1000" dirty="0"/>
              </a:p>
            </p:txBody>
          </p:sp>
          <p:sp>
            <p:nvSpPr>
              <p:cNvPr id="6" name="CasellaDiTesto 30">
                <a:extLst>
                  <a:ext uri="{FF2B5EF4-FFF2-40B4-BE49-F238E27FC236}">
                    <a16:creationId xmlns:a16="http://schemas.microsoft.com/office/drawing/2014/main" id="{8F15DE58-C25C-051C-1527-14785EADE339}"/>
                  </a:ext>
                </a:extLst>
              </p:cNvPr>
              <p:cNvSpPr txBox="1"/>
              <p:nvPr/>
            </p:nvSpPr>
            <p:spPr>
              <a:xfrm>
                <a:off x="8720296" y="2466047"/>
                <a:ext cx="2292405" cy="437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Increasing</a:t>
                </a:r>
                <a:endParaRPr lang="fr-FR" sz="1000" dirty="0"/>
              </a:p>
            </p:txBody>
          </p:sp>
          <p:cxnSp>
            <p:nvCxnSpPr>
              <p:cNvPr id="9" name="Connecteur droit avec flèche 8">
                <a:extLst>
                  <a:ext uri="{FF2B5EF4-FFF2-40B4-BE49-F238E27FC236}">
                    <a16:creationId xmlns:a16="http://schemas.microsoft.com/office/drawing/2014/main" id="{7A20FF53-9B8F-0C48-61A7-F698B66C8D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66498" y="3350124"/>
                <a:ext cx="0" cy="320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cteur droit avec flèche 9">
                <a:extLst>
                  <a:ext uri="{FF2B5EF4-FFF2-40B4-BE49-F238E27FC236}">
                    <a16:creationId xmlns:a16="http://schemas.microsoft.com/office/drawing/2014/main" id="{88F540AD-802F-F3D7-D128-5BBDAB82CAC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866498" y="2965798"/>
                <a:ext cx="0" cy="320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>
              <a:extLst>
                <a:ext uri="{FF2B5EF4-FFF2-40B4-BE49-F238E27FC236}">
                  <a16:creationId xmlns:a16="http://schemas.microsoft.com/office/drawing/2014/main" id="{CACE6A71-7B41-CDA4-BD55-FBF974C69D98}"/>
                </a:ext>
              </a:extLst>
            </p:cNvPr>
            <p:cNvGrpSpPr/>
            <p:nvPr/>
          </p:nvGrpSpPr>
          <p:grpSpPr>
            <a:xfrm rot="5400000" flipH="1">
              <a:off x="5581355" y="1323620"/>
              <a:ext cx="484934" cy="502568"/>
              <a:chOff x="5469467" y="1266277"/>
              <a:chExt cx="484934" cy="502568"/>
            </a:xfrm>
          </p:grpSpPr>
          <p:cxnSp>
            <p:nvCxnSpPr>
              <p:cNvPr id="33" name="Connecteur droit 32">
                <a:extLst>
                  <a:ext uri="{FF2B5EF4-FFF2-40B4-BE49-F238E27FC236}">
                    <a16:creationId xmlns:a16="http://schemas.microsoft.com/office/drawing/2014/main" id="{A750CB64-DA10-50A6-0F11-5770ACB9A980}"/>
                  </a:ext>
                </a:extLst>
              </p:cNvPr>
              <p:cNvCxnSpPr/>
              <p:nvPr/>
            </p:nvCxnSpPr>
            <p:spPr>
              <a:xfrm>
                <a:off x="5469467" y="1766711"/>
                <a:ext cx="7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33">
                <a:extLst>
                  <a:ext uri="{FF2B5EF4-FFF2-40B4-BE49-F238E27FC236}">
                    <a16:creationId xmlns:a16="http://schemas.microsoft.com/office/drawing/2014/main" id="{14EED315-76E4-934D-18D6-9AB02765D5E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497689" y="1732845"/>
                <a:ext cx="7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34">
                <a:extLst>
                  <a:ext uri="{FF2B5EF4-FFF2-40B4-BE49-F238E27FC236}">
                    <a16:creationId xmlns:a16="http://schemas.microsoft.com/office/drawing/2014/main" id="{80851DE2-8FFE-2BA3-8098-17B5DBE0A23B}"/>
                  </a:ext>
                </a:extLst>
              </p:cNvPr>
              <p:cNvCxnSpPr/>
              <p:nvPr/>
            </p:nvCxnSpPr>
            <p:spPr>
              <a:xfrm>
                <a:off x="5528045" y="1696845"/>
                <a:ext cx="144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Connecteur droit 35">
                <a:extLst>
                  <a:ext uri="{FF2B5EF4-FFF2-40B4-BE49-F238E27FC236}">
                    <a16:creationId xmlns:a16="http://schemas.microsoft.com/office/drawing/2014/main" id="{AB7B3508-38C8-8D97-20A9-8EFEE8729BB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594401" y="1624845"/>
                <a:ext cx="144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>
                <a:extLst>
                  <a:ext uri="{FF2B5EF4-FFF2-40B4-BE49-F238E27FC236}">
                    <a16:creationId xmlns:a16="http://schemas.microsoft.com/office/drawing/2014/main" id="{C65B182B-796F-ACA4-4CBE-A56D180D5692}"/>
                  </a:ext>
                </a:extLst>
              </p:cNvPr>
              <p:cNvCxnSpPr/>
              <p:nvPr/>
            </p:nvCxnSpPr>
            <p:spPr>
              <a:xfrm>
                <a:off x="5666401" y="1552845"/>
                <a:ext cx="288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Connecteur droit 37">
                <a:extLst>
                  <a:ext uri="{FF2B5EF4-FFF2-40B4-BE49-F238E27FC236}">
                    <a16:creationId xmlns:a16="http://schemas.microsoft.com/office/drawing/2014/main" id="{1623FA07-472A-0ED7-E725-4DE2AA05B6E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810401" y="1410277"/>
                <a:ext cx="288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Groupe 53">
              <a:extLst>
                <a:ext uri="{FF2B5EF4-FFF2-40B4-BE49-F238E27FC236}">
                  <a16:creationId xmlns:a16="http://schemas.microsoft.com/office/drawing/2014/main" id="{44F6CF7E-4F95-4E81-76F5-54B0B05733AF}"/>
                </a:ext>
              </a:extLst>
            </p:cNvPr>
            <p:cNvGrpSpPr/>
            <p:nvPr/>
          </p:nvGrpSpPr>
          <p:grpSpPr>
            <a:xfrm rot="5400000" flipV="1">
              <a:off x="5570993" y="2914831"/>
              <a:ext cx="484934" cy="502568"/>
              <a:chOff x="5469467" y="1266277"/>
              <a:chExt cx="484934" cy="502568"/>
            </a:xfrm>
          </p:grpSpPr>
          <p:cxnSp>
            <p:nvCxnSpPr>
              <p:cNvPr id="55" name="Connecteur droit 54">
                <a:extLst>
                  <a:ext uri="{FF2B5EF4-FFF2-40B4-BE49-F238E27FC236}">
                    <a16:creationId xmlns:a16="http://schemas.microsoft.com/office/drawing/2014/main" id="{E4BD69C2-AB3C-0C9E-A8A1-88B3E409A717}"/>
                  </a:ext>
                </a:extLst>
              </p:cNvPr>
              <p:cNvCxnSpPr/>
              <p:nvPr/>
            </p:nvCxnSpPr>
            <p:spPr>
              <a:xfrm>
                <a:off x="5469467" y="1766711"/>
                <a:ext cx="7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>
                <a:extLst>
                  <a:ext uri="{FF2B5EF4-FFF2-40B4-BE49-F238E27FC236}">
                    <a16:creationId xmlns:a16="http://schemas.microsoft.com/office/drawing/2014/main" id="{66BC5A3B-A7B9-F58E-8415-3D778D92281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497689" y="1732845"/>
                <a:ext cx="7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>
                <a:extLst>
                  <a:ext uri="{FF2B5EF4-FFF2-40B4-BE49-F238E27FC236}">
                    <a16:creationId xmlns:a16="http://schemas.microsoft.com/office/drawing/2014/main" id="{992E2371-B8DB-555C-16CC-564C406020FE}"/>
                  </a:ext>
                </a:extLst>
              </p:cNvPr>
              <p:cNvCxnSpPr/>
              <p:nvPr/>
            </p:nvCxnSpPr>
            <p:spPr>
              <a:xfrm>
                <a:off x="5528045" y="1696845"/>
                <a:ext cx="144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>
                <a:extLst>
                  <a:ext uri="{FF2B5EF4-FFF2-40B4-BE49-F238E27FC236}">
                    <a16:creationId xmlns:a16="http://schemas.microsoft.com/office/drawing/2014/main" id="{2ADE2D63-9479-4749-FB79-E00AC884EE6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594401" y="1624845"/>
                <a:ext cx="144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>
                <a:extLst>
                  <a:ext uri="{FF2B5EF4-FFF2-40B4-BE49-F238E27FC236}">
                    <a16:creationId xmlns:a16="http://schemas.microsoft.com/office/drawing/2014/main" id="{08671D4D-C197-166E-2746-1211DAD77BDE}"/>
                  </a:ext>
                </a:extLst>
              </p:cNvPr>
              <p:cNvCxnSpPr/>
              <p:nvPr/>
            </p:nvCxnSpPr>
            <p:spPr>
              <a:xfrm>
                <a:off x="5666401" y="1552845"/>
                <a:ext cx="288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>
                <a:extLst>
                  <a:ext uri="{FF2B5EF4-FFF2-40B4-BE49-F238E27FC236}">
                    <a16:creationId xmlns:a16="http://schemas.microsoft.com/office/drawing/2014/main" id="{8372BA00-B6D4-5AB7-AD17-DDBE13A9468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810401" y="1410277"/>
                <a:ext cx="288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3" name="ZoneTexte 12">
            <a:extLst>
              <a:ext uri="{FF2B5EF4-FFF2-40B4-BE49-F238E27FC236}">
                <a16:creationId xmlns:a16="http://schemas.microsoft.com/office/drawing/2014/main" id="{A049D4E7-D983-1763-0481-C00482EBF882}"/>
              </a:ext>
            </a:extLst>
          </p:cNvPr>
          <p:cNvSpPr txBox="1"/>
          <p:nvPr/>
        </p:nvSpPr>
        <p:spPr>
          <a:xfrm>
            <a:off x="2906246" y="3957774"/>
            <a:ext cx="1972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/>
              <a:t>Amplitude change in the stimulus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3393A5A-DEC6-EBC1-8028-F72AE58F76C9}"/>
              </a:ext>
            </a:extLst>
          </p:cNvPr>
          <p:cNvSpPr txBox="1"/>
          <p:nvPr/>
        </p:nvSpPr>
        <p:spPr>
          <a:xfrm>
            <a:off x="652141" y="833629"/>
            <a:ext cx="13920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/>
              <a:t>Amplitude change </a:t>
            </a:r>
          </a:p>
          <a:p>
            <a:pPr algn="ctr"/>
            <a:r>
              <a:rPr lang="fr-FR" sz="1000" b="1" dirty="0"/>
              <a:t>in the </a:t>
            </a:r>
            <a:r>
              <a:rPr lang="fr-FR" sz="1000" b="1" dirty="0" err="1"/>
              <a:t>child’s</a:t>
            </a:r>
            <a:r>
              <a:rPr lang="fr-FR" sz="1000" b="1" dirty="0"/>
              <a:t> </a:t>
            </a:r>
            <a:r>
              <a:rPr lang="fr-FR" sz="1000" b="1" dirty="0" err="1"/>
              <a:t>response</a:t>
            </a:r>
            <a:endParaRPr lang="fr-FR" sz="1000" b="1" dirty="0"/>
          </a:p>
        </p:txBody>
      </p:sp>
      <p:sp>
        <p:nvSpPr>
          <p:cNvPr id="12" name="ZoneTexte 3">
            <a:extLst>
              <a:ext uri="{FF2B5EF4-FFF2-40B4-BE49-F238E27FC236}">
                <a16:creationId xmlns:a16="http://schemas.microsoft.com/office/drawing/2014/main" id="{7F6877EB-F53F-1547-F159-E5FBA81CAC8E}"/>
              </a:ext>
            </a:extLst>
          </p:cNvPr>
          <p:cNvSpPr txBox="1"/>
          <p:nvPr/>
        </p:nvSpPr>
        <p:spPr>
          <a:xfrm>
            <a:off x="5605532" y="2867259"/>
            <a:ext cx="9893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/>
              <a:t>Stimulus type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7C1363F-C521-5450-DDCC-850709D48FCE}"/>
              </a:ext>
            </a:extLst>
          </p:cNvPr>
          <p:cNvSpPr txBox="1"/>
          <p:nvPr/>
        </p:nvSpPr>
        <p:spPr>
          <a:xfrm>
            <a:off x="1759897" y="4770341"/>
            <a:ext cx="3970369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Amplitude change as a function of staircase patterns.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The amplitude change (given by the difference in slope between the line of the drawn maxima and the line of the drawn minima) is plotted for each pattern on the x axis and for each age group. A positive change means the drawn pattern increased in amplitude, a negative change means it decreased, a change close to zero means it remained constant.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092911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E4BEE180-B34E-2D89-C771-AE66F303C014}"/>
              </a:ext>
            </a:extLst>
          </p:cNvPr>
          <p:cNvSpPr txBox="1"/>
          <p:nvPr/>
        </p:nvSpPr>
        <p:spPr>
          <a:xfrm>
            <a:off x="1302159" y="766972"/>
            <a:ext cx="99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5-year-olds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B6F2A070-AF14-9678-80ED-DE3A1F34C4D6}"/>
              </a:ext>
            </a:extLst>
          </p:cNvPr>
          <p:cNvSpPr txBox="1"/>
          <p:nvPr/>
        </p:nvSpPr>
        <p:spPr>
          <a:xfrm>
            <a:off x="175508" y="2507001"/>
            <a:ext cx="7984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Spiral out</a:t>
            </a:r>
          </a:p>
        </p:txBody>
      </p:sp>
      <p:sp>
        <p:nvSpPr>
          <p:cNvPr id="5" name="CasellaDiTesto 6">
            <a:extLst>
              <a:ext uri="{FF2B5EF4-FFF2-40B4-BE49-F238E27FC236}">
                <a16:creationId xmlns:a16="http://schemas.microsoft.com/office/drawing/2014/main" id="{6AFBEE0A-BBEA-AC03-9319-A84C779E502D}"/>
              </a:ext>
            </a:extLst>
          </p:cNvPr>
          <p:cNvSpPr txBox="1"/>
          <p:nvPr/>
        </p:nvSpPr>
        <p:spPr>
          <a:xfrm>
            <a:off x="306345" y="3497613"/>
            <a:ext cx="536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Circle</a:t>
            </a:r>
          </a:p>
        </p:txBody>
      </p:sp>
      <p:sp>
        <p:nvSpPr>
          <p:cNvPr id="6" name="ZoneTexte 1">
            <a:extLst>
              <a:ext uri="{FF2B5EF4-FFF2-40B4-BE49-F238E27FC236}">
                <a16:creationId xmlns:a16="http://schemas.microsoft.com/office/drawing/2014/main" id="{E976C7F1-6A09-176D-05B6-37B200CEFF4D}"/>
              </a:ext>
            </a:extLst>
          </p:cNvPr>
          <p:cNvSpPr txBox="1"/>
          <p:nvPr/>
        </p:nvSpPr>
        <p:spPr>
          <a:xfrm>
            <a:off x="2501679" y="768642"/>
            <a:ext cx="99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6-year-olds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34E2A3E-F691-8414-FF2E-4177B0C1446C}"/>
              </a:ext>
            </a:extLst>
          </p:cNvPr>
          <p:cNvSpPr txBox="1"/>
          <p:nvPr/>
        </p:nvSpPr>
        <p:spPr>
          <a:xfrm>
            <a:off x="260435" y="4487613"/>
            <a:ext cx="628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Square</a:t>
            </a:r>
          </a:p>
        </p:txBody>
      </p:sp>
      <p:sp>
        <p:nvSpPr>
          <p:cNvPr id="8" name="CasellaDiTesto 3">
            <a:extLst>
              <a:ext uri="{FF2B5EF4-FFF2-40B4-BE49-F238E27FC236}">
                <a16:creationId xmlns:a16="http://schemas.microsoft.com/office/drawing/2014/main" id="{7A76F357-A03D-A3E4-ABF1-D92C7145D6F5}"/>
              </a:ext>
            </a:extLst>
          </p:cNvPr>
          <p:cNvSpPr txBox="1"/>
          <p:nvPr/>
        </p:nvSpPr>
        <p:spPr>
          <a:xfrm>
            <a:off x="224401" y="1517613"/>
            <a:ext cx="700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Spiral in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429D416E-A061-C46C-231C-370FFDE9FC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0000" y="318611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1665FE89-529D-87B0-BD7D-0343A1586F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0000" y="120611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E45C931E-C110-F344-D667-832C9E3963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21668" y="417611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B84F9CDE-EB0B-D86F-9165-920269E911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50000" y="219611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3" name="Image 12" descr="Une image contenant Ambré, Caractère coloré, obscurité, art&#10;&#10;Description générée automatiquement">
            <a:extLst>
              <a:ext uri="{FF2B5EF4-FFF2-40B4-BE49-F238E27FC236}">
                <a16:creationId xmlns:a16="http://schemas.microsoft.com/office/drawing/2014/main" id="{63E55EC9-D2C9-2D28-7EEB-F46466AF3A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49520" y="3191084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4" name="Image 13" descr="Une image contenant Ambré, feu, léger&#10;&#10;Description générée automatiquement">
            <a:extLst>
              <a:ext uri="{FF2B5EF4-FFF2-40B4-BE49-F238E27FC236}">
                <a16:creationId xmlns:a16="http://schemas.microsoft.com/office/drawing/2014/main" id="{4AB109C8-349D-9E5B-4849-5D6FAFA493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49520" y="120611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5" name="Image 14" descr="Une image contenant art, Caractère coloré, rouge, capture d’écran&#10;&#10;Description générée automatiquement">
            <a:extLst>
              <a:ext uri="{FF2B5EF4-FFF2-40B4-BE49-F238E27FC236}">
                <a16:creationId xmlns:a16="http://schemas.microsoft.com/office/drawing/2014/main" id="{274BA5B1-05D6-9BD0-9EAF-CE2E70FD866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49520" y="4186055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6" name="Image 15" descr="Une image contenant vortex, Caractère coloré, art, Art fractal&#10;&#10;Description générée automatiquement">
            <a:extLst>
              <a:ext uri="{FF2B5EF4-FFF2-40B4-BE49-F238E27FC236}">
                <a16:creationId xmlns:a16="http://schemas.microsoft.com/office/drawing/2014/main" id="{E2A0084C-1B52-DDF6-852B-D3891893EE1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49520" y="2196113"/>
            <a:ext cx="900000" cy="90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444C4D0F-F404-9092-6FF5-7C5F64C47C69}"/>
              </a:ext>
            </a:extLst>
          </p:cNvPr>
          <p:cNvSpPr txBox="1"/>
          <p:nvPr/>
        </p:nvSpPr>
        <p:spPr>
          <a:xfrm>
            <a:off x="312655" y="5717531"/>
            <a:ext cx="3970369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Prolongations of geometric shapes. </a:t>
            </a:r>
            <a:r>
              <a:rPr lang="en-US" sz="1100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image presents all individual children’s drawings superposed one on each other, separately for the two age groups.</a:t>
            </a:r>
            <a:endParaRPr lang="it-FR" sz="1100" kern="15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66814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 descr="Une image contenant croquis, conception&#10;&#10;Description générée automatiquement">
            <a:extLst>
              <a:ext uri="{FF2B5EF4-FFF2-40B4-BE49-F238E27FC236}">
                <a16:creationId xmlns:a16="http://schemas.microsoft.com/office/drawing/2014/main" id="{48D3E98B-FCA9-C984-846C-1E5B12A51C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4446480">
            <a:off x="1407374" y="3240521"/>
            <a:ext cx="783179" cy="783179"/>
          </a:xfrm>
          <a:prstGeom prst="rect">
            <a:avLst/>
          </a:prstGeom>
        </p:spPr>
      </p:pic>
      <p:pic>
        <p:nvPicPr>
          <p:cNvPr id="12" name="Image 11" descr="Une image contenant croquis, cercle, dessin, conception&#10;&#10;Description générée automatiquement">
            <a:extLst>
              <a:ext uri="{FF2B5EF4-FFF2-40B4-BE49-F238E27FC236}">
                <a16:creationId xmlns:a16="http://schemas.microsoft.com/office/drawing/2014/main" id="{7292CAA3-8080-7EAC-2E77-D4ED86F70C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0312" y="2491149"/>
            <a:ext cx="637302" cy="637302"/>
          </a:xfrm>
          <a:prstGeom prst="rect">
            <a:avLst/>
          </a:prstGeom>
        </p:spPr>
      </p:pic>
      <p:pic>
        <p:nvPicPr>
          <p:cNvPr id="13" name="Image 12" descr="Une image contenant cercle, croquis, conception&#10;&#10;Description générée automatiquement">
            <a:extLst>
              <a:ext uri="{FF2B5EF4-FFF2-40B4-BE49-F238E27FC236}">
                <a16:creationId xmlns:a16="http://schemas.microsoft.com/office/drawing/2014/main" id="{2101B5B6-55D3-0217-7FBC-0E246051F8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03351">
            <a:off x="1307168" y="1591769"/>
            <a:ext cx="983591" cy="983591"/>
          </a:xfrm>
          <a:prstGeom prst="rect">
            <a:avLst/>
          </a:prstGeom>
        </p:spPr>
      </p:pic>
      <p:grpSp>
        <p:nvGrpSpPr>
          <p:cNvPr id="14" name="Groupe 13">
            <a:extLst>
              <a:ext uri="{FF2B5EF4-FFF2-40B4-BE49-F238E27FC236}">
                <a16:creationId xmlns:a16="http://schemas.microsoft.com/office/drawing/2014/main" id="{0A624DB1-45F6-C3E5-1690-017B8BC2B7CE}"/>
              </a:ext>
            </a:extLst>
          </p:cNvPr>
          <p:cNvGrpSpPr/>
          <p:nvPr/>
        </p:nvGrpSpPr>
        <p:grpSpPr>
          <a:xfrm>
            <a:off x="1406563" y="4094320"/>
            <a:ext cx="784800" cy="784800"/>
            <a:chOff x="11142273" y="2083154"/>
            <a:chExt cx="784800" cy="784800"/>
          </a:xfrm>
        </p:grpSpPr>
        <p:pic>
          <p:nvPicPr>
            <p:cNvPr id="15" name="Image 14" descr="Une image contenant ligne, conception&#10;&#10;Description générée automatiquement">
              <a:extLst>
                <a:ext uri="{FF2B5EF4-FFF2-40B4-BE49-F238E27FC236}">
                  <a16:creationId xmlns:a16="http://schemas.microsoft.com/office/drawing/2014/main" id="{18E71AC6-BE3E-C76B-5C0B-3CEA9D17AF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142273" y="2083154"/>
              <a:ext cx="784800" cy="784800"/>
            </a:xfrm>
            <a:prstGeom prst="rect">
              <a:avLst/>
            </a:prstGeom>
          </p:spPr>
        </p:pic>
        <p:cxnSp>
          <p:nvCxnSpPr>
            <p:cNvPr id="16" name="Connecteur droit 15">
              <a:extLst>
                <a:ext uri="{FF2B5EF4-FFF2-40B4-BE49-F238E27FC236}">
                  <a16:creationId xmlns:a16="http://schemas.microsoft.com/office/drawing/2014/main" id="{9963DE38-6AD1-57BB-685A-C7F82386F65D}"/>
                </a:ext>
              </a:extLst>
            </p:cNvPr>
            <p:cNvCxnSpPr>
              <a:cxnSpLocks/>
            </p:cNvCxnSpPr>
            <p:nvPr/>
          </p:nvCxnSpPr>
          <p:spPr>
            <a:xfrm>
              <a:off x="11286403" y="2212324"/>
              <a:ext cx="593316" cy="450555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Image 8">
            <a:extLst>
              <a:ext uri="{FF2B5EF4-FFF2-40B4-BE49-F238E27FC236}">
                <a16:creationId xmlns:a16="http://schemas.microsoft.com/office/drawing/2014/main" id="{311E37E1-F0D8-7384-D9EE-219EB96404A3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3176" r="37321" b="11068"/>
          <a:stretch/>
        </p:blipFill>
        <p:spPr>
          <a:xfrm>
            <a:off x="2116433" y="1497973"/>
            <a:ext cx="2023274" cy="3485096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8DA17AD5-D775-908E-9485-3DC84F96FE28}"/>
              </a:ext>
            </a:extLst>
          </p:cNvPr>
          <p:cNvSpPr txBox="1"/>
          <p:nvPr/>
        </p:nvSpPr>
        <p:spPr>
          <a:xfrm>
            <a:off x="2067055" y="1240604"/>
            <a:ext cx="1143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5-year-olds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08B260B4-EA26-F5FE-9E43-20ED02543680}"/>
              </a:ext>
            </a:extLst>
          </p:cNvPr>
          <p:cNvSpPr txBox="1"/>
          <p:nvPr/>
        </p:nvSpPr>
        <p:spPr>
          <a:xfrm>
            <a:off x="3123946" y="1240604"/>
            <a:ext cx="9125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6-year-olds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346195A1-2B5D-26EA-ED49-0FE08988423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5171" r="67767" b="11068"/>
          <a:stretch/>
        </p:blipFill>
        <p:spPr>
          <a:xfrm>
            <a:off x="970040" y="1468698"/>
            <a:ext cx="484313" cy="3485096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172FA592-5E2A-C730-2EA0-39D364C687AD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7188" t="31758" r="514" b="41992"/>
          <a:stretch/>
        </p:blipFill>
        <p:spPr>
          <a:xfrm>
            <a:off x="4283679" y="2679174"/>
            <a:ext cx="581638" cy="1064143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5A2F3C53-EC51-58D6-6441-F82B023A8101}"/>
              </a:ext>
            </a:extLst>
          </p:cNvPr>
          <p:cNvSpPr txBox="1"/>
          <p:nvPr/>
        </p:nvSpPr>
        <p:spPr>
          <a:xfrm>
            <a:off x="899429" y="1367621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Shapes</a:t>
            </a:r>
            <a:endParaRPr lang="fr-FR" sz="1200" b="1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09584FB9-5D70-3B8C-BA87-62B81F05FFA0}"/>
              </a:ext>
            </a:extLst>
          </p:cNvPr>
          <p:cNvSpPr txBox="1"/>
          <p:nvPr/>
        </p:nvSpPr>
        <p:spPr>
          <a:xfrm>
            <a:off x="653827" y="5454993"/>
            <a:ext cx="3970369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 Percentage of correctly completed geometric shapes. </a:t>
            </a:r>
            <a:r>
              <a:rPr lang="en-US" sz="1100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case reports the percentage of drawings that correctly completed the given geometric shape (y axis), separately for the two age groups.</a:t>
            </a:r>
            <a:endParaRPr lang="it-FR" sz="1100" kern="15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973725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6C2B7C-6D86-E8C0-2141-F5AC2C2F318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FCDC0DD0-6090-1B30-A9C9-D805B0890FDF}"/>
              </a:ext>
            </a:extLst>
          </p:cNvPr>
          <p:cNvSpPr/>
          <p:nvPr/>
        </p:nvSpPr>
        <p:spPr>
          <a:xfrm>
            <a:off x="3363707" y="318111"/>
            <a:ext cx="1295306" cy="91742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D9B032BE-B524-C6A1-927F-0E55C39B3BC3}"/>
              </a:ext>
            </a:extLst>
          </p:cNvPr>
          <p:cNvSpPr txBox="1"/>
          <p:nvPr/>
        </p:nvSpPr>
        <p:spPr>
          <a:xfrm>
            <a:off x="353980" y="3130134"/>
            <a:ext cx="575421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. Experimental procedure for the multiple-choice task (experiment 2). 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each trial, after a fixation point, half of a mathematical pattern/function was presented for 2000ms, followed by six prolongations, that stayed on screen until participants’ selection of one of them (and for a maximum of 15 seconds).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D58BA9B5-1037-5F23-6A77-AACB1257961B}"/>
              </a:ext>
            </a:extLst>
          </p:cNvPr>
          <p:cNvSpPr txBox="1"/>
          <p:nvPr/>
        </p:nvSpPr>
        <p:spPr>
          <a:xfrm>
            <a:off x="2575049" y="1975407"/>
            <a:ext cx="1412576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/>
              <a:t>Fixation point</a:t>
            </a:r>
          </a:p>
          <a:p>
            <a:pPr algn="ctr"/>
            <a:r>
              <a:rPr lang="fr-FR" sz="1000" i="1" dirty="0"/>
              <a:t>1000 ms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CA053D2E-F125-02F4-3157-C57CD7D79CB1}"/>
              </a:ext>
            </a:extLst>
          </p:cNvPr>
          <p:cNvSpPr txBox="1"/>
          <p:nvPr/>
        </p:nvSpPr>
        <p:spPr>
          <a:xfrm>
            <a:off x="3595642" y="1288128"/>
            <a:ext cx="1157158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/>
              <a:t>Stimulus </a:t>
            </a:r>
            <a:r>
              <a:rPr lang="fr-FR" sz="1200" i="1" dirty="0" err="1"/>
              <a:t>presentation</a:t>
            </a:r>
            <a:endParaRPr lang="fr-FR" sz="1200" i="1" dirty="0"/>
          </a:p>
          <a:p>
            <a:pPr algn="ctr"/>
            <a:r>
              <a:rPr lang="fr-FR" sz="1000" i="1" dirty="0"/>
              <a:t>2000 ms</a:t>
            </a:r>
          </a:p>
        </p:txBody>
      </p:sp>
      <p:grpSp>
        <p:nvGrpSpPr>
          <p:cNvPr id="112" name="Groupe 111">
            <a:extLst>
              <a:ext uri="{FF2B5EF4-FFF2-40B4-BE49-F238E27FC236}">
                <a16:creationId xmlns:a16="http://schemas.microsoft.com/office/drawing/2014/main" id="{45E666BD-037B-21C6-788C-20741FF0FA19}"/>
              </a:ext>
            </a:extLst>
          </p:cNvPr>
          <p:cNvGrpSpPr/>
          <p:nvPr/>
        </p:nvGrpSpPr>
        <p:grpSpPr>
          <a:xfrm>
            <a:off x="3419205" y="416459"/>
            <a:ext cx="1184311" cy="720733"/>
            <a:chOff x="3416815" y="461449"/>
            <a:chExt cx="1184311" cy="720733"/>
          </a:xfrm>
        </p:grpSpPr>
        <p:pic>
          <p:nvPicPr>
            <p:cNvPr id="94" name="Image 93" descr="Une image contenant lime en acier, outil, stylet&#10;&#10;Description générée automatiquement avec une confiance moyenne">
              <a:extLst>
                <a:ext uri="{FF2B5EF4-FFF2-40B4-BE49-F238E27FC236}">
                  <a16:creationId xmlns:a16="http://schemas.microsoft.com/office/drawing/2014/main" id="{2E21F506-8578-7E4C-7343-422282732D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28971" y="925212"/>
              <a:ext cx="360000" cy="256970"/>
            </a:xfrm>
            <a:prstGeom prst="rect">
              <a:avLst/>
            </a:prstGeom>
          </p:spPr>
        </p:pic>
        <p:pic>
          <p:nvPicPr>
            <p:cNvPr id="96" name="Image 95" descr="Une image contenant épée&#10;&#10;Description générée automatiquement">
              <a:extLst>
                <a:ext uri="{FF2B5EF4-FFF2-40B4-BE49-F238E27FC236}">
                  <a16:creationId xmlns:a16="http://schemas.microsoft.com/office/drawing/2014/main" id="{2E5A561F-9A39-87D4-8D1F-2C0488B973C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16815" y="925212"/>
              <a:ext cx="360000" cy="256970"/>
            </a:xfrm>
            <a:prstGeom prst="rect">
              <a:avLst/>
            </a:prstGeom>
          </p:spPr>
        </p:pic>
        <p:pic>
          <p:nvPicPr>
            <p:cNvPr id="98" name="Image 97" descr="Une image contenant levier, outil&#10;&#10;Description générée automatiquement">
              <a:extLst>
                <a:ext uri="{FF2B5EF4-FFF2-40B4-BE49-F238E27FC236}">
                  <a16:creationId xmlns:a16="http://schemas.microsoft.com/office/drawing/2014/main" id="{2594DEAD-AED0-1529-EEAB-77B5A99F8F8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41126" y="925212"/>
              <a:ext cx="360000" cy="256970"/>
            </a:xfrm>
            <a:prstGeom prst="rect">
              <a:avLst/>
            </a:prstGeom>
          </p:spPr>
        </p:pic>
        <p:pic>
          <p:nvPicPr>
            <p:cNvPr id="100" name="Image 99" descr="Une image contenant lime en acier, outil, stylet, conception&#10;&#10;Description générée automatiquement">
              <a:extLst>
                <a:ext uri="{FF2B5EF4-FFF2-40B4-BE49-F238E27FC236}">
                  <a16:creationId xmlns:a16="http://schemas.microsoft.com/office/drawing/2014/main" id="{E47241EA-1F39-FAFD-6CE6-1E1E23BAABA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41126" y="461449"/>
              <a:ext cx="360000" cy="256970"/>
            </a:xfrm>
            <a:prstGeom prst="rect">
              <a:avLst/>
            </a:prstGeom>
          </p:spPr>
        </p:pic>
        <p:pic>
          <p:nvPicPr>
            <p:cNvPr id="102" name="Image 101" descr="Une image contenant conception, clé, outil&#10;&#10;Description générée automatiquement">
              <a:extLst>
                <a:ext uri="{FF2B5EF4-FFF2-40B4-BE49-F238E27FC236}">
                  <a16:creationId xmlns:a16="http://schemas.microsoft.com/office/drawing/2014/main" id="{CF7823CE-E0A3-415B-6356-772BF325CEF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28971" y="461449"/>
              <a:ext cx="360000" cy="256970"/>
            </a:xfrm>
            <a:prstGeom prst="rect">
              <a:avLst/>
            </a:prstGeom>
          </p:spPr>
        </p:pic>
        <p:pic>
          <p:nvPicPr>
            <p:cNvPr id="107" name="Image 106" descr="Une image contenant outil, clé, conception&#10;&#10;Description générée automatiquement">
              <a:extLst>
                <a:ext uri="{FF2B5EF4-FFF2-40B4-BE49-F238E27FC236}">
                  <a16:creationId xmlns:a16="http://schemas.microsoft.com/office/drawing/2014/main" id="{31723ACE-726B-FB82-3F8E-6CA7D6E0E0E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416815" y="461449"/>
              <a:ext cx="360000" cy="256970"/>
            </a:xfrm>
            <a:prstGeom prst="rect">
              <a:avLst/>
            </a:prstGeom>
          </p:spPr>
        </p:pic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BE07D748-6F23-1583-B22E-2F54DFFFE766}"/>
              </a:ext>
            </a:extLst>
          </p:cNvPr>
          <p:cNvSpPr/>
          <p:nvPr/>
        </p:nvSpPr>
        <p:spPr>
          <a:xfrm>
            <a:off x="2395812" y="954568"/>
            <a:ext cx="1295306" cy="91742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26" name="Groupe 125">
            <a:extLst>
              <a:ext uri="{FF2B5EF4-FFF2-40B4-BE49-F238E27FC236}">
                <a16:creationId xmlns:a16="http://schemas.microsoft.com/office/drawing/2014/main" id="{F15A1ECE-E0EE-D93B-2D6F-2C12B25B8EC8}"/>
              </a:ext>
            </a:extLst>
          </p:cNvPr>
          <p:cNvGrpSpPr/>
          <p:nvPr/>
        </p:nvGrpSpPr>
        <p:grpSpPr>
          <a:xfrm>
            <a:off x="2442294" y="1040499"/>
            <a:ext cx="1195218" cy="744820"/>
            <a:chOff x="2455740" y="1027053"/>
            <a:chExt cx="1195218" cy="744820"/>
          </a:xfrm>
        </p:grpSpPr>
        <p:pic>
          <p:nvPicPr>
            <p:cNvPr id="114" name="Image 113" descr="Une image contenant match, briquet, stylet, conception&#10;&#10;Description générée automatiquement">
              <a:extLst>
                <a:ext uri="{FF2B5EF4-FFF2-40B4-BE49-F238E27FC236}">
                  <a16:creationId xmlns:a16="http://schemas.microsoft.com/office/drawing/2014/main" id="{0D98A2B1-4F8A-3E96-3117-9CF84E4AF61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55740" y="1027053"/>
              <a:ext cx="360000" cy="256970"/>
            </a:xfrm>
            <a:prstGeom prst="rect">
              <a:avLst/>
            </a:prstGeom>
          </p:spPr>
        </p:pic>
        <p:pic>
          <p:nvPicPr>
            <p:cNvPr id="116" name="Image 115" descr="Une image contenant match, briquet, stylet, conception&#10;&#10;Description générée automatiquement">
              <a:extLst>
                <a:ext uri="{FF2B5EF4-FFF2-40B4-BE49-F238E27FC236}">
                  <a16:creationId xmlns:a16="http://schemas.microsoft.com/office/drawing/2014/main" id="{B99A0C11-1628-5C59-5183-8777A94444F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73349" y="1027053"/>
              <a:ext cx="360000" cy="256970"/>
            </a:xfrm>
            <a:prstGeom prst="rect">
              <a:avLst/>
            </a:prstGeom>
          </p:spPr>
        </p:pic>
        <p:pic>
          <p:nvPicPr>
            <p:cNvPr id="118" name="Image 117" descr="Une image contenant match, briquet, stylet, conception&#10;&#10;Description générée automatiquement">
              <a:extLst>
                <a:ext uri="{FF2B5EF4-FFF2-40B4-BE49-F238E27FC236}">
                  <a16:creationId xmlns:a16="http://schemas.microsoft.com/office/drawing/2014/main" id="{BF443F20-7D1D-7A17-6379-F41D69C8DD4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290958" y="1027053"/>
              <a:ext cx="360000" cy="256970"/>
            </a:xfrm>
            <a:prstGeom prst="rect">
              <a:avLst/>
            </a:prstGeom>
          </p:spPr>
        </p:pic>
        <p:pic>
          <p:nvPicPr>
            <p:cNvPr id="120" name="Image 119" descr="Une image contenant match, briquet, stylet, conception&#10;&#10;Description générée automatiquement">
              <a:extLst>
                <a:ext uri="{FF2B5EF4-FFF2-40B4-BE49-F238E27FC236}">
                  <a16:creationId xmlns:a16="http://schemas.microsoft.com/office/drawing/2014/main" id="{23C460C4-26E4-5B6D-38B8-D8D1EDFA62B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290958" y="1514903"/>
              <a:ext cx="360000" cy="256970"/>
            </a:xfrm>
            <a:prstGeom prst="rect">
              <a:avLst/>
            </a:prstGeom>
          </p:spPr>
        </p:pic>
        <p:pic>
          <p:nvPicPr>
            <p:cNvPr id="122" name="Image 121" descr="Une image contenant match, briquet, stylet, conception&#10;&#10;Description générée automatiquement">
              <a:extLst>
                <a:ext uri="{FF2B5EF4-FFF2-40B4-BE49-F238E27FC236}">
                  <a16:creationId xmlns:a16="http://schemas.microsoft.com/office/drawing/2014/main" id="{59EDC5D9-16D2-4564-60C3-D5A7E2E0B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73349" y="1514903"/>
              <a:ext cx="360000" cy="256970"/>
            </a:xfrm>
            <a:prstGeom prst="rect">
              <a:avLst/>
            </a:prstGeom>
          </p:spPr>
        </p:pic>
        <p:pic>
          <p:nvPicPr>
            <p:cNvPr id="124" name="Image 123" descr="Une image contenant match, briquet, stylet, conception&#10;&#10;Description générée automatiquement">
              <a:extLst>
                <a:ext uri="{FF2B5EF4-FFF2-40B4-BE49-F238E27FC236}">
                  <a16:creationId xmlns:a16="http://schemas.microsoft.com/office/drawing/2014/main" id="{136AACCC-740E-5D05-B919-F706DC42A0E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55740" y="1514903"/>
              <a:ext cx="360000" cy="256970"/>
            </a:xfrm>
            <a:prstGeom prst="rect">
              <a:avLst/>
            </a:prstGeom>
          </p:spPr>
        </p:pic>
      </p:grpSp>
      <p:sp>
        <p:nvSpPr>
          <p:cNvPr id="21" name="Rectangle 20">
            <a:extLst>
              <a:ext uri="{FF2B5EF4-FFF2-40B4-BE49-F238E27FC236}">
                <a16:creationId xmlns:a16="http://schemas.microsoft.com/office/drawing/2014/main" id="{E6965058-A230-B469-13BC-287A1DDD9E95}"/>
              </a:ext>
            </a:extLst>
          </p:cNvPr>
          <p:cNvSpPr/>
          <p:nvPr/>
        </p:nvSpPr>
        <p:spPr>
          <a:xfrm>
            <a:off x="1447537" y="1574493"/>
            <a:ext cx="1295306" cy="91742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Ellipse 34">
            <a:extLst>
              <a:ext uri="{FF2B5EF4-FFF2-40B4-BE49-F238E27FC236}">
                <a16:creationId xmlns:a16="http://schemas.microsoft.com/office/drawing/2014/main" id="{8CC1D384-B7EA-E8DE-C91B-597F9809D209}"/>
              </a:ext>
            </a:extLst>
          </p:cNvPr>
          <p:cNvSpPr/>
          <p:nvPr/>
        </p:nvSpPr>
        <p:spPr>
          <a:xfrm>
            <a:off x="2059190" y="2000403"/>
            <a:ext cx="72000" cy="72000"/>
          </a:xfrm>
          <a:prstGeom prst="ellipse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1759D3D9-C64D-5F5E-6AC0-0FA4BC1678ED}"/>
              </a:ext>
            </a:extLst>
          </p:cNvPr>
          <p:cNvSpPr txBox="1"/>
          <p:nvPr/>
        </p:nvSpPr>
        <p:spPr>
          <a:xfrm>
            <a:off x="4329675" y="547532"/>
            <a:ext cx="158253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err="1"/>
              <a:t>Response</a:t>
            </a:r>
            <a:endParaRPr lang="fr-FR" sz="1200" i="1" dirty="0"/>
          </a:p>
          <a:p>
            <a:pPr algn="ctr"/>
            <a:r>
              <a:rPr lang="fr-FR" sz="1000" i="1" dirty="0" err="1"/>
              <a:t>Within</a:t>
            </a:r>
            <a:r>
              <a:rPr lang="fr-FR" sz="1000" i="1" dirty="0"/>
              <a:t> 15s</a:t>
            </a:r>
          </a:p>
        </p:txBody>
      </p:sp>
      <p:cxnSp>
        <p:nvCxnSpPr>
          <p:cNvPr id="132" name="Connecteur droit avec flèche 131">
            <a:extLst>
              <a:ext uri="{FF2B5EF4-FFF2-40B4-BE49-F238E27FC236}">
                <a16:creationId xmlns:a16="http://schemas.microsoft.com/office/drawing/2014/main" id="{268C05FC-159B-8493-4593-B0F53B2B6F7B}"/>
              </a:ext>
            </a:extLst>
          </p:cNvPr>
          <p:cNvCxnSpPr>
            <a:cxnSpLocks/>
          </p:cNvCxnSpPr>
          <p:nvPr/>
        </p:nvCxnSpPr>
        <p:spPr>
          <a:xfrm flipV="1">
            <a:off x="3691118" y="1122704"/>
            <a:ext cx="1687603" cy="1460009"/>
          </a:xfrm>
          <a:prstGeom prst="straightConnector1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36" name="ZoneTexte 135">
            <a:extLst>
              <a:ext uri="{FF2B5EF4-FFF2-40B4-BE49-F238E27FC236}">
                <a16:creationId xmlns:a16="http://schemas.microsoft.com/office/drawing/2014/main" id="{56D894E3-B3C1-C980-9BA2-D8D4E1BA6774}"/>
              </a:ext>
            </a:extLst>
          </p:cNvPr>
          <p:cNvSpPr txBox="1"/>
          <p:nvPr/>
        </p:nvSpPr>
        <p:spPr>
          <a:xfrm>
            <a:off x="4816018" y="934966"/>
            <a:ext cx="1582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/>
              <a:t>Time</a:t>
            </a:r>
            <a:endParaRPr lang="fr-FR" sz="1000" i="1" dirty="0"/>
          </a:p>
        </p:txBody>
      </p:sp>
    </p:spTree>
    <p:extLst>
      <p:ext uri="{BB962C8B-B14F-4D97-AF65-F5344CB8AC3E}">
        <p14:creationId xmlns:p14="http://schemas.microsoft.com/office/powerpoint/2010/main" val="17284388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4B5A3B9-4062-6B60-B69D-060EDE77BB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88EA3CE1-63A8-DFA7-9707-AF26863AD7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0800667"/>
              </p:ext>
            </p:extLst>
          </p:nvPr>
        </p:nvGraphicFramePr>
        <p:xfrm>
          <a:off x="241314" y="0"/>
          <a:ext cx="6325472" cy="8460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92000">
                  <a:extLst>
                    <a:ext uri="{9D8B030D-6E8A-4147-A177-3AD203B41FA5}">
                      <a16:colId xmlns:a16="http://schemas.microsoft.com/office/drawing/2014/main" val="2297954170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503350955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1292920254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2583124190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2623948246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4276354975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266536482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18515745"/>
                    </a:ext>
                  </a:extLst>
                </a:gridCol>
              </a:tblGrid>
              <a:tr h="252000">
                <a:tc rowSpan="2"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Stimulu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b="1" dirty="0"/>
                        <a:t>Correct </a:t>
                      </a:r>
                      <a:r>
                        <a:rPr lang="fr-FR" sz="1000" b="1" dirty="0" err="1"/>
                        <a:t>response</a:t>
                      </a:r>
                      <a:endParaRPr lang="fr-FR" sz="1000" b="1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Violation of…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977653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first point position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first point </a:t>
                      </a:r>
                      <a:r>
                        <a:rPr lang="fr-FR" sz="1000" dirty="0" err="1"/>
                        <a:t>derivative</a:t>
                      </a:r>
                      <a:endParaRPr lang="fr-FR" sz="100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</a:t>
                      </a:r>
                      <a:r>
                        <a:rPr lang="fr-FR" sz="1000" dirty="0" err="1"/>
                        <a:t>overall</a:t>
                      </a:r>
                      <a:r>
                        <a:rPr lang="fr-FR" sz="1000" dirty="0"/>
                        <a:t> tren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</a:t>
                      </a:r>
                      <a:r>
                        <a:rPr lang="fr-FR" sz="1000" dirty="0" err="1"/>
                        <a:t>curvature</a:t>
                      </a:r>
                      <a:endParaRPr lang="fr-FR" sz="100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non </a:t>
                      </a:r>
                      <a:r>
                        <a:rPr lang="fr-FR" sz="1000" dirty="0" err="1"/>
                        <a:t>periodicity</a:t>
                      </a:r>
                      <a:endParaRPr lang="fr-FR" sz="100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79304972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Constant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9745082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Linear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increasing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7649476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Linear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decreasing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1466489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Quadratic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increasing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0085424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Quadratic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decreasing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3119781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Exponential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increasing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3898155"/>
                  </a:ext>
                </a:extLst>
              </a:tr>
              <a:tr h="1116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Exponential</a:t>
                      </a:r>
                      <a:r>
                        <a:rPr lang="fr-FR" sz="1000" dirty="0"/>
                        <a:t> </a:t>
                      </a:r>
                      <a:r>
                        <a:rPr lang="fr-FR" sz="1000" dirty="0" err="1"/>
                        <a:t>decreasing</a:t>
                      </a:r>
                      <a:endParaRPr lang="fr-FR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950160"/>
                  </a:ext>
                </a:extLst>
              </a:tr>
            </a:tbl>
          </a:graphicData>
        </a:graphic>
      </p:graphicFrame>
      <p:sp>
        <p:nvSpPr>
          <p:cNvPr id="115" name="ZoneTexte 114">
            <a:extLst>
              <a:ext uri="{FF2B5EF4-FFF2-40B4-BE49-F238E27FC236}">
                <a16:creationId xmlns:a16="http://schemas.microsoft.com/office/drawing/2014/main" id="{D8D2212B-C105-2DA7-3999-2BC75193044C}"/>
              </a:ext>
            </a:extLst>
          </p:cNvPr>
          <p:cNvSpPr txBox="1"/>
          <p:nvPr/>
        </p:nvSpPr>
        <p:spPr>
          <a:xfrm>
            <a:off x="241314" y="9150291"/>
            <a:ext cx="648296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8. Percentage of chosen prolongations for linear and non-linear functions.  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case reports the percentage of trials in which participants chose that specific prolongation among the six available options, separately for 5- </a:t>
            </a:r>
            <a:r>
              <a:rPr lang="en-US" sz="1100" kern="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6-year-old 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ldren.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CDFD4CFF-F69D-F50E-A4C7-09BD921E72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0242" y="7388275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9" name="Image 8" descr="Une image contenant levier&#10;&#10;Description générée automatiquement">
            <a:extLst>
              <a:ext uri="{FF2B5EF4-FFF2-40B4-BE49-F238E27FC236}">
                <a16:creationId xmlns:a16="http://schemas.microsoft.com/office/drawing/2014/main" id="{ECC6775D-AEE7-CAB3-DF75-EE79825BDE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23570" y="7388275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1" name="Image 10" descr="Une image contenant levier&#10;&#10;Description générée automatiquement">
            <a:extLst>
              <a:ext uri="{FF2B5EF4-FFF2-40B4-BE49-F238E27FC236}">
                <a16:creationId xmlns:a16="http://schemas.microsoft.com/office/drawing/2014/main" id="{EBB611F4-63BE-B73F-52BC-AEA47BCF44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1031" y="7388275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61429FB3-63FD-6694-79AE-B0E904D14E1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53390" y="7388275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5" name="Image 14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AFCD45D6-8492-7D05-5032-6D6E94E9FF2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09604" y="7388275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7" name="Image 16" descr="Une image contenant levier&#10;&#10;Description générée automatiquement avec une confiance moyenne">
            <a:extLst>
              <a:ext uri="{FF2B5EF4-FFF2-40B4-BE49-F238E27FC236}">
                <a16:creationId xmlns:a16="http://schemas.microsoft.com/office/drawing/2014/main" id="{99C838F0-B66F-C8A0-D7B9-5F7EA993A1A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61584" y="7645244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21" name="Image 20" descr="Une image contenant levier&#10;&#10;Description générée automatiquement">
            <a:extLst>
              <a:ext uri="{FF2B5EF4-FFF2-40B4-BE49-F238E27FC236}">
                <a16:creationId xmlns:a16="http://schemas.microsoft.com/office/drawing/2014/main" id="{F04CA6A8-4D4C-28B1-335F-60A19616684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28672" y="7388275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484B8DA3-CB14-C926-AB6E-1D996A8C076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60242" y="627400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29" name="Image 28" descr="Une image contenant levier&#10;&#10;Description générée automatiquement">
            <a:extLst>
              <a:ext uri="{FF2B5EF4-FFF2-40B4-BE49-F238E27FC236}">
                <a16:creationId xmlns:a16="http://schemas.microsoft.com/office/drawing/2014/main" id="{84A4BC7B-433E-E7C6-5100-A2B321ECDC5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23570" y="627400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F9714687-27DA-D905-497E-F2F2D672C7A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42585" y="627400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2A6CFF20-1C60-4806-766D-9C8A44FB135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46133" y="627400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41" name="Image 40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D0BFFBC9-189C-FAE3-FACC-8E2D9D11FB1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07068" y="627400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45" name="Image 44">
            <a:extLst>
              <a:ext uri="{FF2B5EF4-FFF2-40B4-BE49-F238E27FC236}">
                <a16:creationId xmlns:a16="http://schemas.microsoft.com/office/drawing/2014/main" id="{7B03FCB0-FD2D-5E78-F890-B068CD8F1B0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61584" y="653264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49" name="Image 48" descr="Une image contenant croquis, levier&#10;&#10;Description générée automatiquement">
            <a:extLst>
              <a:ext uri="{FF2B5EF4-FFF2-40B4-BE49-F238E27FC236}">
                <a16:creationId xmlns:a16="http://schemas.microsoft.com/office/drawing/2014/main" id="{4392792F-542D-3D49-90CF-45323BB791E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28672" y="627400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53" name="Image 52" descr="Une image contenant outil, levier&#10;&#10;Description générée automatiquement">
            <a:extLst>
              <a:ext uri="{FF2B5EF4-FFF2-40B4-BE49-F238E27FC236}">
                <a16:creationId xmlns:a16="http://schemas.microsoft.com/office/drawing/2014/main" id="{C19B529A-1F5A-1CD2-669D-A7F5594F439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860242" y="292365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57" name="Image 56" descr="Une image contenant levier&#10;&#10;Description générée automatiquement">
            <a:extLst>
              <a:ext uri="{FF2B5EF4-FFF2-40B4-BE49-F238E27FC236}">
                <a16:creationId xmlns:a16="http://schemas.microsoft.com/office/drawing/2014/main" id="{58FFC8C4-AD3A-5CAA-C292-848FCFB665B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014241" y="292365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61" name="Image 60" descr="Une image contenant levier, outil&#10;&#10;Description générée automatiquement">
            <a:extLst>
              <a:ext uri="{FF2B5EF4-FFF2-40B4-BE49-F238E27FC236}">
                <a16:creationId xmlns:a16="http://schemas.microsoft.com/office/drawing/2014/main" id="{DF91D6EC-24B3-A108-A2D5-ADB3BCA1D52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435455" y="292365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65" name="Image 64" descr="Une image contenant stylet, levier&#10;&#10;Description générée automatiquement avec une confiance moyenne">
            <a:extLst>
              <a:ext uri="{FF2B5EF4-FFF2-40B4-BE49-F238E27FC236}">
                <a16:creationId xmlns:a16="http://schemas.microsoft.com/office/drawing/2014/main" id="{D025BE77-2EC8-6706-9D7D-049463EF64D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653390" y="292365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69" name="Image 68" descr="Une image contenant levier, conception&#10;&#10;Description générée automatiquement avec une confiance moyenne">
            <a:extLst>
              <a:ext uri="{FF2B5EF4-FFF2-40B4-BE49-F238E27FC236}">
                <a16:creationId xmlns:a16="http://schemas.microsoft.com/office/drawing/2014/main" id="{A0654BAB-6E26-F026-B16A-C30715E4AD1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814325" y="292365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73" name="Image 72" descr="Une image contenant match, briquet&#10;&#10;Description générée automatiquement">
            <a:extLst>
              <a:ext uri="{FF2B5EF4-FFF2-40B4-BE49-F238E27FC236}">
                <a16:creationId xmlns:a16="http://schemas.microsoft.com/office/drawing/2014/main" id="{781784FE-E3E3-EA43-BB77-A1749E818C18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067025" y="3183997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77" name="Image 76" descr="Une image contenant conception&#10;&#10;Description générée automatiquement">
            <a:extLst>
              <a:ext uri="{FF2B5EF4-FFF2-40B4-BE49-F238E27FC236}">
                <a16:creationId xmlns:a16="http://schemas.microsoft.com/office/drawing/2014/main" id="{C3A98AA1-BE2B-9023-C47F-C7A65626F41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228672" y="292365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81" name="Image 80" descr="Une image contenant outil, levier, stylet&#10;&#10;Description générée automatiquement">
            <a:extLst>
              <a:ext uri="{FF2B5EF4-FFF2-40B4-BE49-F238E27FC236}">
                <a16:creationId xmlns:a16="http://schemas.microsoft.com/office/drawing/2014/main" id="{92E27478-66DA-5541-ECA5-FBBB4C4E02AD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860242" y="1809486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85" name="Image 84" descr="Une image contenant levier&#10;&#10;Description générée automatiquement">
            <a:extLst>
              <a:ext uri="{FF2B5EF4-FFF2-40B4-BE49-F238E27FC236}">
                <a16:creationId xmlns:a16="http://schemas.microsoft.com/office/drawing/2014/main" id="{8E04926B-9715-CD92-2D77-70BA99799C68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021820" y="1809486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89" name="Image 88" descr="Une image contenant levier&#10;&#10;Description générée automatiquement">
            <a:extLst>
              <a:ext uri="{FF2B5EF4-FFF2-40B4-BE49-F238E27FC236}">
                <a16:creationId xmlns:a16="http://schemas.microsoft.com/office/drawing/2014/main" id="{63A0BF12-17AC-EC85-6F40-13A96E7F1F17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441031" y="1809486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93" name="Image 92" descr="Une image contenant outil, stylet, levier&#10;&#10;Description générée automatiquement">
            <a:extLst>
              <a:ext uri="{FF2B5EF4-FFF2-40B4-BE49-F238E27FC236}">
                <a16:creationId xmlns:a16="http://schemas.microsoft.com/office/drawing/2014/main" id="{EA77664F-A436-32C9-1A37-F93CEC8D2399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654785" y="1809486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97" name="Image 96">
            <a:extLst>
              <a:ext uri="{FF2B5EF4-FFF2-40B4-BE49-F238E27FC236}">
                <a16:creationId xmlns:a16="http://schemas.microsoft.com/office/drawing/2014/main" id="{A5F7EB74-AFFB-AA7E-5A5B-62F2998C508D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807068" y="1809486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01" name="Image 100" descr="Une image contenant outil, stylet, levier&#10;&#10;Description générée automatiquement">
            <a:extLst>
              <a:ext uri="{FF2B5EF4-FFF2-40B4-BE49-F238E27FC236}">
                <a16:creationId xmlns:a16="http://schemas.microsoft.com/office/drawing/2014/main" id="{042843D3-AE91-21E2-1F75-3DB9E22227BC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068841" y="206520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05" name="Image 104" descr="Une image contenant outil, clé, cadre, conception&#10;&#10;Description générée automatiquement">
            <a:extLst>
              <a:ext uri="{FF2B5EF4-FFF2-40B4-BE49-F238E27FC236}">
                <a16:creationId xmlns:a16="http://schemas.microsoft.com/office/drawing/2014/main" id="{66A1D7D0-EDF1-C59E-F7AE-2B2E894BBE4F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4228672" y="1809486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09" name="Image 108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DDACAF26-3989-7CAC-DE2C-EEC9B665F7B0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860242" y="5161812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13" name="Image 112" descr="Une image contenant levier&#10;&#10;Description générée automatiquement">
            <a:extLst>
              <a:ext uri="{FF2B5EF4-FFF2-40B4-BE49-F238E27FC236}">
                <a16:creationId xmlns:a16="http://schemas.microsoft.com/office/drawing/2014/main" id="{4584E579-F60C-6CB9-2461-E1FED524B299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014563" y="5161812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20" name="Image 119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1B05375B-E83A-ADCA-A53B-84BCA6ACE8F2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3439283" y="5161812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22" name="Image 121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FB8BB9AB-2939-364D-2F93-CAB104990304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2651643" y="5161812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24" name="Image 123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A19A379E-0B8B-28E3-F97B-AE4B518C91BC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5809460" y="5161812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26" name="Image 125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810FB572-8811-9F84-4699-499C64542773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068841" y="5417923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28" name="Image 127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A87EA51A-9585-5B73-AA03-D3BAAD3F14CF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4227550" y="5161812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30" name="Image 129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2B3FA9A0-F399-AA03-D24A-206615FBF5BA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860242" y="404353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32" name="Image 131" descr="Une image contenant objets en métal, levier&#10;&#10;Description générée automatiquement">
            <a:extLst>
              <a:ext uri="{FF2B5EF4-FFF2-40B4-BE49-F238E27FC236}">
                <a16:creationId xmlns:a16="http://schemas.microsoft.com/office/drawing/2014/main" id="{8EBE21C4-53A7-091C-A7C9-2B37783BD3FC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5014241" y="404353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46" name="Image 145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EAB29DB0-FC36-1C0F-32A8-6792E102CEA8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3442585" y="404353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56" name="Image 155" descr="Une image contenant croquis, dessin&#10;&#10;Description générée automatiquement">
            <a:extLst>
              <a:ext uri="{FF2B5EF4-FFF2-40B4-BE49-F238E27FC236}">
                <a16:creationId xmlns:a16="http://schemas.microsoft.com/office/drawing/2014/main" id="{F13E8D03-846A-BE8C-76F4-3BE87E7614BE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2654137" y="404353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58" name="Image 157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A2AD5378-45CB-D5AD-053B-A0FAF96F314D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5816717" y="404353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60" name="Image 159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EF0A7932-7BD7-0CDA-8048-9A392AE372DE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1065023" y="4353580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62" name="Image 161" descr="Une image contenant croquis&#10;&#10;Description générée automatiquement">
            <a:extLst>
              <a:ext uri="{FF2B5EF4-FFF2-40B4-BE49-F238E27FC236}">
                <a16:creationId xmlns:a16="http://schemas.microsoft.com/office/drawing/2014/main" id="{ABE14FA8-6710-9F68-D6FB-E3BB8942DF23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4226279" y="404353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64" name="Image 163" descr="Une image contenant minimaliste&#10;&#10;Description générée automatiquement avec une confiance faible">
            <a:extLst>
              <a:ext uri="{FF2B5EF4-FFF2-40B4-BE49-F238E27FC236}">
                <a16:creationId xmlns:a16="http://schemas.microsoft.com/office/drawing/2014/main" id="{27712291-54FE-A920-A2DC-20E7F04265A9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1860242" y="68767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66" name="Image 165" descr="Une image contenant levier&#10;&#10;Description générée automatiquement">
            <a:extLst>
              <a:ext uri="{FF2B5EF4-FFF2-40B4-BE49-F238E27FC236}">
                <a16:creationId xmlns:a16="http://schemas.microsoft.com/office/drawing/2014/main" id="{49640EB7-6627-D3E2-A4FC-5B2DD78ED51A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5021498" y="68767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68" name="Image 167" descr="Une image contenant levier, conception&#10;&#10;Description générée automatiquement">
            <a:extLst>
              <a:ext uri="{FF2B5EF4-FFF2-40B4-BE49-F238E27FC236}">
                <a16:creationId xmlns:a16="http://schemas.microsoft.com/office/drawing/2014/main" id="{A7A58662-BEBA-38FE-7ED1-31E60F8C01DB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4228441" y="68767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70" name="Image 169" descr="Une image contenant capture d’écran, ligne, minimaliste, conception&#10;&#10;Description générée automatiquement">
            <a:extLst>
              <a:ext uri="{FF2B5EF4-FFF2-40B4-BE49-F238E27FC236}">
                <a16:creationId xmlns:a16="http://schemas.microsoft.com/office/drawing/2014/main" id="{905E7DAA-9D75-84CF-D6E8-C6F6937D5117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2654137" y="68767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72" name="Image 171" descr="Une image contenant ligne, conception&#10;&#10;Description générée automatiquement">
            <a:extLst>
              <a:ext uri="{FF2B5EF4-FFF2-40B4-BE49-F238E27FC236}">
                <a16:creationId xmlns:a16="http://schemas.microsoft.com/office/drawing/2014/main" id="{F051202F-FF55-F895-79DC-59EB85FD8DF7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5814739" y="687679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74" name="Image 173" descr="Une image contenant minimaliste, conception&#10;&#10;Description générée automatiquement avec une confiance faible">
            <a:extLst>
              <a:ext uri="{FF2B5EF4-FFF2-40B4-BE49-F238E27FC236}">
                <a16:creationId xmlns:a16="http://schemas.microsoft.com/office/drawing/2014/main" id="{9E8F7EF2-29C9-3712-A153-3AD842CB1651}"/>
              </a:ext>
            </a:extLst>
          </p:cNvPr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1068841" y="946403"/>
            <a:ext cx="720000" cy="513939"/>
          </a:xfrm>
          <a:prstGeom prst="rect">
            <a:avLst/>
          </a:prstGeom>
          <a:ln>
            <a:noFill/>
          </a:ln>
        </p:spPr>
      </p:pic>
      <p:pic>
        <p:nvPicPr>
          <p:cNvPr id="176" name="Image 175" descr="Une image contenant levier, outil, conception&#10;&#10;Description générée automatiquement">
            <a:extLst>
              <a:ext uri="{FF2B5EF4-FFF2-40B4-BE49-F238E27FC236}">
                <a16:creationId xmlns:a16="http://schemas.microsoft.com/office/drawing/2014/main" id="{55ACE36D-787E-AB22-CF9D-834E33BDDE1C}"/>
              </a:ext>
            </a:extLst>
          </p:cNvPr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3439283" y="687679"/>
            <a:ext cx="720000" cy="513939"/>
          </a:xfrm>
          <a:prstGeom prst="rect">
            <a:avLst/>
          </a:prstGeom>
          <a:ln>
            <a:noFill/>
          </a:ln>
        </p:spPr>
      </p:pic>
      <p:sp>
        <p:nvSpPr>
          <p:cNvPr id="184" name="ZoneTexte 183">
            <a:extLst>
              <a:ext uri="{FF2B5EF4-FFF2-40B4-BE49-F238E27FC236}">
                <a16:creationId xmlns:a16="http://schemas.microsoft.com/office/drawing/2014/main" id="{60E943FE-E9AB-D12D-A5D8-6A86A88413D3}"/>
              </a:ext>
            </a:extLst>
          </p:cNvPr>
          <p:cNvSpPr txBox="1"/>
          <p:nvPr/>
        </p:nvSpPr>
        <p:spPr>
          <a:xfrm rot="18848527">
            <a:off x="1830684" y="8614162"/>
            <a:ext cx="7768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/>
              <a:t>6 </a:t>
            </a:r>
            <a:r>
              <a:rPr lang="fr-FR" sz="1000" b="1" dirty="0" err="1"/>
              <a:t>year-old</a:t>
            </a:r>
            <a:endParaRPr lang="fr-FR" sz="1000" b="1" dirty="0"/>
          </a:p>
        </p:txBody>
      </p:sp>
      <p:sp>
        <p:nvSpPr>
          <p:cNvPr id="185" name="ZoneTexte 184">
            <a:extLst>
              <a:ext uri="{FF2B5EF4-FFF2-40B4-BE49-F238E27FC236}">
                <a16:creationId xmlns:a16="http://schemas.microsoft.com/office/drawing/2014/main" id="{FB51D912-FB29-7F8C-81EA-C316F5EEB22B}"/>
              </a:ext>
            </a:extLst>
          </p:cNvPr>
          <p:cNvSpPr txBox="1"/>
          <p:nvPr/>
        </p:nvSpPr>
        <p:spPr>
          <a:xfrm rot="18848527">
            <a:off x="1417787" y="8612332"/>
            <a:ext cx="7768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/>
              <a:t>5 </a:t>
            </a:r>
            <a:r>
              <a:rPr lang="fr-FR" sz="1000" b="1" dirty="0" err="1"/>
              <a:t>year-old</a:t>
            </a:r>
            <a:endParaRPr lang="fr-FR" sz="1000" b="1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380101C5-756B-153B-8A3E-E96A483E4A1B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8286" r="11066" b="80892"/>
          <a:stretch/>
        </p:blipFill>
        <p:spPr>
          <a:xfrm>
            <a:off x="1860242" y="1259050"/>
            <a:ext cx="4669847" cy="358261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9D96614B-8C79-C687-302A-5ACFC4AA378F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19224" r="11066" b="69878"/>
          <a:stretch/>
        </p:blipFill>
        <p:spPr>
          <a:xfrm>
            <a:off x="1860242" y="2377323"/>
            <a:ext cx="4669847" cy="360761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E0279B79-1198-AC9F-6BD5-129AA99AFCE5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30345" r="11066" b="58757"/>
          <a:stretch/>
        </p:blipFill>
        <p:spPr>
          <a:xfrm>
            <a:off x="1860242" y="3485513"/>
            <a:ext cx="4669847" cy="360761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93817951-0374-631C-231A-B362B6A791BA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43074" r="11066" b="47237"/>
          <a:stretch/>
        </p:blipFill>
        <p:spPr>
          <a:xfrm>
            <a:off x="1860242" y="4691219"/>
            <a:ext cx="4669847" cy="320758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5D07E7AF-9F34-AAAE-0169-5C620B515161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54194" r="11066" b="34908"/>
          <a:stretch/>
        </p:blipFill>
        <p:spPr>
          <a:xfrm>
            <a:off x="1864478" y="5818424"/>
            <a:ext cx="4669847" cy="360761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85975E48-3E5A-A26C-D8BC-9D98E60C3F09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65316" r="11066" b="23786"/>
          <a:stretch/>
        </p:blipFill>
        <p:spPr>
          <a:xfrm>
            <a:off x="1857221" y="6914320"/>
            <a:ext cx="4669847" cy="360761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E2793A4A-E383-7B0B-5F1C-C7FA8309BC0E}"/>
              </a:ext>
            </a:extLst>
          </p:cNvPr>
          <p:cNvPicPr>
            <a:picLocks noChangeAspect="1"/>
          </p:cNvPicPr>
          <p:nvPr/>
        </p:nvPicPr>
        <p:blipFill>
          <a:blip r:embed="rId52"/>
          <a:srcRect l="18400" t="76438" r="11066" b="12664"/>
          <a:stretch/>
        </p:blipFill>
        <p:spPr>
          <a:xfrm>
            <a:off x="1857221" y="8008386"/>
            <a:ext cx="4669847" cy="360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724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13726B-B47B-812A-5D1F-06315DA99FF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EF1DFE3A-6693-5895-7660-6585063989AC}"/>
              </a:ext>
            </a:extLst>
          </p:cNvPr>
          <p:cNvGraphicFramePr>
            <a:graphicFrameLocks noGrp="1"/>
          </p:cNvGraphicFramePr>
          <p:nvPr/>
        </p:nvGraphicFramePr>
        <p:xfrm>
          <a:off x="296924" y="595142"/>
          <a:ext cx="6325472" cy="2808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92000">
                  <a:extLst>
                    <a:ext uri="{9D8B030D-6E8A-4147-A177-3AD203B41FA5}">
                      <a16:colId xmlns:a16="http://schemas.microsoft.com/office/drawing/2014/main" val="2297954170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503350955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1292920254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2583124190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2623948246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4276354975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266536482"/>
                    </a:ext>
                  </a:extLst>
                </a:gridCol>
                <a:gridCol w="790496">
                  <a:extLst>
                    <a:ext uri="{9D8B030D-6E8A-4147-A177-3AD203B41FA5}">
                      <a16:colId xmlns:a16="http://schemas.microsoft.com/office/drawing/2014/main" val="318515745"/>
                    </a:ext>
                  </a:extLst>
                </a:gridCol>
              </a:tblGrid>
              <a:tr h="252000">
                <a:tc rowSpan="2"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Stimulus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fr-FR" sz="1000" b="1" dirty="0"/>
                        <a:t>Correct </a:t>
                      </a:r>
                      <a:r>
                        <a:rPr lang="fr-FR" sz="1000" b="1" dirty="0" err="1"/>
                        <a:t>response</a:t>
                      </a:r>
                      <a:endParaRPr lang="fr-FR" sz="1000" b="1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Violation of…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977653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first point position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first point </a:t>
                      </a:r>
                      <a:r>
                        <a:rPr lang="fr-FR" sz="1000" dirty="0" err="1"/>
                        <a:t>derivative</a:t>
                      </a:r>
                      <a:endParaRPr lang="fr-FR" sz="100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</a:t>
                      </a:r>
                      <a:r>
                        <a:rPr lang="fr-FR" sz="1000" dirty="0" err="1"/>
                        <a:t>overall</a:t>
                      </a:r>
                      <a:r>
                        <a:rPr lang="fr-FR" sz="1000" dirty="0"/>
                        <a:t> tren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motif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…non </a:t>
                      </a:r>
                      <a:r>
                        <a:rPr lang="fr-FR" sz="1000" dirty="0" err="1"/>
                        <a:t>periodicity</a:t>
                      </a:r>
                      <a:endParaRPr lang="fr-FR" sz="100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79304972"/>
                  </a:ext>
                </a:extLst>
              </a:tr>
              <a:tr h="1080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/>
                        <a:t>Sinusoïd</a:t>
                      </a:r>
                      <a:endParaRPr lang="fr-FR" sz="1000" dirty="0"/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9745082"/>
                  </a:ext>
                </a:extLst>
              </a:tr>
              <a:tr h="108000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/>
                        <a:t>Zigzag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77649476"/>
                  </a:ext>
                </a:extLst>
              </a:tr>
            </a:tbl>
          </a:graphicData>
        </a:graphic>
      </p:graphicFrame>
      <p:sp>
        <p:nvSpPr>
          <p:cNvPr id="115" name="ZoneTexte 114">
            <a:extLst>
              <a:ext uri="{FF2B5EF4-FFF2-40B4-BE49-F238E27FC236}">
                <a16:creationId xmlns:a16="http://schemas.microsoft.com/office/drawing/2014/main" id="{991068CE-9810-4FEF-49B1-602EEBA006C6}"/>
              </a:ext>
            </a:extLst>
          </p:cNvPr>
          <p:cNvSpPr txBox="1"/>
          <p:nvPr/>
        </p:nvSpPr>
        <p:spPr>
          <a:xfrm>
            <a:off x="299220" y="4613231"/>
            <a:ext cx="632547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9. Percentage of chosen prolongations for oscillating functions.  </a:t>
            </a:r>
            <a:r>
              <a:rPr lang="en-US" sz="11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ch case reports the percentage of trials in which participants chose that specific prolongation among the six available options, separately for 5- and 6-year-old children.</a:t>
            </a:r>
            <a:endParaRPr lang="it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0F4A270D-1792-B818-550B-8E38464DC85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870" t="50301" r="13801" b="31076"/>
          <a:stretch/>
        </p:blipFill>
        <p:spPr>
          <a:xfrm>
            <a:off x="1895864" y="1926206"/>
            <a:ext cx="4707005" cy="363645"/>
          </a:xfrm>
          <a:prstGeom prst="rect">
            <a:avLst/>
          </a:prstGeom>
        </p:spPr>
      </p:pic>
      <p:pic>
        <p:nvPicPr>
          <p:cNvPr id="7" name="Image 6" descr="Une image contenant ligne, conception&#10;&#10;Description générée automatiquement">
            <a:extLst>
              <a:ext uri="{FF2B5EF4-FFF2-40B4-BE49-F238E27FC236}">
                <a16:creationId xmlns:a16="http://schemas.microsoft.com/office/drawing/2014/main" id="{280E96CA-B609-8734-9021-A9CFB719F9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6059" y="2483798"/>
            <a:ext cx="720000" cy="513939"/>
          </a:xfrm>
          <a:prstGeom prst="rect">
            <a:avLst/>
          </a:prstGeom>
        </p:spPr>
      </p:pic>
      <p:pic>
        <p:nvPicPr>
          <p:cNvPr id="11" name="Image 10" descr="Une image contenant conception, typographie&#10;&#10;Description générée automatiquement avec une confiance moyenne">
            <a:extLst>
              <a:ext uri="{FF2B5EF4-FFF2-40B4-BE49-F238E27FC236}">
                <a16:creationId xmlns:a16="http://schemas.microsoft.com/office/drawing/2014/main" id="{97AC3293-CAB9-4932-372F-9233AC88A2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3865" y="1291469"/>
            <a:ext cx="720000" cy="513939"/>
          </a:xfrm>
          <a:prstGeom prst="rect">
            <a:avLst/>
          </a:prstGeom>
        </p:spPr>
      </p:pic>
      <p:pic>
        <p:nvPicPr>
          <p:cNvPr id="15" name="Image 14" descr="Une image contenant conception, typographie&#10;&#10;Description générée automatiquement avec une confiance moyenne">
            <a:extLst>
              <a:ext uri="{FF2B5EF4-FFF2-40B4-BE49-F238E27FC236}">
                <a16:creationId xmlns:a16="http://schemas.microsoft.com/office/drawing/2014/main" id="{AE6A9388-17EA-F676-0203-92116110FC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1956" y="1291469"/>
            <a:ext cx="720000" cy="513939"/>
          </a:xfrm>
          <a:prstGeom prst="rect">
            <a:avLst/>
          </a:prstGeom>
        </p:spPr>
      </p:pic>
      <p:pic>
        <p:nvPicPr>
          <p:cNvPr id="18" name="Image 17" descr="Une image contenant conception, typographie&#10;&#10;Description générée automatiquement avec une confiance moyenne">
            <a:extLst>
              <a:ext uri="{FF2B5EF4-FFF2-40B4-BE49-F238E27FC236}">
                <a16:creationId xmlns:a16="http://schemas.microsoft.com/office/drawing/2014/main" id="{A21B0EFD-6FAC-4A7E-943F-1651A728E8A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49842" y="1291469"/>
            <a:ext cx="720000" cy="513939"/>
          </a:xfrm>
          <a:prstGeom prst="rect">
            <a:avLst/>
          </a:prstGeom>
        </p:spPr>
      </p:pic>
      <p:pic>
        <p:nvPicPr>
          <p:cNvPr id="21" name="Image 20" descr="Une image contenant conception&#10;&#10;Description générée automatiquement">
            <a:extLst>
              <a:ext uri="{FF2B5EF4-FFF2-40B4-BE49-F238E27FC236}">
                <a16:creationId xmlns:a16="http://schemas.microsoft.com/office/drawing/2014/main" id="{CE7CD0EF-4C42-720B-EDA9-A591756ABF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4035" y="1291469"/>
            <a:ext cx="720000" cy="513939"/>
          </a:xfrm>
          <a:prstGeom prst="rect">
            <a:avLst/>
          </a:prstGeom>
        </p:spPr>
      </p:pic>
      <p:pic>
        <p:nvPicPr>
          <p:cNvPr id="24" name="Image 23" descr="Une image contenant diagramme, conception&#10;&#10;Description générée automatiquement">
            <a:extLst>
              <a:ext uri="{FF2B5EF4-FFF2-40B4-BE49-F238E27FC236}">
                <a16:creationId xmlns:a16="http://schemas.microsoft.com/office/drawing/2014/main" id="{3BA4988B-ED65-2B4A-26FE-90B05D0A973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93472" y="1291469"/>
            <a:ext cx="720000" cy="513939"/>
          </a:xfrm>
          <a:prstGeom prst="rect">
            <a:avLst/>
          </a:prstGeom>
        </p:spPr>
      </p:pic>
      <p:pic>
        <p:nvPicPr>
          <p:cNvPr id="26" name="Image 25" descr="Une image contenant conception&#10;&#10;Description générée automatiquement">
            <a:extLst>
              <a:ext uri="{FF2B5EF4-FFF2-40B4-BE49-F238E27FC236}">
                <a16:creationId xmlns:a16="http://schemas.microsoft.com/office/drawing/2014/main" id="{4C43132F-2D37-4FDD-5677-992D97CF488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19983" y="1529232"/>
            <a:ext cx="720000" cy="513939"/>
          </a:xfrm>
          <a:prstGeom prst="rect">
            <a:avLst/>
          </a:prstGeom>
        </p:spPr>
      </p:pic>
      <p:pic>
        <p:nvPicPr>
          <p:cNvPr id="29" name="Image 28" descr="Une image contenant conception, typographie&#10;&#10;Description générée automatiquement avec une confiance moyenne">
            <a:extLst>
              <a:ext uri="{FF2B5EF4-FFF2-40B4-BE49-F238E27FC236}">
                <a16:creationId xmlns:a16="http://schemas.microsoft.com/office/drawing/2014/main" id="{29D136BC-0564-14D4-91A7-A06C20E2734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86059" y="1291469"/>
            <a:ext cx="720000" cy="513939"/>
          </a:xfrm>
          <a:prstGeom prst="rect">
            <a:avLst/>
          </a:prstGeom>
        </p:spPr>
      </p:pic>
      <p:pic>
        <p:nvPicPr>
          <p:cNvPr id="32" name="Image 31" descr="Une image contenant ligne, conception&#10;&#10;Description générée automatiquement">
            <a:extLst>
              <a:ext uri="{FF2B5EF4-FFF2-40B4-BE49-F238E27FC236}">
                <a16:creationId xmlns:a16="http://schemas.microsoft.com/office/drawing/2014/main" id="{84E0A219-9C8C-5B84-A1D8-A65646C1C2A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53865" y="2483798"/>
            <a:ext cx="720000" cy="513939"/>
          </a:xfrm>
          <a:prstGeom prst="rect">
            <a:avLst/>
          </a:prstGeom>
        </p:spPr>
      </p:pic>
      <p:pic>
        <p:nvPicPr>
          <p:cNvPr id="34" name="Image 33" descr="Une image contenant ligne, conception&#10;&#10;Description générée automatiquement">
            <a:extLst>
              <a:ext uri="{FF2B5EF4-FFF2-40B4-BE49-F238E27FC236}">
                <a16:creationId xmlns:a16="http://schemas.microsoft.com/office/drawing/2014/main" id="{FE24DB21-D590-81B7-B8F4-14E02DF4F4D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61956" y="2483798"/>
            <a:ext cx="720000" cy="513939"/>
          </a:xfrm>
          <a:prstGeom prst="rect">
            <a:avLst/>
          </a:prstGeom>
        </p:spPr>
      </p:pic>
      <p:pic>
        <p:nvPicPr>
          <p:cNvPr id="37" name="Image 36" descr="Une image contenant conception&#10;&#10;Description générée automatiquement">
            <a:extLst>
              <a:ext uri="{FF2B5EF4-FFF2-40B4-BE49-F238E27FC236}">
                <a16:creationId xmlns:a16="http://schemas.microsoft.com/office/drawing/2014/main" id="{DE5FE80F-FAF1-35DF-4994-191809F51F7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49842" y="2483798"/>
            <a:ext cx="720000" cy="513939"/>
          </a:xfrm>
          <a:prstGeom prst="rect">
            <a:avLst/>
          </a:prstGeom>
        </p:spPr>
      </p:pic>
      <p:pic>
        <p:nvPicPr>
          <p:cNvPr id="40" name="Image 39" descr="Une image contenant Police, conception&#10;&#10;Description générée automatiquement">
            <a:extLst>
              <a:ext uri="{FF2B5EF4-FFF2-40B4-BE49-F238E27FC236}">
                <a16:creationId xmlns:a16="http://schemas.microsoft.com/office/drawing/2014/main" id="{B8A60974-6394-B9E7-E22B-C6BA3848E94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84035" y="2483798"/>
            <a:ext cx="720000" cy="513939"/>
          </a:xfrm>
          <a:prstGeom prst="rect">
            <a:avLst/>
          </a:prstGeom>
        </p:spPr>
      </p:pic>
      <p:pic>
        <p:nvPicPr>
          <p:cNvPr id="42" name="Image 41" descr="Une image contenant ligne, diagramme, Graphique, conception&#10;&#10;Description générée automatiquement">
            <a:extLst>
              <a:ext uri="{FF2B5EF4-FFF2-40B4-BE49-F238E27FC236}">
                <a16:creationId xmlns:a16="http://schemas.microsoft.com/office/drawing/2014/main" id="{EA1EAD67-5DFF-B4F1-0DE6-7AAC496B1C1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893472" y="2483798"/>
            <a:ext cx="720000" cy="513939"/>
          </a:xfrm>
          <a:prstGeom prst="rect">
            <a:avLst/>
          </a:prstGeom>
        </p:spPr>
      </p:pic>
      <p:pic>
        <p:nvPicPr>
          <p:cNvPr id="46" name="Image 45" descr="Une image contenant Graphique, conception&#10;&#10;Description générée automatiquement">
            <a:extLst>
              <a:ext uri="{FF2B5EF4-FFF2-40B4-BE49-F238E27FC236}">
                <a16:creationId xmlns:a16="http://schemas.microsoft.com/office/drawing/2014/main" id="{347EAC4C-512E-B59B-AE44-57E91017F5B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19983" y="2728267"/>
            <a:ext cx="720000" cy="513939"/>
          </a:xfrm>
          <a:prstGeom prst="rect">
            <a:avLst/>
          </a:prstGeom>
        </p:spPr>
      </p:pic>
      <p:pic>
        <p:nvPicPr>
          <p:cNvPr id="48" name="Image 47">
            <a:extLst>
              <a:ext uri="{FF2B5EF4-FFF2-40B4-BE49-F238E27FC236}">
                <a16:creationId xmlns:a16="http://schemas.microsoft.com/office/drawing/2014/main" id="{BA8FE952-57DE-9CBA-EBD3-E28B7D13B9C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870" t="21269" r="13801" b="60108"/>
          <a:stretch/>
        </p:blipFill>
        <p:spPr>
          <a:xfrm>
            <a:off x="1904508" y="3068921"/>
            <a:ext cx="4707005" cy="363645"/>
          </a:xfrm>
          <a:prstGeom prst="rect">
            <a:avLst/>
          </a:prstGeom>
        </p:spPr>
      </p:pic>
      <p:sp>
        <p:nvSpPr>
          <p:cNvPr id="50" name="ZoneTexte 49">
            <a:extLst>
              <a:ext uri="{FF2B5EF4-FFF2-40B4-BE49-F238E27FC236}">
                <a16:creationId xmlns:a16="http://schemas.microsoft.com/office/drawing/2014/main" id="{872C9B83-B450-1D1E-1554-FD70BAD9E3A0}"/>
              </a:ext>
            </a:extLst>
          </p:cNvPr>
          <p:cNvSpPr txBox="1"/>
          <p:nvPr/>
        </p:nvSpPr>
        <p:spPr>
          <a:xfrm rot="18848527">
            <a:off x="1874950" y="3668892"/>
            <a:ext cx="7768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/>
              <a:t>6 </a:t>
            </a:r>
            <a:r>
              <a:rPr lang="fr-FR" sz="1000" b="1" dirty="0" err="1"/>
              <a:t>year-old</a:t>
            </a:r>
            <a:endParaRPr lang="fr-FR" sz="1000" b="1" dirty="0"/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8285576D-4791-7D4B-0A90-E1DE5462FF26}"/>
              </a:ext>
            </a:extLst>
          </p:cNvPr>
          <p:cNvSpPr txBox="1"/>
          <p:nvPr/>
        </p:nvSpPr>
        <p:spPr>
          <a:xfrm rot="18848527">
            <a:off x="1462053" y="3667062"/>
            <a:ext cx="7768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/>
              <a:t>5 </a:t>
            </a:r>
            <a:r>
              <a:rPr lang="fr-FR" sz="1000" b="1" dirty="0" err="1"/>
              <a:t>year-old</a:t>
            </a:r>
            <a:endParaRPr lang="fr-FR" sz="1000" b="1" dirty="0"/>
          </a:p>
        </p:txBody>
      </p:sp>
    </p:spTree>
    <p:extLst>
      <p:ext uri="{BB962C8B-B14F-4D97-AF65-F5344CB8AC3E}">
        <p14:creationId xmlns:p14="http://schemas.microsoft.com/office/powerpoint/2010/main" val="12751397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 2013 – 2022">
  <a:themeElements>
    <a:clrScheme name="Thème Office 2013 –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 2013 –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 2013 –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5238</TotalTime>
  <Words>652</Words>
  <Application>Microsoft Macintosh PowerPoint</Application>
  <PresentationFormat>Personalizzato</PresentationFormat>
  <Paragraphs>128</Paragraphs>
  <Slides>10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Thème Office 2013 – 2022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rosoft Office User</dc:creator>
  <cp:lastModifiedBy>Microsoft Office User</cp:lastModifiedBy>
  <cp:revision>257</cp:revision>
  <dcterms:created xsi:type="dcterms:W3CDTF">2024-04-24T15:59:27Z</dcterms:created>
  <dcterms:modified xsi:type="dcterms:W3CDTF">2025-09-04T08:33:39Z</dcterms:modified>
</cp:coreProperties>
</file>